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.xml" ContentType="application/vnd.openxmlformats-officedocument.drawingml.chart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399" r:id="rId2"/>
    <p:sldId id="256" r:id="rId3"/>
    <p:sldId id="407" r:id="rId4"/>
    <p:sldId id="405" r:id="rId5"/>
    <p:sldId id="404" r:id="rId6"/>
    <p:sldId id="403" r:id="rId7"/>
    <p:sldId id="400" r:id="rId8"/>
    <p:sldId id="401" r:id="rId9"/>
    <p:sldId id="402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20" autoAdjust="0"/>
    <p:restoredTop sz="70051" autoAdjust="0"/>
  </p:normalViewPr>
  <p:slideViewPr>
    <p:cSldViewPr snapToGrid="0">
      <p:cViewPr varScale="1">
        <p:scale>
          <a:sx n="33" d="100"/>
          <a:sy n="33" d="100"/>
        </p:scale>
        <p:origin x="-2368" y="-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E:\Elaborazione%20linee%20cellulari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30555121354523"/>
          <c:y val="1.6204634363390296E-2"/>
          <c:w val="0.87086396959000811"/>
          <c:h val="0.771866129898728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glio1!$A$3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trendline>
            <c:name>baseline (MCF10a)</c:name>
            <c:spPr>
              <a:ln w="63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BarType val="both"/>
            <c:errValType val="cust"/>
            <c:noEndCap val="0"/>
            <c:plus>
              <c:numRef>
                <c:f>Foglio1!$B$37:$L$37</c:f>
                <c:numCache>
                  <c:formatCode>General</c:formatCode>
                  <c:ptCount val="11"/>
                  <c:pt idx="0">
                    <c:v>7.3179999999999995E-2</c:v>
                  </c:pt>
                  <c:pt idx="1">
                    <c:v>4.4350000000000001E-2</c:v>
                  </c:pt>
                  <c:pt idx="2">
                    <c:v>4.1020000000000001E-2</c:v>
                  </c:pt>
                  <c:pt idx="3">
                    <c:v>0.11024</c:v>
                  </c:pt>
                  <c:pt idx="4">
                    <c:v>6.8949999999999997E-2</c:v>
                  </c:pt>
                  <c:pt idx="5">
                    <c:v>4.2819999999999997E-2</c:v>
                  </c:pt>
                  <c:pt idx="6">
                    <c:v>2.4379999999999999E-2</c:v>
                  </c:pt>
                  <c:pt idx="7">
                    <c:v>5.5809999999999998E-2</c:v>
                  </c:pt>
                  <c:pt idx="8">
                    <c:v>7.0720000000000005E-2</c:v>
                  </c:pt>
                  <c:pt idx="9">
                    <c:v>4.657E-2</c:v>
                  </c:pt>
                  <c:pt idx="10">
                    <c:v>0.26657999999999998</c:v>
                  </c:pt>
                </c:numCache>
              </c:numRef>
            </c:plus>
            <c:minus>
              <c:numRef>
                <c:f>Foglio1!$B$37:$L$37</c:f>
                <c:numCache>
                  <c:formatCode>General</c:formatCode>
                  <c:ptCount val="11"/>
                  <c:pt idx="0">
                    <c:v>7.3179999999999995E-2</c:v>
                  </c:pt>
                  <c:pt idx="1">
                    <c:v>4.4350000000000001E-2</c:v>
                  </c:pt>
                  <c:pt idx="2">
                    <c:v>4.1020000000000001E-2</c:v>
                  </c:pt>
                  <c:pt idx="3">
                    <c:v>0.11024</c:v>
                  </c:pt>
                  <c:pt idx="4">
                    <c:v>6.8949999999999997E-2</c:v>
                  </c:pt>
                  <c:pt idx="5">
                    <c:v>4.2819999999999997E-2</c:v>
                  </c:pt>
                  <c:pt idx="6">
                    <c:v>2.4379999999999999E-2</c:v>
                  </c:pt>
                  <c:pt idx="7">
                    <c:v>5.5809999999999998E-2</c:v>
                  </c:pt>
                  <c:pt idx="8">
                    <c:v>7.0720000000000005E-2</c:v>
                  </c:pt>
                  <c:pt idx="9">
                    <c:v>4.657E-2</c:v>
                  </c:pt>
                  <c:pt idx="10">
                    <c:v>0.26657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B$30:$L$30</c:f>
              <c:strCache>
                <c:ptCount val="11"/>
                <c:pt idx="0">
                  <c:v>AURKA</c:v>
                </c:pt>
                <c:pt idx="1">
                  <c:v>CCNB1</c:v>
                </c:pt>
                <c:pt idx="2">
                  <c:v>CCNB2</c:v>
                </c:pt>
                <c:pt idx="3">
                  <c:v>CDC20</c:v>
                </c:pt>
                <c:pt idx="4">
                  <c:v>CDC45</c:v>
                </c:pt>
                <c:pt idx="5">
                  <c:v>CDK1</c:v>
                </c:pt>
                <c:pt idx="6">
                  <c:v>ESPL1</c:v>
                </c:pt>
                <c:pt idx="7">
                  <c:v>NEK2</c:v>
                </c:pt>
                <c:pt idx="8">
                  <c:v>PLK1</c:v>
                </c:pt>
                <c:pt idx="9">
                  <c:v>PTTG1</c:v>
                </c:pt>
                <c:pt idx="10">
                  <c:v>RAD54L</c:v>
                </c:pt>
              </c:strCache>
            </c:strRef>
          </c:cat>
          <c:val>
            <c:numRef>
              <c:f>Foglio1!$B$31:$L$31</c:f>
              <c:numCache>
                <c:formatCode>0\,0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BA4-47DF-86FE-025C765429DA}"/>
            </c:ext>
          </c:extLst>
        </c:ser>
        <c:ser>
          <c:idx val="1"/>
          <c:order val="1"/>
          <c:tx>
            <c:strRef>
              <c:f>Foglio1!$A$32</c:f>
              <c:strCache>
                <c:ptCount val="1"/>
                <c:pt idx="0">
                  <c:v>Luminal A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B$38:$L$38</c:f>
                <c:numCache>
                  <c:formatCode>General</c:formatCode>
                  <c:ptCount val="11"/>
                  <c:pt idx="0">
                    <c:v>3.4619999999999998E-2</c:v>
                  </c:pt>
                  <c:pt idx="1">
                    <c:v>9.6850000000000006E-2</c:v>
                  </c:pt>
                  <c:pt idx="2">
                    <c:v>5.7695000000000003E-2</c:v>
                  </c:pt>
                  <c:pt idx="3">
                    <c:v>0.14957499999999999</c:v>
                  </c:pt>
                  <c:pt idx="4">
                    <c:v>0.13772000000000001</c:v>
                  </c:pt>
                  <c:pt idx="5">
                    <c:v>6.6654999999999992E-2</c:v>
                  </c:pt>
                  <c:pt idx="6">
                    <c:v>0.219945</c:v>
                  </c:pt>
                  <c:pt idx="7">
                    <c:v>0.20350499999999999</c:v>
                  </c:pt>
                  <c:pt idx="8">
                    <c:v>0.10864499999999999</c:v>
                  </c:pt>
                  <c:pt idx="9">
                    <c:v>0.86849500000000002</c:v>
                  </c:pt>
                  <c:pt idx="10">
                    <c:v>8.842499999999999E-2</c:v>
                  </c:pt>
                </c:numCache>
              </c:numRef>
            </c:plus>
            <c:minus>
              <c:numRef>
                <c:f>Foglio1!$B$38:$L$38</c:f>
                <c:numCache>
                  <c:formatCode>General</c:formatCode>
                  <c:ptCount val="11"/>
                  <c:pt idx="0">
                    <c:v>3.4619999999999998E-2</c:v>
                  </c:pt>
                  <c:pt idx="1">
                    <c:v>9.6850000000000006E-2</c:v>
                  </c:pt>
                  <c:pt idx="2">
                    <c:v>5.7695000000000003E-2</c:v>
                  </c:pt>
                  <c:pt idx="3">
                    <c:v>0.14957499999999999</c:v>
                  </c:pt>
                  <c:pt idx="4">
                    <c:v>0.13772000000000001</c:v>
                  </c:pt>
                  <c:pt idx="5">
                    <c:v>6.6654999999999992E-2</c:v>
                  </c:pt>
                  <c:pt idx="6">
                    <c:v>0.219945</c:v>
                  </c:pt>
                  <c:pt idx="7">
                    <c:v>0.20350499999999999</c:v>
                  </c:pt>
                  <c:pt idx="8">
                    <c:v>0.10864499999999999</c:v>
                  </c:pt>
                  <c:pt idx="9">
                    <c:v>0.86849500000000002</c:v>
                  </c:pt>
                  <c:pt idx="10">
                    <c:v>8.8424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B$30:$L$30</c:f>
              <c:strCache>
                <c:ptCount val="11"/>
                <c:pt idx="0">
                  <c:v>AURKA</c:v>
                </c:pt>
                <c:pt idx="1">
                  <c:v>CCNB1</c:v>
                </c:pt>
                <c:pt idx="2">
                  <c:v>CCNB2</c:v>
                </c:pt>
                <c:pt idx="3">
                  <c:v>CDC20</c:v>
                </c:pt>
                <c:pt idx="4">
                  <c:v>CDC45</c:v>
                </c:pt>
                <c:pt idx="5">
                  <c:v>CDK1</c:v>
                </c:pt>
                <c:pt idx="6">
                  <c:v>ESPL1</c:v>
                </c:pt>
                <c:pt idx="7">
                  <c:v>NEK2</c:v>
                </c:pt>
                <c:pt idx="8">
                  <c:v>PLK1</c:v>
                </c:pt>
                <c:pt idx="9">
                  <c:v>PTTG1</c:v>
                </c:pt>
                <c:pt idx="10">
                  <c:v>RAD54L</c:v>
                </c:pt>
              </c:strCache>
            </c:strRef>
          </c:cat>
          <c:val>
            <c:numRef>
              <c:f>Foglio1!$B$32:$L$32</c:f>
              <c:numCache>
                <c:formatCode>0\,0</c:formatCode>
                <c:ptCount val="11"/>
                <c:pt idx="0">
                  <c:v>5.0119727314883029</c:v>
                </c:pt>
                <c:pt idx="1">
                  <c:v>6.6694546792261811</c:v>
                </c:pt>
                <c:pt idx="2">
                  <c:v>5.9263791934128598</c:v>
                </c:pt>
                <c:pt idx="3">
                  <c:v>0.59414344473090186</c:v>
                </c:pt>
                <c:pt idx="4">
                  <c:v>3.3899801044775577</c:v>
                </c:pt>
                <c:pt idx="5">
                  <c:v>8.8603787142751678</c:v>
                </c:pt>
                <c:pt idx="6">
                  <c:v>6.6916267849401194</c:v>
                </c:pt>
                <c:pt idx="7">
                  <c:v>3.6059172811863589</c:v>
                </c:pt>
                <c:pt idx="8">
                  <c:v>0.14113288219639389</c:v>
                </c:pt>
                <c:pt idx="9">
                  <c:v>3.4530449481514394</c:v>
                </c:pt>
                <c:pt idx="10" formatCode="General">
                  <c:v>3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BA4-47DF-86FE-025C765429DA}"/>
            </c:ext>
          </c:extLst>
        </c:ser>
        <c:ser>
          <c:idx val="2"/>
          <c:order val="2"/>
          <c:tx>
            <c:strRef>
              <c:f>Foglio1!$A$33</c:f>
              <c:strCache>
                <c:ptCount val="1"/>
                <c:pt idx="0">
                  <c:v>Luminal B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B$39:$L$39</c:f>
                <c:numCache>
                  <c:formatCode>General</c:formatCode>
                  <c:ptCount val="11"/>
                  <c:pt idx="0">
                    <c:v>5.985E-2</c:v>
                  </c:pt>
                  <c:pt idx="1">
                    <c:v>4.3014999999999998E-2</c:v>
                  </c:pt>
                  <c:pt idx="2">
                    <c:v>4.3810000000000002E-2</c:v>
                  </c:pt>
                  <c:pt idx="3">
                    <c:v>0.45143</c:v>
                  </c:pt>
                  <c:pt idx="4">
                    <c:v>7.2940000000000005E-2</c:v>
                  </c:pt>
                  <c:pt idx="5">
                    <c:v>9.8659999999999998E-2</c:v>
                  </c:pt>
                  <c:pt idx="6">
                    <c:v>0.33728000000000002</c:v>
                  </c:pt>
                  <c:pt idx="7">
                    <c:v>7.6270000000000004E-2</c:v>
                  </c:pt>
                  <c:pt idx="8">
                    <c:v>0.10105</c:v>
                  </c:pt>
                  <c:pt idx="9">
                    <c:v>4.999E-2</c:v>
                  </c:pt>
                  <c:pt idx="10">
                    <c:v>0.30005999999999999</c:v>
                  </c:pt>
                </c:numCache>
              </c:numRef>
            </c:plus>
            <c:minus>
              <c:numRef>
                <c:f>Foglio1!$B$39:$L$39</c:f>
                <c:numCache>
                  <c:formatCode>General</c:formatCode>
                  <c:ptCount val="11"/>
                  <c:pt idx="0">
                    <c:v>5.985E-2</c:v>
                  </c:pt>
                  <c:pt idx="1">
                    <c:v>4.3014999999999998E-2</c:v>
                  </c:pt>
                  <c:pt idx="2">
                    <c:v>4.3810000000000002E-2</c:v>
                  </c:pt>
                  <c:pt idx="3">
                    <c:v>0.45143</c:v>
                  </c:pt>
                  <c:pt idx="4">
                    <c:v>7.2940000000000005E-2</c:v>
                  </c:pt>
                  <c:pt idx="5">
                    <c:v>9.8659999999999998E-2</c:v>
                  </c:pt>
                  <c:pt idx="6">
                    <c:v>0.33728000000000002</c:v>
                  </c:pt>
                  <c:pt idx="7">
                    <c:v>7.6270000000000004E-2</c:v>
                  </c:pt>
                  <c:pt idx="8">
                    <c:v>0.10105</c:v>
                  </c:pt>
                  <c:pt idx="9">
                    <c:v>4.999E-2</c:v>
                  </c:pt>
                  <c:pt idx="10">
                    <c:v>0.30005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B$30:$L$30</c:f>
              <c:strCache>
                <c:ptCount val="11"/>
                <c:pt idx="0">
                  <c:v>AURKA</c:v>
                </c:pt>
                <c:pt idx="1">
                  <c:v>CCNB1</c:v>
                </c:pt>
                <c:pt idx="2">
                  <c:v>CCNB2</c:v>
                </c:pt>
                <c:pt idx="3">
                  <c:v>CDC20</c:v>
                </c:pt>
                <c:pt idx="4">
                  <c:v>CDC45</c:v>
                </c:pt>
                <c:pt idx="5">
                  <c:v>CDK1</c:v>
                </c:pt>
                <c:pt idx="6">
                  <c:v>ESPL1</c:v>
                </c:pt>
                <c:pt idx="7">
                  <c:v>NEK2</c:v>
                </c:pt>
                <c:pt idx="8">
                  <c:v>PLK1</c:v>
                </c:pt>
                <c:pt idx="9">
                  <c:v>PTTG1</c:v>
                </c:pt>
                <c:pt idx="10">
                  <c:v>RAD54L</c:v>
                </c:pt>
              </c:strCache>
            </c:strRef>
          </c:cat>
          <c:val>
            <c:numRef>
              <c:f>Foglio1!$B$33:$L$33</c:f>
              <c:numCache>
                <c:formatCode>0\,0</c:formatCode>
                <c:ptCount val="11"/>
                <c:pt idx="0">
                  <c:v>9.4269221999730792</c:v>
                </c:pt>
                <c:pt idx="1">
                  <c:v>4.5815751135857328</c:v>
                </c:pt>
                <c:pt idx="2">
                  <c:v>7.5569664330243249</c:v>
                </c:pt>
                <c:pt idx="3">
                  <c:v>0.6104073730975299</c:v>
                </c:pt>
                <c:pt idx="4">
                  <c:v>5.1413529915520559</c:v>
                </c:pt>
                <c:pt idx="5">
                  <c:v>13.286303737858125</c:v>
                </c:pt>
                <c:pt idx="6">
                  <c:v>4.5929078831380545</c:v>
                </c:pt>
                <c:pt idx="7">
                  <c:v>3.7420267055871674</c:v>
                </c:pt>
                <c:pt idx="8">
                  <c:v>9.7665738133017627E-2</c:v>
                </c:pt>
                <c:pt idx="9">
                  <c:v>4.7139203835522956</c:v>
                </c:pt>
                <c:pt idx="10" formatCode="General">
                  <c:v>5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BA4-47DF-86FE-025C765429DA}"/>
            </c:ext>
          </c:extLst>
        </c:ser>
        <c:ser>
          <c:idx val="3"/>
          <c:order val="3"/>
          <c:tx>
            <c:strRef>
              <c:f>Foglio1!$A$34</c:f>
              <c:strCache>
                <c:ptCount val="1"/>
                <c:pt idx="0">
                  <c:v>Her2+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B$40:$L$40</c:f>
                <c:numCache>
                  <c:formatCode>General</c:formatCode>
                  <c:ptCount val="11"/>
                  <c:pt idx="0">
                    <c:v>0.12338499999999999</c:v>
                  </c:pt>
                  <c:pt idx="1">
                    <c:v>0.103265</c:v>
                  </c:pt>
                  <c:pt idx="2">
                    <c:v>4.2070000000000003E-2</c:v>
                  </c:pt>
                  <c:pt idx="3">
                    <c:v>0.23078499999999999</c:v>
                  </c:pt>
                  <c:pt idx="4">
                    <c:v>7.8780000000000003E-2</c:v>
                  </c:pt>
                  <c:pt idx="5">
                    <c:v>8.6969999999999992E-2</c:v>
                  </c:pt>
                  <c:pt idx="6">
                    <c:v>9.2609999999999998E-2</c:v>
                  </c:pt>
                  <c:pt idx="7">
                    <c:v>0.20605499999999999</c:v>
                  </c:pt>
                  <c:pt idx="8">
                    <c:v>0.23692000000000002</c:v>
                  </c:pt>
                  <c:pt idx="9">
                    <c:v>0.20297500000000002</c:v>
                  </c:pt>
                  <c:pt idx="10">
                    <c:v>0.25717500000000004</c:v>
                  </c:pt>
                </c:numCache>
              </c:numRef>
            </c:plus>
            <c:minus>
              <c:numRef>
                <c:f>Foglio1!$B$40:$L$40</c:f>
                <c:numCache>
                  <c:formatCode>General</c:formatCode>
                  <c:ptCount val="11"/>
                  <c:pt idx="0">
                    <c:v>0.12338499999999999</c:v>
                  </c:pt>
                  <c:pt idx="1">
                    <c:v>0.103265</c:v>
                  </c:pt>
                  <c:pt idx="2">
                    <c:v>4.2070000000000003E-2</c:v>
                  </c:pt>
                  <c:pt idx="3">
                    <c:v>0.23078499999999999</c:v>
                  </c:pt>
                  <c:pt idx="4">
                    <c:v>7.8780000000000003E-2</c:v>
                  </c:pt>
                  <c:pt idx="5">
                    <c:v>8.6969999999999992E-2</c:v>
                  </c:pt>
                  <c:pt idx="6">
                    <c:v>9.2609999999999998E-2</c:v>
                  </c:pt>
                  <c:pt idx="7">
                    <c:v>0.20605499999999999</c:v>
                  </c:pt>
                  <c:pt idx="8">
                    <c:v>0.23692000000000002</c:v>
                  </c:pt>
                  <c:pt idx="9">
                    <c:v>0.20297500000000002</c:v>
                  </c:pt>
                  <c:pt idx="10">
                    <c:v>0.257175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B$30:$L$30</c:f>
              <c:strCache>
                <c:ptCount val="11"/>
                <c:pt idx="0">
                  <c:v>AURKA</c:v>
                </c:pt>
                <c:pt idx="1">
                  <c:v>CCNB1</c:v>
                </c:pt>
                <c:pt idx="2">
                  <c:v>CCNB2</c:v>
                </c:pt>
                <c:pt idx="3">
                  <c:v>CDC20</c:v>
                </c:pt>
                <c:pt idx="4">
                  <c:v>CDC45</c:v>
                </c:pt>
                <c:pt idx="5">
                  <c:v>CDK1</c:v>
                </c:pt>
                <c:pt idx="6">
                  <c:v>ESPL1</c:v>
                </c:pt>
                <c:pt idx="7">
                  <c:v>NEK2</c:v>
                </c:pt>
                <c:pt idx="8">
                  <c:v>PLK1</c:v>
                </c:pt>
                <c:pt idx="9">
                  <c:v>PTTG1</c:v>
                </c:pt>
                <c:pt idx="10">
                  <c:v>RAD54L</c:v>
                </c:pt>
              </c:strCache>
            </c:strRef>
          </c:cat>
          <c:val>
            <c:numRef>
              <c:f>Foglio1!$B$34:$L$34</c:f>
              <c:numCache>
                <c:formatCode>0\,0</c:formatCode>
                <c:ptCount val="11"/>
                <c:pt idx="0">
                  <c:v>2.7997273319682807</c:v>
                </c:pt>
                <c:pt idx="1">
                  <c:v>3.9326642215871228</c:v>
                </c:pt>
                <c:pt idx="2">
                  <c:v>3.9766455824028273</c:v>
                </c:pt>
                <c:pt idx="3">
                  <c:v>0.40743388904465067</c:v>
                </c:pt>
                <c:pt idx="4">
                  <c:v>4.8937918030782575</c:v>
                </c:pt>
                <c:pt idx="5">
                  <c:v>4.7289740221987353</c:v>
                </c:pt>
                <c:pt idx="6">
                  <c:v>2.4255768058927782</c:v>
                </c:pt>
                <c:pt idx="7">
                  <c:v>1.7509638826356031</c:v>
                </c:pt>
                <c:pt idx="8">
                  <c:v>7.8930029112397715E-2</c:v>
                </c:pt>
                <c:pt idx="9">
                  <c:v>1.133637947344591</c:v>
                </c:pt>
                <c:pt idx="10" formatCode="General">
                  <c:v>3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CBA4-47DF-86FE-025C765429DA}"/>
            </c:ext>
          </c:extLst>
        </c:ser>
        <c:ser>
          <c:idx val="4"/>
          <c:order val="4"/>
          <c:tx>
            <c:strRef>
              <c:f>Foglio1!$A$35</c:f>
              <c:strCache>
                <c:ptCount val="1"/>
                <c:pt idx="0">
                  <c:v>Triple Negative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oglio1!$B$41:$L$41</c:f>
                <c:numCache>
                  <c:formatCode>General</c:formatCode>
                  <c:ptCount val="11"/>
                  <c:pt idx="0">
                    <c:v>0.24113499999999999</c:v>
                  </c:pt>
                  <c:pt idx="1">
                    <c:v>6.2579999999999997E-2</c:v>
                  </c:pt>
                  <c:pt idx="2">
                    <c:v>0.20991500000000002</c:v>
                  </c:pt>
                  <c:pt idx="3">
                    <c:v>5.4035E-2</c:v>
                  </c:pt>
                  <c:pt idx="4">
                    <c:v>3.5949999999999996E-2</c:v>
                  </c:pt>
                  <c:pt idx="5">
                    <c:v>0.20241500000000001</c:v>
                  </c:pt>
                  <c:pt idx="6">
                    <c:v>0.20132</c:v>
                  </c:pt>
                  <c:pt idx="7">
                    <c:v>0.110995</c:v>
                  </c:pt>
                  <c:pt idx="8">
                    <c:v>4.1665000000000001E-2</c:v>
                  </c:pt>
                  <c:pt idx="9">
                    <c:v>0.20073000000000002</c:v>
                  </c:pt>
                  <c:pt idx="10">
                    <c:v>0.31671499999999997</c:v>
                  </c:pt>
                </c:numCache>
              </c:numRef>
            </c:plus>
            <c:minus>
              <c:numRef>
                <c:f>Foglio1!$B$41:$L$41</c:f>
                <c:numCache>
                  <c:formatCode>General</c:formatCode>
                  <c:ptCount val="11"/>
                  <c:pt idx="0">
                    <c:v>0.24113499999999999</c:v>
                  </c:pt>
                  <c:pt idx="1">
                    <c:v>6.2579999999999997E-2</c:v>
                  </c:pt>
                  <c:pt idx="2">
                    <c:v>0.20991500000000002</c:v>
                  </c:pt>
                  <c:pt idx="3">
                    <c:v>5.4035E-2</c:v>
                  </c:pt>
                  <c:pt idx="4">
                    <c:v>3.5949999999999996E-2</c:v>
                  </c:pt>
                  <c:pt idx="5">
                    <c:v>0.20241500000000001</c:v>
                  </c:pt>
                  <c:pt idx="6">
                    <c:v>0.20132</c:v>
                  </c:pt>
                  <c:pt idx="7">
                    <c:v>0.110995</c:v>
                  </c:pt>
                  <c:pt idx="8">
                    <c:v>4.1665000000000001E-2</c:v>
                  </c:pt>
                  <c:pt idx="9">
                    <c:v>0.20073000000000002</c:v>
                  </c:pt>
                  <c:pt idx="10">
                    <c:v>0.3167149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B$30:$L$30</c:f>
              <c:strCache>
                <c:ptCount val="11"/>
                <c:pt idx="0">
                  <c:v>AURKA</c:v>
                </c:pt>
                <c:pt idx="1">
                  <c:v>CCNB1</c:v>
                </c:pt>
                <c:pt idx="2">
                  <c:v>CCNB2</c:v>
                </c:pt>
                <c:pt idx="3">
                  <c:v>CDC20</c:v>
                </c:pt>
                <c:pt idx="4">
                  <c:v>CDC45</c:v>
                </c:pt>
                <c:pt idx="5">
                  <c:v>CDK1</c:v>
                </c:pt>
                <c:pt idx="6">
                  <c:v>ESPL1</c:v>
                </c:pt>
                <c:pt idx="7">
                  <c:v>NEK2</c:v>
                </c:pt>
                <c:pt idx="8">
                  <c:v>PLK1</c:v>
                </c:pt>
                <c:pt idx="9">
                  <c:v>PTTG1</c:v>
                </c:pt>
                <c:pt idx="10">
                  <c:v>RAD54L</c:v>
                </c:pt>
              </c:strCache>
            </c:strRef>
          </c:cat>
          <c:val>
            <c:numRef>
              <c:f>Foglio1!$B$35:$L$35</c:f>
              <c:numCache>
                <c:formatCode>0\,0</c:formatCode>
                <c:ptCount val="11"/>
                <c:pt idx="0">
                  <c:v>1.3756205925976168</c:v>
                </c:pt>
                <c:pt idx="1">
                  <c:v>2.2381842893391446</c:v>
                </c:pt>
                <c:pt idx="2">
                  <c:v>1.3306071909275474</c:v>
                </c:pt>
                <c:pt idx="3">
                  <c:v>0.28626262930409641</c:v>
                </c:pt>
                <c:pt idx="4">
                  <c:v>2.3926290729576247</c:v>
                </c:pt>
                <c:pt idx="5">
                  <c:v>1.2267868769254526</c:v>
                </c:pt>
                <c:pt idx="6">
                  <c:v>2.9538227394419674</c:v>
                </c:pt>
                <c:pt idx="7">
                  <c:v>0.98541436962713203</c:v>
                </c:pt>
                <c:pt idx="8">
                  <c:v>8.9752532321704728E-2</c:v>
                </c:pt>
                <c:pt idx="9">
                  <c:v>2.1470249727835591</c:v>
                </c:pt>
                <c:pt idx="10" formatCode="General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CBA4-47DF-86FE-025C765429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505216"/>
        <c:axId val="170386560"/>
      </c:barChart>
      <c:catAx>
        <c:axId val="194505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70386560"/>
        <c:crosses val="autoZero"/>
        <c:auto val="1"/>
        <c:lblAlgn val="ctr"/>
        <c:lblOffset val="100"/>
        <c:noMultiLvlLbl val="0"/>
      </c:catAx>
      <c:valAx>
        <c:axId val="170386560"/>
        <c:scaling>
          <c:orientation val="minMax"/>
          <c:max val="1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>
                    <a:solidFill>
                      <a:sysClr val="windowText" lastClr="000000"/>
                    </a:solidFill>
                  </a:rPr>
                  <a:t>Relative Normalized</a:t>
                </a:r>
                <a:r>
                  <a:rPr lang="it-IT" baseline="0">
                    <a:solidFill>
                      <a:sysClr val="windowText" lastClr="000000"/>
                    </a:solidFill>
                  </a:rPr>
                  <a:t> Expression</a:t>
                </a:r>
                <a:endParaRPr lang="it-IT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450521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3385463293936589"/>
          <c:y val="0.85098331143066586"/>
          <c:w val="0.81979121317777881"/>
          <c:h val="7.71015997731473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E63621-4A1B-457E-BCD9-AF8896B43E16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4BA60-7F40-4986-9D92-0D7646269D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2974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</a:t>
            </a:r>
            <a:r>
              <a:rPr lang="en-US" sz="1200" b="1" dirty="0" smtClean="0">
                <a:latin typeface="Palatino Linotype" panose="02040502050505030304" pitchFamily="18" charset="0"/>
              </a:rPr>
              <a:t>The probability distribution of APCC for each breast subtype</a:t>
            </a:r>
            <a:r>
              <a:rPr lang="en-US" sz="1200" dirty="0" smtClean="0">
                <a:latin typeface="Palatino Linotype" panose="02040502050505030304" pitchFamily="18" charset="0"/>
              </a:rPr>
              <a:t>. APCC (Average Pearson Correlation Coefficient) distribution of each analyzed breast subtype shows a </a:t>
            </a:r>
            <a:r>
              <a:rPr lang="en-US" sz="1200" dirty="0" err="1" smtClean="0">
                <a:latin typeface="Palatino Linotype" panose="02040502050505030304" pitchFamily="18" charset="0"/>
              </a:rPr>
              <a:t>trimodal</a:t>
            </a:r>
            <a:r>
              <a:rPr lang="en-US" sz="1200" dirty="0" smtClean="0">
                <a:latin typeface="Palatino Linotype" panose="02040502050505030304" pitchFamily="18" charset="0"/>
              </a:rPr>
              <a:t> pattern where peaks correspond to date/party/fight-club hubs. Date hubs are hubs with APCC &lt; 0.5 (i.e. low co-expression with their partners); party hubs are hubs with APCC ≥ 0.5 (i.e. high co-expression with their partners), and fight-club hubs are hubs with negative APCC values (i.e. inversely correlated with their partners).</a:t>
            </a:r>
            <a:r>
              <a:rPr lang="en-US" sz="18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it-IT" sz="1800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EDB52B-1E7E-41F7-9205-D9B96ED4683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11685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</a:t>
            </a:r>
            <a:r>
              <a:rPr lang="en-US" sz="1200" b="1" dirty="0" smtClean="0">
                <a:latin typeface="Palatino Linotype" panose="02040502050505030304" pitchFamily="18" charset="0"/>
              </a:rPr>
              <a:t>Venn diagrams of switch genes identified by the SWIM tool. </a:t>
            </a:r>
            <a:r>
              <a:rPr lang="en-US" sz="1200" dirty="0" smtClean="0">
                <a:latin typeface="Palatino Linotype" panose="02040502050505030304" pitchFamily="18" charset="0"/>
              </a:rPr>
              <a:t>A) Swim output based on </a:t>
            </a:r>
            <a:r>
              <a:rPr lang="en-US" sz="1200" dirty="0" err="1" smtClean="0">
                <a:latin typeface="Palatino Linotype" panose="02040502050505030304" pitchFamily="18" charset="0"/>
              </a:rPr>
              <a:t>Immunohistochemical</a:t>
            </a:r>
            <a:r>
              <a:rPr lang="en-US" sz="1200" dirty="0" smtClean="0">
                <a:latin typeface="Palatino Linotype" panose="02040502050505030304" pitchFamily="18" charset="0"/>
              </a:rPr>
              <a:t> subtype classification (Luminal Her2-Negative, Luminal B-like, Her2 positive and Triple-negative). B) SWIM output based on genetic (PAM50) subtype classification (Luminal A, Luminal B, Her2 positive and Basal-like).</a:t>
            </a:r>
            <a:endParaRPr lang="it-IT" sz="1800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32382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it-IT" sz="1200" b="1" dirty="0" smtClean="0">
                <a:latin typeface="Palatino Linotype" panose="02040502050505030304" pitchFamily="18" charset="0"/>
              </a:rPr>
              <a:t>Figure S3: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Heatmaps</a:t>
            </a:r>
            <a:r>
              <a:rPr lang="it-IT" sz="1200" b="1" dirty="0" smtClean="0">
                <a:latin typeface="Palatino Linotype" panose="02040502050505030304" pitchFamily="18" charset="0"/>
              </a:rPr>
              <a:t> for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switch</a:t>
            </a:r>
            <a:r>
              <a:rPr lang="it-IT" sz="1200" b="1" dirty="0" smtClean="0">
                <a:latin typeface="Palatino Linotype" panose="02040502050505030304" pitchFamily="18" charset="0"/>
              </a:rPr>
              <a:t>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genes</a:t>
            </a:r>
            <a:r>
              <a:rPr lang="it-IT" sz="1200" b="1" dirty="0" smtClean="0">
                <a:latin typeface="Palatino Linotype" panose="02040502050505030304" pitchFamily="18" charset="0"/>
              </a:rPr>
              <a:t> of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each</a:t>
            </a:r>
            <a:r>
              <a:rPr lang="it-IT" sz="1200" b="1" dirty="0" smtClean="0">
                <a:latin typeface="Palatino Linotype" panose="02040502050505030304" pitchFamily="18" charset="0"/>
              </a:rPr>
              <a:t>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breast</a:t>
            </a:r>
            <a:r>
              <a:rPr lang="it-IT" sz="1200" b="1" dirty="0" smtClean="0">
                <a:latin typeface="Palatino Linotype" panose="02040502050505030304" pitchFamily="18" charset="0"/>
              </a:rPr>
              <a:t> </a:t>
            </a:r>
            <a:r>
              <a:rPr lang="it-IT" sz="1200" b="1" dirty="0" err="1" smtClean="0">
                <a:latin typeface="Palatino Linotype" panose="02040502050505030304" pitchFamily="18" charset="0"/>
              </a:rPr>
              <a:t>subtype</a:t>
            </a:r>
            <a:r>
              <a:rPr lang="it-IT" sz="1200" b="1" dirty="0" smtClean="0">
                <a:latin typeface="Palatino Linotype" panose="02040502050505030304" pitchFamily="18" charset="0"/>
              </a:rPr>
              <a:t>.</a:t>
            </a:r>
            <a:r>
              <a:rPr lang="en-US" sz="1200" b="1" dirty="0" smtClean="0">
                <a:latin typeface="Palatino Linotype" panose="02040502050505030304" pitchFamily="18" charset="0"/>
              </a:rPr>
              <a:t> </a:t>
            </a:r>
            <a:r>
              <a:rPr lang="en-US" sz="1200" dirty="0" err="1" smtClean="0">
                <a:latin typeface="Palatino Linotype" panose="02040502050505030304" pitchFamily="18" charset="0"/>
              </a:rPr>
              <a:t>Heatmaps</a:t>
            </a:r>
            <a:r>
              <a:rPr lang="en-US" sz="1200" dirty="0" smtClean="0">
                <a:latin typeface="Palatino Linotype" panose="02040502050505030304" pitchFamily="18" charset="0"/>
              </a:rPr>
              <a:t> representing the expression profiles of switch genes (rows) identified for each breast subtype of</a:t>
            </a:r>
            <a:r>
              <a:rPr lang="it-IT" sz="1200" dirty="0" smtClean="0">
                <a:latin typeface="Palatino Linotype" panose="02040502050505030304" pitchFamily="18" charset="0"/>
              </a:rPr>
              <a:t> IHC </a:t>
            </a:r>
            <a:r>
              <a:rPr lang="it-IT" sz="1200" dirty="0" err="1" smtClean="0">
                <a:latin typeface="Palatino Linotype" panose="02040502050505030304" pitchFamily="18" charset="0"/>
              </a:rPr>
              <a:t>classification</a:t>
            </a:r>
            <a:r>
              <a:rPr lang="it-IT" sz="1200" dirty="0" smtClean="0">
                <a:latin typeface="Palatino Linotype" panose="02040502050505030304" pitchFamily="18" charset="0"/>
              </a:rPr>
              <a:t> (</a:t>
            </a:r>
            <a:r>
              <a:rPr lang="it-IT" sz="1200" dirty="0" err="1" smtClean="0">
                <a:latin typeface="Palatino Linotype" panose="02040502050505030304" pitchFamily="18" charset="0"/>
              </a:rPr>
              <a:t>upper</a:t>
            </a:r>
            <a:r>
              <a:rPr lang="it-IT" sz="1200" dirty="0" smtClean="0">
                <a:latin typeface="Palatino Linotype" panose="02040502050505030304" pitchFamily="18" charset="0"/>
              </a:rPr>
              <a:t> panel) and PAM50 </a:t>
            </a:r>
            <a:r>
              <a:rPr lang="it-IT" sz="1200" dirty="0" err="1" smtClean="0">
                <a:latin typeface="Palatino Linotype" panose="02040502050505030304" pitchFamily="18" charset="0"/>
              </a:rPr>
              <a:t>classification</a:t>
            </a:r>
            <a:r>
              <a:rPr lang="it-IT" sz="1200" dirty="0" smtClean="0">
                <a:latin typeface="Palatino Linotype" panose="02040502050505030304" pitchFamily="18" charset="0"/>
              </a:rPr>
              <a:t> (bottom panel) </a:t>
            </a:r>
            <a:r>
              <a:rPr lang="it-IT" sz="1200" dirty="0" err="1" smtClean="0">
                <a:latin typeface="Palatino Linotype" panose="02040502050505030304" pitchFamily="18" charset="0"/>
              </a:rPr>
              <a:t>across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all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tumor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samples</a:t>
            </a:r>
            <a:r>
              <a:rPr lang="it-IT" sz="1200" dirty="0" smtClean="0">
                <a:latin typeface="Palatino Linotype" panose="02040502050505030304" pitchFamily="18" charset="0"/>
              </a:rPr>
              <a:t> (</a:t>
            </a:r>
            <a:r>
              <a:rPr lang="it-IT" sz="1200" dirty="0" err="1" smtClean="0">
                <a:latin typeface="Palatino Linotype" panose="02040502050505030304" pitchFamily="18" charset="0"/>
              </a:rPr>
              <a:t>coloums</a:t>
            </a:r>
            <a:r>
              <a:rPr lang="it-IT" sz="1200" dirty="0" smtClean="0">
                <a:latin typeface="Palatino Linotype" panose="02040502050505030304" pitchFamily="18" charset="0"/>
              </a:rPr>
              <a:t>).  </a:t>
            </a:r>
            <a:r>
              <a:rPr lang="en-US" sz="1200" dirty="0" smtClean="0">
                <a:latin typeface="Palatino Linotype" panose="02040502050505030304" pitchFamily="18" charset="0"/>
              </a:rPr>
              <a:t>The expression profiles of switch genes were clustered according to rows by using Pearson correlation distance as metrics and </a:t>
            </a:r>
            <a:r>
              <a:rPr lang="it-IT" sz="1200" dirty="0" smtClean="0">
                <a:latin typeface="Palatino Linotype" panose="02040502050505030304" pitchFamily="18" charset="0"/>
              </a:rPr>
              <a:t>the </a:t>
            </a:r>
            <a:r>
              <a:rPr lang="it-IT" sz="1200" dirty="0" err="1" smtClean="0">
                <a:latin typeface="Palatino Linotype" panose="02040502050505030304" pitchFamily="18" charset="0"/>
              </a:rPr>
              <a:t>tumor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samples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were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grouped</a:t>
            </a:r>
            <a:r>
              <a:rPr lang="it-IT" sz="1200" dirty="0" smtClean="0">
                <a:latin typeface="Palatino Linotype" panose="02040502050505030304" pitchFamily="18" charset="0"/>
              </a:rPr>
              <a:t> and coloured </a:t>
            </a:r>
            <a:r>
              <a:rPr lang="it-IT" sz="1200" dirty="0" err="1" smtClean="0">
                <a:latin typeface="Palatino Linotype" panose="02040502050505030304" pitchFamily="18" charset="0"/>
              </a:rPr>
              <a:t>according</a:t>
            </a:r>
            <a:r>
              <a:rPr lang="it-IT" sz="1200" dirty="0" smtClean="0">
                <a:latin typeface="Palatino Linotype" panose="02040502050505030304" pitchFamily="18" charset="0"/>
              </a:rPr>
              <a:t> to the </a:t>
            </a:r>
            <a:r>
              <a:rPr lang="it-IT" sz="1200" dirty="0" err="1" smtClean="0">
                <a:latin typeface="Palatino Linotype" panose="02040502050505030304" pitchFamily="18" charset="0"/>
              </a:rPr>
              <a:t>specific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breast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subtype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they</a:t>
            </a:r>
            <a:r>
              <a:rPr lang="it-IT" sz="1200" dirty="0" smtClean="0">
                <a:latin typeface="Palatino Linotype" panose="02040502050505030304" pitchFamily="18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</a:rPr>
              <a:t>belong</a:t>
            </a:r>
            <a:r>
              <a:rPr lang="it-IT" sz="1200" dirty="0" smtClean="0">
                <a:latin typeface="Palatino Linotype" panose="02040502050505030304" pitchFamily="18" charset="0"/>
              </a:rPr>
              <a:t>. </a:t>
            </a:r>
            <a:r>
              <a:rPr lang="en-US" sz="1200" dirty="0" err="1" smtClean="0">
                <a:latin typeface="Palatino Linotype" panose="02040502050505030304" pitchFamily="18" charset="0"/>
              </a:rPr>
              <a:t>Heatmap</a:t>
            </a:r>
            <a:r>
              <a:rPr lang="en-US" sz="1200" dirty="0" smtClean="0">
                <a:latin typeface="Palatino Linotype" panose="02040502050505030304" pitchFamily="18" charset="0"/>
              </a:rPr>
              <a:t> colors represent different expression levels (z-score normalized) that increase from blue to yellow.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3EBD34-31C3-4E49-AE26-6A75F109724E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51036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</a:t>
            </a:r>
            <a:r>
              <a:rPr lang="en-US" sz="1200" b="1" dirty="0" smtClean="0">
                <a:latin typeface="Palatino Linotype" panose="02040502050505030304" pitchFamily="18" charset="0"/>
              </a:rPr>
              <a:t>Match between IHC and PAM50 classification switch genes defining Intersected Specific-Subtype (ISS) switches. </a:t>
            </a:r>
            <a:r>
              <a:rPr lang="en-US" sz="1200" dirty="0" smtClean="0">
                <a:latin typeface="Palatino Linotype" panose="02040502050505030304" pitchFamily="18" charset="0"/>
              </a:rPr>
              <a:t>Venn diagrams show the following intersections: A) Luminal subtype (IHC and PAM50). B) HER2+ subtype (IHC and PAM50). C) Basal subtype (IHC and PAM50).</a:t>
            </a:r>
            <a:endParaRPr lang="it-IT" sz="1800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790906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 </a:t>
            </a:r>
            <a:r>
              <a:rPr lang="en-GB" sz="1200" b="1" dirty="0" smtClean="0">
                <a:latin typeface="Palatino Linotype" panose="02040502050505030304" pitchFamily="18" charset="0"/>
              </a:rPr>
              <a:t>Protein-protein interaction (PPI) network of the 12 Intersected IHC–PAM50 switches (</a:t>
            </a:r>
            <a:r>
              <a:rPr lang="en-US" sz="1200" b="1" dirty="0" smtClean="0">
                <a:latin typeface="Palatino Linotype" panose="02040502050505030304" pitchFamily="18" charset="0"/>
              </a:rPr>
              <a:t>IS-switches)</a:t>
            </a:r>
            <a:r>
              <a:rPr lang="en-GB" sz="1200" b="1" dirty="0" smtClean="0">
                <a:latin typeface="Palatino Linotype" panose="02040502050505030304" pitchFamily="18" charset="0"/>
              </a:rPr>
              <a:t>. </a:t>
            </a:r>
            <a:r>
              <a:rPr lang="en-US" sz="1200" dirty="0" smtClean="0">
                <a:latin typeface="Palatino Linotype" panose="02040502050505030304" pitchFamily="18" charset="0"/>
              </a:rPr>
              <a:t>A) Pathway enrichment analysis of the </a:t>
            </a:r>
            <a:r>
              <a:rPr lang="en-GB" sz="1200" dirty="0" smtClean="0">
                <a:latin typeface="Palatino Linotype" panose="02040502050505030304" pitchFamily="18" charset="0"/>
              </a:rPr>
              <a:t>12 </a:t>
            </a:r>
            <a:r>
              <a:rPr lang="en-US" sz="1200" dirty="0" smtClean="0">
                <a:latin typeface="Palatino Linotype" panose="02040502050505030304" pitchFamily="18" charset="0"/>
              </a:rPr>
              <a:t>IS-switches</a:t>
            </a:r>
            <a:r>
              <a:rPr lang="en-GB" sz="1200" dirty="0" smtClean="0">
                <a:latin typeface="Palatino Linotype" panose="02040502050505030304" pitchFamily="18" charset="0"/>
              </a:rPr>
              <a:t>.</a:t>
            </a:r>
            <a:r>
              <a:rPr lang="en-GB" sz="1200" b="1" dirty="0" smtClean="0">
                <a:latin typeface="Palatino Linotype" panose="02040502050505030304" pitchFamily="18" charset="0"/>
              </a:rPr>
              <a:t> </a:t>
            </a:r>
            <a:r>
              <a:rPr lang="en-US" sz="1200" dirty="0" smtClean="0">
                <a:latin typeface="Palatino Linotype" panose="02040502050505030304" pitchFamily="18" charset="0"/>
              </a:rPr>
              <a:t>B) Protein-protein interaction (PPI) network of the </a:t>
            </a:r>
            <a:r>
              <a:rPr lang="en-GB" sz="1200" dirty="0" smtClean="0">
                <a:latin typeface="Palatino Linotype" panose="02040502050505030304" pitchFamily="18" charset="0"/>
              </a:rPr>
              <a:t>12 </a:t>
            </a:r>
            <a:r>
              <a:rPr lang="en-US" sz="1200" dirty="0" smtClean="0">
                <a:latin typeface="Palatino Linotype" panose="02040502050505030304" pitchFamily="18" charset="0"/>
              </a:rPr>
              <a:t>IS-switches</a:t>
            </a:r>
            <a:r>
              <a:rPr lang="en-GB" sz="1200" dirty="0" smtClean="0">
                <a:latin typeface="Palatino Linotype" panose="02040502050505030304" pitchFamily="18" charset="0"/>
              </a:rPr>
              <a:t>.</a:t>
            </a:r>
            <a:r>
              <a:rPr lang="en-US" sz="1200" dirty="0" smtClean="0">
                <a:latin typeface="Palatino Linotype" panose="02040502050505030304" pitchFamily="18" charset="0"/>
              </a:rPr>
              <a:t> C) </a:t>
            </a:r>
            <a:r>
              <a:rPr lang="en-GB" sz="1200" dirty="0" smtClean="0">
                <a:latin typeface="Palatino Linotype" panose="02040502050505030304" pitchFamily="18" charset="0"/>
              </a:rPr>
              <a:t>MCODE1 represents a densely connected protein complex (7 in red out of 12) of the PPI network by the Molecular Complex Detection algorithm.</a:t>
            </a:r>
            <a:endParaRPr lang="it-IT" sz="1200" dirty="0" smtClean="0">
              <a:latin typeface="Palatino Linotype" panose="0204050205050503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615829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: </a:t>
            </a:r>
            <a:r>
              <a:rPr lang="en-GB" sz="1200" b="1" dirty="0" smtClean="0">
                <a:latin typeface="Palatino Linotype" panose="02040502050505030304" pitchFamily="18" charset="0"/>
              </a:rPr>
              <a:t>Switch gene expression in BC cell lines vs control cell. </a:t>
            </a:r>
            <a:r>
              <a:rPr lang="en-GB" sz="1200" dirty="0" smtClean="0">
                <a:latin typeface="Palatino Linotype" panose="02040502050505030304" pitchFamily="18" charset="0"/>
              </a:rPr>
              <a:t>Switch gene expression in BC cancer cells and grouped for BC subtypes was evaluated in BC cell lines by real-time PCR.</a:t>
            </a:r>
            <a:endParaRPr lang="it-IT" sz="1200" dirty="0" smtClean="0">
              <a:latin typeface="Palatino Linotype" panose="0204050205050503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685946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: </a:t>
            </a:r>
            <a:r>
              <a:rPr lang="en-US" sz="1200" b="1" dirty="0" smtClean="0">
                <a:latin typeface="Palatino Linotype" panose="02040502050505030304" pitchFamily="18" charset="0"/>
              </a:rPr>
              <a:t>Distribution of switch genes among luminal and not luminal BC subtypes. </a:t>
            </a:r>
            <a:r>
              <a:rPr lang="en-US" sz="1200" dirty="0" smtClean="0">
                <a:latin typeface="Palatino Linotype" panose="02040502050505030304" pitchFamily="18" charset="0"/>
              </a:rPr>
              <a:t>AURKA (A), CDC45 (B), ESPL1 (C) and RAD54L (D) switch genes. Luminal = Luminal A and Luminal B subtypes; Not Luminal = HER2 positive and Triple-negative subtypes. </a:t>
            </a:r>
            <a:r>
              <a:rPr lang="en-GB" sz="1200" dirty="0" smtClean="0">
                <a:latin typeface="Palatino Linotype" panose="02040502050505030304" pitchFamily="18" charset="0"/>
              </a:rPr>
              <a:t>Mann Whitney test </a:t>
            </a:r>
            <a:r>
              <a:rPr lang="en-US" sz="1200" dirty="0" smtClean="0">
                <a:latin typeface="Palatino Linotype" panose="02040502050505030304" pitchFamily="18" charset="0"/>
              </a:rPr>
              <a:t>with pairwise multiple comparison always resulted in not statistically significant (p≥0.05). </a:t>
            </a:r>
            <a:endParaRPr lang="it-IT" sz="1200" dirty="0" smtClean="0">
              <a:latin typeface="Palatino Linotype" panose="0204050205050503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767568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8: </a:t>
            </a:r>
            <a:r>
              <a:rPr lang="en-US" sz="1200" b="1" dirty="0" smtClean="0">
                <a:latin typeface="Palatino Linotype" panose="02040502050505030304" pitchFamily="18" charset="0"/>
              </a:rPr>
              <a:t>Distribution of switch genes among G1-G2 and G3. </a:t>
            </a:r>
            <a:r>
              <a:rPr lang="en-US" sz="1200" dirty="0" smtClean="0">
                <a:latin typeface="Palatino Linotype" panose="02040502050505030304" pitchFamily="18" charset="0"/>
              </a:rPr>
              <a:t>AURKA (A), CDC45 (B), ESPL1 (C), and RAD54L (D) switch genes.</a:t>
            </a:r>
            <a:r>
              <a:rPr lang="en-US" sz="1200" b="1" dirty="0" smtClean="0">
                <a:latin typeface="Palatino Linotype" panose="02040502050505030304" pitchFamily="18" charset="0"/>
              </a:rPr>
              <a:t> </a:t>
            </a:r>
            <a:r>
              <a:rPr lang="en-US" sz="1200" dirty="0" smtClean="0">
                <a:latin typeface="Palatino Linotype" panose="02040502050505030304" pitchFamily="18" charset="0"/>
              </a:rPr>
              <a:t>G=Grade. </a:t>
            </a:r>
            <a:r>
              <a:rPr lang="en-GB" sz="1200" dirty="0" smtClean="0">
                <a:latin typeface="Palatino Linotype" panose="02040502050505030304" pitchFamily="18" charset="0"/>
              </a:rPr>
              <a:t>Mann Whitney test</a:t>
            </a:r>
            <a:r>
              <a:rPr lang="en-US" sz="1200" dirty="0" smtClean="0">
                <a:latin typeface="Palatino Linotype" panose="02040502050505030304" pitchFamily="18" charset="0"/>
              </a:rPr>
              <a:t> with pairwise multiple comparison always resulted in not statistically significant (p≥0.05). </a:t>
            </a:r>
            <a:endParaRPr lang="it-IT" sz="1200" dirty="0" smtClean="0">
              <a:latin typeface="Palatino Linotype" panose="0204050205050503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06072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9: </a:t>
            </a:r>
            <a:r>
              <a:rPr lang="en-US" sz="1200" b="1" dirty="0" smtClean="0">
                <a:latin typeface="Palatino Linotype" panose="02040502050505030304" pitchFamily="18" charset="0"/>
              </a:rPr>
              <a:t>Distribution of switch genes among disease Stages. </a:t>
            </a:r>
            <a:r>
              <a:rPr lang="en-US" sz="1200" dirty="0" smtClean="0">
                <a:latin typeface="Palatino Linotype" panose="02040502050505030304" pitchFamily="18" charset="0"/>
              </a:rPr>
              <a:t>AURKA (A), CDC45 (B), ESPL1 (C), and RAD54L (D) switch genes.</a:t>
            </a:r>
            <a:r>
              <a:rPr lang="en-US" sz="1200" b="1" dirty="0" smtClean="0">
                <a:latin typeface="Palatino Linotype" panose="02040502050505030304" pitchFamily="18" charset="0"/>
              </a:rPr>
              <a:t> </a:t>
            </a:r>
            <a:r>
              <a:rPr lang="en-US" sz="1200" dirty="0" smtClean="0">
                <a:latin typeface="Palatino Linotype" panose="02040502050505030304" pitchFamily="18" charset="0"/>
              </a:rPr>
              <a:t>1= Stage I, 2= Stage II, 3= Stage II and 4= Stage IV. In the table, for each hub genes analyzed, are reported p-values. </a:t>
            </a:r>
            <a:r>
              <a:rPr lang="en-GB" sz="1200" dirty="0" smtClean="0">
                <a:latin typeface="Palatino Linotype" panose="02040502050505030304" pitchFamily="18" charset="0"/>
              </a:rPr>
              <a:t>Mann Whitney test</a:t>
            </a:r>
            <a:r>
              <a:rPr lang="en-US" sz="1200" dirty="0" smtClean="0">
                <a:latin typeface="Palatino Linotype" panose="02040502050505030304" pitchFamily="18" charset="0"/>
              </a:rPr>
              <a:t> with pairwise multiple comparisons was used to assess statistical significance p≤0.05.</a:t>
            </a:r>
            <a:endParaRPr lang="it-IT" sz="1200" dirty="0" smtClean="0">
              <a:latin typeface="Palatino Linotype" panose="0204050205050503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34BA60-7F40-4986-9D92-0D7646269D5A}" type="slidenum">
              <a:rPr lang="it-IT" smtClean="0"/>
              <a:t>9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15688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5565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161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5294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1339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1423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1883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4971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1379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1876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7458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9849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190EF-43CE-4B03-AC73-D08270C6C48D}" type="datetimeFigureOut">
              <a:rPr lang="it-IT" smtClean="0"/>
              <a:t>07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E991C-C422-4604-9EB2-1CD21CCF25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4692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869" name="Gruppo 20868"/>
          <p:cNvGrpSpPr>
            <a:grpSpLocks noChangeAspect="1"/>
          </p:cNvGrpSpPr>
          <p:nvPr/>
        </p:nvGrpSpPr>
        <p:grpSpPr>
          <a:xfrm>
            <a:off x="482392" y="340486"/>
            <a:ext cx="5962262" cy="8849674"/>
            <a:chOff x="116632" y="-4574"/>
            <a:chExt cx="6624736" cy="9076589"/>
          </a:xfrm>
        </p:grpSpPr>
        <p:sp>
          <p:nvSpPr>
            <p:cNvPr id="4523" name="CasellaDiTesto 4522"/>
            <p:cNvSpPr txBox="1"/>
            <p:nvPr/>
          </p:nvSpPr>
          <p:spPr>
            <a:xfrm>
              <a:off x="1556792" y="-4574"/>
              <a:ext cx="3816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000" b="1" dirty="0">
                  <a:solidFill>
                    <a:srgbClr val="00B050"/>
                  </a:solidFill>
                  <a:latin typeface="+mj-lt"/>
                </a:rPr>
                <a:t>IHC </a:t>
              </a:r>
              <a:r>
                <a:rPr lang="it-IT" sz="2000" b="1" dirty="0" err="1">
                  <a:solidFill>
                    <a:srgbClr val="00B050"/>
                  </a:solidFill>
                  <a:latin typeface="+mj-lt"/>
                </a:rPr>
                <a:t>classification</a:t>
              </a:r>
              <a:endParaRPr lang="it-IT" sz="2000" b="1" dirty="0">
                <a:solidFill>
                  <a:srgbClr val="00B050"/>
                </a:solidFill>
                <a:latin typeface="+mj-lt"/>
              </a:endParaRPr>
            </a:p>
          </p:txBody>
        </p:sp>
        <p:sp>
          <p:nvSpPr>
            <p:cNvPr id="2560" name="CasellaDiTesto 8"/>
            <p:cNvSpPr txBox="1"/>
            <p:nvPr/>
          </p:nvSpPr>
          <p:spPr>
            <a:xfrm>
              <a:off x="764704" y="4675946"/>
              <a:ext cx="55446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it-IT" sz="2000" b="1" dirty="0">
                  <a:solidFill>
                    <a:srgbClr val="0070C0"/>
                  </a:solidFill>
                </a:rPr>
                <a:t>PAM50 </a:t>
              </a:r>
              <a:r>
                <a:rPr lang="it-IT" sz="2000" b="1" dirty="0" err="1">
                  <a:solidFill>
                    <a:srgbClr val="0070C0"/>
                  </a:solidFill>
                </a:rPr>
                <a:t>classification</a:t>
              </a:r>
              <a:r>
                <a:rPr lang="it-IT" sz="2000" b="1" dirty="0">
                  <a:solidFill>
                    <a:srgbClr val="0070C0"/>
                  </a:solidFill>
                </a:rPr>
                <a:t> </a:t>
              </a:r>
            </a:p>
          </p:txBody>
        </p:sp>
        <p:sp>
          <p:nvSpPr>
            <p:cNvPr id="5" name="Rettangolo 4"/>
            <p:cNvSpPr/>
            <p:nvPr/>
          </p:nvSpPr>
          <p:spPr>
            <a:xfrm>
              <a:off x="4674953" y="2483768"/>
              <a:ext cx="1010213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B050"/>
                  </a:solidFill>
                  <a:latin typeface="+mj-lt"/>
                </a:rPr>
                <a:t>Triple negative</a:t>
              </a:r>
              <a:endParaRPr lang="it-IT" sz="1100" b="1" dirty="0">
                <a:solidFill>
                  <a:srgbClr val="00B050"/>
                </a:solidFill>
                <a:latin typeface="+mj-lt"/>
              </a:endParaRPr>
            </a:p>
          </p:txBody>
        </p:sp>
        <p:sp>
          <p:nvSpPr>
            <p:cNvPr id="22917" name="Rettangolo 22916"/>
            <p:cNvSpPr/>
            <p:nvPr/>
          </p:nvSpPr>
          <p:spPr>
            <a:xfrm>
              <a:off x="116632" y="35496"/>
              <a:ext cx="6624736" cy="4608512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2918" name="Rettangolo 22917"/>
            <p:cNvSpPr/>
            <p:nvPr/>
          </p:nvSpPr>
          <p:spPr>
            <a:xfrm>
              <a:off x="116632" y="4716015"/>
              <a:ext cx="6624736" cy="4356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4494" name="Group 146"/>
            <p:cNvGrpSpPr>
              <a:grpSpLocks noChangeAspect="1"/>
            </p:cNvGrpSpPr>
            <p:nvPr/>
          </p:nvGrpSpPr>
          <p:grpSpPr bwMode="auto">
            <a:xfrm>
              <a:off x="3949220" y="2550724"/>
              <a:ext cx="2728421" cy="1911170"/>
              <a:chOff x="583" y="849"/>
              <a:chExt cx="2080" cy="1678"/>
            </a:xfrm>
          </p:grpSpPr>
          <p:sp>
            <p:nvSpPr>
              <p:cNvPr id="4497" name="Rectangle 148"/>
              <p:cNvSpPr>
                <a:spLocks noChangeArrowheads="1"/>
              </p:cNvSpPr>
              <p:nvPr/>
            </p:nvSpPr>
            <p:spPr bwMode="auto">
              <a:xfrm>
                <a:off x="687" y="1012"/>
                <a:ext cx="1844" cy="1416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498" name="Line 149"/>
              <p:cNvSpPr>
                <a:spLocks noChangeShapeType="1"/>
              </p:cNvSpPr>
              <p:nvPr/>
            </p:nvSpPr>
            <p:spPr bwMode="auto">
              <a:xfrm>
                <a:off x="687" y="2428"/>
                <a:ext cx="197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499" name="Line 150"/>
              <p:cNvSpPr>
                <a:spLocks noChangeShapeType="1"/>
              </p:cNvSpPr>
              <p:nvPr/>
            </p:nvSpPr>
            <p:spPr bwMode="auto">
              <a:xfrm flipV="1">
                <a:off x="687" y="849"/>
                <a:ext cx="0" cy="158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0" name="Line 151"/>
              <p:cNvSpPr>
                <a:spLocks noChangeShapeType="1"/>
              </p:cNvSpPr>
              <p:nvPr/>
            </p:nvSpPr>
            <p:spPr bwMode="auto">
              <a:xfrm flipV="1">
                <a:off x="687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1" name="Rectangle 152"/>
              <p:cNvSpPr>
                <a:spLocks noChangeArrowheads="1"/>
              </p:cNvSpPr>
              <p:nvPr/>
            </p:nvSpPr>
            <p:spPr bwMode="auto">
              <a:xfrm>
                <a:off x="635" y="2440"/>
                <a:ext cx="10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02" name="Line 153"/>
              <p:cNvSpPr>
                <a:spLocks noChangeShapeType="1"/>
              </p:cNvSpPr>
              <p:nvPr/>
            </p:nvSpPr>
            <p:spPr bwMode="auto">
              <a:xfrm flipV="1">
                <a:off x="891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3" name="Rectangle 154"/>
              <p:cNvSpPr>
                <a:spLocks noChangeArrowheads="1"/>
              </p:cNvSpPr>
              <p:nvPr/>
            </p:nvSpPr>
            <p:spPr bwMode="auto">
              <a:xfrm>
                <a:off x="839" y="2440"/>
                <a:ext cx="10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04" name="Line 155"/>
              <p:cNvSpPr>
                <a:spLocks noChangeShapeType="1"/>
              </p:cNvSpPr>
              <p:nvPr/>
            </p:nvSpPr>
            <p:spPr bwMode="auto">
              <a:xfrm flipV="1">
                <a:off x="1095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5" name="Rectangle 156"/>
              <p:cNvSpPr>
                <a:spLocks noChangeArrowheads="1"/>
              </p:cNvSpPr>
              <p:nvPr/>
            </p:nvSpPr>
            <p:spPr bwMode="auto">
              <a:xfrm>
                <a:off x="1043" y="2440"/>
                <a:ext cx="10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06" name="Line 157"/>
              <p:cNvSpPr>
                <a:spLocks noChangeShapeType="1"/>
              </p:cNvSpPr>
              <p:nvPr/>
            </p:nvSpPr>
            <p:spPr bwMode="auto">
              <a:xfrm flipV="1">
                <a:off x="1299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7" name="Rectangle 158"/>
              <p:cNvSpPr>
                <a:spLocks noChangeArrowheads="1"/>
              </p:cNvSpPr>
              <p:nvPr/>
            </p:nvSpPr>
            <p:spPr bwMode="auto">
              <a:xfrm>
                <a:off x="1247" y="2440"/>
                <a:ext cx="10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08" name="Line 159"/>
              <p:cNvSpPr>
                <a:spLocks noChangeShapeType="1"/>
              </p:cNvSpPr>
              <p:nvPr/>
            </p:nvSpPr>
            <p:spPr bwMode="auto">
              <a:xfrm flipV="1">
                <a:off x="1503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09" name="Rectangle 160"/>
              <p:cNvSpPr>
                <a:spLocks noChangeArrowheads="1"/>
              </p:cNvSpPr>
              <p:nvPr/>
            </p:nvSpPr>
            <p:spPr bwMode="auto">
              <a:xfrm>
                <a:off x="1491" y="2440"/>
                <a:ext cx="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10" name="Line 161"/>
              <p:cNvSpPr>
                <a:spLocks noChangeShapeType="1"/>
              </p:cNvSpPr>
              <p:nvPr/>
            </p:nvSpPr>
            <p:spPr bwMode="auto">
              <a:xfrm flipV="1">
                <a:off x="1711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11" name="Rectangle 162"/>
              <p:cNvSpPr>
                <a:spLocks noChangeArrowheads="1"/>
              </p:cNvSpPr>
              <p:nvPr/>
            </p:nvSpPr>
            <p:spPr bwMode="auto">
              <a:xfrm>
                <a:off x="1675" y="2440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12" name="Line 163"/>
              <p:cNvSpPr>
                <a:spLocks noChangeShapeType="1"/>
              </p:cNvSpPr>
              <p:nvPr/>
            </p:nvSpPr>
            <p:spPr bwMode="auto">
              <a:xfrm flipV="1">
                <a:off x="1915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13" name="Rectangle 164"/>
              <p:cNvSpPr>
                <a:spLocks noChangeArrowheads="1"/>
              </p:cNvSpPr>
              <p:nvPr/>
            </p:nvSpPr>
            <p:spPr bwMode="auto">
              <a:xfrm>
                <a:off x="1879" y="2440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14" name="Line 165"/>
              <p:cNvSpPr>
                <a:spLocks noChangeShapeType="1"/>
              </p:cNvSpPr>
              <p:nvPr/>
            </p:nvSpPr>
            <p:spPr bwMode="auto">
              <a:xfrm flipV="1">
                <a:off x="2119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15" name="Rectangle 166"/>
              <p:cNvSpPr>
                <a:spLocks noChangeArrowheads="1"/>
              </p:cNvSpPr>
              <p:nvPr/>
            </p:nvSpPr>
            <p:spPr bwMode="auto">
              <a:xfrm>
                <a:off x="2083" y="2440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16" name="Line 167"/>
              <p:cNvSpPr>
                <a:spLocks noChangeShapeType="1"/>
              </p:cNvSpPr>
              <p:nvPr/>
            </p:nvSpPr>
            <p:spPr bwMode="auto">
              <a:xfrm flipV="1">
                <a:off x="2323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17" name="Rectangle 168"/>
              <p:cNvSpPr>
                <a:spLocks noChangeArrowheads="1"/>
              </p:cNvSpPr>
              <p:nvPr/>
            </p:nvSpPr>
            <p:spPr bwMode="auto">
              <a:xfrm>
                <a:off x="2287" y="2440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18" name="Line 169"/>
              <p:cNvSpPr>
                <a:spLocks noChangeShapeType="1"/>
              </p:cNvSpPr>
              <p:nvPr/>
            </p:nvSpPr>
            <p:spPr bwMode="auto">
              <a:xfrm flipV="1">
                <a:off x="2531" y="2408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19" name="Rectangle 170"/>
              <p:cNvSpPr>
                <a:spLocks noChangeArrowheads="1"/>
              </p:cNvSpPr>
              <p:nvPr/>
            </p:nvSpPr>
            <p:spPr bwMode="auto">
              <a:xfrm>
                <a:off x="2519" y="2440"/>
                <a:ext cx="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20" name="Line 171"/>
              <p:cNvSpPr>
                <a:spLocks noChangeShapeType="1"/>
              </p:cNvSpPr>
              <p:nvPr/>
            </p:nvSpPr>
            <p:spPr bwMode="auto">
              <a:xfrm>
                <a:off x="687" y="242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21" name="Rectangle 172"/>
              <p:cNvSpPr>
                <a:spLocks noChangeArrowheads="1"/>
              </p:cNvSpPr>
              <p:nvPr/>
            </p:nvSpPr>
            <p:spPr bwMode="auto">
              <a:xfrm>
                <a:off x="627" y="2396"/>
                <a:ext cx="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22" name="Line 173"/>
              <p:cNvSpPr>
                <a:spLocks noChangeShapeType="1"/>
              </p:cNvSpPr>
              <p:nvPr/>
            </p:nvSpPr>
            <p:spPr bwMode="auto">
              <a:xfrm>
                <a:off x="687" y="214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24" name="Rectangle 174"/>
              <p:cNvSpPr>
                <a:spLocks noChangeArrowheads="1"/>
              </p:cNvSpPr>
              <p:nvPr/>
            </p:nvSpPr>
            <p:spPr bwMode="auto">
              <a:xfrm>
                <a:off x="583" y="2112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25" name="Line 175"/>
              <p:cNvSpPr>
                <a:spLocks noChangeShapeType="1"/>
              </p:cNvSpPr>
              <p:nvPr/>
            </p:nvSpPr>
            <p:spPr bwMode="auto">
              <a:xfrm>
                <a:off x="687" y="186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26" name="Rectangle 176"/>
              <p:cNvSpPr>
                <a:spLocks noChangeArrowheads="1"/>
              </p:cNvSpPr>
              <p:nvPr/>
            </p:nvSpPr>
            <p:spPr bwMode="auto">
              <a:xfrm>
                <a:off x="627" y="1828"/>
                <a:ext cx="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27" name="Line 177"/>
              <p:cNvSpPr>
                <a:spLocks noChangeShapeType="1"/>
              </p:cNvSpPr>
              <p:nvPr/>
            </p:nvSpPr>
            <p:spPr bwMode="auto">
              <a:xfrm>
                <a:off x="687" y="158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28" name="Rectangle 178"/>
              <p:cNvSpPr>
                <a:spLocks noChangeArrowheads="1"/>
              </p:cNvSpPr>
              <p:nvPr/>
            </p:nvSpPr>
            <p:spPr bwMode="auto">
              <a:xfrm>
                <a:off x="583" y="1548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29" name="Line 179"/>
              <p:cNvSpPr>
                <a:spLocks noChangeShapeType="1"/>
              </p:cNvSpPr>
              <p:nvPr/>
            </p:nvSpPr>
            <p:spPr bwMode="auto">
              <a:xfrm>
                <a:off x="687" y="1296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30" name="Rectangle 180"/>
              <p:cNvSpPr>
                <a:spLocks noChangeArrowheads="1"/>
              </p:cNvSpPr>
              <p:nvPr/>
            </p:nvSpPr>
            <p:spPr bwMode="auto">
              <a:xfrm>
                <a:off x="627" y="1264"/>
                <a:ext cx="3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31" name="Line 181"/>
              <p:cNvSpPr>
                <a:spLocks noChangeShapeType="1"/>
              </p:cNvSpPr>
              <p:nvPr/>
            </p:nvSpPr>
            <p:spPr bwMode="auto">
              <a:xfrm>
                <a:off x="687" y="1016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32" name="Rectangle 182"/>
              <p:cNvSpPr>
                <a:spLocks noChangeArrowheads="1"/>
              </p:cNvSpPr>
              <p:nvPr/>
            </p:nvSpPr>
            <p:spPr bwMode="auto">
              <a:xfrm>
                <a:off x="583" y="984"/>
                <a:ext cx="8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.5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33" name="Freeform 183"/>
              <p:cNvSpPr>
                <a:spLocks/>
              </p:cNvSpPr>
              <p:nvPr/>
            </p:nvSpPr>
            <p:spPr bwMode="auto">
              <a:xfrm>
                <a:off x="763" y="1032"/>
                <a:ext cx="1712" cy="1392"/>
              </a:xfrm>
              <a:custGeom>
                <a:avLst/>
                <a:gdLst>
                  <a:gd name="T0" fmla="*/ 16 w 1712"/>
                  <a:gd name="T1" fmla="*/ 1392 h 1392"/>
                  <a:gd name="T2" fmla="*/ 52 w 1712"/>
                  <a:gd name="T3" fmla="*/ 1392 h 1392"/>
                  <a:gd name="T4" fmla="*/ 88 w 1712"/>
                  <a:gd name="T5" fmla="*/ 1392 h 1392"/>
                  <a:gd name="T6" fmla="*/ 120 w 1712"/>
                  <a:gd name="T7" fmla="*/ 1392 h 1392"/>
                  <a:gd name="T8" fmla="*/ 156 w 1712"/>
                  <a:gd name="T9" fmla="*/ 1388 h 1392"/>
                  <a:gd name="T10" fmla="*/ 188 w 1712"/>
                  <a:gd name="T11" fmla="*/ 1388 h 1392"/>
                  <a:gd name="T12" fmla="*/ 224 w 1712"/>
                  <a:gd name="T13" fmla="*/ 1388 h 1392"/>
                  <a:gd name="T14" fmla="*/ 260 w 1712"/>
                  <a:gd name="T15" fmla="*/ 1380 h 1392"/>
                  <a:gd name="T16" fmla="*/ 292 w 1712"/>
                  <a:gd name="T17" fmla="*/ 1356 h 1392"/>
                  <a:gd name="T18" fmla="*/ 328 w 1712"/>
                  <a:gd name="T19" fmla="*/ 1284 h 1392"/>
                  <a:gd name="T20" fmla="*/ 364 w 1712"/>
                  <a:gd name="T21" fmla="*/ 1144 h 1392"/>
                  <a:gd name="T22" fmla="*/ 396 w 1712"/>
                  <a:gd name="T23" fmla="*/ 976 h 1392"/>
                  <a:gd name="T24" fmla="*/ 432 w 1712"/>
                  <a:gd name="T25" fmla="*/ 872 h 1392"/>
                  <a:gd name="T26" fmla="*/ 468 w 1712"/>
                  <a:gd name="T27" fmla="*/ 912 h 1392"/>
                  <a:gd name="T28" fmla="*/ 500 w 1712"/>
                  <a:gd name="T29" fmla="*/ 1044 h 1392"/>
                  <a:gd name="T30" fmla="*/ 536 w 1712"/>
                  <a:gd name="T31" fmla="*/ 1168 h 1392"/>
                  <a:gd name="T32" fmla="*/ 568 w 1712"/>
                  <a:gd name="T33" fmla="*/ 1228 h 1392"/>
                  <a:gd name="T34" fmla="*/ 604 w 1712"/>
                  <a:gd name="T35" fmla="*/ 1236 h 1392"/>
                  <a:gd name="T36" fmla="*/ 640 w 1712"/>
                  <a:gd name="T37" fmla="*/ 1228 h 1392"/>
                  <a:gd name="T38" fmla="*/ 672 w 1712"/>
                  <a:gd name="T39" fmla="*/ 1220 h 1392"/>
                  <a:gd name="T40" fmla="*/ 708 w 1712"/>
                  <a:gd name="T41" fmla="*/ 1220 h 1392"/>
                  <a:gd name="T42" fmla="*/ 744 w 1712"/>
                  <a:gd name="T43" fmla="*/ 1216 h 1392"/>
                  <a:gd name="T44" fmla="*/ 776 w 1712"/>
                  <a:gd name="T45" fmla="*/ 1212 h 1392"/>
                  <a:gd name="T46" fmla="*/ 812 w 1712"/>
                  <a:gd name="T47" fmla="*/ 1192 h 1392"/>
                  <a:gd name="T48" fmla="*/ 848 w 1712"/>
                  <a:gd name="T49" fmla="*/ 1156 h 1392"/>
                  <a:gd name="T50" fmla="*/ 880 w 1712"/>
                  <a:gd name="T51" fmla="*/ 1112 h 1392"/>
                  <a:gd name="T52" fmla="*/ 916 w 1712"/>
                  <a:gd name="T53" fmla="*/ 1044 h 1392"/>
                  <a:gd name="T54" fmla="*/ 948 w 1712"/>
                  <a:gd name="T55" fmla="*/ 948 h 1392"/>
                  <a:gd name="T56" fmla="*/ 984 w 1712"/>
                  <a:gd name="T57" fmla="*/ 796 h 1392"/>
                  <a:gd name="T58" fmla="*/ 1020 w 1712"/>
                  <a:gd name="T59" fmla="*/ 592 h 1392"/>
                  <a:gd name="T60" fmla="*/ 1052 w 1712"/>
                  <a:gd name="T61" fmla="*/ 356 h 1392"/>
                  <a:gd name="T62" fmla="*/ 1088 w 1712"/>
                  <a:gd name="T63" fmla="*/ 124 h 1392"/>
                  <a:gd name="T64" fmla="*/ 1124 w 1712"/>
                  <a:gd name="T65" fmla="*/ 0 h 1392"/>
                  <a:gd name="T66" fmla="*/ 1156 w 1712"/>
                  <a:gd name="T67" fmla="*/ 116 h 1392"/>
                  <a:gd name="T68" fmla="*/ 1192 w 1712"/>
                  <a:gd name="T69" fmla="*/ 448 h 1392"/>
                  <a:gd name="T70" fmla="*/ 1228 w 1712"/>
                  <a:gd name="T71" fmla="*/ 812 h 1392"/>
                  <a:gd name="T72" fmla="*/ 1260 w 1712"/>
                  <a:gd name="T73" fmla="*/ 1044 h 1392"/>
                  <a:gd name="T74" fmla="*/ 1296 w 1712"/>
                  <a:gd name="T75" fmla="*/ 1132 h 1392"/>
                  <a:gd name="T76" fmla="*/ 1332 w 1712"/>
                  <a:gd name="T77" fmla="*/ 1124 h 1392"/>
                  <a:gd name="T78" fmla="*/ 1364 w 1712"/>
                  <a:gd name="T79" fmla="*/ 1072 h 1392"/>
                  <a:gd name="T80" fmla="*/ 1400 w 1712"/>
                  <a:gd name="T81" fmla="*/ 984 h 1392"/>
                  <a:gd name="T82" fmla="*/ 1432 w 1712"/>
                  <a:gd name="T83" fmla="*/ 880 h 1392"/>
                  <a:gd name="T84" fmla="*/ 1468 w 1712"/>
                  <a:gd name="T85" fmla="*/ 832 h 1392"/>
                  <a:gd name="T86" fmla="*/ 1504 w 1712"/>
                  <a:gd name="T87" fmla="*/ 912 h 1392"/>
                  <a:gd name="T88" fmla="*/ 1536 w 1712"/>
                  <a:gd name="T89" fmla="*/ 1088 h 1392"/>
                  <a:gd name="T90" fmla="*/ 1572 w 1712"/>
                  <a:gd name="T91" fmla="*/ 1248 h 1392"/>
                  <a:gd name="T92" fmla="*/ 1608 w 1712"/>
                  <a:gd name="T93" fmla="*/ 1344 h 1392"/>
                  <a:gd name="T94" fmla="*/ 1640 w 1712"/>
                  <a:gd name="T95" fmla="*/ 1380 h 1392"/>
                  <a:gd name="T96" fmla="*/ 1676 w 1712"/>
                  <a:gd name="T97" fmla="*/ 1392 h 1392"/>
                  <a:gd name="T98" fmla="*/ 1712 w 1712"/>
                  <a:gd name="T99" fmla="*/ 1392 h 13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712" h="1392">
                    <a:moveTo>
                      <a:pt x="0" y="1392"/>
                    </a:moveTo>
                    <a:lnTo>
                      <a:pt x="16" y="1392"/>
                    </a:lnTo>
                    <a:lnTo>
                      <a:pt x="36" y="1392"/>
                    </a:lnTo>
                    <a:lnTo>
                      <a:pt x="52" y="1392"/>
                    </a:lnTo>
                    <a:lnTo>
                      <a:pt x="68" y="1392"/>
                    </a:lnTo>
                    <a:lnTo>
                      <a:pt x="88" y="1392"/>
                    </a:lnTo>
                    <a:lnTo>
                      <a:pt x="104" y="1392"/>
                    </a:lnTo>
                    <a:lnTo>
                      <a:pt x="120" y="1392"/>
                    </a:lnTo>
                    <a:lnTo>
                      <a:pt x="140" y="1388"/>
                    </a:lnTo>
                    <a:lnTo>
                      <a:pt x="156" y="1388"/>
                    </a:lnTo>
                    <a:lnTo>
                      <a:pt x="172" y="1388"/>
                    </a:lnTo>
                    <a:lnTo>
                      <a:pt x="188" y="1388"/>
                    </a:lnTo>
                    <a:lnTo>
                      <a:pt x="208" y="1388"/>
                    </a:lnTo>
                    <a:lnTo>
                      <a:pt x="224" y="1388"/>
                    </a:lnTo>
                    <a:lnTo>
                      <a:pt x="240" y="1384"/>
                    </a:lnTo>
                    <a:lnTo>
                      <a:pt x="260" y="1380"/>
                    </a:lnTo>
                    <a:lnTo>
                      <a:pt x="276" y="1372"/>
                    </a:lnTo>
                    <a:lnTo>
                      <a:pt x="292" y="1356"/>
                    </a:lnTo>
                    <a:lnTo>
                      <a:pt x="312" y="1328"/>
                    </a:lnTo>
                    <a:lnTo>
                      <a:pt x="328" y="1284"/>
                    </a:lnTo>
                    <a:lnTo>
                      <a:pt x="344" y="1224"/>
                    </a:lnTo>
                    <a:lnTo>
                      <a:pt x="364" y="1144"/>
                    </a:lnTo>
                    <a:lnTo>
                      <a:pt x="380" y="1060"/>
                    </a:lnTo>
                    <a:lnTo>
                      <a:pt x="396" y="976"/>
                    </a:lnTo>
                    <a:lnTo>
                      <a:pt x="416" y="908"/>
                    </a:lnTo>
                    <a:lnTo>
                      <a:pt x="432" y="872"/>
                    </a:lnTo>
                    <a:lnTo>
                      <a:pt x="448" y="876"/>
                    </a:lnTo>
                    <a:lnTo>
                      <a:pt x="468" y="912"/>
                    </a:lnTo>
                    <a:lnTo>
                      <a:pt x="484" y="976"/>
                    </a:lnTo>
                    <a:lnTo>
                      <a:pt x="500" y="1044"/>
                    </a:lnTo>
                    <a:lnTo>
                      <a:pt x="520" y="1112"/>
                    </a:lnTo>
                    <a:lnTo>
                      <a:pt x="536" y="1168"/>
                    </a:lnTo>
                    <a:lnTo>
                      <a:pt x="552" y="1204"/>
                    </a:lnTo>
                    <a:lnTo>
                      <a:pt x="568" y="1228"/>
                    </a:lnTo>
                    <a:lnTo>
                      <a:pt x="588" y="1236"/>
                    </a:lnTo>
                    <a:lnTo>
                      <a:pt x="604" y="1236"/>
                    </a:lnTo>
                    <a:lnTo>
                      <a:pt x="620" y="1232"/>
                    </a:lnTo>
                    <a:lnTo>
                      <a:pt x="640" y="1228"/>
                    </a:lnTo>
                    <a:lnTo>
                      <a:pt x="656" y="1224"/>
                    </a:lnTo>
                    <a:lnTo>
                      <a:pt x="672" y="1220"/>
                    </a:lnTo>
                    <a:lnTo>
                      <a:pt x="692" y="1220"/>
                    </a:lnTo>
                    <a:lnTo>
                      <a:pt x="708" y="1220"/>
                    </a:lnTo>
                    <a:lnTo>
                      <a:pt x="724" y="1220"/>
                    </a:lnTo>
                    <a:lnTo>
                      <a:pt x="744" y="1216"/>
                    </a:lnTo>
                    <a:lnTo>
                      <a:pt x="760" y="1216"/>
                    </a:lnTo>
                    <a:lnTo>
                      <a:pt x="776" y="1212"/>
                    </a:lnTo>
                    <a:lnTo>
                      <a:pt x="796" y="1204"/>
                    </a:lnTo>
                    <a:lnTo>
                      <a:pt x="812" y="1192"/>
                    </a:lnTo>
                    <a:lnTo>
                      <a:pt x="828" y="1176"/>
                    </a:lnTo>
                    <a:lnTo>
                      <a:pt x="848" y="1156"/>
                    </a:lnTo>
                    <a:lnTo>
                      <a:pt x="864" y="1136"/>
                    </a:lnTo>
                    <a:lnTo>
                      <a:pt x="880" y="1112"/>
                    </a:lnTo>
                    <a:lnTo>
                      <a:pt x="900" y="1080"/>
                    </a:lnTo>
                    <a:lnTo>
                      <a:pt x="916" y="1044"/>
                    </a:lnTo>
                    <a:lnTo>
                      <a:pt x="932" y="1004"/>
                    </a:lnTo>
                    <a:lnTo>
                      <a:pt x="948" y="948"/>
                    </a:lnTo>
                    <a:lnTo>
                      <a:pt x="968" y="876"/>
                    </a:lnTo>
                    <a:lnTo>
                      <a:pt x="984" y="796"/>
                    </a:lnTo>
                    <a:lnTo>
                      <a:pt x="1000" y="700"/>
                    </a:lnTo>
                    <a:lnTo>
                      <a:pt x="1020" y="592"/>
                    </a:lnTo>
                    <a:lnTo>
                      <a:pt x="1036" y="480"/>
                    </a:lnTo>
                    <a:lnTo>
                      <a:pt x="1052" y="356"/>
                    </a:lnTo>
                    <a:lnTo>
                      <a:pt x="1072" y="236"/>
                    </a:lnTo>
                    <a:lnTo>
                      <a:pt x="1088" y="124"/>
                    </a:lnTo>
                    <a:lnTo>
                      <a:pt x="1104" y="40"/>
                    </a:lnTo>
                    <a:lnTo>
                      <a:pt x="1124" y="0"/>
                    </a:lnTo>
                    <a:lnTo>
                      <a:pt x="1140" y="28"/>
                    </a:lnTo>
                    <a:lnTo>
                      <a:pt x="1156" y="116"/>
                    </a:lnTo>
                    <a:lnTo>
                      <a:pt x="1176" y="264"/>
                    </a:lnTo>
                    <a:lnTo>
                      <a:pt x="1192" y="448"/>
                    </a:lnTo>
                    <a:lnTo>
                      <a:pt x="1208" y="636"/>
                    </a:lnTo>
                    <a:lnTo>
                      <a:pt x="1228" y="812"/>
                    </a:lnTo>
                    <a:lnTo>
                      <a:pt x="1244" y="948"/>
                    </a:lnTo>
                    <a:lnTo>
                      <a:pt x="1260" y="1044"/>
                    </a:lnTo>
                    <a:lnTo>
                      <a:pt x="1280" y="1104"/>
                    </a:lnTo>
                    <a:lnTo>
                      <a:pt x="1296" y="1132"/>
                    </a:lnTo>
                    <a:lnTo>
                      <a:pt x="1312" y="1136"/>
                    </a:lnTo>
                    <a:lnTo>
                      <a:pt x="1332" y="1124"/>
                    </a:lnTo>
                    <a:lnTo>
                      <a:pt x="1348" y="1104"/>
                    </a:lnTo>
                    <a:lnTo>
                      <a:pt x="1364" y="1072"/>
                    </a:lnTo>
                    <a:lnTo>
                      <a:pt x="1380" y="1032"/>
                    </a:lnTo>
                    <a:lnTo>
                      <a:pt x="1400" y="984"/>
                    </a:lnTo>
                    <a:lnTo>
                      <a:pt x="1416" y="932"/>
                    </a:lnTo>
                    <a:lnTo>
                      <a:pt x="1432" y="880"/>
                    </a:lnTo>
                    <a:lnTo>
                      <a:pt x="1452" y="844"/>
                    </a:lnTo>
                    <a:lnTo>
                      <a:pt x="1468" y="832"/>
                    </a:lnTo>
                    <a:lnTo>
                      <a:pt x="1484" y="856"/>
                    </a:lnTo>
                    <a:lnTo>
                      <a:pt x="1504" y="912"/>
                    </a:lnTo>
                    <a:lnTo>
                      <a:pt x="1520" y="996"/>
                    </a:lnTo>
                    <a:lnTo>
                      <a:pt x="1536" y="1088"/>
                    </a:lnTo>
                    <a:lnTo>
                      <a:pt x="1556" y="1176"/>
                    </a:lnTo>
                    <a:lnTo>
                      <a:pt x="1572" y="1248"/>
                    </a:lnTo>
                    <a:lnTo>
                      <a:pt x="1588" y="1304"/>
                    </a:lnTo>
                    <a:lnTo>
                      <a:pt x="1608" y="1344"/>
                    </a:lnTo>
                    <a:lnTo>
                      <a:pt x="1624" y="1368"/>
                    </a:lnTo>
                    <a:lnTo>
                      <a:pt x="1640" y="1380"/>
                    </a:lnTo>
                    <a:lnTo>
                      <a:pt x="1660" y="1388"/>
                    </a:lnTo>
                    <a:lnTo>
                      <a:pt x="1676" y="1392"/>
                    </a:lnTo>
                    <a:lnTo>
                      <a:pt x="1692" y="1392"/>
                    </a:lnTo>
                    <a:lnTo>
                      <a:pt x="1712" y="1392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4536" name="Group 189"/>
            <p:cNvGrpSpPr>
              <a:grpSpLocks noChangeAspect="1"/>
            </p:cNvGrpSpPr>
            <p:nvPr/>
          </p:nvGrpSpPr>
          <p:grpSpPr bwMode="auto">
            <a:xfrm>
              <a:off x="418378" y="5038340"/>
              <a:ext cx="2664842" cy="1806907"/>
              <a:chOff x="575" y="2880"/>
              <a:chExt cx="2056" cy="1647"/>
            </a:xfrm>
          </p:grpSpPr>
          <p:sp>
            <p:nvSpPr>
              <p:cNvPr id="4539" name="Rectangle 191"/>
              <p:cNvSpPr>
                <a:spLocks noChangeArrowheads="1"/>
              </p:cNvSpPr>
              <p:nvPr/>
            </p:nvSpPr>
            <p:spPr bwMode="auto">
              <a:xfrm>
                <a:off x="687" y="3012"/>
                <a:ext cx="1844" cy="1412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40" name="Line 192"/>
              <p:cNvSpPr>
                <a:spLocks noChangeShapeType="1"/>
              </p:cNvSpPr>
              <p:nvPr/>
            </p:nvSpPr>
            <p:spPr bwMode="auto">
              <a:xfrm>
                <a:off x="687" y="4424"/>
                <a:ext cx="1944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41" name="Line 193"/>
              <p:cNvSpPr>
                <a:spLocks noChangeShapeType="1"/>
              </p:cNvSpPr>
              <p:nvPr/>
            </p:nvSpPr>
            <p:spPr bwMode="auto">
              <a:xfrm flipV="1">
                <a:off x="687" y="2880"/>
                <a:ext cx="0" cy="154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42" name="Line 194"/>
              <p:cNvSpPr>
                <a:spLocks noChangeShapeType="1"/>
              </p:cNvSpPr>
              <p:nvPr/>
            </p:nvSpPr>
            <p:spPr bwMode="auto">
              <a:xfrm flipV="1">
                <a:off x="687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543" name="Rectangle 195"/>
              <p:cNvSpPr>
                <a:spLocks noChangeArrowheads="1"/>
              </p:cNvSpPr>
              <p:nvPr/>
            </p:nvSpPr>
            <p:spPr bwMode="auto">
              <a:xfrm>
                <a:off x="635" y="4436"/>
                <a:ext cx="10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88" name="Line 196"/>
              <p:cNvSpPr>
                <a:spLocks noChangeShapeType="1"/>
              </p:cNvSpPr>
              <p:nvPr/>
            </p:nvSpPr>
            <p:spPr bwMode="auto">
              <a:xfrm flipV="1">
                <a:off x="89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89" name="Rectangle 197"/>
              <p:cNvSpPr>
                <a:spLocks noChangeArrowheads="1"/>
              </p:cNvSpPr>
              <p:nvPr/>
            </p:nvSpPr>
            <p:spPr bwMode="auto">
              <a:xfrm>
                <a:off x="839" y="4436"/>
                <a:ext cx="10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90" name="Line 198"/>
              <p:cNvSpPr>
                <a:spLocks noChangeShapeType="1"/>
              </p:cNvSpPr>
              <p:nvPr/>
            </p:nvSpPr>
            <p:spPr bwMode="auto">
              <a:xfrm flipV="1">
                <a:off x="1095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91" name="Rectangle 199"/>
              <p:cNvSpPr>
                <a:spLocks noChangeArrowheads="1"/>
              </p:cNvSpPr>
              <p:nvPr/>
            </p:nvSpPr>
            <p:spPr bwMode="auto">
              <a:xfrm>
                <a:off x="1043" y="4436"/>
                <a:ext cx="10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92" name="Line 200"/>
              <p:cNvSpPr>
                <a:spLocks noChangeShapeType="1"/>
              </p:cNvSpPr>
              <p:nvPr/>
            </p:nvSpPr>
            <p:spPr bwMode="auto">
              <a:xfrm flipV="1">
                <a:off x="1299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93" name="Rectangle 201"/>
              <p:cNvSpPr>
                <a:spLocks noChangeArrowheads="1"/>
              </p:cNvSpPr>
              <p:nvPr/>
            </p:nvSpPr>
            <p:spPr bwMode="auto">
              <a:xfrm>
                <a:off x="1247" y="4436"/>
                <a:ext cx="106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94" name="Line 202"/>
              <p:cNvSpPr>
                <a:spLocks noChangeShapeType="1"/>
              </p:cNvSpPr>
              <p:nvPr/>
            </p:nvSpPr>
            <p:spPr bwMode="auto">
              <a:xfrm flipV="1">
                <a:off x="1503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95" name="Rectangle 203"/>
              <p:cNvSpPr>
                <a:spLocks noChangeArrowheads="1"/>
              </p:cNvSpPr>
              <p:nvPr/>
            </p:nvSpPr>
            <p:spPr bwMode="auto">
              <a:xfrm>
                <a:off x="1491" y="4436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96" name="Line 204"/>
              <p:cNvSpPr>
                <a:spLocks noChangeShapeType="1"/>
              </p:cNvSpPr>
              <p:nvPr/>
            </p:nvSpPr>
            <p:spPr bwMode="auto">
              <a:xfrm flipV="1">
                <a:off x="171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97" name="Rectangle 205"/>
              <p:cNvSpPr>
                <a:spLocks noChangeArrowheads="1"/>
              </p:cNvSpPr>
              <p:nvPr/>
            </p:nvSpPr>
            <p:spPr bwMode="auto">
              <a:xfrm>
                <a:off x="1675" y="4436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098" name="Line 206"/>
              <p:cNvSpPr>
                <a:spLocks noChangeShapeType="1"/>
              </p:cNvSpPr>
              <p:nvPr/>
            </p:nvSpPr>
            <p:spPr bwMode="auto">
              <a:xfrm flipV="1">
                <a:off x="1915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099" name="Rectangle 207"/>
              <p:cNvSpPr>
                <a:spLocks noChangeArrowheads="1"/>
              </p:cNvSpPr>
              <p:nvPr/>
            </p:nvSpPr>
            <p:spPr bwMode="auto">
              <a:xfrm>
                <a:off x="1879" y="4436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00" name="Line 208"/>
              <p:cNvSpPr>
                <a:spLocks noChangeShapeType="1"/>
              </p:cNvSpPr>
              <p:nvPr/>
            </p:nvSpPr>
            <p:spPr bwMode="auto">
              <a:xfrm flipV="1">
                <a:off x="2119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01" name="Rectangle 209"/>
              <p:cNvSpPr>
                <a:spLocks noChangeArrowheads="1"/>
              </p:cNvSpPr>
              <p:nvPr/>
            </p:nvSpPr>
            <p:spPr bwMode="auto">
              <a:xfrm>
                <a:off x="2083" y="4436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02" name="Line 210"/>
              <p:cNvSpPr>
                <a:spLocks noChangeShapeType="1"/>
              </p:cNvSpPr>
              <p:nvPr/>
            </p:nvSpPr>
            <p:spPr bwMode="auto">
              <a:xfrm flipV="1">
                <a:off x="2323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03" name="Rectangle 211"/>
              <p:cNvSpPr>
                <a:spLocks noChangeArrowheads="1"/>
              </p:cNvSpPr>
              <p:nvPr/>
            </p:nvSpPr>
            <p:spPr bwMode="auto">
              <a:xfrm>
                <a:off x="2287" y="4436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04" name="Line 212"/>
              <p:cNvSpPr>
                <a:spLocks noChangeShapeType="1"/>
              </p:cNvSpPr>
              <p:nvPr/>
            </p:nvSpPr>
            <p:spPr bwMode="auto">
              <a:xfrm flipV="1">
                <a:off x="253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05" name="Rectangle 213"/>
              <p:cNvSpPr>
                <a:spLocks noChangeArrowheads="1"/>
              </p:cNvSpPr>
              <p:nvPr/>
            </p:nvSpPr>
            <p:spPr bwMode="auto">
              <a:xfrm>
                <a:off x="2519" y="4436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06" name="Line 214"/>
              <p:cNvSpPr>
                <a:spLocks noChangeShapeType="1"/>
              </p:cNvSpPr>
              <p:nvPr/>
            </p:nvSpPr>
            <p:spPr bwMode="auto">
              <a:xfrm>
                <a:off x="687" y="442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07" name="Rectangle 215"/>
              <p:cNvSpPr>
                <a:spLocks noChangeArrowheads="1"/>
              </p:cNvSpPr>
              <p:nvPr/>
            </p:nvSpPr>
            <p:spPr bwMode="auto">
              <a:xfrm>
                <a:off x="619" y="4392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08" name="Line 216"/>
              <p:cNvSpPr>
                <a:spLocks noChangeShapeType="1"/>
              </p:cNvSpPr>
              <p:nvPr/>
            </p:nvSpPr>
            <p:spPr bwMode="auto">
              <a:xfrm>
                <a:off x="687" y="424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09" name="Rectangle 217"/>
              <p:cNvSpPr>
                <a:spLocks noChangeArrowheads="1"/>
              </p:cNvSpPr>
              <p:nvPr/>
            </p:nvSpPr>
            <p:spPr bwMode="auto">
              <a:xfrm>
                <a:off x="575" y="4212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10" name="Line 218"/>
              <p:cNvSpPr>
                <a:spLocks noChangeShapeType="1"/>
              </p:cNvSpPr>
              <p:nvPr/>
            </p:nvSpPr>
            <p:spPr bwMode="auto">
              <a:xfrm>
                <a:off x="687" y="406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11" name="Rectangle 219"/>
              <p:cNvSpPr>
                <a:spLocks noChangeArrowheads="1"/>
              </p:cNvSpPr>
              <p:nvPr/>
            </p:nvSpPr>
            <p:spPr bwMode="auto">
              <a:xfrm>
                <a:off x="619" y="4036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12" name="Line 220"/>
              <p:cNvSpPr>
                <a:spLocks noChangeShapeType="1"/>
              </p:cNvSpPr>
              <p:nvPr/>
            </p:nvSpPr>
            <p:spPr bwMode="auto">
              <a:xfrm>
                <a:off x="687" y="389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13" name="Rectangle 221"/>
              <p:cNvSpPr>
                <a:spLocks noChangeArrowheads="1"/>
              </p:cNvSpPr>
              <p:nvPr/>
            </p:nvSpPr>
            <p:spPr bwMode="auto">
              <a:xfrm>
                <a:off x="575" y="3860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14" name="Line 222"/>
              <p:cNvSpPr>
                <a:spLocks noChangeShapeType="1"/>
              </p:cNvSpPr>
              <p:nvPr/>
            </p:nvSpPr>
            <p:spPr bwMode="auto">
              <a:xfrm>
                <a:off x="687" y="3716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15" name="Rectangle 223"/>
              <p:cNvSpPr>
                <a:spLocks noChangeArrowheads="1"/>
              </p:cNvSpPr>
              <p:nvPr/>
            </p:nvSpPr>
            <p:spPr bwMode="auto">
              <a:xfrm>
                <a:off x="619" y="3684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16" name="Line 224"/>
              <p:cNvSpPr>
                <a:spLocks noChangeShapeType="1"/>
              </p:cNvSpPr>
              <p:nvPr/>
            </p:nvSpPr>
            <p:spPr bwMode="auto">
              <a:xfrm>
                <a:off x="687" y="354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17" name="Rectangle 225"/>
              <p:cNvSpPr>
                <a:spLocks noChangeArrowheads="1"/>
              </p:cNvSpPr>
              <p:nvPr/>
            </p:nvSpPr>
            <p:spPr bwMode="auto">
              <a:xfrm>
                <a:off x="575" y="3508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18" name="Line 226"/>
              <p:cNvSpPr>
                <a:spLocks noChangeShapeType="1"/>
              </p:cNvSpPr>
              <p:nvPr/>
            </p:nvSpPr>
            <p:spPr bwMode="auto">
              <a:xfrm>
                <a:off x="687" y="336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19" name="Rectangle 227"/>
              <p:cNvSpPr>
                <a:spLocks noChangeArrowheads="1"/>
              </p:cNvSpPr>
              <p:nvPr/>
            </p:nvSpPr>
            <p:spPr bwMode="auto">
              <a:xfrm>
                <a:off x="619" y="3332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21" name="Line 228"/>
              <p:cNvSpPr>
                <a:spLocks noChangeShapeType="1"/>
              </p:cNvSpPr>
              <p:nvPr/>
            </p:nvSpPr>
            <p:spPr bwMode="auto">
              <a:xfrm>
                <a:off x="687" y="318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22" name="Rectangle 229"/>
              <p:cNvSpPr>
                <a:spLocks noChangeArrowheads="1"/>
              </p:cNvSpPr>
              <p:nvPr/>
            </p:nvSpPr>
            <p:spPr bwMode="auto">
              <a:xfrm>
                <a:off x="575" y="3156"/>
                <a:ext cx="8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.5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23" name="Line 230"/>
              <p:cNvSpPr>
                <a:spLocks noChangeShapeType="1"/>
              </p:cNvSpPr>
              <p:nvPr/>
            </p:nvSpPr>
            <p:spPr bwMode="auto">
              <a:xfrm>
                <a:off x="687" y="301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24" name="Rectangle 231"/>
              <p:cNvSpPr>
                <a:spLocks noChangeArrowheads="1"/>
              </p:cNvSpPr>
              <p:nvPr/>
            </p:nvSpPr>
            <p:spPr bwMode="auto">
              <a:xfrm>
                <a:off x="619" y="2980"/>
                <a:ext cx="3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25" name="Freeform 232"/>
              <p:cNvSpPr>
                <a:spLocks/>
              </p:cNvSpPr>
              <p:nvPr/>
            </p:nvSpPr>
            <p:spPr bwMode="auto">
              <a:xfrm>
                <a:off x="763" y="3164"/>
                <a:ext cx="1696" cy="1256"/>
              </a:xfrm>
              <a:custGeom>
                <a:avLst/>
                <a:gdLst>
                  <a:gd name="T0" fmla="*/ 16 w 1696"/>
                  <a:gd name="T1" fmla="*/ 1256 h 1256"/>
                  <a:gd name="T2" fmla="*/ 52 w 1696"/>
                  <a:gd name="T3" fmla="*/ 1256 h 1256"/>
                  <a:gd name="T4" fmla="*/ 84 w 1696"/>
                  <a:gd name="T5" fmla="*/ 1252 h 1256"/>
                  <a:gd name="T6" fmla="*/ 120 w 1696"/>
                  <a:gd name="T7" fmla="*/ 1248 h 1256"/>
                  <a:gd name="T8" fmla="*/ 152 w 1696"/>
                  <a:gd name="T9" fmla="*/ 1240 h 1256"/>
                  <a:gd name="T10" fmla="*/ 188 w 1696"/>
                  <a:gd name="T11" fmla="*/ 1228 h 1256"/>
                  <a:gd name="T12" fmla="*/ 220 w 1696"/>
                  <a:gd name="T13" fmla="*/ 1212 h 1256"/>
                  <a:gd name="T14" fmla="*/ 256 w 1696"/>
                  <a:gd name="T15" fmla="*/ 1200 h 1256"/>
                  <a:gd name="T16" fmla="*/ 292 w 1696"/>
                  <a:gd name="T17" fmla="*/ 1168 h 1256"/>
                  <a:gd name="T18" fmla="*/ 324 w 1696"/>
                  <a:gd name="T19" fmla="*/ 1084 h 1256"/>
                  <a:gd name="T20" fmla="*/ 360 w 1696"/>
                  <a:gd name="T21" fmla="*/ 952 h 1256"/>
                  <a:gd name="T22" fmla="*/ 392 w 1696"/>
                  <a:gd name="T23" fmla="*/ 876 h 1256"/>
                  <a:gd name="T24" fmla="*/ 428 w 1696"/>
                  <a:gd name="T25" fmla="*/ 952 h 1256"/>
                  <a:gd name="T26" fmla="*/ 460 w 1696"/>
                  <a:gd name="T27" fmla="*/ 1076 h 1256"/>
                  <a:gd name="T28" fmla="*/ 496 w 1696"/>
                  <a:gd name="T29" fmla="*/ 1144 h 1256"/>
                  <a:gd name="T30" fmla="*/ 532 w 1696"/>
                  <a:gd name="T31" fmla="*/ 1176 h 1256"/>
                  <a:gd name="T32" fmla="*/ 564 w 1696"/>
                  <a:gd name="T33" fmla="*/ 1200 h 1256"/>
                  <a:gd name="T34" fmla="*/ 600 w 1696"/>
                  <a:gd name="T35" fmla="*/ 1212 h 1256"/>
                  <a:gd name="T36" fmla="*/ 632 w 1696"/>
                  <a:gd name="T37" fmla="*/ 1216 h 1256"/>
                  <a:gd name="T38" fmla="*/ 668 w 1696"/>
                  <a:gd name="T39" fmla="*/ 1224 h 1256"/>
                  <a:gd name="T40" fmla="*/ 700 w 1696"/>
                  <a:gd name="T41" fmla="*/ 1236 h 1256"/>
                  <a:gd name="T42" fmla="*/ 736 w 1696"/>
                  <a:gd name="T43" fmla="*/ 1236 h 1256"/>
                  <a:gd name="T44" fmla="*/ 772 w 1696"/>
                  <a:gd name="T45" fmla="*/ 1228 h 1256"/>
                  <a:gd name="T46" fmla="*/ 804 w 1696"/>
                  <a:gd name="T47" fmla="*/ 1224 h 1256"/>
                  <a:gd name="T48" fmla="*/ 840 w 1696"/>
                  <a:gd name="T49" fmla="*/ 1232 h 1256"/>
                  <a:gd name="T50" fmla="*/ 872 w 1696"/>
                  <a:gd name="T51" fmla="*/ 1232 h 1256"/>
                  <a:gd name="T52" fmla="*/ 908 w 1696"/>
                  <a:gd name="T53" fmla="*/ 1228 h 1256"/>
                  <a:gd name="T54" fmla="*/ 940 w 1696"/>
                  <a:gd name="T55" fmla="*/ 1232 h 1256"/>
                  <a:gd name="T56" fmla="*/ 976 w 1696"/>
                  <a:gd name="T57" fmla="*/ 1236 h 1256"/>
                  <a:gd name="T58" fmla="*/ 1012 w 1696"/>
                  <a:gd name="T59" fmla="*/ 1240 h 1256"/>
                  <a:gd name="T60" fmla="*/ 1044 w 1696"/>
                  <a:gd name="T61" fmla="*/ 1236 h 1256"/>
                  <a:gd name="T62" fmla="*/ 1080 w 1696"/>
                  <a:gd name="T63" fmla="*/ 1220 h 1256"/>
                  <a:gd name="T64" fmla="*/ 1112 w 1696"/>
                  <a:gd name="T65" fmla="*/ 1172 h 1256"/>
                  <a:gd name="T66" fmla="*/ 1148 w 1696"/>
                  <a:gd name="T67" fmla="*/ 1004 h 1256"/>
                  <a:gd name="T68" fmla="*/ 1180 w 1696"/>
                  <a:gd name="T69" fmla="*/ 600 h 1256"/>
                  <a:gd name="T70" fmla="*/ 1216 w 1696"/>
                  <a:gd name="T71" fmla="*/ 128 h 1256"/>
                  <a:gd name="T72" fmla="*/ 1252 w 1696"/>
                  <a:gd name="T73" fmla="*/ 0 h 1256"/>
                  <a:gd name="T74" fmla="*/ 1284 w 1696"/>
                  <a:gd name="T75" fmla="*/ 220 h 1256"/>
                  <a:gd name="T76" fmla="*/ 1320 w 1696"/>
                  <a:gd name="T77" fmla="*/ 468 h 1256"/>
                  <a:gd name="T78" fmla="*/ 1352 w 1696"/>
                  <a:gd name="T79" fmla="*/ 580 h 1256"/>
                  <a:gd name="T80" fmla="*/ 1388 w 1696"/>
                  <a:gd name="T81" fmla="*/ 520 h 1256"/>
                  <a:gd name="T82" fmla="*/ 1424 w 1696"/>
                  <a:gd name="T83" fmla="*/ 504 h 1256"/>
                  <a:gd name="T84" fmla="*/ 1456 w 1696"/>
                  <a:gd name="T85" fmla="*/ 744 h 1256"/>
                  <a:gd name="T86" fmla="*/ 1492 w 1696"/>
                  <a:gd name="T87" fmla="*/ 1036 h 1256"/>
                  <a:gd name="T88" fmla="*/ 1524 w 1696"/>
                  <a:gd name="T89" fmla="*/ 1180 h 1256"/>
                  <a:gd name="T90" fmla="*/ 1560 w 1696"/>
                  <a:gd name="T91" fmla="*/ 1228 h 1256"/>
                  <a:gd name="T92" fmla="*/ 1592 w 1696"/>
                  <a:gd name="T93" fmla="*/ 1244 h 1256"/>
                  <a:gd name="T94" fmla="*/ 1628 w 1696"/>
                  <a:gd name="T95" fmla="*/ 1252 h 1256"/>
                  <a:gd name="T96" fmla="*/ 1664 w 1696"/>
                  <a:gd name="T97" fmla="*/ 1256 h 1256"/>
                  <a:gd name="T98" fmla="*/ 1696 w 1696"/>
                  <a:gd name="T99" fmla="*/ 1256 h 1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696" h="1256">
                    <a:moveTo>
                      <a:pt x="0" y="1256"/>
                    </a:moveTo>
                    <a:lnTo>
                      <a:pt x="16" y="1256"/>
                    </a:lnTo>
                    <a:lnTo>
                      <a:pt x="32" y="1256"/>
                    </a:lnTo>
                    <a:lnTo>
                      <a:pt x="52" y="1256"/>
                    </a:lnTo>
                    <a:lnTo>
                      <a:pt x="68" y="1256"/>
                    </a:lnTo>
                    <a:lnTo>
                      <a:pt x="84" y="1252"/>
                    </a:lnTo>
                    <a:lnTo>
                      <a:pt x="100" y="1248"/>
                    </a:lnTo>
                    <a:lnTo>
                      <a:pt x="120" y="1248"/>
                    </a:lnTo>
                    <a:lnTo>
                      <a:pt x="136" y="1244"/>
                    </a:lnTo>
                    <a:lnTo>
                      <a:pt x="152" y="1240"/>
                    </a:lnTo>
                    <a:lnTo>
                      <a:pt x="172" y="1236"/>
                    </a:lnTo>
                    <a:lnTo>
                      <a:pt x="188" y="1228"/>
                    </a:lnTo>
                    <a:lnTo>
                      <a:pt x="204" y="1220"/>
                    </a:lnTo>
                    <a:lnTo>
                      <a:pt x="220" y="1212"/>
                    </a:lnTo>
                    <a:lnTo>
                      <a:pt x="240" y="1208"/>
                    </a:lnTo>
                    <a:lnTo>
                      <a:pt x="256" y="1200"/>
                    </a:lnTo>
                    <a:lnTo>
                      <a:pt x="272" y="1188"/>
                    </a:lnTo>
                    <a:lnTo>
                      <a:pt x="292" y="1168"/>
                    </a:lnTo>
                    <a:lnTo>
                      <a:pt x="308" y="1132"/>
                    </a:lnTo>
                    <a:lnTo>
                      <a:pt x="324" y="1084"/>
                    </a:lnTo>
                    <a:lnTo>
                      <a:pt x="340" y="1020"/>
                    </a:lnTo>
                    <a:lnTo>
                      <a:pt x="360" y="952"/>
                    </a:lnTo>
                    <a:lnTo>
                      <a:pt x="376" y="900"/>
                    </a:lnTo>
                    <a:lnTo>
                      <a:pt x="392" y="876"/>
                    </a:lnTo>
                    <a:lnTo>
                      <a:pt x="412" y="900"/>
                    </a:lnTo>
                    <a:lnTo>
                      <a:pt x="428" y="952"/>
                    </a:lnTo>
                    <a:lnTo>
                      <a:pt x="444" y="1020"/>
                    </a:lnTo>
                    <a:lnTo>
                      <a:pt x="460" y="1076"/>
                    </a:lnTo>
                    <a:lnTo>
                      <a:pt x="480" y="1120"/>
                    </a:lnTo>
                    <a:lnTo>
                      <a:pt x="496" y="1144"/>
                    </a:lnTo>
                    <a:lnTo>
                      <a:pt x="512" y="1164"/>
                    </a:lnTo>
                    <a:lnTo>
                      <a:pt x="532" y="1176"/>
                    </a:lnTo>
                    <a:lnTo>
                      <a:pt x="548" y="1188"/>
                    </a:lnTo>
                    <a:lnTo>
                      <a:pt x="564" y="1200"/>
                    </a:lnTo>
                    <a:lnTo>
                      <a:pt x="580" y="1208"/>
                    </a:lnTo>
                    <a:lnTo>
                      <a:pt x="600" y="1212"/>
                    </a:lnTo>
                    <a:lnTo>
                      <a:pt x="616" y="1216"/>
                    </a:lnTo>
                    <a:lnTo>
                      <a:pt x="632" y="1216"/>
                    </a:lnTo>
                    <a:lnTo>
                      <a:pt x="652" y="1220"/>
                    </a:lnTo>
                    <a:lnTo>
                      <a:pt x="668" y="1224"/>
                    </a:lnTo>
                    <a:lnTo>
                      <a:pt x="684" y="1228"/>
                    </a:lnTo>
                    <a:lnTo>
                      <a:pt x="700" y="1236"/>
                    </a:lnTo>
                    <a:lnTo>
                      <a:pt x="720" y="1236"/>
                    </a:lnTo>
                    <a:lnTo>
                      <a:pt x="736" y="1236"/>
                    </a:lnTo>
                    <a:lnTo>
                      <a:pt x="752" y="1232"/>
                    </a:lnTo>
                    <a:lnTo>
                      <a:pt x="772" y="1228"/>
                    </a:lnTo>
                    <a:lnTo>
                      <a:pt x="788" y="1224"/>
                    </a:lnTo>
                    <a:lnTo>
                      <a:pt x="804" y="1224"/>
                    </a:lnTo>
                    <a:lnTo>
                      <a:pt x="820" y="1228"/>
                    </a:lnTo>
                    <a:lnTo>
                      <a:pt x="840" y="1232"/>
                    </a:lnTo>
                    <a:lnTo>
                      <a:pt x="856" y="1232"/>
                    </a:lnTo>
                    <a:lnTo>
                      <a:pt x="872" y="1232"/>
                    </a:lnTo>
                    <a:lnTo>
                      <a:pt x="892" y="1232"/>
                    </a:lnTo>
                    <a:lnTo>
                      <a:pt x="908" y="1228"/>
                    </a:lnTo>
                    <a:lnTo>
                      <a:pt x="924" y="1228"/>
                    </a:lnTo>
                    <a:lnTo>
                      <a:pt x="940" y="1232"/>
                    </a:lnTo>
                    <a:lnTo>
                      <a:pt x="960" y="1232"/>
                    </a:lnTo>
                    <a:lnTo>
                      <a:pt x="976" y="1236"/>
                    </a:lnTo>
                    <a:lnTo>
                      <a:pt x="992" y="1240"/>
                    </a:lnTo>
                    <a:lnTo>
                      <a:pt x="1012" y="1240"/>
                    </a:lnTo>
                    <a:lnTo>
                      <a:pt x="1028" y="1236"/>
                    </a:lnTo>
                    <a:lnTo>
                      <a:pt x="1044" y="1236"/>
                    </a:lnTo>
                    <a:lnTo>
                      <a:pt x="1060" y="1232"/>
                    </a:lnTo>
                    <a:lnTo>
                      <a:pt x="1080" y="1220"/>
                    </a:lnTo>
                    <a:lnTo>
                      <a:pt x="1096" y="1204"/>
                    </a:lnTo>
                    <a:lnTo>
                      <a:pt x="1112" y="1172"/>
                    </a:lnTo>
                    <a:lnTo>
                      <a:pt x="1132" y="1112"/>
                    </a:lnTo>
                    <a:lnTo>
                      <a:pt x="1148" y="1004"/>
                    </a:lnTo>
                    <a:lnTo>
                      <a:pt x="1164" y="832"/>
                    </a:lnTo>
                    <a:lnTo>
                      <a:pt x="1180" y="600"/>
                    </a:lnTo>
                    <a:lnTo>
                      <a:pt x="1200" y="348"/>
                    </a:lnTo>
                    <a:lnTo>
                      <a:pt x="1216" y="128"/>
                    </a:lnTo>
                    <a:lnTo>
                      <a:pt x="1232" y="4"/>
                    </a:lnTo>
                    <a:lnTo>
                      <a:pt x="1252" y="0"/>
                    </a:lnTo>
                    <a:lnTo>
                      <a:pt x="1268" y="88"/>
                    </a:lnTo>
                    <a:lnTo>
                      <a:pt x="1284" y="220"/>
                    </a:lnTo>
                    <a:lnTo>
                      <a:pt x="1300" y="356"/>
                    </a:lnTo>
                    <a:lnTo>
                      <a:pt x="1320" y="468"/>
                    </a:lnTo>
                    <a:lnTo>
                      <a:pt x="1336" y="548"/>
                    </a:lnTo>
                    <a:lnTo>
                      <a:pt x="1352" y="580"/>
                    </a:lnTo>
                    <a:lnTo>
                      <a:pt x="1372" y="564"/>
                    </a:lnTo>
                    <a:lnTo>
                      <a:pt x="1388" y="520"/>
                    </a:lnTo>
                    <a:lnTo>
                      <a:pt x="1404" y="484"/>
                    </a:lnTo>
                    <a:lnTo>
                      <a:pt x="1424" y="504"/>
                    </a:lnTo>
                    <a:lnTo>
                      <a:pt x="1440" y="596"/>
                    </a:lnTo>
                    <a:lnTo>
                      <a:pt x="1456" y="744"/>
                    </a:lnTo>
                    <a:lnTo>
                      <a:pt x="1472" y="904"/>
                    </a:lnTo>
                    <a:lnTo>
                      <a:pt x="1492" y="1036"/>
                    </a:lnTo>
                    <a:lnTo>
                      <a:pt x="1508" y="1128"/>
                    </a:lnTo>
                    <a:lnTo>
                      <a:pt x="1524" y="1180"/>
                    </a:lnTo>
                    <a:lnTo>
                      <a:pt x="1544" y="1212"/>
                    </a:lnTo>
                    <a:lnTo>
                      <a:pt x="1560" y="1228"/>
                    </a:lnTo>
                    <a:lnTo>
                      <a:pt x="1576" y="1236"/>
                    </a:lnTo>
                    <a:lnTo>
                      <a:pt x="1592" y="1244"/>
                    </a:lnTo>
                    <a:lnTo>
                      <a:pt x="1612" y="1248"/>
                    </a:lnTo>
                    <a:lnTo>
                      <a:pt x="1628" y="1252"/>
                    </a:lnTo>
                    <a:lnTo>
                      <a:pt x="1644" y="1256"/>
                    </a:lnTo>
                    <a:lnTo>
                      <a:pt x="1664" y="1256"/>
                    </a:lnTo>
                    <a:lnTo>
                      <a:pt x="1680" y="1256"/>
                    </a:lnTo>
                    <a:lnTo>
                      <a:pt x="1696" y="125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7128" name="Group 238"/>
            <p:cNvGrpSpPr>
              <a:grpSpLocks noChangeAspect="1"/>
            </p:cNvGrpSpPr>
            <p:nvPr/>
          </p:nvGrpSpPr>
          <p:grpSpPr bwMode="auto">
            <a:xfrm>
              <a:off x="3970208" y="5088119"/>
              <a:ext cx="2649893" cy="1767053"/>
              <a:chOff x="615" y="2892"/>
              <a:chExt cx="2032" cy="1636"/>
            </a:xfrm>
          </p:grpSpPr>
          <p:sp>
            <p:nvSpPr>
              <p:cNvPr id="17131" name="Rectangle 240"/>
              <p:cNvSpPr>
                <a:spLocks noChangeArrowheads="1"/>
              </p:cNvSpPr>
              <p:nvPr/>
            </p:nvSpPr>
            <p:spPr bwMode="auto">
              <a:xfrm>
                <a:off x="687" y="3012"/>
                <a:ext cx="1844" cy="1412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2" name="Line 241"/>
              <p:cNvSpPr>
                <a:spLocks noChangeShapeType="1"/>
              </p:cNvSpPr>
              <p:nvPr/>
            </p:nvSpPr>
            <p:spPr bwMode="auto">
              <a:xfrm>
                <a:off x="687" y="4424"/>
                <a:ext cx="196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3" name="Line 242"/>
              <p:cNvSpPr>
                <a:spLocks noChangeShapeType="1"/>
              </p:cNvSpPr>
              <p:nvPr/>
            </p:nvSpPr>
            <p:spPr bwMode="auto">
              <a:xfrm flipV="1">
                <a:off x="687" y="2892"/>
                <a:ext cx="0" cy="153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4" name="Line 243"/>
              <p:cNvSpPr>
                <a:spLocks noChangeShapeType="1"/>
              </p:cNvSpPr>
              <p:nvPr/>
            </p:nvSpPr>
            <p:spPr bwMode="auto">
              <a:xfrm flipV="1">
                <a:off x="687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5" name="Rectangle 244"/>
              <p:cNvSpPr>
                <a:spLocks noChangeArrowheads="1"/>
              </p:cNvSpPr>
              <p:nvPr/>
            </p:nvSpPr>
            <p:spPr bwMode="auto">
              <a:xfrm>
                <a:off x="635" y="4436"/>
                <a:ext cx="10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36" name="Line 245"/>
              <p:cNvSpPr>
                <a:spLocks noChangeShapeType="1"/>
              </p:cNvSpPr>
              <p:nvPr/>
            </p:nvSpPr>
            <p:spPr bwMode="auto">
              <a:xfrm flipV="1">
                <a:off x="89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7" name="Rectangle 246"/>
              <p:cNvSpPr>
                <a:spLocks noChangeArrowheads="1"/>
              </p:cNvSpPr>
              <p:nvPr/>
            </p:nvSpPr>
            <p:spPr bwMode="auto">
              <a:xfrm>
                <a:off x="839" y="4436"/>
                <a:ext cx="10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38" name="Line 247"/>
              <p:cNvSpPr>
                <a:spLocks noChangeShapeType="1"/>
              </p:cNvSpPr>
              <p:nvPr/>
            </p:nvSpPr>
            <p:spPr bwMode="auto">
              <a:xfrm flipV="1">
                <a:off x="1095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39" name="Rectangle 248"/>
              <p:cNvSpPr>
                <a:spLocks noChangeArrowheads="1"/>
              </p:cNvSpPr>
              <p:nvPr/>
            </p:nvSpPr>
            <p:spPr bwMode="auto">
              <a:xfrm>
                <a:off x="1043" y="4436"/>
                <a:ext cx="10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40" name="Line 249"/>
              <p:cNvSpPr>
                <a:spLocks noChangeShapeType="1"/>
              </p:cNvSpPr>
              <p:nvPr/>
            </p:nvSpPr>
            <p:spPr bwMode="auto">
              <a:xfrm flipV="1">
                <a:off x="1299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41" name="Rectangle 250"/>
              <p:cNvSpPr>
                <a:spLocks noChangeArrowheads="1"/>
              </p:cNvSpPr>
              <p:nvPr/>
            </p:nvSpPr>
            <p:spPr bwMode="auto">
              <a:xfrm>
                <a:off x="1247" y="4436"/>
                <a:ext cx="106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42" name="Line 251"/>
              <p:cNvSpPr>
                <a:spLocks noChangeShapeType="1"/>
              </p:cNvSpPr>
              <p:nvPr/>
            </p:nvSpPr>
            <p:spPr bwMode="auto">
              <a:xfrm flipV="1">
                <a:off x="1503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43" name="Rectangle 252"/>
              <p:cNvSpPr>
                <a:spLocks noChangeArrowheads="1"/>
              </p:cNvSpPr>
              <p:nvPr/>
            </p:nvSpPr>
            <p:spPr bwMode="auto">
              <a:xfrm>
                <a:off x="1491" y="4436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44" name="Line 253"/>
              <p:cNvSpPr>
                <a:spLocks noChangeShapeType="1"/>
              </p:cNvSpPr>
              <p:nvPr/>
            </p:nvSpPr>
            <p:spPr bwMode="auto">
              <a:xfrm flipV="1">
                <a:off x="171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45" name="Rectangle 254"/>
              <p:cNvSpPr>
                <a:spLocks noChangeArrowheads="1"/>
              </p:cNvSpPr>
              <p:nvPr/>
            </p:nvSpPr>
            <p:spPr bwMode="auto">
              <a:xfrm>
                <a:off x="1675" y="4436"/>
                <a:ext cx="85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46" name="Line 255"/>
              <p:cNvSpPr>
                <a:spLocks noChangeShapeType="1"/>
              </p:cNvSpPr>
              <p:nvPr/>
            </p:nvSpPr>
            <p:spPr bwMode="auto">
              <a:xfrm flipV="1">
                <a:off x="1915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47" name="Rectangle 256"/>
              <p:cNvSpPr>
                <a:spLocks noChangeArrowheads="1"/>
              </p:cNvSpPr>
              <p:nvPr/>
            </p:nvSpPr>
            <p:spPr bwMode="auto">
              <a:xfrm>
                <a:off x="1879" y="4436"/>
                <a:ext cx="85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48" name="Line 257"/>
              <p:cNvSpPr>
                <a:spLocks noChangeShapeType="1"/>
              </p:cNvSpPr>
              <p:nvPr/>
            </p:nvSpPr>
            <p:spPr bwMode="auto">
              <a:xfrm flipV="1">
                <a:off x="2119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49" name="Rectangle 258"/>
              <p:cNvSpPr>
                <a:spLocks noChangeArrowheads="1"/>
              </p:cNvSpPr>
              <p:nvPr/>
            </p:nvSpPr>
            <p:spPr bwMode="auto">
              <a:xfrm>
                <a:off x="2083" y="4436"/>
                <a:ext cx="85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150" name="Line 259"/>
              <p:cNvSpPr>
                <a:spLocks noChangeShapeType="1"/>
              </p:cNvSpPr>
              <p:nvPr/>
            </p:nvSpPr>
            <p:spPr bwMode="auto">
              <a:xfrm flipV="1">
                <a:off x="2323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7151" name="Rectangle 260"/>
              <p:cNvSpPr>
                <a:spLocks noChangeArrowheads="1"/>
              </p:cNvSpPr>
              <p:nvPr/>
            </p:nvSpPr>
            <p:spPr bwMode="auto">
              <a:xfrm>
                <a:off x="2287" y="4436"/>
                <a:ext cx="85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08" name="Line 261"/>
              <p:cNvSpPr>
                <a:spLocks noChangeShapeType="1"/>
              </p:cNvSpPr>
              <p:nvPr/>
            </p:nvSpPr>
            <p:spPr bwMode="auto">
              <a:xfrm flipV="1">
                <a:off x="2531" y="4404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09" name="Rectangle 262"/>
              <p:cNvSpPr>
                <a:spLocks noChangeArrowheads="1"/>
              </p:cNvSpPr>
              <p:nvPr/>
            </p:nvSpPr>
            <p:spPr bwMode="auto">
              <a:xfrm>
                <a:off x="2519" y="4436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10" name="Line 263"/>
              <p:cNvSpPr>
                <a:spLocks noChangeShapeType="1"/>
              </p:cNvSpPr>
              <p:nvPr/>
            </p:nvSpPr>
            <p:spPr bwMode="auto">
              <a:xfrm>
                <a:off x="687" y="442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11" name="Rectangle 264"/>
              <p:cNvSpPr>
                <a:spLocks noChangeArrowheads="1"/>
              </p:cNvSpPr>
              <p:nvPr/>
            </p:nvSpPr>
            <p:spPr bwMode="auto">
              <a:xfrm>
                <a:off x="643" y="4392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12" name="Line 265"/>
              <p:cNvSpPr>
                <a:spLocks noChangeShapeType="1"/>
              </p:cNvSpPr>
              <p:nvPr/>
            </p:nvSpPr>
            <p:spPr bwMode="auto">
              <a:xfrm>
                <a:off x="687" y="418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13" name="Rectangle 266"/>
              <p:cNvSpPr>
                <a:spLocks noChangeArrowheads="1"/>
              </p:cNvSpPr>
              <p:nvPr/>
            </p:nvSpPr>
            <p:spPr bwMode="auto">
              <a:xfrm>
                <a:off x="643" y="4156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14" name="Line 267"/>
              <p:cNvSpPr>
                <a:spLocks noChangeShapeType="1"/>
              </p:cNvSpPr>
              <p:nvPr/>
            </p:nvSpPr>
            <p:spPr bwMode="auto">
              <a:xfrm>
                <a:off x="687" y="395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15" name="Rectangle 268"/>
              <p:cNvSpPr>
                <a:spLocks noChangeArrowheads="1"/>
              </p:cNvSpPr>
              <p:nvPr/>
            </p:nvSpPr>
            <p:spPr bwMode="auto">
              <a:xfrm>
                <a:off x="643" y="3920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16" name="Line 269"/>
              <p:cNvSpPr>
                <a:spLocks noChangeShapeType="1"/>
              </p:cNvSpPr>
              <p:nvPr/>
            </p:nvSpPr>
            <p:spPr bwMode="auto">
              <a:xfrm>
                <a:off x="687" y="3716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17" name="Rectangle 270"/>
              <p:cNvSpPr>
                <a:spLocks noChangeArrowheads="1"/>
              </p:cNvSpPr>
              <p:nvPr/>
            </p:nvSpPr>
            <p:spPr bwMode="auto">
              <a:xfrm>
                <a:off x="643" y="3684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18" name="Line 271"/>
              <p:cNvSpPr>
                <a:spLocks noChangeShapeType="1"/>
              </p:cNvSpPr>
              <p:nvPr/>
            </p:nvSpPr>
            <p:spPr bwMode="auto">
              <a:xfrm>
                <a:off x="687" y="348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19" name="Rectangle 272"/>
              <p:cNvSpPr>
                <a:spLocks noChangeArrowheads="1"/>
              </p:cNvSpPr>
              <p:nvPr/>
            </p:nvSpPr>
            <p:spPr bwMode="auto">
              <a:xfrm>
                <a:off x="643" y="3448"/>
                <a:ext cx="34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20" name="Line 273"/>
              <p:cNvSpPr>
                <a:spLocks noChangeShapeType="1"/>
              </p:cNvSpPr>
              <p:nvPr/>
            </p:nvSpPr>
            <p:spPr bwMode="auto">
              <a:xfrm>
                <a:off x="687" y="324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21" name="Rectangle 274"/>
              <p:cNvSpPr>
                <a:spLocks noChangeArrowheads="1"/>
              </p:cNvSpPr>
              <p:nvPr/>
            </p:nvSpPr>
            <p:spPr bwMode="auto">
              <a:xfrm>
                <a:off x="615" y="3212"/>
                <a:ext cx="6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22" name="Line 275"/>
              <p:cNvSpPr>
                <a:spLocks noChangeShapeType="1"/>
              </p:cNvSpPr>
              <p:nvPr/>
            </p:nvSpPr>
            <p:spPr bwMode="auto">
              <a:xfrm>
                <a:off x="687" y="301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23" name="Rectangle 276"/>
              <p:cNvSpPr>
                <a:spLocks noChangeArrowheads="1"/>
              </p:cNvSpPr>
              <p:nvPr/>
            </p:nvSpPr>
            <p:spPr bwMode="auto">
              <a:xfrm>
                <a:off x="615" y="2980"/>
                <a:ext cx="69" cy="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2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24" name="Freeform 277"/>
              <p:cNvSpPr>
                <a:spLocks/>
              </p:cNvSpPr>
              <p:nvPr/>
            </p:nvSpPr>
            <p:spPr bwMode="auto">
              <a:xfrm>
                <a:off x="879" y="3208"/>
                <a:ext cx="1444" cy="1212"/>
              </a:xfrm>
              <a:custGeom>
                <a:avLst/>
                <a:gdLst>
                  <a:gd name="T0" fmla="*/ 12 w 1444"/>
                  <a:gd name="T1" fmla="*/ 1212 h 1212"/>
                  <a:gd name="T2" fmla="*/ 44 w 1444"/>
                  <a:gd name="T3" fmla="*/ 1208 h 1212"/>
                  <a:gd name="T4" fmla="*/ 72 w 1444"/>
                  <a:gd name="T5" fmla="*/ 1212 h 1212"/>
                  <a:gd name="T6" fmla="*/ 100 w 1444"/>
                  <a:gd name="T7" fmla="*/ 1204 h 1212"/>
                  <a:gd name="T8" fmla="*/ 132 w 1444"/>
                  <a:gd name="T9" fmla="*/ 1192 h 1212"/>
                  <a:gd name="T10" fmla="*/ 160 w 1444"/>
                  <a:gd name="T11" fmla="*/ 904 h 1212"/>
                  <a:gd name="T12" fmla="*/ 188 w 1444"/>
                  <a:gd name="T13" fmla="*/ 1052 h 1212"/>
                  <a:gd name="T14" fmla="*/ 220 w 1444"/>
                  <a:gd name="T15" fmla="*/ 1136 h 1212"/>
                  <a:gd name="T16" fmla="*/ 248 w 1444"/>
                  <a:gd name="T17" fmla="*/ 1160 h 1212"/>
                  <a:gd name="T18" fmla="*/ 276 w 1444"/>
                  <a:gd name="T19" fmla="*/ 1172 h 1212"/>
                  <a:gd name="T20" fmla="*/ 304 w 1444"/>
                  <a:gd name="T21" fmla="*/ 1200 h 1212"/>
                  <a:gd name="T22" fmla="*/ 336 w 1444"/>
                  <a:gd name="T23" fmla="*/ 1192 h 1212"/>
                  <a:gd name="T24" fmla="*/ 364 w 1444"/>
                  <a:gd name="T25" fmla="*/ 1196 h 1212"/>
                  <a:gd name="T26" fmla="*/ 392 w 1444"/>
                  <a:gd name="T27" fmla="*/ 1204 h 1212"/>
                  <a:gd name="T28" fmla="*/ 424 w 1444"/>
                  <a:gd name="T29" fmla="*/ 1208 h 1212"/>
                  <a:gd name="T30" fmla="*/ 452 w 1444"/>
                  <a:gd name="T31" fmla="*/ 1208 h 1212"/>
                  <a:gd name="T32" fmla="*/ 480 w 1444"/>
                  <a:gd name="T33" fmla="*/ 1204 h 1212"/>
                  <a:gd name="T34" fmla="*/ 512 w 1444"/>
                  <a:gd name="T35" fmla="*/ 1200 h 1212"/>
                  <a:gd name="T36" fmla="*/ 540 w 1444"/>
                  <a:gd name="T37" fmla="*/ 1208 h 1212"/>
                  <a:gd name="T38" fmla="*/ 568 w 1444"/>
                  <a:gd name="T39" fmla="*/ 1208 h 1212"/>
                  <a:gd name="T40" fmla="*/ 600 w 1444"/>
                  <a:gd name="T41" fmla="*/ 1204 h 1212"/>
                  <a:gd name="T42" fmla="*/ 628 w 1444"/>
                  <a:gd name="T43" fmla="*/ 1208 h 1212"/>
                  <a:gd name="T44" fmla="*/ 656 w 1444"/>
                  <a:gd name="T45" fmla="*/ 1212 h 1212"/>
                  <a:gd name="T46" fmla="*/ 684 w 1444"/>
                  <a:gd name="T47" fmla="*/ 1208 h 1212"/>
                  <a:gd name="T48" fmla="*/ 716 w 1444"/>
                  <a:gd name="T49" fmla="*/ 1212 h 1212"/>
                  <a:gd name="T50" fmla="*/ 744 w 1444"/>
                  <a:gd name="T51" fmla="*/ 1212 h 1212"/>
                  <a:gd name="T52" fmla="*/ 772 w 1444"/>
                  <a:gd name="T53" fmla="*/ 1212 h 1212"/>
                  <a:gd name="T54" fmla="*/ 804 w 1444"/>
                  <a:gd name="T55" fmla="*/ 1208 h 1212"/>
                  <a:gd name="T56" fmla="*/ 832 w 1444"/>
                  <a:gd name="T57" fmla="*/ 1208 h 1212"/>
                  <a:gd name="T58" fmla="*/ 860 w 1444"/>
                  <a:gd name="T59" fmla="*/ 1208 h 1212"/>
                  <a:gd name="T60" fmla="*/ 892 w 1444"/>
                  <a:gd name="T61" fmla="*/ 1204 h 1212"/>
                  <a:gd name="T62" fmla="*/ 920 w 1444"/>
                  <a:gd name="T63" fmla="*/ 1212 h 1212"/>
                  <a:gd name="T64" fmla="*/ 948 w 1444"/>
                  <a:gd name="T65" fmla="*/ 1204 h 1212"/>
                  <a:gd name="T66" fmla="*/ 976 w 1444"/>
                  <a:gd name="T67" fmla="*/ 1196 h 1212"/>
                  <a:gd name="T68" fmla="*/ 1008 w 1444"/>
                  <a:gd name="T69" fmla="*/ 1188 h 1212"/>
                  <a:gd name="T70" fmla="*/ 1036 w 1444"/>
                  <a:gd name="T71" fmla="*/ 1144 h 1212"/>
                  <a:gd name="T72" fmla="*/ 1064 w 1444"/>
                  <a:gd name="T73" fmla="*/ 1008 h 1212"/>
                  <a:gd name="T74" fmla="*/ 1096 w 1444"/>
                  <a:gd name="T75" fmla="*/ 608 h 1212"/>
                  <a:gd name="T76" fmla="*/ 1124 w 1444"/>
                  <a:gd name="T77" fmla="*/ 68 h 1212"/>
                  <a:gd name="T78" fmla="*/ 1152 w 1444"/>
                  <a:gd name="T79" fmla="*/ 340 h 1212"/>
                  <a:gd name="T80" fmla="*/ 1184 w 1444"/>
                  <a:gd name="T81" fmla="*/ 1104 h 1212"/>
                  <a:gd name="T82" fmla="*/ 1212 w 1444"/>
                  <a:gd name="T83" fmla="*/ 1172 h 1212"/>
                  <a:gd name="T84" fmla="*/ 1240 w 1444"/>
                  <a:gd name="T85" fmla="*/ 1180 h 1212"/>
                  <a:gd name="T86" fmla="*/ 1272 w 1444"/>
                  <a:gd name="T87" fmla="*/ 1140 h 1212"/>
                  <a:gd name="T88" fmla="*/ 1300 w 1444"/>
                  <a:gd name="T89" fmla="*/ 1156 h 1212"/>
                  <a:gd name="T90" fmla="*/ 1328 w 1444"/>
                  <a:gd name="T91" fmla="*/ 1204 h 1212"/>
                  <a:gd name="T92" fmla="*/ 1356 w 1444"/>
                  <a:gd name="T93" fmla="*/ 1208 h 1212"/>
                  <a:gd name="T94" fmla="*/ 1388 w 1444"/>
                  <a:gd name="T95" fmla="*/ 1212 h 1212"/>
                  <a:gd name="T96" fmla="*/ 1416 w 1444"/>
                  <a:gd name="T97" fmla="*/ 1212 h 1212"/>
                  <a:gd name="T98" fmla="*/ 1444 w 1444"/>
                  <a:gd name="T99" fmla="*/ 1212 h 12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444" h="1212">
                    <a:moveTo>
                      <a:pt x="0" y="1212"/>
                    </a:moveTo>
                    <a:lnTo>
                      <a:pt x="12" y="1212"/>
                    </a:lnTo>
                    <a:lnTo>
                      <a:pt x="28" y="1212"/>
                    </a:lnTo>
                    <a:lnTo>
                      <a:pt x="44" y="1208"/>
                    </a:lnTo>
                    <a:lnTo>
                      <a:pt x="56" y="1208"/>
                    </a:lnTo>
                    <a:lnTo>
                      <a:pt x="72" y="1212"/>
                    </a:lnTo>
                    <a:lnTo>
                      <a:pt x="88" y="1212"/>
                    </a:lnTo>
                    <a:lnTo>
                      <a:pt x="100" y="1204"/>
                    </a:lnTo>
                    <a:lnTo>
                      <a:pt x="116" y="1204"/>
                    </a:lnTo>
                    <a:lnTo>
                      <a:pt x="132" y="1192"/>
                    </a:lnTo>
                    <a:lnTo>
                      <a:pt x="144" y="1080"/>
                    </a:lnTo>
                    <a:lnTo>
                      <a:pt x="160" y="904"/>
                    </a:lnTo>
                    <a:lnTo>
                      <a:pt x="176" y="928"/>
                    </a:lnTo>
                    <a:lnTo>
                      <a:pt x="188" y="1052"/>
                    </a:lnTo>
                    <a:lnTo>
                      <a:pt x="204" y="1116"/>
                    </a:lnTo>
                    <a:lnTo>
                      <a:pt x="220" y="1136"/>
                    </a:lnTo>
                    <a:lnTo>
                      <a:pt x="232" y="1144"/>
                    </a:lnTo>
                    <a:lnTo>
                      <a:pt x="248" y="1160"/>
                    </a:lnTo>
                    <a:lnTo>
                      <a:pt x="264" y="1172"/>
                    </a:lnTo>
                    <a:lnTo>
                      <a:pt x="276" y="1172"/>
                    </a:lnTo>
                    <a:lnTo>
                      <a:pt x="292" y="1192"/>
                    </a:lnTo>
                    <a:lnTo>
                      <a:pt x="304" y="1200"/>
                    </a:lnTo>
                    <a:lnTo>
                      <a:pt x="320" y="1196"/>
                    </a:lnTo>
                    <a:lnTo>
                      <a:pt x="336" y="1192"/>
                    </a:lnTo>
                    <a:lnTo>
                      <a:pt x="348" y="1200"/>
                    </a:lnTo>
                    <a:lnTo>
                      <a:pt x="364" y="1196"/>
                    </a:lnTo>
                    <a:lnTo>
                      <a:pt x="380" y="1196"/>
                    </a:lnTo>
                    <a:lnTo>
                      <a:pt x="392" y="1204"/>
                    </a:lnTo>
                    <a:lnTo>
                      <a:pt x="408" y="1212"/>
                    </a:lnTo>
                    <a:lnTo>
                      <a:pt x="424" y="1208"/>
                    </a:lnTo>
                    <a:lnTo>
                      <a:pt x="436" y="1200"/>
                    </a:lnTo>
                    <a:lnTo>
                      <a:pt x="452" y="1208"/>
                    </a:lnTo>
                    <a:lnTo>
                      <a:pt x="468" y="1208"/>
                    </a:lnTo>
                    <a:lnTo>
                      <a:pt x="480" y="1204"/>
                    </a:lnTo>
                    <a:lnTo>
                      <a:pt x="496" y="1200"/>
                    </a:lnTo>
                    <a:lnTo>
                      <a:pt x="512" y="1200"/>
                    </a:lnTo>
                    <a:lnTo>
                      <a:pt x="524" y="1204"/>
                    </a:lnTo>
                    <a:lnTo>
                      <a:pt x="540" y="1208"/>
                    </a:lnTo>
                    <a:lnTo>
                      <a:pt x="556" y="1208"/>
                    </a:lnTo>
                    <a:lnTo>
                      <a:pt x="568" y="1208"/>
                    </a:lnTo>
                    <a:lnTo>
                      <a:pt x="584" y="1208"/>
                    </a:lnTo>
                    <a:lnTo>
                      <a:pt x="600" y="1204"/>
                    </a:lnTo>
                    <a:lnTo>
                      <a:pt x="612" y="1204"/>
                    </a:lnTo>
                    <a:lnTo>
                      <a:pt x="628" y="1208"/>
                    </a:lnTo>
                    <a:lnTo>
                      <a:pt x="640" y="1212"/>
                    </a:lnTo>
                    <a:lnTo>
                      <a:pt x="656" y="1212"/>
                    </a:lnTo>
                    <a:lnTo>
                      <a:pt x="672" y="1212"/>
                    </a:lnTo>
                    <a:lnTo>
                      <a:pt x="684" y="1208"/>
                    </a:lnTo>
                    <a:lnTo>
                      <a:pt x="700" y="1204"/>
                    </a:lnTo>
                    <a:lnTo>
                      <a:pt x="716" y="1212"/>
                    </a:lnTo>
                    <a:lnTo>
                      <a:pt x="728" y="1212"/>
                    </a:lnTo>
                    <a:lnTo>
                      <a:pt x="744" y="1212"/>
                    </a:lnTo>
                    <a:lnTo>
                      <a:pt x="760" y="1212"/>
                    </a:lnTo>
                    <a:lnTo>
                      <a:pt x="772" y="1212"/>
                    </a:lnTo>
                    <a:lnTo>
                      <a:pt x="788" y="1208"/>
                    </a:lnTo>
                    <a:lnTo>
                      <a:pt x="804" y="1208"/>
                    </a:lnTo>
                    <a:lnTo>
                      <a:pt x="816" y="1208"/>
                    </a:lnTo>
                    <a:lnTo>
                      <a:pt x="832" y="1208"/>
                    </a:lnTo>
                    <a:lnTo>
                      <a:pt x="848" y="1208"/>
                    </a:lnTo>
                    <a:lnTo>
                      <a:pt x="860" y="1208"/>
                    </a:lnTo>
                    <a:lnTo>
                      <a:pt x="876" y="1204"/>
                    </a:lnTo>
                    <a:lnTo>
                      <a:pt x="892" y="1204"/>
                    </a:lnTo>
                    <a:lnTo>
                      <a:pt x="904" y="1208"/>
                    </a:lnTo>
                    <a:lnTo>
                      <a:pt x="920" y="1212"/>
                    </a:lnTo>
                    <a:lnTo>
                      <a:pt x="936" y="1212"/>
                    </a:lnTo>
                    <a:lnTo>
                      <a:pt x="948" y="1204"/>
                    </a:lnTo>
                    <a:lnTo>
                      <a:pt x="964" y="1196"/>
                    </a:lnTo>
                    <a:lnTo>
                      <a:pt x="976" y="1196"/>
                    </a:lnTo>
                    <a:lnTo>
                      <a:pt x="992" y="1196"/>
                    </a:lnTo>
                    <a:lnTo>
                      <a:pt x="1008" y="1188"/>
                    </a:lnTo>
                    <a:lnTo>
                      <a:pt x="1020" y="1168"/>
                    </a:lnTo>
                    <a:lnTo>
                      <a:pt x="1036" y="1144"/>
                    </a:lnTo>
                    <a:lnTo>
                      <a:pt x="1052" y="1108"/>
                    </a:lnTo>
                    <a:lnTo>
                      <a:pt x="1064" y="1008"/>
                    </a:lnTo>
                    <a:lnTo>
                      <a:pt x="1080" y="832"/>
                    </a:lnTo>
                    <a:lnTo>
                      <a:pt x="1096" y="608"/>
                    </a:lnTo>
                    <a:lnTo>
                      <a:pt x="1108" y="360"/>
                    </a:lnTo>
                    <a:lnTo>
                      <a:pt x="1124" y="68"/>
                    </a:lnTo>
                    <a:lnTo>
                      <a:pt x="1140" y="0"/>
                    </a:lnTo>
                    <a:lnTo>
                      <a:pt x="1152" y="340"/>
                    </a:lnTo>
                    <a:lnTo>
                      <a:pt x="1168" y="848"/>
                    </a:lnTo>
                    <a:lnTo>
                      <a:pt x="1184" y="1104"/>
                    </a:lnTo>
                    <a:lnTo>
                      <a:pt x="1196" y="1160"/>
                    </a:lnTo>
                    <a:lnTo>
                      <a:pt x="1212" y="1172"/>
                    </a:lnTo>
                    <a:lnTo>
                      <a:pt x="1228" y="1176"/>
                    </a:lnTo>
                    <a:lnTo>
                      <a:pt x="1240" y="1180"/>
                    </a:lnTo>
                    <a:lnTo>
                      <a:pt x="1256" y="1172"/>
                    </a:lnTo>
                    <a:lnTo>
                      <a:pt x="1272" y="1140"/>
                    </a:lnTo>
                    <a:lnTo>
                      <a:pt x="1284" y="1132"/>
                    </a:lnTo>
                    <a:lnTo>
                      <a:pt x="1300" y="1156"/>
                    </a:lnTo>
                    <a:lnTo>
                      <a:pt x="1312" y="1188"/>
                    </a:lnTo>
                    <a:lnTo>
                      <a:pt x="1328" y="1204"/>
                    </a:lnTo>
                    <a:lnTo>
                      <a:pt x="1344" y="1208"/>
                    </a:lnTo>
                    <a:lnTo>
                      <a:pt x="1356" y="1208"/>
                    </a:lnTo>
                    <a:lnTo>
                      <a:pt x="1372" y="1208"/>
                    </a:lnTo>
                    <a:lnTo>
                      <a:pt x="1388" y="1212"/>
                    </a:lnTo>
                    <a:lnTo>
                      <a:pt x="1400" y="1212"/>
                    </a:lnTo>
                    <a:lnTo>
                      <a:pt x="1416" y="1212"/>
                    </a:lnTo>
                    <a:lnTo>
                      <a:pt x="1432" y="1212"/>
                    </a:lnTo>
                    <a:lnTo>
                      <a:pt x="1444" y="1212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19027" name="Group 283"/>
            <p:cNvGrpSpPr>
              <a:grpSpLocks noChangeAspect="1"/>
            </p:cNvGrpSpPr>
            <p:nvPr/>
          </p:nvGrpSpPr>
          <p:grpSpPr bwMode="auto">
            <a:xfrm>
              <a:off x="425442" y="7091076"/>
              <a:ext cx="2654308" cy="1809463"/>
              <a:chOff x="583" y="3178"/>
              <a:chExt cx="2052" cy="1625"/>
            </a:xfrm>
          </p:grpSpPr>
          <p:sp>
            <p:nvSpPr>
              <p:cNvPr id="19030" name="Rectangle 285"/>
              <p:cNvSpPr>
                <a:spLocks noChangeArrowheads="1"/>
              </p:cNvSpPr>
              <p:nvPr/>
            </p:nvSpPr>
            <p:spPr bwMode="auto">
              <a:xfrm>
                <a:off x="687" y="3286"/>
                <a:ext cx="1844" cy="1416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1" name="Line 286"/>
              <p:cNvSpPr>
                <a:spLocks noChangeShapeType="1"/>
              </p:cNvSpPr>
              <p:nvPr/>
            </p:nvSpPr>
            <p:spPr bwMode="auto">
              <a:xfrm>
                <a:off x="687" y="4702"/>
                <a:ext cx="194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2" name="Line 287"/>
              <p:cNvSpPr>
                <a:spLocks noChangeShapeType="1"/>
              </p:cNvSpPr>
              <p:nvPr/>
            </p:nvSpPr>
            <p:spPr bwMode="auto">
              <a:xfrm flipV="1">
                <a:off x="687" y="3178"/>
                <a:ext cx="0" cy="152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3" name="Line 288"/>
              <p:cNvSpPr>
                <a:spLocks noChangeShapeType="1"/>
              </p:cNvSpPr>
              <p:nvPr/>
            </p:nvSpPr>
            <p:spPr bwMode="auto">
              <a:xfrm flipV="1">
                <a:off x="687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4" name="Rectangle 289"/>
              <p:cNvSpPr>
                <a:spLocks noChangeArrowheads="1"/>
              </p:cNvSpPr>
              <p:nvPr/>
            </p:nvSpPr>
            <p:spPr bwMode="auto">
              <a:xfrm>
                <a:off x="635" y="4714"/>
                <a:ext cx="107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35" name="Line 290"/>
              <p:cNvSpPr>
                <a:spLocks noChangeShapeType="1"/>
              </p:cNvSpPr>
              <p:nvPr/>
            </p:nvSpPr>
            <p:spPr bwMode="auto">
              <a:xfrm flipV="1">
                <a:off x="89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6" name="Rectangle 291"/>
              <p:cNvSpPr>
                <a:spLocks noChangeArrowheads="1"/>
              </p:cNvSpPr>
              <p:nvPr/>
            </p:nvSpPr>
            <p:spPr bwMode="auto">
              <a:xfrm>
                <a:off x="839" y="4714"/>
                <a:ext cx="107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37" name="Line 292"/>
              <p:cNvSpPr>
                <a:spLocks noChangeShapeType="1"/>
              </p:cNvSpPr>
              <p:nvPr/>
            </p:nvSpPr>
            <p:spPr bwMode="auto">
              <a:xfrm flipV="1">
                <a:off x="1095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38" name="Rectangle 293"/>
              <p:cNvSpPr>
                <a:spLocks noChangeArrowheads="1"/>
              </p:cNvSpPr>
              <p:nvPr/>
            </p:nvSpPr>
            <p:spPr bwMode="auto">
              <a:xfrm>
                <a:off x="1043" y="4714"/>
                <a:ext cx="107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39" name="Line 294"/>
              <p:cNvSpPr>
                <a:spLocks noChangeShapeType="1"/>
              </p:cNvSpPr>
              <p:nvPr/>
            </p:nvSpPr>
            <p:spPr bwMode="auto">
              <a:xfrm flipV="1">
                <a:off x="1299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40" name="Rectangle 295"/>
              <p:cNvSpPr>
                <a:spLocks noChangeArrowheads="1"/>
              </p:cNvSpPr>
              <p:nvPr/>
            </p:nvSpPr>
            <p:spPr bwMode="auto">
              <a:xfrm>
                <a:off x="1247" y="4714"/>
                <a:ext cx="107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41" name="Line 296"/>
              <p:cNvSpPr>
                <a:spLocks noChangeShapeType="1"/>
              </p:cNvSpPr>
              <p:nvPr/>
            </p:nvSpPr>
            <p:spPr bwMode="auto">
              <a:xfrm flipV="1">
                <a:off x="1503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42" name="Rectangle 297"/>
              <p:cNvSpPr>
                <a:spLocks noChangeArrowheads="1"/>
              </p:cNvSpPr>
              <p:nvPr/>
            </p:nvSpPr>
            <p:spPr bwMode="auto">
              <a:xfrm>
                <a:off x="1491" y="4714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43" name="Line 298"/>
              <p:cNvSpPr>
                <a:spLocks noChangeShapeType="1"/>
              </p:cNvSpPr>
              <p:nvPr/>
            </p:nvSpPr>
            <p:spPr bwMode="auto">
              <a:xfrm flipV="1">
                <a:off x="171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44" name="Rectangle 299"/>
              <p:cNvSpPr>
                <a:spLocks noChangeArrowheads="1"/>
              </p:cNvSpPr>
              <p:nvPr/>
            </p:nvSpPr>
            <p:spPr bwMode="auto">
              <a:xfrm>
                <a:off x="1675" y="4714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45" name="Line 300"/>
              <p:cNvSpPr>
                <a:spLocks noChangeShapeType="1"/>
              </p:cNvSpPr>
              <p:nvPr/>
            </p:nvSpPr>
            <p:spPr bwMode="auto">
              <a:xfrm flipV="1">
                <a:off x="1915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47" name="Rectangle 301"/>
              <p:cNvSpPr>
                <a:spLocks noChangeArrowheads="1"/>
              </p:cNvSpPr>
              <p:nvPr/>
            </p:nvSpPr>
            <p:spPr bwMode="auto">
              <a:xfrm>
                <a:off x="1879" y="4714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48" name="Line 302"/>
              <p:cNvSpPr>
                <a:spLocks noChangeShapeType="1"/>
              </p:cNvSpPr>
              <p:nvPr/>
            </p:nvSpPr>
            <p:spPr bwMode="auto">
              <a:xfrm flipV="1">
                <a:off x="2119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49" name="Rectangle 303"/>
              <p:cNvSpPr>
                <a:spLocks noChangeArrowheads="1"/>
              </p:cNvSpPr>
              <p:nvPr/>
            </p:nvSpPr>
            <p:spPr bwMode="auto">
              <a:xfrm>
                <a:off x="2083" y="4714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50" name="Line 304"/>
              <p:cNvSpPr>
                <a:spLocks noChangeShapeType="1"/>
              </p:cNvSpPr>
              <p:nvPr/>
            </p:nvSpPr>
            <p:spPr bwMode="auto">
              <a:xfrm flipV="1">
                <a:off x="2323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51" name="Rectangle 305"/>
              <p:cNvSpPr>
                <a:spLocks noChangeArrowheads="1"/>
              </p:cNvSpPr>
              <p:nvPr/>
            </p:nvSpPr>
            <p:spPr bwMode="auto">
              <a:xfrm>
                <a:off x="2287" y="4714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52" name="Line 306"/>
              <p:cNvSpPr>
                <a:spLocks noChangeShapeType="1"/>
              </p:cNvSpPr>
              <p:nvPr/>
            </p:nvSpPr>
            <p:spPr bwMode="auto">
              <a:xfrm flipV="1">
                <a:off x="253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53" name="Rectangle 307"/>
              <p:cNvSpPr>
                <a:spLocks noChangeArrowheads="1"/>
              </p:cNvSpPr>
              <p:nvPr/>
            </p:nvSpPr>
            <p:spPr bwMode="auto">
              <a:xfrm>
                <a:off x="2519" y="4714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54" name="Line 308"/>
              <p:cNvSpPr>
                <a:spLocks noChangeShapeType="1"/>
              </p:cNvSpPr>
              <p:nvPr/>
            </p:nvSpPr>
            <p:spPr bwMode="auto">
              <a:xfrm>
                <a:off x="687" y="470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55" name="Rectangle 309"/>
              <p:cNvSpPr>
                <a:spLocks noChangeArrowheads="1"/>
              </p:cNvSpPr>
              <p:nvPr/>
            </p:nvSpPr>
            <p:spPr bwMode="auto">
              <a:xfrm>
                <a:off x="627" y="4670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56" name="Line 310"/>
              <p:cNvSpPr>
                <a:spLocks noChangeShapeType="1"/>
              </p:cNvSpPr>
              <p:nvPr/>
            </p:nvSpPr>
            <p:spPr bwMode="auto">
              <a:xfrm>
                <a:off x="687" y="455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57" name="Rectangle 311"/>
              <p:cNvSpPr>
                <a:spLocks noChangeArrowheads="1"/>
              </p:cNvSpPr>
              <p:nvPr/>
            </p:nvSpPr>
            <p:spPr bwMode="auto">
              <a:xfrm>
                <a:off x="583" y="4526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58" name="Line 312"/>
              <p:cNvSpPr>
                <a:spLocks noChangeShapeType="1"/>
              </p:cNvSpPr>
              <p:nvPr/>
            </p:nvSpPr>
            <p:spPr bwMode="auto">
              <a:xfrm>
                <a:off x="687" y="441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59" name="Rectangle 313"/>
              <p:cNvSpPr>
                <a:spLocks noChangeArrowheads="1"/>
              </p:cNvSpPr>
              <p:nvPr/>
            </p:nvSpPr>
            <p:spPr bwMode="auto">
              <a:xfrm>
                <a:off x="627" y="4386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60" name="Line 314"/>
              <p:cNvSpPr>
                <a:spLocks noChangeShapeType="1"/>
              </p:cNvSpPr>
              <p:nvPr/>
            </p:nvSpPr>
            <p:spPr bwMode="auto">
              <a:xfrm>
                <a:off x="687" y="427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61" name="Rectangle 315"/>
              <p:cNvSpPr>
                <a:spLocks noChangeArrowheads="1"/>
              </p:cNvSpPr>
              <p:nvPr/>
            </p:nvSpPr>
            <p:spPr bwMode="auto">
              <a:xfrm>
                <a:off x="583" y="4246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62" name="Line 316"/>
              <p:cNvSpPr>
                <a:spLocks noChangeShapeType="1"/>
              </p:cNvSpPr>
              <p:nvPr/>
            </p:nvSpPr>
            <p:spPr bwMode="auto">
              <a:xfrm>
                <a:off x="687" y="413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63" name="Rectangle 317"/>
              <p:cNvSpPr>
                <a:spLocks noChangeArrowheads="1"/>
              </p:cNvSpPr>
              <p:nvPr/>
            </p:nvSpPr>
            <p:spPr bwMode="auto">
              <a:xfrm>
                <a:off x="627" y="4102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64" name="Line 318"/>
              <p:cNvSpPr>
                <a:spLocks noChangeShapeType="1"/>
              </p:cNvSpPr>
              <p:nvPr/>
            </p:nvSpPr>
            <p:spPr bwMode="auto">
              <a:xfrm>
                <a:off x="687" y="399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65" name="Rectangle 319"/>
              <p:cNvSpPr>
                <a:spLocks noChangeArrowheads="1"/>
              </p:cNvSpPr>
              <p:nvPr/>
            </p:nvSpPr>
            <p:spPr bwMode="auto">
              <a:xfrm>
                <a:off x="583" y="3962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66" name="Line 320"/>
              <p:cNvSpPr>
                <a:spLocks noChangeShapeType="1"/>
              </p:cNvSpPr>
              <p:nvPr/>
            </p:nvSpPr>
            <p:spPr bwMode="auto">
              <a:xfrm>
                <a:off x="687" y="385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67" name="Rectangle 321"/>
              <p:cNvSpPr>
                <a:spLocks noChangeArrowheads="1"/>
              </p:cNvSpPr>
              <p:nvPr/>
            </p:nvSpPr>
            <p:spPr bwMode="auto">
              <a:xfrm>
                <a:off x="627" y="3822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68" name="Line 322"/>
              <p:cNvSpPr>
                <a:spLocks noChangeShapeType="1"/>
              </p:cNvSpPr>
              <p:nvPr/>
            </p:nvSpPr>
            <p:spPr bwMode="auto">
              <a:xfrm>
                <a:off x="687" y="371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69" name="Rectangle 323"/>
              <p:cNvSpPr>
                <a:spLocks noChangeArrowheads="1"/>
              </p:cNvSpPr>
              <p:nvPr/>
            </p:nvSpPr>
            <p:spPr bwMode="auto">
              <a:xfrm>
                <a:off x="583" y="3678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70" name="Line 324"/>
              <p:cNvSpPr>
                <a:spLocks noChangeShapeType="1"/>
              </p:cNvSpPr>
              <p:nvPr/>
            </p:nvSpPr>
            <p:spPr bwMode="auto">
              <a:xfrm>
                <a:off x="687" y="357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19071" name="Rectangle 325"/>
              <p:cNvSpPr>
                <a:spLocks noChangeArrowheads="1"/>
              </p:cNvSpPr>
              <p:nvPr/>
            </p:nvSpPr>
            <p:spPr bwMode="auto">
              <a:xfrm>
                <a:off x="627" y="3538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64" name="Line 326"/>
              <p:cNvSpPr>
                <a:spLocks noChangeShapeType="1"/>
              </p:cNvSpPr>
              <p:nvPr/>
            </p:nvSpPr>
            <p:spPr bwMode="auto">
              <a:xfrm>
                <a:off x="687" y="343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65" name="Rectangle 327"/>
              <p:cNvSpPr>
                <a:spLocks noChangeArrowheads="1"/>
              </p:cNvSpPr>
              <p:nvPr/>
            </p:nvSpPr>
            <p:spPr bwMode="auto">
              <a:xfrm>
                <a:off x="583" y="3398"/>
                <a:ext cx="86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66" name="Line 328"/>
              <p:cNvSpPr>
                <a:spLocks noChangeShapeType="1"/>
              </p:cNvSpPr>
              <p:nvPr/>
            </p:nvSpPr>
            <p:spPr bwMode="auto">
              <a:xfrm>
                <a:off x="687" y="329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67" name="Rectangle 329"/>
              <p:cNvSpPr>
                <a:spLocks noChangeArrowheads="1"/>
              </p:cNvSpPr>
              <p:nvPr/>
            </p:nvSpPr>
            <p:spPr bwMode="auto">
              <a:xfrm>
                <a:off x="627" y="3258"/>
                <a:ext cx="35" cy="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68" name="Freeform 330"/>
              <p:cNvSpPr>
                <a:spLocks/>
              </p:cNvSpPr>
              <p:nvPr/>
            </p:nvSpPr>
            <p:spPr bwMode="auto">
              <a:xfrm>
                <a:off x="731" y="3398"/>
                <a:ext cx="1660" cy="1300"/>
              </a:xfrm>
              <a:custGeom>
                <a:avLst/>
                <a:gdLst>
                  <a:gd name="T0" fmla="*/ 16 w 1660"/>
                  <a:gd name="T1" fmla="*/ 1300 h 1300"/>
                  <a:gd name="T2" fmla="*/ 48 w 1660"/>
                  <a:gd name="T3" fmla="*/ 1300 h 1300"/>
                  <a:gd name="T4" fmla="*/ 84 w 1660"/>
                  <a:gd name="T5" fmla="*/ 1300 h 1300"/>
                  <a:gd name="T6" fmla="*/ 116 w 1660"/>
                  <a:gd name="T7" fmla="*/ 1300 h 1300"/>
                  <a:gd name="T8" fmla="*/ 148 w 1660"/>
                  <a:gd name="T9" fmla="*/ 1300 h 1300"/>
                  <a:gd name="T10" fmla="*/ 184 w 1660"/>
                  <a:gd name="T11" fmla="*/ 1296 h 1300"/>
                  <a:gd name="T12" fmla="*/ 216 w 1660"/>
                  <a:gd name="T13" fmla="*/ 1296 h 1300"/>
                  <a:gd name="T14" fmla="*/ 252 w 1660"/>
                  <a:gd name="T15" fmla="*/ 1296 h 1300"/>
                  <a:gd name="T16" fmla="*/ 284 w 1660"/>
                  <a:gd name="T17" fmla="*/ 1288 h 1300"/>
                  <a:gd name="T18" fmla="*/ 316 w 1660"/>
                  <a:gd name="T19" fmla="*/ 1272 h 1300"/>
                  <a:gd name="T20" fmla="*/ 352 w 1660"/>
                  <a:gd name="T21" fmla="*/ 1168 h 1300"/>
                  <a:gd name="T22" fmla="*/ 384 w 1660"/>
                  <a:gd name="T23" fmla="*/ 920 h 1300"/>
                  <a:gd name="T24" fmla="*/ 420 w 1660"/>
                  <a:gd name="T25" fmla="*/ 860 h 1300"/>
                  <a:gd name="T26" fmla="*/ 452 w 1660"/>
                  <a:gd name="T27" fmla="*/ 1068 h 1300"/>
                  <a:gd name="T28" fmla="*/ 484 w 1660"/>
                  <a:gd name="T29" fmla="*/ 1176 h 1300"/>
                  <a:gd name="T30" fmla="*/ 520 w 1660"/>
                  <a:gd name="T31" fmla="*/ 1208 h 1300"/>
                  <a:gd name="T32" fmla="*/ 552 w 1660"/>
                  <a:gd name="T33" fmla="*/ 1228 h 1300"/>
                  <a:gd name="T34" fmla="*/ 588 w 1660"/>
                  <a:gd name="T35" fmla="*/ 1236 h 1300"/>
                  <a:gd name="T36" fmla="*/ 620 w 1660"/>
                  <a:gd name="T37" fmla="*/ 1252 h 1300"/>
                  <a:gd name="T38" fmla="*/ 652 w 1660"/>
                  <a:gd name="T39" fmla="*/ 1264 h 1300"/>
                  <a:gd name="T40" fmla="*/ 688 w 1660"/>
                  <a:gd name="T41" fmla="*/ 1264 h 1300"/>
                  <a:gd name="T42" fmla="*/ 720 w 1660"/>
                  <a:gd name="T43" fmla="*/ 1256 h 1300"/>
                  <a:gd name="T44" fmla="*/ 756 w 1660"/>
                  <a:gd name="T45" fmla="*/ 1260 h 1300"/>
                  <a:gd name="T46" fmla="*/ 788 w 1660"/>
                  <a:gd name="T47" fmla="*/ 1264 h 1300"/>
                  <a:gd name="T48" fmla="*/ 820 w 1660"/>
                  <a:gd name="T49" fmla="*/ 1276 h 1300"/>
                  <a:gd name="T50" fmla="*/ 856 w 1660"/>
                  <a:gd name="T51" fmla="*/ 1280 h 1300"/>
                  <a:gd name="T52" fmla="*/ 888 w 1660"/>
                  <a:gd name="T53" fmla="*/ 1264 h 1300"/>
                  <a:gd name="T54" fmla="*/ 924 w 1660"/>
                  <a:gd name="T55" fmla="*/ 1260 h 1300"/>
                  <a:gd name="T56" fmla="*/ 956 w 1660"/>
                  <a:gd name="T57" fmla="*/ 1264 h 1300"/>
                  <a:gd name="T58" fmla="*/ 988 w 1660"/>
                  <a:gd name="T59" fmla="*/ 1256 h 1300"/>
                  <a:gd name="T60" fmla="*/ 1024 w 1660"/>
                  <a:gd name="T61" fmla="*/ 1236 h 1300"/>
                  <a:gd name="T62" fmla="*/ 1056 w 1660"/>
                  <a:gd name="T63" fmla="*/ 1212 h 1300"/>
                  <a:gd name="T64" fmla="*/ 1092 w 1660"/>
                  <a:gd name="T65" fmla="*/ 1152 h 1300"/>
                  <a:gd name="T66" fmla="*/ 1124 w 1660"/>
                  <a:gd name="T67" fmla="*/ 988 h 1300"/>
                  <a:gd name="T68" fmla="*/ 1156 w 1660"/>
                  <a:gd name="T69" fmla="*/ 628 h 1300"/>
                  <a:gd name="T70" fmla="*/ 1192 w 1660"/>
                  <a:gd name="T71" fmla="*/ 180 h 1300"/>
                  <a:gd name="T72" fmla="*/ 1224 w 1660"/>
                  <a:gd name="T73" fmla="*/ 0 h 1300"/>
                  <a:gd name="T74" fmla="*/ 1260 w 1660"/>
                  <a:gd name="T75" fmla="*/ 320 h 1300"/>
                  <a:gd name="T76" fmla="*/ 1292 w 1660"/>
                  <a:gd name="T77" fmla="*/ 872 h 1300"/>
                  <a:gd name="T78" fmla="*/ 1324 w 1660"/>
                  <a:gd name="T79" fmla="*/ 1108 h 1300"/>
                  <a:gd name="T80" fmla="*/ 1360 w 1660"/>
                  <a:gd name="T81" fmla="*/ 1144 h 1300"/>
                  <a:gd name="T82" fmla="*/ 1392 w 1660"/>
                  <a:gd name="T83" fmla="*/ 1156 h 1300"/>
                  <a:gd name="T84" fmla="*/ 1428 w 1660"/>
                  <a:gd name="T85" fmla="*/ 1160 h 1300"/>
                  <a:gd name="T86" fmla="*/ 1460 w 1660"/>
                  <a:gd name="T87" fmla="*/ 1092 h 1300"/>
                  <a:gd name="T88" fmla="*/ 1492 w 1660"/>
                  <a:gd name="T89" fmla="*/ 996 h 1300"/>
                  <a:gd name="T90" fmla="*/ 1528 w 1660"/>
                  <a:gd name="T91" fmla="*/ 1116 h 1300"/>
                  <a:gd name="T92" fmla="*/ 1560 w 1660"/>
                  <a:gd name="T93" fmla="*/ 1252 h 1300"/>
                  <a:gd name="T94" fmla="*/ 1596 w 1660"/>
                  <a:gd name="T95" fmla="*/ 1292 h 1300"/>
                  <a:gd name="T96" fmla="*/ 1628 w 1660"/>
                  <a:gd name="T97" fmla="*/ 1300 h 1300"/>
                  <a:gd name="T98" fmla="*/ 1660 w 1660"/>
                  <a:gd name="T99" fmla="*/ 1300 h 1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660" h="1300">
                    <a:moveTo>
                      <a:pt x="0" y="1300"/>
                    </a:moveTo>
                    <a:lnTo>
                      <a:pt x="16" y="1300"/>
                    </a:lnTo>
                    <a:lnTo>
                      <a:pt x="32" y="1300"/>
                    </a:lnTo>
                    <a:lnTo>
                      <a:pt x="48" y="1300"/>
                    </a:lnTo>
                    <a:lnTo>
                      <a:pt x="64" y="1300"/>
                    </a:lnTo>
                    <a:lnTo>
                      <a:pt x="84" y="1300"/>
                    </a:lnTo>
                    <a:lnTo>
                      <a:pt x="100" y="1300"/>
                    </a:lnTo>
                    <a:lnTo>
                      <a:pt x="116" y="1300"/>
                    </a:lnTo>
                    <a:lnTo>
                      <a:pt x="132" y="1300"/>
                    </a:lnTo>
                    <a:lnTo>
                      <a:pt x="148" y="1300"/>
                    </a:lnTo>
                    <a:lnTo>
                      <a:pt x="168" y="1300"/>
                    </a:lnTo>
                    <a:lnTo>
                      <a:pt x="184" y="1296"/>
                    </a:lnTo>
                    <a:lnTo>
                      <a:pt x="200" y="1296"/>
                    </a:lnTo>
                    <a:lnTo>
                      <a:pt x="216" y="1296"/>
                    </a:lnTo>
                    <a:lnTo>
                      <a:pt x="232" y="1300"/>
                    </a:lnTo>
                    <a:lnTo>
                      <a:pt x="252" y="1296"/>
                    </a:lnTo>
                    <a:lnTo>
                      <a:pt x="268" y="1292"/>
                    </a:lnTo>
                    <a:lnTo>
                      <a:pt x="284" y="1288"/>
                    </a:lnTo>
                    <a:lnTo>
                      <a:pt x="300" y="1284"/>
                    </a:lnTo>
                    <a:lnTo>
                      <a:pt x="316" y="1272"/>
                    </a:lnTo>
                    <a:lnTo>
                      <a:pt x="336" y="1240"/>
                    </a:lnTo>
                    <a:lnTo>
                      <a:pt x="352" y="1168"/>
                    </a:lnTo>
                    <a:lnTo>
                      <a:pt x="368" y="1052"/>
                    </a:lnTo>
                    <a:lnTo>
                      <a:pt x="384" y="920"/>
                    </a:lnTo>
                    <a:lnTo>
                      <a:pt x="400" y="836"/>
                    </a:lnTo>
                    <a:lnTo>
                      <a:pt x="420" y="860"/>
                    </a:lnTo>
                    <a:lnTo>
                      <a:pt x="436" y="964"/>
                    </a:lnTo>
                    <a:lnTo>
                      <a:pt x="452" y="1068"/>
                    </a:lnTo>
                    <a:lnTo>
                      <a:pt x="468" y="1140"/>
                    </a:lnTo>
                    <a:lnTo>
                      <a:pt x="484" y="1176"/>
                    </a:lnTo>
                    <a:lnTo>
                      <a:pt x="504" y="1196"/>
                    </a:lnTo>
                    <a:lnTo>
                      <a:pt x="520" y="1208"/>
                    </a:lnTo>
                    <a:lnTo>
                      <a:pt x="536" y="1220"/>
                    </a:lnTo>
                    <a:lnTo>
                      <a:pt x="552" y="1228"/>
                    </a:lnTo>
                    <a:lnTo>
                      <a:pt x="568" y="1232"/>
                    </a:lnTo>
                    <a:lnTo>
                      <a:pt x="588" y="1236"/>
                    </a:lnTo>
                    <a:lnTo>
                      <a:pt x="604" y="1244"/>
                    </a:lnTo>
                    <a:lnTo>
                      <a:pt x="620" y="1252"/>
                    </a:lnTo>
                    <a:lnTo>
                      <a:pt x="636" y="1256"/>
                    </a:lnTo>
                    <a:lnTo>
                      <a:pt x="652" y="1264"/>
                    </a:lnTo>
                    <a:lnTo>
                      <a:pt x="672" y="1268"/>
                    </a:lnTo>
                    <a:lnTo>
                      <a:pt x="688" y="1264"/>
                    </a:lnTo>
                    <a:lnTo>
                      <a:pt x="704" y="1260"/>
                    </a:lnTo>
                    <a:lnTo>
                      <a:pt x="720" y="1256"/>
                    </a:lnTo>
                    <a:lnTo>
                      <a:pt x="736" y="1260"/>
                    </a:lnTo>
                    <a:lnTo>
                      <a:pt x="756" y="1260"/>
                    </a:lnTo>
                    <a:lnTo>
                      <a:pt x="772" y="1260"/>
                    </a:lnTo>
                    <a:lnTo>
                      <a:pt x="788" y="1264"/>
                    </a:lnTo>
                    <a:lnTo>
                      <a:pt x="804" y="1268"/>
                    </a:lnTo>
                    <a:lnTo>
                      <a:pt x="820" y="1276"/>
                    </a:lnTo>
                    <a:lnTo>
                      <a:pt x="840" y="1280"/>
                    </a:lnTo>
                    <a:lnTo>
                      <a:pt x="856" y="1280"/>
                    </a:lnTo>
                    <a:lnTo>
                      <a:pt x="872" y="1272"/>
                    </a:lnTo>
                    <a:lnTo>
                      <a:pt x="888" y="1264"/>
                    </a:lnTo>
                    <a:lnTo>
                      <a:pt x="904" y="1260"/>
                    </a:lnTo>
                    <a:lnTo>
                      <a:pt x="924" y="1260"/>
                    </a:lnTo>
                    <a:lnTo>
                      <a:pt x="940" y="1264"/>
                    </a:lnTo>
                    <a:lnTo>
                      <a:pt x="956" y="1264"/>
                    </a:lnTo>
                    <a:lnTo>
                      <a:pt x="972" y="1260"/>
                    </a:lnTo>
                    <a:lnTo>
                      <a:pt x="988" y="1256"/>
                    </a:lnTo>
                    <a:lnTo>
                      <a:pt x="1008" y="1248"/>
                    </a:lnTo>
                    <a:lnTo>
                      <a:pt x="1024" y="1236"/>
                    </a:lnTo>
                    <a:lnTo>
                      <a:pt x="1040" y="1228"/>
                    </a:lnTo>
                    <a:lnTo>
                      <a:pt x="1056" y="1212"/>
                    </a:lnTo>
                    <a:lnTo>
                      <a:pt x="1072" y="1188"/>
                    </a:lnTo>
                    <a:lnTo>
                      <a:pt x="1092" y="1152"/>
                    </a:lnTo>
                    <a:lnTo>
                      <a:pt x="1108" y="1088"/>
                    </a:lnTo>
                    <a:lnTo>
                      <a:pt x="1124" y="988"/>
                    </a:lnTo>
                    <a:lnTo>
                      <a:pt x="1140" y="836"/>
                    </a:lnTo>
                    <a:lnTo>
                      <a:pt x="1156" y="628"/>
                    </a:lnTo>
                    <a:lnTo>
                      <a:pt x="1176" y="396"/>
                    </a:lnTo>
                    <a:lnTo>
                      <a:pt x="1192" y="180"/>
                    </a:lnTo>
                    <a:lnTo>
                      <a:pt x="1208" y="36"/>
                    </a:lnTo>
                    <a:lnTo>
                      <a:pt x="1224" y="0"/>
                    </a:lnTo>
                    <a:lnTo>
                      <a:pt x="1240" y="96"/>
                    </a:lnTo>
                    <a:lnTo>
                      <a:pt x="1260" y="320"/>
                    </a:lnTo>
                    <a:lnTo>
                      <a:pt x="1276" y="616"/>
                    </a:lnTo>
                    <a:lnTo>
                      <a:pt x="1292" y="872"/>
                    </a:lnTo>
                    <a:lnTo>
                      <a:pt x="1308" y="1032"/>
                    </a:lnTo>
                    <a:lnTo>
                      <a:pt x="1324" y="1108"/>
                    </a:lnTo>
                    <a:lnTo>
                      <a:pt x="1344" y="1136"/>
                    </a:lnTo>
                    <a:lnTo>
                      <a:pt x="1360" y="1144"/>
                    </a:lnTo>
                    <a:lnTo>
                      <a:pt x="1376" y="1152"/>
                    </a:lnTo>
                    <a:lnTo>
                      <a:pt x="1392" y="1156"/>
                    </a:lnTo>
                    <a:lnTo>
                      <a:pt x="1408" y="1160"/>
                    </a:lnTo>
                    <a:lnTo>
                      <a:pt x="1428" y="1160"/>
                    </a:lnTo>
                    <a:lnTo>
                      <a:pt x="1444" y="1140"/>
                    </a:lnTo>
                    <a:lnTo>
                      <a:pt x="1460" y="1092"/>
                    </a:lnTo>
                    <a:lnTo>
                      <a:pt x="1476" y="1028"/>
                    </a:lnTo>
                    <a:lnTo>
                      <a:pt x="1492" y="996"/>
                    </a:lnTo>
                    <a:lnTo>
                      <a:pt x="1512" y="1032"/>
                    </a:lnTo>
                    <a:lnTo>
                      <a:pt x="1528" y="1116"/>
                    </a:lnTo>
                    <a:lnTo>
                      <a:pt x="1544" y="1200"/>
                    </a:lnTo>
                    <a:lnTo>
                      <a:pt x="1560" y="1252"/>
                    </a:lnTo>
                    <a:lnTo>
                      <a:pt x="1576" y="1276"/>
                    </a:lnTo>
                    <a:lnTo>
                      <a:pt x="1596" y="1292"/>
                    </a:lnTo>
                    <a:lnTo>
                      <a:pt x="1612" y="1296"/>
                    </a:lnTo>
                    <a:lnTo>
                      <a:pt x="1628" y="1300"/>
                    </a:lnTo>
                    <a:lnTo>
                      <a:pt x="1644" y="1300"/>
                    </a:lnTo>
                    <a:lnTo>
                      <a:pt x="1660" y="130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grpSp>
          <p:nvGrpSpPr>
            <p:cNvPr id="20871" name="Group 336"/>
            <p:cNvGrpSpPr>
              <a:grpSpLocks noChangeAspect="1"/>
            </p:cNvGrpSpPr>
            <p:nvPr/>
          </p:nvGrpSpPr>
          <p:grpSpPr bwMode="auto">
            <a:xfrm>
              <a:off x="3936875" y="7049887"/>
              <a:ext cx="2687757" cy="1834000"/>
              <a:chOff x="587" y="3118"/>
              <a:chExt cx="2049" cy="1687"/>
            </a:xfrm>
          </p:grpSpPr>
          <p:sp>
            <p:nvSpPr>
              <p:cNvPr id="20874" name="Rectangle 338"/>
              <p:cNvSpPr>
                <a:spLocks noChangeArrowheads="1"/>
              </p:cNvSpPr>
              <p:nvPr/>
            </p:nvSpPr>
            <p:spPr bwMode="auto">
              <a:xfrm>
                <a:off x="687" y="3286"/>
                <a:ext cx="1844" cy="1416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75" name="Line 339"/>
              <p:cNvSpPr>
                <a:spLocks noChangeShapeType="1"/>
              </p:cNvSpPr>
              <p:nvPr/>
            </p:nvSpPr>
            <p:spPr bwMode="auto">
              <a:xfrm>
                <a:off x="687" y="4702"/>
                <a:ext cx="194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76" name="Line 340"/>
              <p:cNvSpPr>
                <a:spLocks noChangeShapeType="1"/>
              </p:cNvSpPr>
              <p:nvPr/>
            </p:nvSpPr>
            <p:spPr bwMode="auto">
              <a:xfrm flipV="1">
                <a:off x="687" y="3118"/>
                <a:ext cx="0" cy="159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 type="none" w="med" len="med"/>
                <a:tailEnd type="arrow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77" name="Line 341"/>
              <p:cNvSpPr>
                <a:spLocks noChangeShapeType="1"/>
              </p:cNvSpPr>
              <p:nvPr/>
            </p:nvSpPr>
            <p:spPr bwMode="auto">
              <a:xfrm flipV="1">
                <a:off x="687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78" name="Rectangle 342"/>
              <p:cNvSpPr>
                <a:spLocks noChangeArrowheads="1"/>
              </p:cNvSpPr>
              <p:nvPr/>
            </p:nvSpPr>
            <p:spPr bwMode="auto">
              <a:xfrm>
                <a:off x="635" y="4714"/>
                <a:ext cx="10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79" name="Line 343"/>
              <p:cNvSpPr>
                <a:spLocks noChangeShapeType="1"/>
              </p:cNvSpPr>
              <p:nvPr/>
            </p:nvSpPr>
            <p:spPr bwMode="auto">
              <a:xfrm flipV="1">
                <a:off x="89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80" name="Rectangle 344"/>
              <p:cNvSpPr>
                <a:spLocks noChangeArrowheads="1"/>
              </p:cNvSpPr>
              <p:nvPr/>
            </p:nvSpPr>
            <p:spPr bwMode="auto">
              <a:xfrm>
                <a:off x="839" y="4714"/>
                <a:ext cx="10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81" name="Line 345"/>
              <p:cNvSpPr>
                <a:spLocks noChangeShapeType="1"/>
              </p:cNvSpPr>
              <p:nvPr/>
            </p:nvSpPr>
            <p:spPr bwMode="auto">
              <a:xfrm flipV="1">
                <a:off x="1095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82" name="Rectangle 346"/>
              <p:cNvSpPr>
                <a:spLocks noChangeArrowheads="1"/>
              </p:cNvSpPr>
              <p:nvPr/>
            </p:nvSpPr>
            <p:spPr bwMode="auto">
              <a:xfrm>
                <a:off x="1043" y="4714"/>
                <a:ext cx="10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83" name="Line 347"/>
              <p:cNvSpPr>
                <a:spLocks noChangeShapeType="1"/>
              </p:cNvSpPr>
              <p:nvPr/>
            </p:nvSpPr>
            <p:spPr bwMode="auto">
              <a:xfrm flipV="1">
                <a:off x="1299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84" name="Rectangle 348"/>
              <p:cNvSpPr>
                <a:spLocks noChangeArrowheads="1"/>
              </p:cNvSpPr>
              <p:nvPr/>
            </p:nvSpPr>
            <p:spPr bwMode="auto">
              <a:xfrm>
                <a:off x="1247" y="4714"/>
                <a:ext cx="105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85" name="Line 349"/>
              <p:cNvSpPr>
                <a:spLocks noChangeShapeType="1"/>
              </p:cNvSpPr>
              <p:nvPr/>
            </p:nvSpPr>
            <p:spPr bwMode="auto">
              <a:xfrm flipV="1">
                <a:off x="1503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86" name="Rectangle 350"/>
              <p:cNvSpPr>
                <a:spLocks noChangeArrowheads="1"/>
              </p:cNvSpPr>
              <p:nvPr/>
            </p:nvSpPr>
            <p:spPr bwMode="auto">
              <a:xfrm>
                <a:off x="1491" y="4714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87" name="Line 351"/>
              <p:cNvSpPr>
                <a:spLocks noChangeShapeType="1"/>
              </p:cNvSpPr>
              <p:nvPr/>
            </p:nvSpPr>
            <p:spPr bwMode="auto">
              <a:xfrm flipV="1">
                <a:off x="171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88" name="Rectangle 352"/>
              <p:cNvSpPr>
                <a:spLocks noChangeArrowheads="1"/>
              </p:cNvSpPr>
              <p:nvPr/>
            </p:nvSpPr>
            <p:spPr bwMode="auto">
              <a:xfrm>
                <a:off x="1675" y="4714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89" name="Line 353"/>
              <p:cNvSpPr>
                <a:spLocks noChangeShapeType="1"/>
              </p:cNvSpPr>
              <p:nvPr/>
            </p:nvSpPr>
            <p:spPr bwMode="auto">
              <a:xfrm flipV="1">
                <a:off x="1915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90" name="Rectangle 354"/>
              <p:cNvSpPr>
                <a:spLocks noChangeArrowheads="1"/>
              </p:cNvSpPr>
              <p:nvPr/>
            </p:nvSpPr>
            <p:spPr bwMode="auto">
              <a:xfrm>
                <a:off x="1879" y="4714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4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91" name="Line 355"/>
              <p:cNvSpPr>
                <a:spLocks noChangeShapeType="1"/>
              </p:cNvSpPr>
              <p:nvPr/>
            </p:nvSpPr>
            <p:spPr bwMode="auto">
              <a:xfrm flipV="1">
                <a:off x="2119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92" name="Rectangle 356"/>
              <p:cNvSpPr>
                <a:spLocks noChangeArrowheads="1"/>
              </p:cNvSpPr>
              <p:nvPr/>
            </p:nvSpPr>
            <p:spPr bwMode="auto">
              <a:xfrm>
                <a:off x="2083" y="4714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6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93" name="Line 357"/>
              <p:cNvSpPr>
                <a:spLocks noChangeShapeType="1"/>
              </p:cNvSpPr>
              <p:nvPr/>
            </p:nvSpPr>
            <p:spPr bwMode="auto">
              <a:xfrm flipV="1">
                <a:off x="2323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94" name="Rectangle 358"/>
              <p:cNvSpPr>
                <a:spLocks noChangeArrowheads="1"/>
              </p:cNvSpPr>
              <p:nvPr/>
            </p:nvSpPr>
            <p:spPr bwMode="auto">
              <a:xfrm>
                <a:off x="2287" y="4714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8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95" name="Line 359"/>
              <p:cNvSpPr>
                <a:spLocks noChangeShapeType="1"/>
              </p:cNvSpPr>
              <p:nvPr/>
            </p:nvSpPr>
            <p:spPr bwMode="auto">
              <a:xfrm flipV="1">
                <a:off x="2531" y="4682"/>
                <a:ext cx="0" cy="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96" name="Rectangle 360"/>
              <p:cNvSpPr>
                <a:spLocks noChangeArrowheads="1"/>
              </p:cNvSpPr>
              <p:nvPr/>
            </p:nvSpPr>
            <p:spPr bwMode="auto">
              <a:xfrm>
                <a:off x="2519" y="4714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97" name="Line 361"/>
              <p:cNvSpPr>
                <a:spLocks noChangeShapeType="1"/>
              </p:cNvSpPr>
              <p:nvPr/>
            </p:nvSpPr>
            <p:spPr bwMode="auto">
              <a:xfrm>
                <a:off x="687" y="4702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898" name="Rectangle 362"/>
              <p:cNvSpPr>
                <a:spLocks noChangeArrowheads="1"/>
              </p:cNvSpPr>
              <p:nvPr/>
            </p:nvSpPr>
            <p:spPr bwMode="auto">
              <a:xfrm>
                <a:off x="631" y="4670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899" name="Line 363"/>
              <p:cNvSpPr>
                <a:spLocks noChangeShapeType="1"/>
              </p:cNvSpPr>
              <p:nvPr/>
            </p:nvSpPr>
            <p:spPr bwMode="auto">
              <a:xfrm>
                <a:off x="687" y="455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01" name="Rectangle 364"/>
              <p:cNvSpPr>
                <a:spLocks noChangeArrowheads="1"/>
              </p:cNvSpPr>
              <p:nvPr/>
            </p:nvSpPr>
            <p:spPr bwMode="auto">
              <a:xfrm>
                <a:off x="587" y="4526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02" name="Line 365"/>
              <p:cNvSpPr>
                <a:spLocks noChangeShapeType="1"/>
              </p:cNvSpPr>
              <p:nvPr/>
            </p:nvSpPr>
            <p:spPr bwMode="auto">
              <a:xfrm>
                <a:off x="687" y="441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03" name="Rectangle 366"/>
              <p:cNvSpPr>
                <a:spLocks noChangeArrowheads="1"/>
              </p:cNvSpPr>
              <p:nvPr/>
            </p:nvSpPr>
            <p:spPr bwMode="auto">
              <a:xfrm>
                <a:off x="631" y="4386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04" name="Line 367"/>
              <p:cNvSpPr>
                <a:spLocks noChangeShapeType="1"/>
              </p:cNvSpPr>
              <p:nvPr/>
            </p:nvSpPr>
            <p:spPr bwMode="auto">
              <a:xfrm>
                <a:off x="687" y="4278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05" name="Rectangle 368"/>
              <p:cNvSpPr>
                <a:spLocks noChangeArrowheads="1"/>
              </p:cNvSpPr>
              <p:nvPr/>
            </p:nvSpPr>
            <p:spPr bwMode="auto">
              <a:xfrm>
                <a:off x="587" y="4246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06" name="Line 369"/>
              <p:cNvSpPr>
                <a:spLocks noChangeShapeType="1"/>
              </p:cNvSpPr>
              <p:nvPr/>
            </p:nvSpPr>
            <p:spPr bwMode="auto">
              <a:xfrm>
                <a:off x="687" y="413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07" name="Rectangle 370"/>
              <p:cNvSpPr>
                <a:spLocks noChangeArrowheads="1"/>
              </p:cNvSpPr>
              <p:nvPr/>
            </p:nvSpPr>
            <p:spPr bwMode="auto">
              <a:xfrm>
                <a:off x="631" y="4102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08" name="Line 371"/>
              <p:cNvSpPr>
                <a:spLocks noChangeShapeType="1"/>
              </p:cNvSpPr>
              <p:nvPr/>
            </p:nvSpPr>
            <p:spPr bwMode="auto">
              <a:xfrm>
                <a:off x="687" y="399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09" name="Rectangle 372"/>
              <p:cNvSpPr>
                <a:spLocks noChangeArrowheads="1"/>
              </p:cNvSpPr>
              <p:nvPr/>
            </p:nvSpPr>
            <p:spPr bwMode="auto">
              <a:xfrm>
                <a:off x="587" y="3962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10" name="Line 373"/>
              <p:cNvSpPr>
                <a:spLocks noChangeShapeType="1"/>
              </p:cNvSpPr>
              <p:nvPr/>
            </p:nvSpPr>
            <p:spPr bwMode="auto">
              <a:xfrm>
                <a:off x="687" y="3854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11" name="Rectangle 374"/>
              <p:cNvSpPr>
                <a:spLocks noChangeArrowheads="1"/>
              </p:cNvSpPr>
              <p:nvPr/>
            </p:nvSpPr>
            <p:spPr bwMode="auto">
              <a:xfrm>
                <a:off x="631" y="3822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12" name="Line 375"/>
              <p:cNvSpPr>
                <a:spLocks noChangeShapeType="1"/>
              </p:cNvSpPr>
              <p:nvPr/>
            </p:nvSpPr>
            <p:spPr bwMode="auto">
              <a:xfrm>
                <a:off x="687" y="371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13" name="Rectangle 376"/>
              <p:cNvSpPr>
                <a:spLocks noChangeArrowheads="1"/>
              </p:cNvSpPr>
              <p:nvPr/>
            </p:nvSpPr>
            <p:spPr bwMode="auto">
              <a:xfrm>
                <a:off x="587" y="3678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.5</a:t>
                </a:r>
                <a:endParaRPr kumimoji="0" lang="it-IT" altLang="it-IT" sz="1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14" name="Line 377"/>
              <p:cNvSpPr>
                <a:spLocks noChangeShapeType="1"/>
              </p:cNvSpPr>
              <p:nvPr/>
            </p:nvSpPr>
            <p:spPr bwMode="auto">
              <a:xfrm>
                <a:off x="687" y="357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15" name="Rectangle 378"/>
              <p:cNvSpPr>
                <a:spLocks noChangeArrowheads="1"/>
              </p:cNvSpPr>
              <p:nvPr/>
            </p:nvSpPr>
            <p:spPr bwMode="auto">
              <a:xfrm>
                <a:off x="631" y="3538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16" name="Line 379"/>
              <p:cNvSpPr>
                <a:spLocks noChangeShapeType="1"/>
              </p:cNvSpPr>
              <p:nvPr/>
            </p:nvSpPr>
            <p:spPr bwMode="auto">
              <a:xfrm>
                <a:off x="687" y="343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17" name="Rectangle 380"/>
              <p:cNvSpPr>
                <a:spLocks noChangeArrowheads="1"/>
              </p:cNvSpPr>
              <p:nvPr/>
            </p:nvSpPr>
            <p:spPr bwMode="auto">
              <a:xfrm>
                <a:off x="587" y="3398"/>
                <a:ext cx="8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4.5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18" name="Line 381"/>
              <p:cNvSpPr>
                <a:spLocks noChangeShapeType="1"/>
              </p:cNvSpPr>
              <p:nvPr/>
            </p:nvSpPr>
            <p:spPr bwMode="auto">
              <a:xfrm>
                <a:off x="687" y="3290"/>
                <a:ext cx="1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0919" name="Rectangle 382"/>
              <p:cNvSpPr>
                <a:spLocks noChangeArrowheads="1"/>
              </p:cNvSpPr>
              <p:nvPr/>
            </p:nvSpPr>
            <p:spPr bwMode="auto">
              <a:xfrm>
                <a:off x="631" y="3258"/>
                <a:ext cx="34" cy="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5</a:t>
                </a:r>
                <a:endParaRPr kumimoji="0" lang="it-IT" altLang="it-IT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0920" name="Freeform 383"/>
              <p:cNvSpPr>
                <a:spLocks/>
              </p:cNvSpPr>
              <p:nvPr/>
            </p:nvSpPr>
            <p:spPr bwMode="auto">
              <a:xfrm>
                <a:off x="815" y="3414"/>
                <a:ext cx="1576" cy="1284"/>
              </a:xfrm>
              <a:custGeom>
                <a:avLst/>
                <a:gdLst>
                  <a:gd name="T0" fmla="*/ 16 w 1576"/>
                  <a:gd name="T1" fmla="*/ 1284 h 1284"/>
                  <a:gd name="T2" fmla="*/ 48 w 1576"/>
                  <a:gd name="T3" fmla="*/ 1284 h 1284"/>
                  <a:gd name="T4" fmla="*/ 80 w 1576"/>
                  <a:gd name="T5" fmla="*/ 1284 h 1284"/>
                  <a:gd name="T6" fmla="*/ 112 w 1576"/>
                  <a:gd name="T7" fmla="*/ 1284 h 1284"/>
                  <a:gd name="T8" fmla="*/ 144 w 1576"/>
                  <a:gd name="T9" fmla="*/ 1284 h 1284"/>
                  <a:gd name="T10" fmla="*/ 176 w 1576"/>
                  <a:gd name="T11" fmla="*/ 1284 h 1284"/>
                  <a:gd name="T12" fmla="*/ 208 w 1576"/>
                  <a:gd name="T13" fmla="*/ 1284 h 1284"/>
                  <a:gd name="T14" fmla="*/ 240 w 1576"/>
                  <a:gd name="T15" fmla="*/ 1284 h 1284"/>
                  <a:gd name="T16" fmla="*/ 272 w 1576"/>
                  <a:gd name="T17" fmla="*/ 1248 h 1284"/>
                  <a:gd name="T18" fmla="*/ 304 w 1576"/>
                  <a:gd name="T19" fmla="*/ 1060 h 1284"/>
                  <a:gd name="T20" fmla="*/ 336 w 1576"/>
                  <a:gd name="T21" fmla="*/ 792 h 1284"/>
                  <a:gd name="T22" fmla="*/ 368 w 1576"/>
                  <a:gd name="T23" fmla="*/ 872 h 1284"/>
                  <a:gd name="T24" fmla="*/ 400 w 1576"/>
                  <a:gd name="T25" fmla="*/ 1080 h 1284"/>
                  <a:gd name="T26" fmla="*/ 432 w 1576"/>
                  <a:gd name="T27" fmla="*/ 1156 h 1284"/>
                  <a:gd name="T28" fmla="*/ 464 w 1576"/>
                  <a:gd name="T29" fmla="*/ 1184 h 1284"/>
                  <a:gd name="T30" fmla="*/ 492 w 1576"/>
                  <a:gd name="T31" fmla="*/ 1212 h 1284"/>
                  <a:gd name="T32" fmla="*/ 524 w 1576"/>
                  <a:gd name="T33" fmla="*/ 1236 h 1284"/>
                  <a:gd name="T34" fmla="*/ 556 w 1576"/>
                  <a:gd name="T35" fmla="*/ 1240 h 1284"/>
                  <a:gd name="T36" fmla="*/ 588 w 1576"/>
                  <a:gd name="T37" fmla="*/ 1240 h 1284"/>
                  <a:gd name="T38" fmla="*/ 620 w 1576"/>
                  <a:gd name="T39" fmla="*/ 1236 h 1284"/>
                  <a:gd name="T40" fmla="*/ 652 w 1576"/>
                  <a:gd name="T41" fmla="*/ 1228 h 1284"/>
                  <a:gd name="T42" fmla="*/ 684 w 1576"/>
                  <a:gd name="T43" fmla="*/ 1232 h 1284"/>
                  <a:gd name="T44" fmla="*/ 716 w 1576"/>
                  <a:gd name="T45" fmla="*/ 1240 h 1284"/>
                  <a:gd name="T46" fmla="*/ 748 w 1576"/>
                  <a:gd name="T47" fmla="*/ 1236 h 1284"/>
                  <a:gd name="T48" fmla="*/ 780 w 1576"/>
                  <a:gd name="T49" fmla="*/ 1224 h 1284"/>
                  <a:gd name="T50" fmla="*/ 812 w 1576"/>
                  <a:gd name="T51" fmla="*/ 1216 h 1284"/>
                  <a:gd name="T52" fmla="*/ 844 w 1576"/>
                  <a:gd name="T53" fmla="*/ 1192 h 1284"/>
                  <a:gd name="T54" fmla="*/ 876 w 1576"/>
                  <a:gd name="T55" fmla="*/ 1148 h 1284"/>
                  <a:gd name="T56" fmla="*/ 908 w 1576"/>
                  <a:gd name="T57" fmla="*/ 1092 h 1284"/>
                  <a:gd name="T58" fmla="*/ 940 w 1576"/>
                  <a:gd name="T59" fmla="*/ 988 h 1284"/>
                  <a:gd name="T60" fmla="*/ 972 w 1576"/>
                  <a:gd name="T61" fmla="*/ 844 h 1284"/>
                  <a:gd name="T62" fmla="*/ 1004 w 1576"/>
                  <a:gd name="T63" fmla="*/ 688 h 1284"/>
                  <a:gd name="T64" fmla="*/ 1036 w 1576"/>
                  <a:gd name="T65" fmla="*/ 444 h 1284"/>
                  <a:gd name="T66" fmla="*/ 1068 w 1576"/>
                  <a:gd name="T67" fmla="*/ 104 h 1284"/>
                  <a:gd name="T68" fmla="*/ 1096 w 1576"/>
                  <a:gd name="T69" fmla="*/ 48 h 1284"/>
                  <a:gd name="T70" fmla="*/ 1128 w 1576"/>
                  <a:gd name="T71" fmla="*/ 596 h 1284"/>
                  <a:gd name="T72" fmla="*/ 1160 w 1576"/>
                  <a:gd name="T73" fmla="*/ 1060 h 1284"/>
                  <a:gd name="T74" fmla="*/ 1192 w 1576"/>
                  <a:gd name="T75" fmla="*/ 1168 h 1284"/>
                  <a:gd name="T76" fmla="*/ 1224 w 1576"/>
                  <a:gd name="T77" fmla="*/ 1184 h 1284"/>
                  <a:gd name="T78" fmla="*/ 1256 w 1576"/>
                  <a:gd name="T79" fmla="*/ 1200 h 1284"/>
                  <a:gd name="T80" fmla="*/ 1288 w 1576"/>
                  <a:gd name="T81" fmla="*/ 1220 h 1284"/>
                  <a:gd name="T82" fmla="*/ 1320 w 1576"/>
                  <a:gd name="T83" fmla="*/ 1216 h 1284"/>
                  <a:gd name="T84" fmla="*/ 1352 w 1576"/>
                  <a:gd name="T85" fmla="*/ 1168 h 1284"/>
                  <a:gd name="T86" fmla="*/ 1384 w 1576"/>
                  <a:gd name="T87" fmla="*/ 1116 h 1284"/>
                  <a:gd name="T88" fmla="*/ 1416 w 1576"/>
                  <a:gd name="T89" fmla="*/ 1164 h 1284"/>
                  <a:gd name="T90" fmla="*/ 1448 w 1576"/>
                  <a:gd name="T91" fmla="*/ 1240 h 1284"/>
                  <a:gd name="T92" fmla="*/ 1480 w 1576"/>
                  <a:gd name="T93" fmla="*/ 1268 h 1284"/>
                  <a:gd name="T94" fmla="*/ 1512 w 1576"/>
                  <a:gd name="T95" fmla="*/ 1280 h 1284"/>
                  <a:gd name="T96" fmla="*/ 1544 w 1576"/>
                  <a:gd name="T97" fmla="*/ 1284 h 1284"/>
                  <a:gd name="T98" fmla="*/ 1576 w 1576"/>
                  <a:gd name="T99" fmla="*/ 1284 h 12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576" h="1284">
                    <a:moveTo>
                      <a:pt x="0" y="1284"/>
                    </a:moveTo>
                    <a:lnTo>
                      <a:pt x="16" y="1284"/>
                    </a:lnTo>
                    <a:lnTo>
                      <a:pt x="32" y="1284"/>
                    </a:lnTo>
                    <a:lnTo>
                      <a:pt x="48" y="1284"/>
                    </a:lnTo>
                    <a:lnTo>
                      <a:pt x="64" y="1284"/>
                    </a:lnTo>
                    <a:lnTo>
                      <a:pt x="80" y="1284"/>
                    </a:lnTo>
                    <a:lnTo>
                      <a:pt x="96" y="1284"/>
                    </a:lnTo>
                    <a:lnTo>
                      <a:pt x="112" y="1284"/>
                    </a:lnTo>
                    <a:lnTo>
                      <a:pt x="128" y="1284"/>
                    </a:lnTo>
                    <a:lnTo>
                      <a:pt x="144" y="1284"/>
                    </a:lnTo>
                    <a:lnTo>
                      <a:pt x="160" y="1284"/>
                    </a:lnTo>
                    <a:lnTo>
                      <a:pt x="176" y="1284"/>
                    </a:lnTo>
                    <a:lnTo>
                      <a:pt x="192" y="1284"/>
                    </a:lnTo>
                    <a:lnTo>
                      <a:pt x="208" y="1284"/>
                    </a:lnTo>
                    <a:lnTo>
                      <a:pt x="224" y="1284"/>
                    </a:lnTo>
                    <a:lnTo>
                      <a:pt x="240" y="1284"/>
                    </a:lnTo>
                    <a:lnTo>
                      <a:pt x="256" y="1276"/>
                    </a:lnTo>
                    <a:lnTo>
                      <a:pt x="272" y="1248"/>
                    </a:lnTo>
                    <a:lnTo>
                      <a:pt x="288" y="1184"/>
                    </a:lnTo>
                    <a:lnTo>
                      <a:pt x="304" y="1060"/>
                    </a:lnTo>
                    <a:lnTo>
                      <a:pt x="320" y="908"/>
                    </a:lnTo>
                    <a:lnTo>
                      <a:pt x="336" y="792"/>
                    </a:lnTo>
                    <a:lnTo>
                      <a:pt x="352" y="784"/>
                    </a:lnTo>
                    <a:lnTo>
                      <a:pt x="368" y="872"/>
                    </a:lnTo>
                    <a:lnTo>
                      <a:pt x="384" y="988"/>
                    </a:lnTo>
                    <a:lnTo>
                      <a:pt x="400" y="1080"/>
                    </a:lnTo>
                    <a:lnTo>
                      <a:pt x="416" y="1132"/>
                    </a:lnTo>
                    <a:lnTo>
                      <a:pt x="432" y="1156"/>
                    </a:lnTo>
                    <a:lnTo>
                      <a:pt x="448" y="1172"/>
                    </a:lnTo>
                    <a:lnTo>
                      <a:pt x="464" y="1184"/>
                    </a:lnTo>
                    <a:lnTo>
                      <a:pt x="480" y="1200"/>
                    </a:lnTo>
                    <a:lnTo>
                      <a:pt x="492" y="1212"/>
                    </a:lnTo>
                    <a:lnTo>
                      <a:pt x="508" y="1224"/>
                    </a:lnTo>
                    <a:lnTo>
                      <a:pt x="524" y="1236"/>
                    </a:lnTo>
                    <a:lnTo>
                      <a:pt x="540" y="1240"/>
                    </a:lnTo>
                    <a:lnTo>
                      <a:pt x="556" y="1240"/>
                    </a:lnTo>
                    <a:lnTo>
                      <a:pt x="572" y="1240"/>
                    </a:lnTo>
                    <a:lnTo>
                      <a:pt x="588" y="1240"/>
                    </a:lnTo>
                    <a:lnTo>
                      <a:pt x="604" y="1240"/>
                    </a:lnTo>
                    <a:lnTo>
                      <a:pt x="620" y="1236"/>
                    </a:lnTo>
                    <a:lnTo>
                      <a:pt x="636" y="1232"/>
                    </a:lnTo>
                    <a:lnTo>
                      <a:pt x="652" y="1228"/>
                    </a:lnTo>
                    <a:lnTo>
                      <a:pt x="668" y="1228"/>
                    </a:lnTo>
                    <a:lnTo>
                      <a:pt x="684" y="1232"/>
                    </a:lnTo>
                    <a:lnTo>
                      <a:pt x="700" y="1236"/>
                    </a:lnTo>
                    <a:lnTo>
                      <a:pt x="716" y="1240"/>
                    </a:lnTo>
                    <a:lnTo>
                      <a:pt x="732" y="1240"/>
                    </a:lnTo>
                    <a:lnTo>
                      <a:pt x="748" y="1236"/>
                    </a:lnTo>
                    <a:lnTo>
                      <a:pt x="764" y="1228"/>
                    </a:lnTo>
                    <a:lnTo>
                      <a:pt x="780" y="1224"/>
                    </a:lnTo>
                    <a:lnTo>
                      <a:pt x="796" y="1220"/>
                    </a:lnTo>
                    <a:lnTo>
                      <a:pt x="812" y="1216"/>
                    </a:lnTo>
                    <a:lnTo>
                      <a:pt x="828" y="1208"/>
                    </a:lnTo>
                    <a:lnTo>
                      <a:pt x="844" y="1192"/>
                    </a:lnTo>
                    <a:lnTo>
                      <a:pt x="860" y="1172"/>
                    </a:lnTo>
                    <a:lnTo>
                      <a:pt x="876" y="1148"/>
                    </a:lnTo>
                    <a:lnTo>
                      <a:pt x="892" y="1120"/>
                    </a:lnTo>
                    <a:lnTo>
                      <a:pt x="908" y="1092"/>
                    </a:lnTo>
                    <a:lnTo>
                      <a:pt x="924" y="1048"/>
                    </a:lnTo>
                    <a:lnTo>
                      <a:pt x="940" y="988"/>
                    </a:lnTo>
                    <a:lnTo>
                      <a:pt x="956" y="916"/>
                    </a:lnTo>
                    <a:lnTo>
                      <a:pt x="972" y="844"/>
                    </a:lnTo>
                    <a:lnTo>
                      <a:pt x="988" y="768"/>
                    </a:lnTo>
                    <a:lnTo>
                      <a:pt x="1004" y="688"/>
                    </a:lnTo>
                    <a:lnTo>
                      <a:pt x="1020" y="584"/>
                    </a:lnTo>
                    <a:lnTo>
                      <a:pt x="1036" y="444"/>
                    </a:lnTo>
                    <a:lnTo>
                      <a:pt x="1052" y="276"/>
                    </a:lnTo>
                    <a:lnTo>
                      <a:pt x="1068" y="104"/>
                    </a:lnTo>
                    <a:lnTo>
                      <a:pt x="1084" y="0"/>
                    </a:lnTo>
                    <a:lnTo>
                      <a:pt x="1096" y="48"/>
                    </a:lnTo>
                    <a:lnTo>
                      <a:pt x="1112" y="272"/>
                    </a:lnTo>
                    <a:lnTo>
                      <a:pt x="1128" y="596"/>
                    </a:lnTo>
                    <a:lnTo>
                      <a:pt x="1144" y="880"/>
                    </a:lnTo>
                    <a:lnTo>
                      <a:pt x="1160" y="1060"/>
                    </a:lnTo>
                    <a:lnTo>
                      <a:pt x="1176" y="1140"/>
                    </a:lnTo>
                    <a:lnTo>
                      <a:pt x="1192" y="1168"/>
                    </a:lnTo>
                    <a:lnTo>
                      <a:pt x="1208" y="1180"/>
                    </a:lnTo>
                    <a:lnTo>
                      <a:pt x="1224" y="1184"/>
                    </a:lnTo>
                    <a:lnTo>
                      <a:pt x="1240" y="1192"/>
                    </a:lnTo>
                    <a:lnTo>
                      <a:pt x="1256" y="1200"/>
                    </a:lnTo>
                    <a:lnTo>
                      <a:pt x="1272" y="1208"/>
                    </a:lnTo>
                    <a:lnTo>
                      <a:pt x="1288" y="1220"/>
                    </a:lnTo>
                    <a:lnTo>
                      <a:pt x="1304" y="1224"/>
                    </a:lnTo>
                    <a:lnTo>
                      <a:pt x="1320" y="1216"/>
                    </a:lnTo>
                    <a:lnTo>
                      <a:pt x="1336" y="1196"/>
                    </a:lnTo>
                    <a:lnTo>
                      <a:pt x="1352" y="1168"/>
                    </a:lnTo>
                    <a:lnTo>
                      <a:pt x="1368" y="1132"/>
                    </a:lnTo>
                    <a:lnTo>
                      <a:pt x="1384" y="1116"/>
                    </a:lnTo>
                    <a:lnTo>
                      <a:pt x="1400" y="1128"/>
                    </a:lnTo>
                    <a:lnTo>
                      <a:pt x="1416" y="1164"/>
                    </a:lnTo>
                    <a:lnTo>
                      <a:pt x="1432" y="1208"/>
                    </a:lnTo>
                    <a:lnTo>
                      <a:pt x="1448" y="1240"/>
                    </a:lnTo>
                    <a:lnTo>
                      <a:pt x="1464" y="1260"/>
                    </a:lnTo>
                    <a:lnTo>
                      <a:pt x="1480" y="1268"/>
                    </a:lnTo>
                    <a:lnTo>
                      <a:pt x="1496" y="1276"/>
                    </a:lnTo>
                    <a:lnTo>
                      <a:pt x="1512" y="1280"/>
                    </a:lnTo>
                    <a:lnTo>
                      <a:pt x="1528" y="1284"/>
                    </a:lnTo>
                    <a:lnTo>
                      <a:pt x="1544" y="1284"/>
                    </a:lnTo>
                    <a:lnTo>
                      <a:pt x="1560" y="1284"/>
                    </a:lnTo>
                    <a:lnTo>
                      <a:pt x="1576" y="1284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376" name="Rectangle 59"/>
            <p:cNvSpPr>
              <a:spLocks noChangeArrowheads="1"/>
            </p:cNvSpPr>
            <p:nvPr/>
          </p:nvSpPr>
          <p:spPr bwMode="auto">
            <a:xfrm>
              <a:off x="4211302" y="4455982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77" name="Rectangle 60"/>
            <p:cNvSpPr>
              <a:spLocks noChangeArrowheads="1"/>
            </p:cNvSpPr>
            <p:nvPr/>
          </p:nvSpPr>
          <p:spPr bwMode="auto">
            <a:xfrm rot="16200000">
              <a:off x="3461329" y="3390566"/>
              <a:ext cx="80495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robabil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dens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0" name="Rectangle 59"/>
            <p:cNvSpPr>
              <a:spLocks noChangeArrowheads="1"/>
            </p:cNvSpPr>
            <p:nvPr/>
          </p:nvSpPr>
          <p:spPr bwMode="auto">
            <a:xfrm>
              <a:off x="4171291" y="2272634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grpSp>
          <p:nvGrpSpPr>
            <p:cNvPr id="50" name="Gruppo 49"/>
            <p:cNvGrpSpPr/>
            <p:nvPr/>
          </p:nvGrpSpPr>
          <p:grpSpPr>
            <a:xfrm>
              <a:off x="3794556" y="376905"/>
              <a:ext cx="2898062" cy="1903475"/>
              <a:chOff x="3794556" y="376905"/>
              <a:chExt cx="2898062" cy="1903475"/>
            </a:xfrm>
          </p:grpSpPr>
          <p:grpSp>
            <p:nvGrpSpPr>
              <p:cNvPr id="51" name="Group 52"/>
              <p:cNvGrpSpPr>
                <a:grpSpLocks noChangeAspect="1"/>
              </p:cNvGrpSpPr>
              <p:nvPr/>
            </p:nvGrpSpPr>
            <p:grpSpPr bwMode="auto">
              <a:xfrm>
                <a:off x="3994330" y="376905"/>
                <a:ext cx="2698288" cy="1903475"/>
                <a:chOff x="635" y="-18"/>
                <a:chExt cx="2011" cy="1657"/>
              </a:xfrm>
            </p:grpSpPr>
            <p:sp>
              <p:nvSpPr>
                <p:cNvPr id="53" name="Rectangle 53"/>
                <p:cNvSpPr>
                  <a:spLocks noChangeArrowheads="1"/>
                </p:cNvSpPr>
                <p:nvPr/>
              </p:nvSpPr>
              <p:spPr bwMode="auto">
                <a:xfrm>
                  <a:off x="687" y="128"/>
                  <a:ext cx="1844" cy="14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4" name="Rectangle 54"/>
                <p:cNvSpPr>
                  <a:spLocks noChangeArrowheads="1"/>
                </p:cNvSpPr>
                <p:nvPr/>
              </p:nvSpPr>
              <p:spPr bwMode="auto">
                <a:xfrm>
                  <a:off x="687" y="128"/>
                  <a:ext cx="1844" cy="1412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5" name="Line 55"/>
                <p:cNvSpPr>
                  <a:spLocks noChangeShapeType="1"/>
                </p:cNvSpPr>
                <p:nvPr/>
              </p:nvSpPr>
              <p:spPr bwMode="auto">
                <a:xfrm>
                  <a:off x="687" y="1540"/>
                  <a:ext cx="1959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arrow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6" name="Line 56"/>
                <p:cNvSpPr>
                  <a:spLocks noChangeShapeType="1"/>
                </p:cNvSpPr>
                <p:nvPr/>
              </p:nvSpPr>
              <p:spPr bwMode="auto">
                <a:xfrm flipV="1">
                  <a:off x="687" y="-18"/>
                  <a:ext cx="0" cy="1567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arrow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7" name="Line 57"/>
                <p:cNvSpPr>
                  <a:spLocks noChangeShapeType="1"/>
                </p:cNvSpPr>
                <p:nvPr/>
              </p:nvSpPr>
              <p:spPr bwMode="auto">
                <a:xfrm flipV="1">
                  <a:off x="687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8" name="Rectangle 58"/>
                <p:cNvSpPr>
                  <a:spLocks noChangeArrowheads="1"/>
                </p:cNvSpPr>
                <p:nvPr/>
              </p:nvSpPr>
              <p:spPr bwMode="auto">
                <a:xfrm>
                  <a:off x="659" y="1552"/>
                  <a:ext cx="5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1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59" name="Line 59"/>
                <p:cNvSpPr>
                  <a:spLocks noChangeShapeType="1"/>
                </p:cNvSpPr>
                <p:nvPr/>
              </p:nvSpPr>
              <p:spPr bwMode="auto">
                <a:xfrm flipV="1">
                  <a:off x="87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0" name="Rectangle 60"/>
                <p:cNvSpPr>
                  <a:spLocks noChangeArrowheads="1"/>
                </p:cNvSpPr>
                <p:nvPr/>
              </p:nvSpPr>
              <p:spPr bwMode="auto">
                <a:xfrm>
                  <a:off x="819" y="1552"/>
                  <a:ext cx="1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8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61" name="Line 61"/>
                <p:cNvSpPr>
                  <a:spLocks noChangeShapeType="1"/>
                </p:cNvSpPr>
                <p:nvPr/>
              </p:nvSpPr>
              <p:spPr bwMode="auto">
                <a:xfrm flipV="1">
                  <a:off x="1055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2" name="Rectangle 62"/>
                <p:cNvSpPr>
                  <a:spLocks noChangeArrowheads="1"/>
                </p:cNvSpPr>
                <p:nvPr/>
              </p:nvSpPr>
              <p:spPr bwMode="auto">
                <a:xfrm>
                  <a:off x="1003" y="1552"/>
                  <a:ext cx="1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6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63" name="Line 63"/>
                <p:cNvSpPr>
                  <a:spLocks noChangeShapeType="1"/>
                </p:cNvSpPr>
                <p:nvPr/>
              </p:nvSpPr>
              <p:spPr bwMode="auto">
                <a:xfrm flipV="1">
                  <a:off x="1239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48" name="Rectangle 64"/>
                <p:cNvSpPr>
                  <a:spLocks noChangeArrowheads="1"/>
                </p:cNvSpPr>
                <p:nvPr/>
              </p:nvSpPr>
              <p:spPr bwMode="auto">
                <a:xfrm>
                  <a:off x="1187" y="1552"/>
                  <a:ext cx="1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4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49" name="Line 65"/>
                <p:cNvSpPr>
                  <a:spLocks noChangeShapeType="1"/>
                </p:cNvSpPr>
                <p:nvPr/>
              </p:nvSpPr>
              <p:spPr bwMode="auto">
                <a:xfrm flipV="1">
                  <a:off x="1423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50" name="Rectangle 66"/>
                <p:cNvSpPr>
                  <a:spLocks noChangeArrowheads="1"/>
                </p:cNvSpPr>
                <p:nvPr/>
              </p:nvSpPr>
              <p:spPr bwMode="auto">
                <a:xfrm>
                  <a:off x="1371" y="1552"/>
                  <a:ext cx="1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2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51" name="Line 67"/>
                <p:cNvSpPr>
                  <a:spLocks noChangeShapeType="1"/>
                </p:cNvSpPr>
                <p:nvPr/>
              </p:nvSpPr>
              <p:spPr bwMode="auto">
                <a:xfrm flipV="1">
                  <a:off x="1607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52" name="Rectangle 68"/>
                <p:cNvSpPr>
                  <a:spLocks noChangeArrowheads="1"/>
                </p:cNvSpPr>
                <p:nvPr/>
              </p:nvSpPr>
              <p:spPr bwMode="auto">
                <a:xfrm>
                  <a:off x="1595" y="1552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53" name="Line 69"/>
                <p:cNvSpPr>
                  <a:spLocks noChangeShapeType="1"/>
                </p:cNvSpPr>
                <p:nvPr/>
              </p:nvSpPr>
              <p:spPr bwMode="auto">
                <a:xfrm flipV="1">
                  <a:off x="179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54" name="Rectangle 70"/>
                <p:cNvSpPr>
                  <a:spLocks noChangeArrowheads="1"/>
                </p:cNvSpPr>
                <p:nvPr/>
              </p:nvSpPr>
              <p:spPr bwMode="auto">
                <a:xfrm>
                  <a:off x="1755" y="1552"/>
                  <a:ext cx="8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2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55" name="Line 71"/>
                <p:cNvSpPr>
                  <a:spLocks noChangeShapeType="1"/>
                </p:cNvSpPr>
                <p:nvPr/>
              </p:nvSpPr>
              <p:spPr bwMode="auto">
                <a:xfrm flipV="1">
                  <a:off x="1975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56" name="Rectangle 72"/>
                <p:cNvSpPr>
                  <a:spLocks noChangeArrowheads="1"/>
                </p:cNvSpPr>
                <p:nvPr/>
              </p:nvSpPr>
              <p:spPr bwMode="auto">
                <a:xfrm>
                  <a:off x="1939" y="1552"/>
                  <a:ext cx="8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4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57" name="Line 73"/>
                <p:cNvSpPr>
                  <a:spLocks noChangeShapeType="1"/>
                </p:cNvSpPr>
                <p:nvPr/>
              </p:nvSpPr>
              <p:spPr bwMode="auto">
                <a:xfrm flipV="1">
                  <a:off x="2159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58" name="Rectangle 74"/>
                <p:cNvSpPr>
                  <a:spLocks noChangeArrowheads="1"/>
                </p:cNvSpPr>
                <p:nvPr/>
              </p:nvSpPr>
              <p:spPr bwMode="auto">
                <a:xfrm>
                  <a:off x="2123" y="1552"/>
                  <a:ext cx="8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6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59" name="Line 75"/>
                <p:cNvSpPr>
                  <a:spLocks noChangeShapeType="1"/>
                </p:cNvSpPr>
                <p:nvPr/>
              </p:nvSpPr>
              <p:spPr bwMode="auto">
                <a:xfrm flipV="1">
                  <a:off x="2343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60" name="Rectangle 76"/>
                <p:cNvSpPr>
                  <a:spLocks noChangeArrowheads="1"/>
                </p:cNvSpPr>
                <p:nvPr/>
              </p:nvSpPr>
              <p:spPr bwMode="auto">
                <a:xfrm>
                  <a:off x="2307" y="1552"/>
                  <a:ext cx="8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8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61" name="Line 77"/>
                <p:cNvSpPr>
                  <a:spLocks noChangeShapeType="1"/>
                </p:cNvSpPr>
                <p:nvPr/>
              </p:nvSpPr>
              <p:spPr bwMode="auto">
                <a:xfrm flipV="1">
                  <a:off x="253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62" name="Rectangle 78"/>
                <p:cNvSpPr>
                  <a:spLocks noChangeArrowheads="1"/>
                </p:cNvSpPr>
                <p:nvPr/>
              </p:nvSpPr>
              <p:spPr bwMode="auto">
                <a:xfrm>
                  <a:off x="2519" y="1552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1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63" name="Line 79"/>
                <p:cNvSpPr>
                  <a:spLocks noChangeShapeType="1"/>
                </p:cNvSpPr>
                <p:nvPr/>
              </p:nvSpPr>
              <p:spPr bwMode="auto">
                <a:xfrm>
                  <a:off x="687" y="1540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64" name="Rectangle 80"/>
                <p:cNvSpPr>
                  <a:spLocks noChangeArrowheads="1"/>
                </p:cNvSpPr>
                <p:nvPr/>
              </p:nvSpPr>
              <p:spPr bwMode="auto">
                <a:xfrm>
                  <a:off x="635" y="1508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65" name="Line 81"/>
                <p:cNvSpPr>
                  <a:spLocks noChangeShapeType="1"/>
                </p:cNvSpPr>
                <p:nvPr/>
              </p:nvSpPr>
              <p:spPr bwMode="auto">
                <a:xfrm>
                  <a:off x="687" y="1304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66" name="Rectangle 82"/>
                <p:cNvSpPr>
                  <a:spLocks noChangeArrowheads="1"/>
                </p:cNvSpPr>
                <p:nvPr/>
              </p:nvSpPr>
              <p:spPr bwMode="auto">
                <a:xfrm>
                  <a:off x="635" y="1272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1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67" name="Line 83"/>
                <p:cNvSpPr>
                  <a:spLocks noChangeShapeType="1"/>
                </p:cNvSpPr>
                <p:nvPr/>
              </p:nvSpPr>
              <p:spPr bwMode="auto">
                <a:xfrm>
                  <a:off x="687" y="1068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68" name="Rectangle 84"/>
                <p:cNvSpPr>
                  <a:spLocks noChangeArrowheads="1"/>
                </p:cNvSpPr>
                <p:nvPr/>
              </p:nvSpPr>
              <p:spPr bwMode="auto">
                <a:xfrm>
                  <a:off x="635" y="1036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2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69" name="Line 85"/>
                <p:cNvSpPr>
                  <a:spLocks noChangeShapeType="1"/>
                </p:cNvSpPr>
                <p:nvPr/>
              </p:nvSpPr>
              <p:spPr bwMode="auto">
                <a:xfrm>
                  <a:off x="687" y="832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70" name="Rectangle 86"/>
                <p:cNvSpPr>
                  <a:spLocks noChangeArrowheads="1"/>
                </p:cNvSpPr>
                <p:nvPr/>
              </p:nvSpPr>
              <p:spPr bwMode="auto">
                <a:xfrm>
                  <a:off x="635" y="800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3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71" name="Line 87"/>
                <p:cNvSpPr>
                  <a:spLocks noChangeShapeType="1"/>
                </p:cNvSpPr>
                <p:nvPr/>
              </p:nvSpPr>
              <p:spPr bwMode="auto">
                <a:xfrm>
                  <a:off x="687" y="596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72" name="Rectangle 88"/>
                <p:cNvSpPr>
                  <a:spLocks noChangeArrowheads="1"/>
                </p:cNvSpPr>
                <p:nvPr/>
              </p:nvSpPr>
              <p:spPr bwMode="auto">
                <a:xfrm>
                  <a:off x="635" y="564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4</a:t>
                  </a:r>
                  <a:endParaRPr kumimoji="0" lang="it-IT" altLang="it-IT" sz="18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73" name="Line 89"/>
                <p:cNvSpPr>
                  <a:spLocks noChangeShapeType="1"/>
                </p:cNvSpPr>
                <p:nvPr/>
              </p:nvSpPr>
              <p:spPr bwMode="auto">
                <a:xfrm>
                  <a:off x="687" y="360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74" name="Rectangle 90"/>
                <p:cNvSpPr>
                  <a:spLocks noChangeArrowheads="1"/>
                </p:cNvSpPr>
                <p:nvPr/>
              </p:nvSpPr>
              <p:spPr bwMode="auto">
                <a:xfrm>
                  <a:off x="635" y="328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5</a:t>
                  </a:r>
                  <a:endParaRPr kumimoji="0" lang="it-IT" altLang="it-IT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75" name="Line 91"/>
                <p:cNvSpPr>
                  <a:spLocks noChangeShapeType="1"/>
                </p:cNvSpPr>
                <p:nvPr/>
              </p:nvSpPr>
              <p:spPr bwMode="auto">
                <a:xfrm>
                  <a:off x="687" y="128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2876" name="Rectangle 92"/>
                <p:cNvSpPr>
                  <a:spLocks noChangeArrowheads="1"/>
                </p:cNvSpPr>
                <p:nvPr/>
              </p:nvSpPr>
              <p:spPr bwMode="auto">
                <a:xfrm>
                  <a:off x="635" y="96"/>
                  <a:ext cx="3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6</a:t>
                  </a:r>
                  <a:endParaRPr kumimoji="0" lang="it-IT" altLang="it-IT" sz="1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877" name="Freeform 93"/>
                <p:cNvSpPr>
                  <a:spLocks/>
                </p:cNvSpPr>
                <p:nvPr/>
              </p:nvSpPr>
              <p:spPr bwMode="auto">
                <a:xfrm>
                  <a:off x="855" y="340"/>
                  <a:ext cx="1584" cy="1196"/>
                </a:xfrm>
                <a:custGeom>
                  <a:avLst/>
                  <a:gdLst>
                    <a:gd name="T0" fmla="*/ 16 w 1584"/>
                    <a:gd name="T1" fmla="*/ 1196 h 1196"/>
                    <a:gd name="T2" fmla="*/ 48 w 1584"/>
                    <a:gd name="T3" fmla="*/ 1196 h 1196"/>
                    <a:gd name="T4" fmla="*/ 80 w 1584"/>
                    <a:gd name="T5" fmla="*/ 1192 h 1196"/>
                    <a:gd name="T6" fmla="*/ 112 w 1584"/>
                    <a:gd name="T7" fmla="*/ 1196 h 1196"/>
                    <a:gd name="T8" fmla="*/ 144 w 1584"/>
                    <a:gd name="T9" fmla="*/ 1192 h 1196"/>
                    <a:gd name="T10" fmla="*/ 176 w 1584"/>
                    <a:gd name="T11" fmla="*/ 1188 h 1196"/>
                    <a:gd name="T12" fmla="*/ 208 w 1584"/>
                    <a:gd name="T13" fmla="*/ 1188 h 1196"/>
                    <a:gd name="T14" fmla="*/ 240 w 1584"/>
                    <a:gd name="T15" fmla="*/ 1188 h 1196"/>
                    <a:gd name="T16" fmla="*/ 272 w 1584"/>
                    <a:gd name="T17" fmla="*/ 1176 h 1196"/>
                    <a:gd name="T18" fmla="*/ 304 w 1584"/>
                    <a:gd name="T19" fmla="*/ 1164 h 1196"/>
                    <a:gd name="T20" fmla="*/ 336 w 1584"/>
                    <a:gd name="T21" fmla="*/ 1140 h 1196"/>
                    <a:gd name="T22" fmla="*/ 368 w 1584"/>
                    <a:gd name="T23" fmla="*/ 1028 h 1196"/>
                    <a:gd name="T24" fmla="*/ 400 w 1584"/>
                    <a:gd name="T25" fmla="*/ 880 h 1196"/>
                    <a:gd name="T26" fmla="*/ 432 w 1584"/>
                    <a:gd name="T27" fmla="*/ 932 h 1196"/>
                    <a:gd name="T28" fmla="*/ 464 w 1584"/>
                    <a:gd name="T29" fmla="*/ 1052 h 1196"/>
                    <a:gd name="T30" fmla="*/ 496 w 1584"/>
                    <a:gd name="T31" fmla="*/ 1112 h 1196"/>
                    <a:gd name="T32" fmla="*/ 528 w 1584"/>
                    <a:gd name="T33" fmla="*/ 1128 h 1196"/>
                    <a:gd name="T34" fmla="*/ 560 w 1584"/>
                    <a:gd name="T35" fmla="*/ 1148 h 1196"/>
                    <a:gd name="T36" fmla="*/ 592 w 1584"/>
                    <a:gd name="T37" fmla="*/ 1156 h 1196"/>
                    <a:gd name="T38" fmla="*/ 624 w 1584"/>
                    <a:gd name="T39" fmla="*/ 1172 h 1196"/>
                    <a:gd name="T40" fmla="*/ 656 w 1584"/>
                    <a:gd name="T41" fmla="*/ 1168 h 1196"/>
                    <a:gd name="T42" fmla="*/ 688 w 1584"/>
                    <a:gd name="T43" fmla="*/ 1172 h 1196"/>
                    <a:gd name="T44" fmla="*/ 720 w 1584"/>
                    <a:gd name="T45" fmla="*/ 1184 h 1196"/>
                    <a:gd name="T46" fmla="*/ 752 w 1584"/>
                    <a:gd name="T47" fmla="*/ 1180 h 1196"/>
                    <a:gd name="T48" fmla="*/ 784 w 1584"/>
                    <a:gd name="T49" fmla="*/ 1184 h 1196"/>
                    <a:gd name="T50" fmla="*/ 816 w 1584"/>
                    <a:gd name="T51" fmla="*/ 1188 h 1196"/>
                    <a:gd name="T52" fmla="*/ 848 w 1584"/>
                    <a:gd name="T53" fmla="*/ 1188 h 1196"/>
                    <a:gd name="T54" fmla="*/ 880 w 1584"/>
                    <a:gd name="T55" fmla="*/ 1192 h 1196"/>
                    <a:gd name="T56" fmla="*/ 912 w 1584"/>
                    <a:gd name="T57" fmla="*/ 1192 h 1196"/>
                    <a:gd name="T58" fmla="*/ 944 w 1584"/>
                    <a:gd name="T59" fmla="*/ 1196 h 1196"/>
                    <a:gd name="T60" fmla="*/ 976 w 1584"/>
                    <a:gd name="T61" fmla="*/ 1192 h 1196"/>
                    <a:gd name="T62" fmla="*/ 1008 w 1584"/>
                    <a:gd name="T63" fmla="*/ 1188 h 1196"/>
                    <a:gd name="T64" fmla="*/ 1040 w 1584"/>
                    <a:gd name="T65" fmla="*/ 1176 h 1196"/>
                    <a:gd name="T66" fmla="*/ 1072 w 1584"/>
                    <a:gd name="T67" fmla="*/ 1116 h 1196"/>
                    <a:gd name="T68" fmla="*/ 1104 w 1584"/>
                    <a:gd name="T69" fmla="*/ 940 h 1196"/>
                    <a:gd name="T70" fmla="*/ 1136 w 1584"/>
                    <a:gd name="T71" fmla="*/ 536 h 1196"/>
                    <a:gd name="T72" fmla="*/ 1168 w 1584"/>
                    <a:gd name="T73" fmla="*/ 32 h 1196"/>
                    <a:gd name="T74" fmla="*/ 1200 w 1584"/>
                    <a:gd name="T75" fmla="*/ 200 h 1196"/>
                    <a:gd name="T76" fmla="*/ 1232 w 1584"/>
                    <a:gd name="T77" fmla="*/ 784 h 1196"/>
                    <a:gd name="T78" fmla="*/ 1264 w 1584"/>
                    <a:gd name="T79" fmla="*/ 1004 h 1196"/>
                    <a:gd name="T80" fmla="*/ 1296 w 1584"/>
                    <a:gd name="T81" fmla="*/ 1048 h 1196"/>
                    <a:gd name="T82" fmla="*/ 1328 w 1584"/>
                    <a:gd name="T83" fmla="*/ 1048 h 1196"/>
                    <a:gd name="T84" fmla="*/ 1360 w 1584"/>
                    <a:gd name="T85" fmla="*/ 1020 h 1196"/>
                    <a:gd name="T86" fmla="*/ 1392 w 1584"/>
                    <a:gd name="T87" fmla="*/ 936 h 1196"/>
                    <a:gd name="T88" fmla="*/ 1424 w 1584"/>
                    <a:gd name="T89" fmla="*/ 832 h 1196"/>
                    <a:gd name="T90" fmla="*/ 1456 w 1584"/>
                    <a:gd name="T91" fmla="*/ 916 h 1196"/>
                    <a:gd name="T92" fmla="*/ 1488 w 1584"/>
                    <a:gd name="T93" fmla="*/ 1104 h 1196"/>
                    <a:gd name="T94" fmla="*/ 1520 w 1584"/>
                    <a:gd name="T95" fmla="*/ 1180 h 1196"/>
                    <a:gd name="T96" fmla="*/ 1552 w 1584"/>
                    <a:gd name="T97" fmla="*/ 1196 h 1196"/>
                    <a:gd name="T98" fmla="*/ 1584 w 1584"/>
                    <a:gd name="T99" fmla="*/ 1196 h 11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1584" h="1196">
                      <a:moveTo>
                        <a:pt x="0" y="1196"/>
                      </a:moveTo>
                      <a:lnTo>
                        <a:pt x="16" y="1196"/>
                      </a:lnTo>
                      <a:lnTo>
                        <a:pt x="32" y="1196"/>
                      </a:lnTo>
                      <a:lnTo>
                        <a:pt x="48" y="1196"/>
                      </a:lnTo>
                      <a:lnTo>
                        <a:pt x="64" y="1192"/>
                      </a:lnTo>
                      <a:lnTo>
                        <a:pt x="80" y="1192"/>
                      </a:lnTo>
                      <a:lnTo>
                        <a:pt x="96" y="1192"/>
                      </a:lnTo>
                      <a:lnTo>
                        <a:pt x="112" y="1196"/>
                      </a:lnTo>
                      <a:lnTo>
                        <a:pt x="128" y="1196"/>
                      </a:lnTo>
                      <a:lnTo>
                        <a:pt x="144" y="1192"/>
                      </a:lnTo>
                      <a:lnTo>
                        <a:pt x="160" y="1192"/>
                      </a:lnTo>
                      <a:lnTo>
                        <a:pt x="176" y="1188"/>
                      </a:lnTo>
                      <a:lnTo>
                        <a:pt x="192" y="1188"/>
                      </a:lnTo>
                      <a:lnTo>
                        <a:pt x="208" y="1188"/>
                      </a:lnTo>
                      <a:lnTo>
                        <a:pt x="224" y="1188"/>
                      </a:lnTo>
                      <a:lnTo>
                        <a:pt x="240" y="1188"/>
                      </a:lnTo>
                      <a:lnTo>
                        <a:pt x="256" y="1184"/>
                      </a:lnTo>
                      <a:lnTo>
                        <a:pt x="272" y="1176"/>
                      </a:lnTo>
                      <a:lnTo>
                        <a:pt x="288" y="1172"/>
                      </a:lnTo>
                      <a:lnTo>
                        <a:pt x="304" y="1164"/>
                      </a:lnTo>
                      <a:lnTo>
                        <a:pt x="320" y="1156"/>
                      </a:lnTo>
                      <a:lnTo>
                        <a:pt x="336" y="1140"/>
                      </a:lnTo>
                      <a:lnTo>
                        <a:pt x="352" y="1100"/>
                      </a:lnTo>
                      <a:lnTo>
                        <a:pt x="368" y="1028"/>
                      </a:lnTo>
                      <a:lnTo>
                        <a:pt x="384" y="940"/>
                      </a:lnTo>
                      <a:lnTo>
                        <a:pt x="400" y="880"/>
                      </a:lnTo>
                      <a:lnTo>
                        <a:pt x="416" y="880"/>
                      </a:lnTo>
                      <a:lnTo>
                        <a:pt x="432" y="932"/>
                      </a:lnTo>
                      <a:lnTo>
                        <a:pt x="448" y="996"/>
                      </a:lnTo>
                      <a:lnTo>
                        <a:pt x="464" y="1052"/>
                      </a:lnTo>
                      <a:lnTo>
                        <a:pt x="480" y="1088"/>
                      </a:lnTo>
                      <a:lnTo>
                        <a:pt x="496" y="1112"/>
                      </a:lnTo>
                      <a:lnTo>
                        <a:pt x="512" y="1120"/>
                      </a:lnTo>
                      <a:lnTo>
                        <a:pt x="528" y="1128"/>
                      </a:lnTo>
                      <a:lnTo>
                        <a:pt x="544" y="1136"/>
                      </a:lnTo>
                      <a:lnTo>
                        <a:pt x="560" y="1148"/>
                      </a:lnTo>
                      <a:lnTo>
                        <a:pt x="576" y="1152"/>
                      </a:lnTo>
                      <a:lnTo>
                        <a:pt x="592" y="1156"/>
                      </a:lnTo>
                      <a:lnTo>
                        <a:pt x="608" y="1164"/>
                      </a:lnTo>
                      <a:lnTo>
                        <a:pt x="624" y="1172"/>
                      </a:lnTo>
                      <a:lnTo>
                        <a:pt x="640" y="1172"/>
                      </a:lnTo>
                      <a:lnTo>
                        <a:pt x="656" y="1168"/>
                      </a:lnTo>
                      <a:lnTo>
                        <a:pt x="672" y="1168"/>
                      </a:lnTo>
                      <a:lnTo>
                        <a:pt x="688" y="1172"/>
                      </a:lnTo>
                      <a:lnTo>
                        <a:pt x="704" y="1180"/>
                      </a:lnTo>
                      <a:lnTo>
                        <a:pt x="720" y="1184"/>
                      </a:lnTo>
                      <a:lnTo>
                        <a:pt x="736" y="1184"/>
                      </a:lnTo>
                      <a:lnTo>
                        <a:pt x="752" y="1180"/>
                      </a:lnTo>
                      <a:lnTo>
                        <a:pt x="768" y="1180"/>
                      </a:lnTo>
                      <a:lnTo>
                        <a:pt x="784" y="1184"/>
                      </a:lnTo>
                      <a:lnTo>
                        <a:pt x="800" y="1188"/>
                      </a:lnTo>
                      <a:lnTo>
                        <a:pt x="816" y="1188"/>
                      </a:lnTo>
                      <a:lnTo>
                        <a:pt x="832" y="1188"/>
                      </a:lnTo>
                      <a:lnTo>
                        <a:pt x="848" y="1188"/>
                      </a:lnTo>
                      <a:lnTo>
                        <a:pt x="864" y="1192"/>
                      </a:lnTo>
                      <a:lnTo>
                        <a:pt x="880" y="1192"/>
                      </a:lnTo>
                      <a:lnTo>
                        <a:pt x="896" y="1192"/>
                      </a:lnTo>
                      <a:lnTo>
                        <a:pt x="912" y="1192"/>
                      </a:lnTo>
                      <a:lnTo>
                        <a:pt x="928" y="1196"/>
                      </a:lnTo>
                      <a:lnTo>
                        <a:pt x="944" y="1196"/>
                      </a:lnTo>
                      <a:lnTo>
                        <a:pt x="960" y="1196"/>
                      </a:lnTo>
                      <a:lnTo>
                        <a:pt x="976" y="1192"/>
                      </a:lnTo>
                      <a:lnTo>
                        <a:pt x="992" y="1192"/>
                      </a:lnTo>
                      <a:lnTo>
                        <a:pt x="1008" y="1188"/>
                      </a:lnTo>
                      <a:lnTo>
                        <a:pt x="1024" y="1184"/>
                      </a:lnTo>
                      <a:lnTo>
                        <a:pt x="1040" y="1176"/>
                      </a:lnTo>
                      <a:lnTo>
                        <a:pt x="1056" y="1156"/>
                      </a:lnTo>
                      <a:lnTo>
                        <a:pt x="1072" y="1116"/>
                      </a:lnTo>
                      <a:lnTo>
                        <a:pt x="1088" y="1048"/>
                      </a:lnTo>
                      <a:lnTo>
                        <a:pt x="1104" y="940"/>
                      </a:lnTo>
                      <a:lnTo>
                        <a:pt x="1120" y="772"/>
                      </a:lnTo>
                      <a:lnTo>
                        <a:pt x="1136" y="536"/>
                      </a:lnTo>
                      <a:lnTo>
                        <a:pt x="1152" y="252"/>
                      </a:lnTo>
                      <a:lnTo>
                        <a:pt x="1168" y="32"/>
                      </a:lnTo>
                      <a:lnTo>
                        <a:pt x="1184" y="0"/>
                      </a:lnTo>
                      <a:lnTo>
                        <a:pt x="1200" y="200"/>
                      </a:lnTo>
                      <a:lnTo>
                        <a:pt x="1216" y="516"/>
                      </a:lnTo>
                      <a:lnTo>
                        <a:pt x="1232" y="784"/>
                      </a:lnTo>
                      <a:lnTo>
                        <a:pt x="1248" y="936"/>
                      </a:lnTo>
                      <a:lnTo>
                        <a:pt x="1264" y="1004"/>
                      </a:lnTo>
                      <a:lnTo>
                        <a:pt x="1280" y="1032"/>
                      </a:lnTo>
                      <a:lnTo>
                        <a:pt x="1296" y="1048"/>
                      </a:lnTo>
                      <a:lnTo>
                        <a:pt x="1312" y="1052"/>
                      </a:lnTo>
                      <a:lnTo>
                        <a:pt x="1328" y="1048"/>
                      </a:lnTo>
                      <a:lnTo>
                        <a:pt x="1344" y="1040"/>
                      </a:lnTo>
                      <a:lnTo>
                        <a:pt x="1360" y="1020"/>
                      </a:lnTo>
                      <a:lnTo>
                        <a:pt x="1376" y="984"/>
                      </a:lnTo>
                      <a:lnTo>
                        <a:pt x="1392" y="936"/>
                      </a:lnTo>
                      <a:lnTo>
                        <a:pt x="1408" y="880"/>
                      </a:lnTo>
                      <a:lnTo>
                        <a:pt x="1424" y="832"/>
                      </a:lnTo>
                      <a:lnTo>
                        <a:pt x="1440" y="840"/>
                      </a:lnTo>
                      <a:lnTo>
                        <a:pt x="1456" y="916"/>
                      </a:lnTo>
                      <a:lnTo>
                        <a:pt x="1472" y="1020"/>
                      </a:lnTo>
                      <a:lnTo>
                        <a:pt x="1488" y="1104"/>
                      </a:lnTo>
                      <a:lnTo>
                        <a:pt x="1504" y="1152"/>
                      </a:lnTo>
                      <a:lnTo>
                        <a:pt x="1520" y="1180"/>
                      </a:lnTo>
                      <a:lnTo>
                        <a:pt x="1536" y="1192"/>
                      </a:lnTo>
                      <a:lnTo>
                        <a:pt x="1552" y="1196"/>
                      </a:lnTo>
                      <a:lnTo>
                        <a:pt x="1568" y="1196"/>
                      </a:lnTo>
                      <a:lnTo>
                        <a:pt x="1584" y="1196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381" name="Rectangle 60"/>
              <p:cNvSpPr>
                <a:spLocks noChangeArrowheads="1"/>
              </p:cNvSpPr>
              <p:nvPr/>
            </p:nvSpPr>
            <p:spPr bwMode="auto">
              <a:xfrm rot="16200000">
                <a:off x="3461329" y="1158318"/>
                <a:ext cx="80495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Probability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density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endParaRPr>
              </a:p>
            </p:txBody>
          </p:sp>
        </p:grpSp>
        <p:sp>
          <p:nvSpPr>
            <p:cNvPr id="3" name="Rettangolo 2"/>
            <p:cNvSpPr/>
            <p:nvPr/>
          </p:nvSpPr>
          <p:spPr>
            <a:xfrm>
              <a:off x="4474445" y="335280"/>
              <a:ext cx="1441420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B050"/>
                  </a:solidFill>
                  <a:latin typeface="+mj-lt"/>
                  <a:cs typeface="Arial" pitchFamily="34" charset="0"/>
                </a:rPr>
                <a:t>Luminal B-like (HER2+)</a:t>
              </a:r>
              <a:endParaRPr lang="it-IT" sz="1100" b="1" dirty="0">
                <a:solidFill>
                  <a:srgbClr val="00B050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382" name="Rectangle 59"/>
            <p:cNvSpPr>
              <a:spLocks noChangeArrowheads="1"/>
            </p:cNvSpPr>
            <p:nvPr/>
          </p:nvSpPr>
          <p:spPr bwMode="auto">
            <a:xfrm>
              <a:off x="566418" y="8897997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3" name="Rectangle 60"/>
            <p:cNvSpPr>
              <a:spLocks noChangeArrowheads="1"/>
            </p:cNvSpPr>
            <p:nvPr/>
          </p:nvSpPr>
          <p:spPr bwMode="auto">
            <a:xfrm rot="16200000">
              <a:off x="-72579" y="7988044"/>
              <a:ext cx="80495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robabil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dens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4" name="Rectangle 59"/>
            <p:cNvSpPr>
              <a:spLocks noChangeArrowheads="1"/>
            </p:cNvSpPr>
            <p:nvPr/>
          </p:nvSpPr>
          <p:spPr bwMode="auto">
            <a:xfrm>
              <a:off x="4139294" y="8892480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6" name="Rectangle 59"/>
            <p:cNvSpPr>
              <a:spLocks noChangeArrowheads="1"/>
            </p:cNvSpPr>
            <p:nvPr/>
          </p:nvSpPr>
          <p:spPr bwMode="auto">
            <a:xfrm>
              <a:off x="648680" y="6870739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7" name="Rectangle 60"/>
            <p:cNvSpPr>
              <a:spLocks noChangeArrowheads="1"/>
            </p:cNvSpPr>
            <p:nvPr/>
          </p:nvSpPr>
          <p:spPr bwMode="auto">
            <a:xfrm rot="16200000">
              <a:off x="-72579" y="5830959"/>
              <a:ext cx="80495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robabil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dens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8" name="Rectangle 59"/>
            <p:cNvSpPr>
              <a:spLocks noChangeArrowheads="1"/>
            </p:cNvSpPr>
            <p:nvPr/>
          </p:nvSpPr>
          <p:spPr bwMode="auto">
            <a:xfrm>
              <a:off x="4177072" y="6875629"/>
              <a:ext cx="2159245" cy="127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Average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ears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rrelation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Coefficient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(APCC)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7120" name="Rettangolo 17119"/>
            <p:cNvSpPr/>
            <p:nvPr/>
          </p:nvSpPr>
          <p:spPr>
            <a:xfrm>
              <a:off x="1262231" y="5030470"/>
              <a:ext cx="764953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70C0"/>
                  </a:solidFill>
                  <a:latin typeface="+mj-lt"/>
                </a:rPr>
                <a:t>Luminal  A</a:t>
              </a:r>
              <a:endParaRPr lang="it-IT" sz="1100" b="1" dirty="0">
                <a:solidFill>
                  <a:srgbClr val="0070C0"/>
                </a:solidFill>
                <a:latin typeface="+mj-lt"/>
              </a:endParaRPr>
            </a:p>
          </p:txBody>
        </p:sp>
        <p:sp>
          <p:nvSpPr>
            <p:cNvPr id="19046" name="Rettangolo 19045"/>
            <p:cNvSpPr/>
            <p:nvPr/>
          </p:nvSpPr>
          <p:spPr>
            <a:xfrm>
              <a:off x="4797035" y="5030470"/>
              <a:ext cx="760144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70C0"/>
                  </a:solidFill>
                  <a:latin typeface="+mj-lt"/>
                </a:rPr>
                <a:t>Luminal  B</a:t>
              </a:r>
              <a:endParaRPr lang="it-IT" sz="1100" b="1" dirty="0">
                <a:solidFill>
                  <a:srgbClr val="0070C0"/>
                </a:solidFill>
                <a:latin typeface="+mj-lt"/>
              </a:endParaRPr>
            </a:p>
          </p:txBody>
        </p:sp>
        <p:sp>
          <p:nvSpPr>
            <p:cNvPr id="22889" name="Rettangolo 22888"/>
            <p:cNvSpPr/>
            <p:nvPr/>
          </p:nvSpPr>
          <p:spPr>
            <a:xfrm>
              <a:off x="4783081" y="7071144"/>
              <a:ext cx="705642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it-IT" sz="1100" b="1" dirty="0" err="1">
                  <a:solidFill>
                    <a:srgbClr val="0070C0"/>
                  </a:solidFill>
                  <a:latin typeface="+mj-lt"/>
                </a:rPr>
                <a:t>Basal-like</a:t>
              </a:r>
              <a:endParaRPr lang="it-IT" sz="1100" b="1" dirty="0">
                <a:solidFill>
                  <a:srgbClr val="0070C0"/>
                </a:solidFill>
                <a:latin typeface="+mj-lt"/>
              </a:endParaRPr>
            </a:p>
          </p:txBody>
        </p:sp>
        <p:sp>
          <p:nvSpPr>
            <p:cNvPr id="385" name="Rectangle 60"/>
            <p:cNvSpPr>
              <a:spLocks noChangeArrowheads="1"/>
            </p:cNvSpPr>
            <p:nvPr/>
          </p:nvSpPr>
          <p:spPr bwMode="auto">
            <a:xfrm rot="16200000">
              <a:off x="3461329" y="8018011"/>
              <a:ext cx="80495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robabil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dens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89" name="Rectangle 60"/>
            <p:cNvSpPr>
              <a:spLocks noChangeArrowheads="1"/>
            </p:cNvSpPr>
            <p:nvPr/>
          </p:nvSpPr>
          <p:spPr bwMode="auto">
            <a:xfrm rot="16200000">
              <a:off x="3461329" y="5860926"/>
              <a:ext cx="80495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Probabil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r>
                <a:rPr kumimoji="0" lang="it-IT" altLang="it-IT" sz="9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density</a:t>
              </a:r>
              <a:r>
                <a:rPr kumimoji="0" lang="it-IT" altLang="it-IT" sz="900" b="1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rPr>
                <a:t> </a:t>
              </a:r>
              <a:endParaRPr kumimoji="0" lang="it-IT" altLang="it-IT" sz="1100" b="0" i="0" u="none" strike="noStrike" cap="none" normalizeH="0" baseline="0" dirty="0">
                <a:ln>
                  <a:noFill/>
                </a:ln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20900" name="Rettangolo 20899"/>
            <p:cNvSpPr/>
            <p:nvPr/>
          </p:nvSpPr>
          <p:spPr>
            <a:xfrm>
              <a:off x="1124744" y="7071144"/>
              <a:ext cx="1005403" cy="2414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it-IT" sz="1100" b="1" dirty="0">
                  <a:solidFill>
                    <a:srgbClr val="0070C0"/>
                  </a:solidFill>
                  <a:latin typeface="+mj-lt"/>
                </a:rPr>
                <a:t>HER2 </a:t>
              </a:r>
              <a:r>
                <a:rPr lang="it-IT" sz="1100" b="1" dirty="0" err="1">
                  <a:solidFill>
                    <a:srgbClr val="0070C0"/>
                  </a:solidFill>
                  <a:latin typeface="+mj-lt"/>
                </a:rPr>
                <a:t>enriched</a:t>
              </a:r>
              <a:endParaRPr lang="it-IT" sz="1100" b="1" dirty="0">
                <a:solidFill>
                  <a:srgbClr val="0070C0"/>
                </a:solidFill>
                <a:latin typeface="+mj-lt"/>
              </a:endParaRPr>
            </a:p>
          </p:txBody>
        </p:sp>
        <p:grpSp>
          <p:nvGrpSpPr>
            <p:cNvPr id="7" name="Gruppo 6"/>
            <p:cNvGrpSpPr/>
            <p:nvPr/>
          </p:nvGrpSpPr>
          <p:grpSpPr>
            <a:xfrm>
              <a:off x="260648" y="2419249"/>
              <a:ext cx="2897132" cy="2070089"/>
              <a:chOff x="260648" y="325500"/>
              <a:chExt cx="2897132" cy="2070089"/>
            </a:xfrm>
          </p:grpSpPr>
          <p:sp>
            <p:nvSpPr>
              <p:cNvPr id="2" name="Rettangolo 1"/>
              <p:cNvSpPr/>
              <p:nvPr/>
            </p:nvSpPr>
            <p:spPr>
              <a:xfrm>
                <a:off x="783885" y="325500"/>
                <a:ext cx="1997043" cy="26831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100" b="1" dirty="0">
                    <a:solidFill>
                      <a:srgbClr val="00B050"/>
                    </a:solidFill>
                    <a:latin typeface="+mj-lt"/>
                    <a:cs typeface="Arial" pitchFamily="34" charset="0"/>
                  </a:rPr>
                  <a:t>HER2-positive (non luminal)</a:t>
                </a:r>
                <a:endParaRPr lang="it-IT" sz="1100" dirty="0">
                  <a:solidFill>
                    <a:srgbClr val="00B050"/>
                  </a:solidFill>
                  <a:latin typeface="+mj-lt"/>
                </a:endParaRPr>
              </a:p>
            </p:txBody>
          </p:sp>
          <p:grpSp>
            <p:nvGrpSpPr>
              <p:cNvPr id="6" name="Group 5"/>
              <p:cNvGrpSpPr>
                <a:grpSpLocks noChangeAspect="1"/>
              </p:cNvGrpSpPr>
              <p:nvPr/>
            </p:nvGrpSpPr>
            <p:grpSpPr bwMode="auto">
              <a:xfrm>
                <a:off x="428274" y="432622"/>
                <a:ext cx="2729506" cy="1848615"/>
                <a:chOff x="583" y="-4"/>
                <a:chExt cx="2059" cy="1644"/>
              </a:xfrm>
            </p:grpSpPr>
            <p:sp>
              <p:nvSpPr>
                <p:cNvPr id="9" name="Rectangle 7"/>
                <p:cNvSpPr>
                  <a:spLocks noChangeArrowheads="1"/>
                </p:cNvSpPr>
                <p:nvPr/>
              </p:nvSpPr>
              <p:spPr bwMode="auto">
                <a:xfrm>
                  <a:off x="687" y="128"/>
                  <a:ext cx="1844" cy="1412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" name="Line 8"/>
                <p:cNvSpPr>
                  <a:spLocks noChangeShapeType="1"/>
                </p:cNvSpPr>
                <p:nvPr/>
              </p:nvSpPr>
              <p:spPr bwMode="auto">
                <a:xfrm>
                  <a:off x="687" y="1540"/>
                  <a:ext cx="1955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arrow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" name="Line 9"/>
                <p:cNvSpPr>
                  <a:spLocks noChangeShapeType="1"/>
                </p:cNvSpPr>
                <p:nvPr/>
              </p:nvSpPr>
              <p:spPr bwMode="auto">
                <a:xfrm flipV="1">
                  <a:off x="687" y="-4"/>
                  <a:ext cx="0" cy="1537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arrow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" name="Line 10"/>
                <p:cNvSpPr>
                  <a:spLocks noChangeShapeType="1"/>
                </p:cNvSpPr>
                <p:nvPr/>
              </p:nvSpPr>
              <p:spPr bwMode="auto">
                <a:xfrm flipV="1">
                  <a:off x="687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" name="Rectangle 11"/>
                <p:cNvSpPr>
                  <a:spLocks noChangeArrowheads="1"/>
                </p:cNvSpPr>
                <p:nvPr/>
              </p:nvSpPr>
              <p:spPr bwMode="auto">
                <a:xfrm>
                  <a:off x="659" y="1552"/>
                  <a:ext cx="5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1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14" name="Line 12"/>
                <p:cNvSpPr>
                  <a:spLocks noChangeShapeType="1"/>
                </p:cNvSpPr>
                <p:nvPr/>
              </p:nvSpPr>
              <p:spPr bwMode="auto">
                <a:xfrm flipV="1">
                  <a:off x="87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5" name="Rectangle 13"/>
                <p:cNvSpPr>
                  <a:spLocks noChangeArrowheads="1"/>
                </p:cNvSpPr>
                <p:nvPr/>
              </p:nvSpPr>
              <p:spPr bwMode="auto">
                <a:xfrm>
                  <a:off x="819" y="1552"/>
                  <a:ext cx="10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8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16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1055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7" name="Rectangle 15"/>
                <p:cNvSpPr>
                  <a:spLocks noChangeArrowheads="1"/>
                </p:cNvSpPr>
                <p:nvPr/>
              </p:nvSpPr>
              <p:spPr bwMode="auto">
                <a:xfrm>
                  <a:off x="1003" y="1552"/>
                  <a:ext cx="10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6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18" name="Line 16"/>
                <p:cNvSpPr>
                  <a:spLocks noChangeShapeType="1"/>
                </p:cNvSpPr>
                <p:nvPr/>
              </p:nvSpPr>
              <p:spPr bwMode="auto">
                <a:xfrm flipV="1">
                  <a:off x="1239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9" name="Rectangle 17"/>
                <p:cNvSpPr>
                  <a:spLocks noChangeArrowheads="1"/>
                </p:cNvSpPr>
                <p:nvPr/>
              </p:nvSpPr>
              <p:spPr bwMode="auto">
                <a:xfrm>
                  <a:off x="1187" y="1552"/>
                  <a:ext cx="10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4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0" name="Line 18"/>
                <p:cNvSpPr>
                  <a:spLocks noChangeShapeType="1"/>
                </p:cNvSpPr>
                <p:nvPr/>
              </p:nvSpPr>
              <p:spPr bwMode="auto">
                <a:xfrm flipV="1">
                  <a:off x="1423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1" name="Rectangle 19"/>
                <p:cNvSpPr>
                  <a:spLocks noChangeArrowheads="1"/>
                </p:cNvSpPr>
                <p:nvPr/>
              </p:nvSpPr>
              <p:spPr bwMode="auto">
                <a:xfrm>
                  <a:off x="1371" y="1552"/>
                  <a:ext cx="10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-0.2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2" name="Line 20"/>
                <p:cNvSpPr>
                  <a:spLocks noChangeShapeType="1"/>
                </p:cNvSpPr>
                <p:nvPr/>
              </p:nvSpPr>
              <p:spPr bwMode="auto">
                <a:xfrm flipV="1">
                  <a:off x="1607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3" name="Rectangle 21"/>
                <p:cNvSpPr>
                  <a:spLocks noChangeArrowheads="1"/>
                </p:cNvSpPr>
                <p:nvPr/>
              </p:nvSpPr>
              <p:spPr bwMode="auto">
                <a:xfrm>
                  <a:off x="1595" y="1552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4" name="Line 22"/>
                <p:cNvSpPr>
                  <a:spLocks noChangeShapeType="1"/>
                </p:cNvSpPr>
                <p:nvPr/>
              </p:nvSpPr>
              <p:spPr bwMode="auto">
                <a:xfrm flipV="1">
                  <a:off x="179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5" name="Rectangle 23"/>
                <p:cNvSpPr>
                  <a:spLocks noChangeArrowheads="1"/>
                </p:cNvSpPr>
                <p:nvPr/>
              </p:nvSpPr>
              <p:spPr bwMode="auto">
                <a:xfrm>
                  <a:off x="1755" y="1552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2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6" name="Line 24"/>
                <p:cNvSpPr>
                  <a:spLocks noChangeShapeType="1"/>
                </p:cNvSpPr>
                <p:nvPr/>
              </p:nvSpPr>
              <p:spPr bwMode="auto">
                <a:xfrm flipV="1">
                  <a:off x="1975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7" name="Rectangle 25"/>
                <p:cNvSpPr>
                  <a:spLocks noChangeArrowheads="1"/>
                </p:cNvSpPr>
                <p:nvPr/>
              </p:nvSpPr>
              <p:spPr bwMode="auto">
                <a:xfrm>
                  <a:off x="1939" y="1552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4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28" name="Line 26"/>
                <p:cNvSpPr>
                  <a:spLocks noChangeShapeType="1"/>
                </p:cNvSpPr>
                <p:nvPr/>
              </p:nvSpPr>
              <p:spPr bwMode="auto">
                <a:xfrm flipV="1">
                  <a:off x="2159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9" name="Rectangle 27"/>
                <p:cNvSpPr>
                  <a:spLocks noChangeArrowheads="1"/>
                </p:cNvSpPr>
                <p:nvPr/>
              </p:nvSpPr>
              <p:spPr bwMode="auto">
                <a:xfrm>
                  <a:off x="2123" y="1552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6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30" name="Line 28"/>
                <p:cNvSpPr>
                  <a:spLocks noChangeShapeType="1"/>
                </p:cNvSpPr>
                <p:nvPr/>
              </p:nvSpPr>
              <p:spPr bwMode="auto">
                <a:xfrm flipV="1">
                  <a:off x="2343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" name="Rectangle 29"/>
                <p:cNvSpPr>
                  <a:spLocks noChangeArrowheads="1"/>
                </p:cNvSpPr>
                <p:nvPr/>
              </p:nvSpPr>
              <p:spPr bwMode="auto">
                <a:xfrm>
                  <a:off x="2307" y="1552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8</a:t>
                  </a:r>
                  <a:endPara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32" name="Line 30"/>
                <p:cNvSpPr>
                  <a:spLocks noChangeShapeType="1"/>
                </p:cNvSpPr>
                <p:nvPr/>
              </p:nvSpPr>
              <p:spPr bwMode="auto">
                <a:xfrm flipV="1">
                  <a:off x="2531" y="1520"/>
                  <a:ext cx="0" cy="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3" name="Rectangle 31"/>
                <p:cNvSpPr>
                  <a:spLocks noChangeArrowheads="1"/>
                </p:cNvSpPr>
                <p:nvPr/>
              </p:nvSpPr>
              <p:spPr bwMode="auto">
                <a:xfrm>
                  <a:off x="2519" y="1552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1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34" name="Line 32"/>
                <p:cNvSpPr>
                  <a:spLocks noChangeShapeType="1"/>
                </p:cNvSpPr>
                <p:nvPr/>
              </p:nvSpPr>
              <p:spPr bwMode="auto">
                <a:xfrm>
                  <a:off x="687" y="1540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5" name="Rectangle 33"/>
                <p:cNvSpPr>
                  <a:spLocks noChangeArrowheads="1"/>
                </p:cNvSpPr>
                <p:nvPr/>
              </p:nvSpPr>
              <p:spPr bwMode="auto">
                <a:xfrm>
                  <a:off x="643" y="1508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</a:t>
                  </a:r>
                  <a:endPara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36" name="Line 34"/>
                <p:cNvSpPr>
                  <a:spLocks noChangeShapeType="1"/>
                </p:cNvSpPr>
                <p:nvPr/>
              </p:nvSpPr>
              <p:spPr bwMode="auto">
                <a:xfrm>
                  <a:off x="687" y="1304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7" name="Rectangle 35"/>
                <p:cNvSpPr>
                  <a:spLocks noChangeArrowheads="1"/>
                </p:cNvSpPr>
                <p:nvPr/>
              </p:nvSpPr>
              <p:spPr bwMode="auto">
                <a:xfrm>
                  <a:off x="583" y="1272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0.5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38" name="Line 36"/>
                <p:cNvSpPr>
                  <a:spLocks noChangeShapeType="1"/>
                </p:cNvSpPr>
                <p:nvPr/>
              </p:nvSpPr>
              <p:spPr bwMode="auto">
                <a:xfrm>
                  <a:off x="687" y="1068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9" name="Rectangle 37"/>
                <p:cNvSpPr>
                  <a:spLocks noChangeArrowheads="1"/>
                </p:cNvSpPr>
                <p:nvPr/>
              </p:nvSpPr>
              <p:spPr bwMode="auto">
                <a:xfrm>
                  <a:off x="627" y="1036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1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40" name="Line 38"/>
                <p:cNvSpPr>
                  <a:spLocks noChangeShapeType="1"/>
                </p:cNvSpPr>
                <p:nvPr/>
              </p:nvSpPr>
              <p:spPr bwMode="auto">
                <a:xfrm>
                  <a:off x="687" y="832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1" name="Rectangle 39"/>
                <p:cNvSpPr>
                  <a:spLocks noChangeArrowheads="1"/>
                </p:cNvSpPr>
                <p:nvPr/>
              </p:nvSpPr>
              <p:spPr bwMode="auto">
                <a:xfrm>
                  <a:off x="583" y="800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1.5</a:t>
                  </a:r>
                  <a:endParaRPr kumimoji="0" lang="it-IT" altLang="it-IT" sz="700" b="1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42" name="Line 40"/>
                <p:cNvSpPr>
                  <a:spLocks noChangeShapeType="1"/>
                </p:cNvSpPr>
                <p:nvPr/>
              </p:nvSpPr>
              <p:spPr bwMode="auto">
                <a:xfrm>
                  <a:off x="687" y="596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3" name="Rectangle 41"/>
                <p:cNvSpPr>
                  <a:spLocks noChangeArrowheads="1"/>
                </p:cNvSpPr>
                <p:nvPr/>
              </p:nvSpPr>
              <p:spPr bwMode="auto">
                <a:xfrm>
                  <a:off x="627" y="564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2</a:t>
                  </a:r>
                  <a:endPara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44" name="Line 42"/>
                <p:cNvSpPr>
                  <a:spLocks noChangeShapeType="1"/>
                </p:cNvSpPr>
                <p:nvPr/>
              </p:nvSpPr>
              <p:spPr bwMode="auto">
                <a:xfrm>
                  <a:off x="687" y="360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5" name="Rectangle 43"/>
                <p:cNvSpPr>
                  <a:spLocks noChangeArrowheads="1"/>
                </p:cNvSpPr>
                <p:nvPr/>
              </p:nvSpPr>
              <p:spPr bwMode="auto">
                <a:xfrm>
                  <a:off x="583" y="328"/>
                  <a:ext cx="83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2.5</a:t>
                  </a:r>
                  <a:endPara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46" name="Line 44"/>
                <p:cNvSpPr>
                  <a:spLocks noChangeShapeType="1"/>
                </p:cNvSpPr>
                <p:nvPr/>
              </p:nvSpPr>
              <p:spPr bwMode="auto">
                <a:xfrm>
                  <a:off x="687" y="128"/>
                  <a:ext cx="16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7" name="Rectangle 45"/>
                <p:cNvSpPr>
                  <a:spLocks noChangeArrowheads="1"/>
                </p:cNvSpPr>
                <p:nvPr/>
              </p:nvSpPr>
              <p:spPr bwMode="auto">
                <a:xfrm>
                  <a:off x="627" y="96"/>
                  <a:ext cx="34" cy="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7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j-lt"/>
                      <a:cs typeface="Arial" pitchFamily="34" charset="0"/>
                    </a:rPr>
                    <a:t>3</a:t>
                  </a:r>
                  <a:endParaRPr kumimoji="0" lang="it-IT" altLang="it-IT" sz="7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j-lt"/>
                    <a:cs typeface="Arial" pitchFamily="34" charset="0"/>
                  </a:endParaRPr>
                </a:p>
              </p:txBody>
            </p:sp>
            <p:sp>
              <p:nvSpPr>
                <p:cNvPr id="48" name="Freeform 46"/>
                <p:cNvSpPr>
                  <a:spLocks/>
                </p:cNvSpPr>
                <p:nvPr/>
              </p:nvSpPr>
              <p:spPr bwMode="auto">
                <a:xfrm>
                  <a:off x="775" y="144"/>
                  <a:ext cx="1740" cy="1392"/>
                </a:xfrm>
                <a:custGeom>
                  <a:avLst/>
                  <a:gdLst>
                    <a:gd name="T0" fmla="*/ 16 w 1740"/>
                    <a:gd name="T1" fmla="*/ 1392 h 1392"/>
                    <a:gd name="T2" fmla="*/ 52 w 1740"/>
                    <a:gd name="T3" fmla="*/ 1392 h 1392"/>
                    <a:gd name="T4" fmla="*/ 88 w 1740"/>
                    <a:gd name="T5" fmla="*/ 1392 h 1392"/>
                    <a:gd name="T6" fmla="*/ 124 w 1740"/>
                    <a:gd name="T7" fmla="*/ 1392 h 1392"/>
                    <a:gd name="T8" fmla="*/ 160 w 1740"/>
                    <a:gd name="T9" fmla="*/ 1388 h 1392"/>
                    <a:gd name="T10" fmla="*/ 192 w 1740"/>
                    <a:gd name="T11" fmla="*/ 1388 h 1392"/>
                    <a:gd name="T12" fmla="*/ 228 w 1740"/>
                    <a:gd name="T13" fmla="*/ 1384 h 1392"/>
                    <a:gd name="T14" fmla="*/ 264 w 1740"/>
                    <a:gd name="T15" fmla="*/ 1388 h 1392"/>
                    <a:gd name="T16" fmla="*/ 300 w 1740"/>
                    <a:gd name="T17" fmla="*/ 1388 h 1392"/>
                    <a:gd name="T18" fmla="*/ 332 w 1740"/>
                    <a:gd name="T19" fmla="*/ 1380 h 1392"/>
                    <a:gd name="T20" fmla="*/ 368 w 1740"/>
                    <a:gd name="T21" fmla="*/ 1364 h 1392"/>
                    <a:gd name="T22" fmla="*/ 404 w 1740"/>
                    <a:gd name="T23" fmla="*/ 1312 h 1392"/>
                    <a:gd name="T24" fmla="*/ 440 w 1740"/>
                    <a:gd name="T25" fmla="*/ 1188 h 1392"/>
                    <a:gd name="T26" fmla="*/ 476 w 1740"/>
                    <a:gd name="T27" fmla="*/ 1036 h 1392"/>
                    <a:gd name="T28" fmla="*/ 508 w 1740"/>
                    <a:gd name="T29" fmla="*/ 960 h 1392"/>
                    <a:gd name="T30" fmla="*/ 544 w 1740"/>
                    <a:gd name="T31" fmla="*/ 1012 h 1392"/>
                    <a:gd name="T32" fmla="*/ 580 w 1740"/>
                    <a:gd name="T33" fmla="*/ 1120 h 1392"/>
                    <a:gd name="T34" fmla="*/ 616 w 1740"/>
                    <a:gd name="T35" fmla="*/ 1208 h 1392"/>
                    <a:gd name="T36" fmla="*/ 652 w 1740"/>
                    <a:gd name="T37" fmla="*/ 1268 h 1392"/>
                    <a:gd name="T38" fmla="*/ 684 w 1740"/>
                    <a:gd name="T39" fmla="*/ 1308 h 1392"/>
                    <a:gd name="T40" fmla="*/ 720 w 1740"/>
                    <a:gd name="T41" fmla="*/ 1332 h 1392"/>
                    <a:gd name="T42" fmla="*/ 756 w 1740"/>
                    <a:gd name="T43" fmla="*/ 1336 h 1392"/>
                    <a:gd name="T44" fmla="*/ 792 w 1740"/>
                    <a:gd name="T45" fmla="*/ 1336 h 1392"/>
                    <a:gd name="T46" fmla="*/ 828 w 1740"/>
                    <a:gd name="T47" fmla="*/ 1336 h 1392"/>
                    <a:gd name="T48" fmla="*/ 860 w 1740"/>
                    <a:gd name="T49" fmla="*/ 1348 h 1392"/>
                    <a:gd name="T50" fmla="*/ 896 w 1740"/>
                    <a:gd name="T51" fmla="*/ 1352 h 1392"/>
                    <a:gd name="T52" fmla="*/ 932 w 1740"/>
                    <a:gd name="T53" fmla="*/ 1340 h 1392"/>
                    <a:gd name="T54" fmla="*/ 968 w 1740"/>
                    <a:gd name="T55" fmla="*/ 1324 h 1392"/>
                    <a:gd name="T56" fmla="*/ 1004 w 1740"/>
                    <a:gd name="T57" fmla="*/ 1304 h 1392"/>
                    <a:gd name="T58" fmla="*/ 1036 w 1740"/>
                    <a:gd name="T59" fmla="*/ 1300 h 1392"/>
                    <a:gd name="T60" fmla="*/ 1072 w 1740"/>
                    <a:gd name="T61" fmla="*/ 1288 h 1392"/>
                    <a:gd name="T62" fmla="*/ 1108 w 1740"/>
                    <a:gd name="T63" fmla="*/ 1220 h 1392"/>
                    <a:gd name="T64" fmla="*/ 1144 w 1740"/>
                    <a:gd name="T65" fmla="*/ 1028 h 1392"/>
                    <a:gd name="T66" fmla="*/ 1180 w 1740"/>
                    <a:gd name="T67" fmla="*/ 672 h 1392"/>
                    <a:gd name="T68" fmla="*/ 1212 w 1740"/>
                    <a:gd name="T69" fmla="*/ 232 h 1392"/>
                    <a:gd name="T70" fmla="*/ 1248 w 1740"/>
                    <a:gd name="T71" fmla="*/ 0 h 1392"/>
                    <a:gd name="T72" fmla="*/ 1284 w 1740"/>
                    <a:gd name="T73" fmla="*/ 192 h 1392"/>
                    <a:gd name="T74" fmla="*/ 1320 w 1740"/>
                    <a:gd name="T75" fmla="*/ 608 h 1392"/>
                    <a:gd name="T76" fmla="*/ 1352 w 1740"/>
                    <a:gd name="T77" fmla="*/ 908 h 1392"/>
                    <a:gd name="T78" fmla="*/ 1388 w 1740"/>
                    <a:gd name="T79" fmla="*/ 1024 h 1392"/>
                    <a:gd name="T80" fmla="*/ 1424 w 1740"/>
                    <a:gd name="T81" fmla="*/ 1044 h 1392"/>
                    <a:gd name="T82" fmla="*/ 1460 w 1740"/>
                    <a:gd name="T83" fmla="*/ 988 h 1392"/>
                    <a:gd name="T84" fmla="*/ 1496 w 1740"/>
                    <a:gd name="T85" fmla="*/ 876 h 1392"/>
                    <a:gd name="T86" fmla="*/ 1528 w 1740"/>
                    <a:gd name="T87" fmla="*/ 804 h 1392"/>
                    <a:gd name="T88" fmla="*/ 1564 w 1740"/>
                    <a:gd name="T89" fmla="*/ 908 h 1392"/>
                    <a:gd name="T90" fmla="*/ 1600 w 1740"/>
                    <a:gd name="T91" fmla="*/ 1136 h 1392"/>
                    <a:gd name="T92" fmla="*/ 1636 w 1740"/>
                    <a:gd name="T93" fmla="*/ 1308 h 1392"/>
                    <a:gd name="T94" fmla="*/ 1672 w 1740"/>
                    <a:gd name="T95" fmla="*/ 1376 h 1392"/>
                    <a:gd name="T96" fmla="*/ 1704 w 1740"/>
                    <a:gd name="T97" fmla="*/ 1392 h 1392"/>
                    <a:gd name="T98" fmla="*/ 1740 w 1740"/>
                    <a:gd name="T99" fmla="*/ 1392 h 13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1740" h="1392">
                      <a:moveTo>
                        <a:pt x="0" y="1392"/>
                      </a:moveTo>
                      <a:lnTo>
                        <a:pt x="16" y="1392"/>
                      </a:lnTo>
                      <a:lnTo>
                        <a:pt x="36" y="1392"/>
                      </a:lnTo>
                      <a:lnTo>
                        <a:pt x="52" y="1392"/>
                      </a:lnTo>
                      <a:lnTo>
                        <a:pt x="72" y="1392"/>
                      </a:lnTo>
                      <a:lnTo>
                        <a:pt x="88" y="1392"/>
                      </a:lnTo>
                      <a:lnTo>
                        <a:pt x="104" y="1392"/>
                      </a:lnTo>
                      <a:lnTo>
                        <a:pt x="124" y="1392"/>
                      </a:lnTo>
                      <a:lnTo>
                        <a:pt x="140" y="1392"/>
                      </a:lnTo>
                      <a:lnTo>
                        <a:pt x="160" y="1388"/>
                      </a:lnTo>
                      <a:lnTo>
                        <a:pt x="176" y="1388"/>
                      </a:lnTo>
                      <a:lnTo>
                        <a:pt x="192" y="1388"/>
                      </a:lnTo>
                      <a:lnTo>
                        <a:pt x="212" y="1384"/>
                      </a:lnTo>
                      <a:lnTo>
                        <a:pt x="228" y="1384"/>
                      </a:lnTo>
                      <a:lnTo>
                        <a:pt x="248" y="1384"/>
                      </a:lnTo>
                      <a:lnTo>
                        <a:pt x="264" y="1388"/>
                      </a:lnTo>
                      <a:lnTo>
                        <a:pt x="280" y="1388"/>
                      </a:lnTo>
                      <a:lnTo>
                        <a:pt x="300" y="1388"/>
                      </a:lnTo>
                      <a:lnTo>
                        <a:pt x="316" y="1384"/>
                      </a:lnTo>
                      <a:lnTo>
                        <a:pt x="332" y="1380"/>
                      </a:lnTo>
                      <a:lnTo>
                        <a:pt x="352" y="1376"/>
                      </a:lnTo>
                      <a:lnTo>
                        <a:pt x="368" y="1364"/>
                      </a:lnTo>
                      <a:lnTo>
                        <a:pt x="388" y="1344"/>
                      </a:lnTo>
                      <a:lnTo>
                        <a:pt x="404" y="1312"/>
                      </a:lnTo>
                      <a:lnTo>
                        <a:pt x="420" y="1256"/>
                      </a:lnTo>
                      <a:lnTo>
                        <a:pt x="440" y="1188"/>
                      </a:lnTo>
                      <a:lnTo>
                        <a:pt x="456" y="1108"/>
                      </a:lnTo>
                      <a:lnTo>
                        <a:pt x="476" y="1036"/>
                      </a:lnTo>
                      <a:lnTo>
                        <a:pt x="492" y="984"/>
                      </a:lnTo>
                      <a:lnTo>
                        <a:pt x="508" y="960"/>
                      </a:lnTo>
                      <a:lnTo>
                        <a:pt x="528" y="972"/>
                      </a:lnTo>
                      <a:lnTo>
                        <a:pt x="544" y="1012"/>
                      </a:lnTo>
                      <a:lnTo>
                        <a:pt x="564" y="1064"/>
                      </a:lnTo>
                      <a:lnTo>
                        <a:pt x="580" y="1120"/>
                      </a:lnTo>
                      <a:lnTo>
                        <a:pt x="596" y="1168"/>
                      </a:lnTo>
                      <a:lnTo>
                        <a:pt x="616" y="1208"/>
                      </a:lnTo>
                      <a:lnTo>
                        <a:pt x="632" y="1244"/>
                      </a:lnTo>
                      <a:lnTo>
                        <a:pt x="652" y="1268"/>
                      </a:lnTo>
                      <a:lnTo>
                        <a:pt x="668" y="1292"/>
                      </a:lnTo>
                      <a:lnTo>
                        <a:pt x="684" y="1308"/>
                      </a:lnTo>
                      <a:lnTo>
                        <a:pt x="704" y="1320"/>
                      </a:lnTo>
                      <a:lnTo>
                        <a:pt x="720" y="1332"/>
                      </a:lnTo>
                      <a:lnTo>
                        <a:pt x="740" y="1336"/>
                      </a:lnTo>
                      <a:lnTo>
                        <a:pt x="756" y="1336"/>
                      </a:lnTo>
                      <a:lnTo>
                        <a:pt x="772" y="1336"/>
                      </a:lnTo>
                      <a:lnTo>
                        <a:pt x="792" y="1336"/>
                      </a:lnTo>
                      <a:lnTo>
                        <a:pt x="808" y="1336"/>
                      </a:lnTo>
                      <a:lnTo>
                        <a:pt x="828" y="1336"/>
                      </a:lnTo>
                      <a:lnTo>
                        <a:pt x="844" y="1340"/>
                      </a:lnTo>
                      <a:lnTo>
                        <a:pt x="860" y="1348"/>
                      </a:lnTo>
                      <a:lnTo>
                        <a:pt x="880" y="1352"/>
                      </a:lnTo>
                      <a:lnTo>
                        <a:pt x="896" y="1352"/>
                      </a:lnTo>
                      <a:lnTo>
                        <a:pt x="916" y="1348"/>
                      </a:lnTo>
                      <a:lnTo>
                        <a:pt x="932" y="1340"/>
                      </a:lnTo>
                      <a:lnTo>
                        <a:pt x="948" y="1332"/>
                      </a:lnTo>
                      <a:lnTo>
                        <a:pt x="968" y="1324"/>
                      </a:lnTo>
                      <a:lnTo>
                        <a:pt x="984" y="1312"/>
                      </a:lnTo>
                      <a:lnTo>
                        <a:pt x="1004" y="1304"/>
                      </a:lnTo>
                      <a:lnTo>
                        <a:pt x="1020" y="1300"/>
                      </a:lnTo>
                      <a:lnTo>
                        <a:pt x="1036" y="1300"/>
                      </a:lnTo>
                      <a:lnTo>
                        <a:pt x="1056" y="1296"/>
                      </a:lnTo>
                      <a:lnTo>
                        <a:pt x="1072" y="1288"/>
                      </a:lnTo>
                      <a:lnTo>
                        <a:pt x="1092" y="1264"/>
                      </a:lnTo>
                      <a:lnTo>
                        <a:pt x="1108" y="1220"/>
                      </a:lnTo>
                      <a:lnTo>
                        <a:pt x="1124" y="1144"/>
                      </a:lnTo>
                      <a:lnTo>
                        <a:pt x="1144" y="1028"/>
                      </a:lnTo>
                      <a:lnTo>
                        <a:pt x="1160" y="868"/>
                      </a:lnTo>
                      <a:lnTo>
                        <a:pt x="1180" y="672"/>
                      </a:lnTo>
                      <a:lnTo>
                        <a:pt x="1196" y="448"/>
                      </a:lnTo>
                      <a:lnTo>
                        <a:pt x="1212" y="232"/>
                      </a:lnTo>
                      <a:lnTo>
                        <a:pt x="1232" y="68"/>
                      </a:lnTo>
                      <a:lnTo>
                        <a:pt x="1248" y="0"/>
                      </a:lnTo>
                      <a:lnTo>
                        <a:pt x="1268" y="44"/>
                      </a:lnTo>
                      <a:lnTo>
                        <a:pt x="1284" y="192"/>
                      </a:lnTo>
                      <a:lnTo>
                        <a:pt x="1300" y="400"/>
                      </a:lnTo>
                      <a:lnTo>
                        <a:pt x="1320" y="608"/>
                      </a:lnTo>
                      <a:lnTo>
                        <a:pt x="1336" y="784"/>
                      </a:lnTo>
                      <a:lnTo>
                        <a:pt x="1352" y="908"/>
                      </a:lnTo>
                      <a:lnTo>
                        <a:pt x="1372" y="984"/>
                      </a:lnTo>
                      <a:lnTo>
                        <a:pt x="1388" y="1024"/>
                      </a:lnTo>
                      <a:lnTo>
                        <a:pt x="1408" y="1044"/>
                      </a:lnTo>
                      <a:lnTo>
                        <a:pt x="1424" y="1044"/>
                      </a:lnTo>
                      <a:lnTo>
                        <a:pt x="1440" y="1024"/>
                      </a:lnTo>
                      <a:lnTo>
                        <a:pt x="1460" y="988"/>
                      </a:lnTo>
                      <a:lnTo>
                        <a:pt x="1476" y="936"/>
                      </a:lnTo>
                      <a:lnTo>
                        <a:pt x="1496" y="876"/>
                      </a:lnTo>
                      <a:lnTo>
                        <a:pt x="1512" y="824"/>
                      </a:lnTo>
                      <a:lnTo>
                        <a:pt x="1528" y="804"/>
                      </a:lnTo>
                      <a:lnTo>
                        <a:pt x="1548" y="832"/>
                      </a:lnTo>
                      <a:lnTo>
                        <a:pt x="1564" y="908"/>
                      </a:lnTo>
                      <a:lnTo>
                        <a:pt x="1584" y="1020"/>
                      </a:lnTo>
                      <a:lnTo>
                        <a:pt x="1600" y="1136"/>
                      </a:lnTo>
                      <a:lnTo>
                        <a:pt x="1616" y="1236"/>
                      </a:lnTo>
                      <a:lnTo>
                        <a:pt x="1636" y="1308"/>
                      </a:lnTo>
                      <a:lnTo>
                        <a:pt x="1652" y="1352"/>
                      </a:lnTo>
                      <a:lnTo>
                        <a:pt x="1672" y="1376"/>
                      </a:lnTo>
                      <a:lnTo>
                        <a:pt x="1688" y="1388"/>
                      </a:lnTo>
                      <a:lnTo>
                        <a:pt x="1704" y="1392"/>
                      </a:lnTo>
                      <a:lnTo>
                        <a:pt x="1724" y="1392"/>
                      </a:lnTo>
                      <a:lnTo>
                        <a:pt x="1740" y="1392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378" name="Rectangle 59"/>
              <p:cNvSpPr>
                <a:spLocks noChangeArrowheads="1"/>
              </p:cNvSpPr>
              <p:nvPr/>
            </p:nvSpPr>
            <p:spPr bwMode="auto">
              <a:xfrm>
                <a:off x="648680" y="2267744"/>
                <a:ext cx="2159245" cy="1278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Average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Pearson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Correlation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Coefficient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(APCC)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379" name="Rectangle 60"/>
              <p:cNvSpPr>
                <a:spLocks noChangeArrowheads="1"/>
              </p:cNvSpPr>
              <p:nvPr/>
            </p:nvSpPr>
            <p:spPr bwMode="auto">
              <a:xfrm rot="16200000">
                <a:off x="-72580" y="1227964"/>
                <a:ext cx="804955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Probability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density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endParaRPr>
              </a:p>
            </p:txBody>
          </p:sp>
          <p:cxnSp>
            <p:nvCxnSpPr>
              <p:cNvPr id="8" name="Connettore 2 7"/>
              <p:cNvCxnSpPr/>
              <p:nvPr/>
            </p:nvCxnSpPr>
            <p:spPr>
              <a:xfrm>
                <a:off x="1196752" y="1426264"/>
                <a:ext cx="97282" cy="19340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9" name="Rectangle 59"/>
              <p:cNvSpPr>
                <a:spLocks noChangeArrowheads="1"/>
              </p:cNvSpPr>
              <p:nvPr/>
            </p:nvSpPr>
            <p:spPr bwMode="auto">
              <a:xfrm>
                <a:off x="902467" y="1280537"/>
                <a:ext cx="607539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 err="1">
                    <a:latin typeface="+mj-lt"/>
                  </a:rPr>
                  <a:t>f</a:t>
                </a:r>
                <a:r>
                  <a:rPr kumimoji="0" lang="it-IT" altLang="it-IT" sz="8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</a:rPr>
                  <a:t>ight</a:t>
                </a:r>
                <a:r>
                  <a:rPr lang="it-IT" altLang="it-IT" sz="800" b="1" dirty="0">
                    <a:latin typeface="+mj-lt"/>
                  </a:rPr>
                  <a:t>-club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sp>
            <p:nvSpPr>
              <p:cNvPr id="370" name="Rectangle 59"/>
              <p:cNvSpPr>
                <a:spLocks noChangeArrowheads="1"/>
              </p:cNvSpPr>
              <p:nvPr/>
            </p:nvSpPr>
            <p:spPr bwMode="auto">
              <a:xfrm>
                <a:off x="1720916" y="776481"/>
                <a:ext cx="403957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>
                    <a:latin typeface="+mj-lt"/>
                  </a:rPr>
                  <a:t>date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sp>
            <p:nvSpPr>
              <p:cNvPr id="371" name="Rectangle 59"/>
              <p:cNvSpPr>
                <a:spLocks noChangeArrowheads="1"/>
              </p:cNvSpPr>
              <p:nvPr/>
            </p:nvSpPr>
            <p:spPr bwMode="auto">
              <a:xfrm>
                <a:off x="2687318" y="1123821"/>
                <a:ext cx="434414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>
                    <a:latin typeface="+mj-lt"/>
                  </a:rPr>
                  <a:t>party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cxnSp>
            <p:nvCxnSpPr>
              <p:cNvPr id="373" name="Connettore 2 372"/>
              <p:cNvCxnSpPr/>
              <p:nvPr/>
            </p:nvCxnSpPr>
            <p:spPr>
              <a:xfrm flipV="1">
                <a:off x="2124167" y="635167"/>
                <a:ext cx="152705" cy="12040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0" name="Connettore 2 389"/>
              <p:cNvCxnSpPr/>
              <p:nvPr/>
            </p:nvCxnSpPr>
            <p:spPr>
              <a:xfrm flipH="1">
                <a:off x="2749943" y="1259632"/>
                <a:ext cx="102993" cy="17900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1" name="Rectangle 59"/>
            <p:cNvSpPr>
              <a:spLocks noChangeArrowheads="1"/>
            </p:cNvSpPr>
            <p:nvPr/>
          </p:nvSpPr>
          <p:spPr bwMode="auto">
            <a:xfrm>
              <a:off x="4293096" y="1403648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392" name="Rectangle 59"/>
            <p:cNvSpPr>
              <a:spLocks noChangeArrowheads="1"/>
            </p:cNvSpPr>
            <p:nvPr/>
          </p:nvSpPr>
          <p:spPr bwMode="auto">
            <a:xfrm>
              <a:off x="5157192" y="611560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393" name="Rectangle 59"/>
            <p:cNvSpPr>
              <a:spLocks noChangeArrowheads="1"/>
            </p:cNvSpPr>
            <p:nvPr/>
          </p:nvSpPr>
          <p:spPr bwMode="auto">
            <a:xfrm>
              <a:off x="6077947" y="1352545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cxnSp>
          <p:nvCxnSpPr>
            <p:cNvPr id="394" name="Connettore 2 393"/>
            <p:cNvCxnSpPr/>
            <p:nvPr/>
          </p:nvCxnSpPr>
          <p:spPr>
            <a:xfrm>
              <a:off x="4699870" y="1547664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" name="Connettore 2 394"/>
            <p:cNvCxnSpPr/>
            <p:nvPr/>
          </p:nvCxnSpPr>
          <p:spPr>
            <a:xfrm flipH="1">
              <a:off x="6191792" y="1504468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6" name="Connettore 2 395"/>
            <p:cNvCxnSpPr/>
            <p:nvPr/>
          </p:nvCxnSpPr>
          <p:spPr>
            <a:xfrm>
              <a:off x="5633690" y="695371"/>
              <a:ext cx="175567" cy="13600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7" name="Rectangle 59"/>
            <p:cNvSpPr>
              <a:spLocks noChangeArrowheads="1"/>
            </p:cNvSpPr>
            <p:nvPr/>
          </p:nvSpPr>
          <p:spPr bwMode="auto">
            <a:xfrm>
              <a:off x="4221088" y="3347864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398" name="Rectangle 59"/>
            <p:cNvSpPr>
              <a:spLocks noChangeArrowheads="1"/>
            </p:cNvSpPr>
            <p:nvPr/>
          </p:nvSpPr>
          <p:spPr bwMode="auto">
            <a:xfrm>
              <a:off x="5025237" y="2936721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399" name="Rectangle 59"/>
            <p:cNvSpPr>
              <a:spLocks noChangeArrowheads="1"/>
            </p:cNvSpPr>
            <p:nvPr/>
          </p:nvSpPr>
          <p:spPr bwMode="auto">
            <a:xfrm>
              <a:off x="6005939" y="3328814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cxnSp>
          <p:nvCxnSpPr>
            <p:cNvPr id="400" name="Connettore 2 399"/>
            <p:cNvCxnSpPr/>
            <p:nvPr/>
          </p:nvCxnSpPr>
          <p:spPr>
            <a:xfrm flipV="1">
              <a:off x="5407302" y="2806502"/>
              <a:ext cx="152705" cy="12040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Connettore 2 400"/>
            <p:cNvCxnSpPr/>
            <p:nvPr/>
          </p:nvCxnSpPr>
          <p:spPr>
            <a:xfrm flipH="1">
              <a:off x="6088799" y="3486758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2" name="Connettore 2 401"/>
            <p:cNvCxnSpPr/>
            <p:nvPr/>
          </p:nvCxnSpPr>
          <p:spPr>
            <a:xfrm>
              <a:off x="4626312" y="3539656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6" name="Rectangle 59"/>
            <p:cNvSpPr>
              <a:spLocks noChangeArrowheads="1"/>
            </p:cNvSpPr>
            <p:nvPr/>
          </p:nvSpPr>
          <p:spPr bwMode="auto">
            <a:xfrm>
              <a:off x="686443" y="5868144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07" name="Rectangle 59"/>
            <p:cNvSpPr>
              <a:spLocks noChangeArrowheads="1"/>
            </p:cNvSpPr>
            <p:nvPr/>
          </p:nvSpPr>
          <p:spPr bwMode="auto">
            <a:xfrm>
              <a:off x="1682792" y="5569333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08" name="Rectangle 59"/>
            <p:cNvSpPr>
              <a:spLocks noChangeArrowheads="1"/>
            </p:cNvSpPr>
            <p:nvPr/>
          </p:nvSpPr>
          <p:spPr bwMode="auto">
            <a:xfrm>
              <a:off x="2471294" y="5508104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09" name="Rectangle 59"/>
            <p:cNvSpPr>
              <a:spLocks noChangeArrowheads="1"/>
            </p:cNvSpPr>
            <p:nvPr/>
          </p:nvSpPr>
          <p:spPr bwMode="auto">
            <a:xfrm>
              <a:off x="4229013" y="6012160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0" name="Rectangle 59"/>
            <p:cNvSpPr>
              <a:spLocks noChangeArrowheads="1"/>
            </p:cNvSpPr>
            <p:nvPr/>
          </p:nvSpPr>
          <p:spPr bwMode="auto">
            <a:xfrm>
              <a:off x="5241261" y="5652120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1" name="Rectangle 59"/>
            <p:cNvSpPr>
              <a:spLocks noChangeArrowheads="1"/>
            </p:cNvSpPr>
            <p:nvPr/>
          </p:nvSpPr>
          <p:spPr bwMode="auto">
            <a:xfrm>
              <a:off x="6006820" y="6233031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2" name="Rectangle 59"/>
            <p:cNvSpPr>
              <a:spLocks noChangeArrowheads="1"/>
            </p:cNvSpPr>
            <p:nvPr/>
          </p:nvSpPr>
          <p:spPr bwMode="auto">
            <a:xfrm>
              <a:off x="4149080" y="7884368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3" name="Rectangle 59"/>
            <p:cNvSpPr>
              <a:spLocks noChangeArrowheads="1"/>
            </p:cNvSpPr>
            <p:nvPr/>
          </p:nvSpPr>
          <p:spPr bwMode="auto">
            <a:xfrm>
              <a:off x="5085184" y="7617241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4" name="Rectangle 59"/>
            <p:cNvSpPr>
              <a:spLocks noChangeArrowheads="1"/>
            </p:cNvSpPr>
            <p:nvPr/>
          </p:nvSpPr>
          <p:spPr bwMode="auto">
            <a:xfrm>
              <a:off x="6077947" y="8172400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5" name="Rectangle 59"/>
            <p:cNvSpPr>
              <a:spLocks noChangeArrowheads="1"/>
            </p:cNvSpPr>
            <p:nvPr/>
          </p:nvSpPr>
          <p:spPr bwMode="auto">
            <a:xfrm>
              <a:off x="670498" y="7833265"/>
              <a:ext cx="607539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 err="1">
                  <a:latin typeface="+mj-lt"/>
                </a:rPr>
                <a:t>f</a:t>
              </a:r>
              <a:r>
                <a:rPr kumimoji="0" lang="it-IT" altLang="it-IT" sz="800" b="1" i="0" u="none" strike="noStrike" cap="none" normalizeH="0" baseline="0" dirty="0" err="1">
                  <a:ln>
                    <a:noFill/>
                  </a:ln>
                  <a:effectLst/>
                  <a:latin typeface="+mj-lt"/>
                </a:rPr>
                <a:t>ight</a:t>
              </a:r>
              <a:r>
                <a:rPr lang="it-IT" altLang="it-IT" sz="800" b="1" dirty="0">
                  <a:latin typeface="+mj-lt"/>
                </a:rPr>
                <a:t>-club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6" name="Rectangle 59"/>
            <p:cNvSpPr>
              <a:spLocks noChangeArrowheads="1"/>
            </p:cNvSpPr>
            <p:nvPr/>
          </p:nvSpPr>
          <p:spPr bwMode="auto">
            <a:xfrm>
              <a:off x="1510922" y="7541671"/>
              <a:ext cx="403957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date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sp>
          <p:nvSpPr>
            <p:cNvPr id="417" name="Rectangle 59"/>
            <p:cNvSpPr>
              <a:spLocks noChangeArrowheads="1"/>
            </p:cNvSpPr>
            <p:nvPr/>
          </p:nvSpPr>
          <p:spPr bwMode="auto">
            <a:xfrm>
              <a:off x="2449346" y="8028384"/>
              <a:ext cx="434414" cy="113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800" b="1" dirty="0">
                  <a:latin typeface="+mj-lt"/>
                </a:rPr>
                <a:t>party </a:t>
              </a:r>
              <a:r>
                <a:rPr lang="it-IT" altLang="it-IT" sz="800" b="1" dirty="0" err="1">
                  <a:latin typeface="+mj-lt"/>
                </a:rPr>
                <a:t>hubs</a:t>
              </a:r>
              <a:endParaRPr kumimoji="0" lang="it-IT" altLang="it-IT" sz="1050" b="1" i="0" u="none" strike="noStrike" cap="none" normalizeH="0" baseline="0" dirty="0">
                <a:ln>
                  <a:noFill/>
                </a:ln>
                <a:effectLst/>
                <a:latin typeface="+mj-lt"/>
              </a:endParaRPr>
            </a:p>
          </p:txBody>
        </p:sp>
        <p:cxnSp>
          <p:nvCxnSpPr>
            <p:cNvPr id="421" name="Connettore 2 420"/>
            <p:cNvCxnSpPr/>
            <p:nvPr/>
          </p:nvCxnSpPr>
          <p:spPr>
            <a:xfrm>
              <a:off x="1068375" y="6047850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Connettore 2 421"/>
            <p:cNvCxnSpPr/>
            <p:nvPr/>
          </p:nvCxnSpPr>
          <p:spPr>
            <a:xfrm flipV="1">
              <a:off x="1981932" y="5394895"/>
              <a:ext cx="182980" cy="14686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3" name="Connettore 2 422"/>
            <p:cNvCxnSpPr/>
            <p:nvPr/>
          </p:nvCxnSpPr>
          <p:spPr>
            <a:xfrm flipH="1">
              <a:off x="2496894" y="5663918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4" name="Connettore 2 423"/>
            <p:cNvCxnSpPr/>
            <p:nvPr/>
          </p:nvCxnSpPr>
          <p:spPr>
            <a:xfrm>
              <a:off x="4433465" y="6167952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Connettore 2 424"/>
            <p:cNvCxnSpPr/>
            <p:nvPr/>
          </p:nvCxnSpPr>
          <p:spPr>
            <a:xfrm flipH="1">
              <a:off x="6014287" y="6398433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Connettore 2 425"/>
            <p:cNvCxnSpPr/>
            <p:nvPr/>
          </p:nvCxnSpPr>
          <p:spPr>
            <a:xfrm flipV="1">
              <a:off x="5544791" y="5441114"/>
              <a:ext cx="182980" cy="14686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7" name="Connettore 2 426"/>
            <p:cNvCxnSpPr/>
            <p:nvPr/>
          </p:nvCxnSpPr>
          <p:spPr>
            <a:xfrm flipH="1">
              <a:off x="6063694" y="8365209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Connettore 2 427"/>
            <p:cNvCxnSpPr/>
            <p:nvPr/>
          </p:nvCxnSpPr>
          <p:spPr>
            <a:xfrm flipV="1">
              <a:off x="5392164" y="7439014"/>
              <a:ext cx="182980" cy="14686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9" name="Connettore 2 428"/>
            <p:cNvCxnSpPr/>
            <p:nvPr/>
          </p:nvCxnSpPr>
          <p:spPr>
            <a:xfrm>
              <a:off x="4555854" y="8028384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0" name="Connettore 2 429"/>
            <p:cNvCxnSpPr/>
            <p:nvPr/>
          </p:nvCxnSpPr>
          <p:spPr>
            <a:xfrm>
              <a:off x="1024967" y="8034567"/>
              <a:ext cx="97282" cy="19340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1" name="Connettore 2 430"/>
            <p:cNvCxnSpPr/>
            <p:nvPr/>
          </p:nvCxnSpPr>
          <p:spPr>
            <a:xfrm flipV="1">
              <a:off x="1951352" y="7413428"/>
              <a:ext cx="182980" cy="14686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2" name="Connettore 2 431"/>
            <p:cNvCxnSpPr/>
            <p:nvPr/>
          </p:nvCxnSpPr>
          <p:spPr>
            <a:xfrm flipH="1">
              <a:off x="2547759" y="8204799"/>
              <a:ext cx="102993" cy="179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33" name="Gruppo 432"/>
            <p:cNvGrpSpPr/>
            <p:nvPr/>
          </p:nvGrpSpPr>
          <p:grpSpPr>
            <a:xfrm>
              <a:off x="260649" y="251520"/>
              <a:ext cx="2853310" cy="2117647"/>
              <a:chOff x="260649" y="2438182"/>
              <a:chExt cx="2853310" cy="2117647"/>
            </a:xfrm>
          </p:grpSpPr>
          <p:sp>
            <p:nvSpPr>
              <p:cNvPr id="434" name="Rettangolo 433"/>
              <p:cNvSpPr/>
              <p:nvPr/>
            </p:nvSpPr>
            <p:spPr>
              <a:xfrm>
                <a:off x="841736" y="2438182"/>
                <a:ext cx="1468672" cy="2414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solidFill>
                      <a:srgbClr val="00B050"/>
                    </a:solidFill>
                    <a:latin typeface="+mj-lt"/>
                  </a:rPr>
                  <a:t>Luminal HER2-negative</a:t>
                </a:r>
                <a:endParaRPr lang="it-IT" sz="1100" b="1" dirty="0">
                  <a:solidFill>
                    <a:srgbClr val="00B050"/>
                  </a:solidFill>
                  <a:latin typeface="+mj-lt"/>
                </a:endParaRPr>
              </a:p>
            </p:txBody>
          </p:sp>
          <p:sp>
            <p:nvSpPr>
              <p:cNvPr id="435" name="Rectangle 59"/>
              <p:cNvSpPr>
                <a:spLocks noChangeArrowheads="1"/>
              </p:cNvSpPr>
              <p:nvPr/>
            </p:nvSpPr>
            <p:spPr bwMode="auto">
              <a:xfrm>
                <a:off x="638426" y="4427984"/>
                <a:ext cx="2159245" cy="1278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Average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Pearson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Correlation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it-IT" altLang="it-IT" sz="9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Coefficient</a:t>
                </a:r>
                <a:r>
                  <a:rPr kumimoji="0" lang="it-IT" altLang="it-IT" sz="900" b="1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rPr>
                  <a:t> (APCC)</a:t>
                </a:r>
                <a:endParaRPr kumimoji="0" lang="it-IT" altLang="it-IT" sz="1100" b="0" i="0" u="none" strike="noStrike" cap="none" normalizeH="0" baseline="0" dirty="0">
                  <a:ln>
                    <a:noFill/>
                  </a:ln>
                  <a:effectLst/>
                  <a:latin typeface="+mj-lt"/>
                  <a:cs typeface="Arial" pitchFamily="34" charset="0"/>
                </a:endParaRPr>
              </a:p>
            </p:txBody>
          </p:sp>
          <p:grpSp>
            <p:nvGrpSpPr>
              <p:cNvPr id="436" name="Gruppo 435"/>
              <p:cNvGrpSpPr/>
              <p:nvPr/>
            </p:nvGrpSpPr>
            <p:grpSpPr>
              <a:xfrm>
                <a:off x="260649" y="2535584"/>
                <a:ext cx="2853310" cy="1913691"/>
                <a:chOff x="260649" y="2535584"/>
                <a:chExt cx="2853310" cy="1913691"/>
              </a:xfrm>
            </p:grpSpPr>
            <p:grpSp>
              <p:nvGrpSpPr>
                <p:cNvPr id="443" name="Group 99"/>
                <p:cNvGrpSpPr>
                  <a:grpSpLocks noChangeAspect="1"/>
                </p:cNvGrpSpPr>
                <p:nvPr/>
              </p:nvGrpSpPr>
              <p:grpSpPr bwMode="auto">
                <a:xfrm>
                  <a:off x="475832" y="2535584"/>
                  <a:ext cx="2638127" cy="1913691"/>
                  <a:chOff x="619" y="421"/>
                  <a:chExt cx="2041" cy="1662"/>
                </a:xfrm>
              </p:grpSpPr>
              <p:sp>
                <p:nvSpPr>
                  <p:cNvPr id="445" name="Rectangle 101"/>
                  <p:cNvSpPr>
                    <a:spLocks noChangeArrowheads="1"/>
                  </p:cNvSpPr>
                  <p:nvPr/>
                </p:nvSpPr>
                <p:spPr bwMode="auto">
                  <a:xfrm>
                    <a:off x="683" y="573"/>
                    <a:ext cx="1848" cy="1412"/>
                  </a:xfrm>
                  <a:prstGeom prst="rect">
                    <a:avLst/>
                  </a:prstGeom>
                  <a:noFill/>
                  <a:ln w="0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46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985"/>
                    <a:ext cx="1977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arrow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47" name="Line 1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83" y="421"/>
                    <a:ext cx="0" cy="1563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arrow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48" name="Line 1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83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49" name="Rectangle 105"/>
                  <p:cNvSpPr>
                    <a:spLocks noChangeArrowheads="1"/>
                  </p:cNvSpPr>
                  <p:nvPr/>
                </p:nvSpPr>
                <p:spPr bwMode="auto">
                  <a:xfrm>
                    <a:off x="631" y="1997"/>
                    <a:ext cx="107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-0.8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50" name="Line 1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91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51" name="Rectangle 107"/>
                  <p:cNvSpPr>
                    <a:spLocks noChangeArrowheads="1"/>
                  </p:cNvSpPr>
                  <p:nvPr/>
                </p:nvSpPr>
                <p:spPr bwMode="auto">
                  <a:xfrm>
                    <a:off x="839" y="1997"/>
                    <a:ext cx="107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-0.6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52" name="Line 1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95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53" name="Rectangle 109"/>
                  <p:cNvSpPr>
                    <a:spLocks noChangeArrowheads="1"/>
                  </p:cNvSpPr>
                  <p:nvPr/>
                </p:nvSpPr>
                <p:spPr bwMode="auto">
                  <a:xfrm>
                    <a:off x="1043" y="1997"/>
                    <a:ext cx="107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-0.4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54" name="Line 1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99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55" name="Rectangle 111"/>
                  <p:cNvSpPr>
                    <a:spLocks noChangeArrowheads="1"/>
                  </p:cNvSpPr>
                  <p:nvPr/>
                </p:nvSpPr>
                <p:spPr bwMode="auto">
                  <a:xfrm>
                    <a:off x="1247" y="1997"/>
                    <a:ext cx="107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-0.2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56" name="Line 1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03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57" name="Rectangle 113"/>
                  <p:cNvSpPr>
                    <a:spLocks noChangeArrowheads="1"/>
                  </p:cNvSpPr>
                  <p:nvPr/>
                </p:nvSpPr>
                <p:spPr bwMode="auto">
                  <a:xfrm>
                    <a:off x="1491" y="1997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58" name="Line 1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11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59" name="Rectangle 115"/>
                  <p:cNvSpPr>
                    <a:spLocks noChangeArrowheads="1"/>
                  </p:cNvSpPr>
                  <p:nvPr/>
                </p:nvSpPr>
                <p:spPr bwMode="auto">
                  <a:xfrm>
                    <a:off x="1675" y="1997"/>
                    <a:ext cx="86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.2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60" name="Line 1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5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61" name="Rectangle 117"/>
                  <p:cNvSpPr>
                    <a:spLocks noChangeArrowheads="1"/>
                  </p:cNvSpPr>
                  <p:nvPr/>
                </p:nvSpPr>
                <p:spPr bwMode="auto">
                  <a:xfrm>
                    <a:off x="1879" y="1997"/>
                    <a:ext cx="86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.4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62" name="Line 1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19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63" name="Rectangle 119"/>
                  <p:cNvSpPr>
                    <a:spLocks noChangeArrowheads="1"/>
                  </p:cNvSpPr>
                  <p:nvPr/>
                </p:nvSpPr>
                <p:spPr bwMode="auto">
                  <a:xfrm>
                    <a:off x="2083" y="1997"/>
                    <a:ext cx="86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.6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64" name="Line 1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23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65" name="Rectangle 121"/>
                  <p:cNvSpPr>
                    <a:spLocks noChangeArrowheads="1"/>
                  </p:cNvSpPr>
                  <p:nvPr/>
                </p:nvSpPr>
                <p:spPr bwMode="auto">
                  <a:xfrm>
                    <a:off x="2287" y="1997"/>
                    <a:ext cx="86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.8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66" name="Line 1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31" y="1965"/>
                    <a:ext cx="0" cy="2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67" name="Rectangle 123"/>
                  <p:cNvSpPr>
                    <a:spLocks noChangeArrowheads="1"/>
                  </p:cNvSpPr>
                  <p:nvPr/>
                </p:nvSpPr>
                <p:spPr bwMode="auto">
                  <a:xfrm>
                    <a:off x="2519" y="1997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1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68" name="Line 124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985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69" name="Rectangle 125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1953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0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70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781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71" name="Rectangle 127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1749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1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72" name="Line 128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581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73" name="Rectangle 129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1549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2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74" name="Line 130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377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75" name="Rectangle 131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1345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3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76" name="Line 132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1177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77" name="Rectangle 133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1145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4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78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973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79" name="Rectangle 135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941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5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80" name="Line 136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773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81" name="Rectangle 137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741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6</a:t>
                    </a:r>
                    <a:endParaRPr kumimoji="0" lang="it-IT" altLang="it-IT" sz="1800" b="1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82" name="Line 138"/>
                  <p:cNvSpPr>
                    <a:spLocks noChangeShapeType="1"/>
                  </p:cNvSpPr>
                  <p:nvPr/>
                </p:nvSpPr>
                <p:spPr bwMode="auto">
                  <a:xfrm>
                    <a:off x="683" y="573"/>
                    <a:ext cx="20" cy="0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  <p:sp>
                <p:nvSpPr>
                  <p:cNvPr id="483" name="Rectangle 139"/>
                  <p:cNvSpPr>
                    <a:spLocks noChangeArrowheads="1"/>
                  </p:cNvSpPr>
                  <p:nvPr/>
                </p:nvSpPr>
                <p:spPr bwMode="auto">
                  <a:xfrm>
                    <a:off x="619" y="541"/>
                    <a:ext cx="35" cy="8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it-IT" altLang="it-IT" sz="7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cs typeface="Arial" pitchFamily="34" charset="0"/>
                      </a:rPr>
                      <a:t>7</a:t>
                    </a:r>
                    <a:endParaRPr kumimoji="0" lang="it-IT" altLang="it-IT" sz="18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j-lt"/>
                      <a:cs typeface="Arial" pitchFamily="34" charset="0"/>
                    </a:endParaRPr>
                  </a:p>
                </p:txBody>
              </p:sp>
              <p:sp>
                <p:nvSpPr>
                  <p:cNvPr id="484" name="Freeform 140"/>
                  <p:cNvSpPr>
                    <a:spLocks/>
                  </p:cNvSpPr>
                  <p:nvPr/>
                </p:nvSpPr>
                <p:spPr bwMode="auto">
                  <a:xfrm>
                    <a:off x="863" y="665"/>
                    <a:ext cx="1516" cy="1316"/>
                  </a:xfrm>
                  <a:custGeom>
                    <a:avLst/>
                    <a:gdLst>
                      <a:gd name="T0" fmla="*/ 16 w 1516"/>
                      <a:gd name="T1" fmla="*/ 1316 h 1316"/>
                      <a:gd name="T2" fmla="*/ 44 w 1516"/>
                      <a:gd name="T3" fmla="*/ 1316 h 1316"/>
                      <a:gd name="T4" fmla="*/ 76 w 1516"/>
                      <a:gd name="T5" fmla="*/ 1316 h 1316"/>
                      <a:gd name="T6" fmla="*/ 108 w 1516"/>
                      <a:gd name="T7" fmla="*/ 1312 h 1316"/>
                      <a:gd name="T8" fmla="*/ 136 w 1516"/>
                      <a:gd name="T9" fmla="*/ 1312 h 1316"/>
                      <a:gd name="T10" fmla="*/ 168 w 1516"/>
                      <a:gd name="T11" fmla="*/ 1316 h 1316"/>
                      <a:gd name="T12" fmla="*/ 200 w 1516"/>
                      <a:gd name="T13" fmla="*/ 1316 h 1316"/>
                      <a:gd name="T14" fmla="*/ 228 w 1516"/>
                      <a:gd name="T15" fmla="*/ 1304 h 1316"/>
                      <a:gd name="T16" fmla="*/ 260 w 1516"/>
                      <a:gd name="T17" fmla="*/ 1304 h 1316"/>
                      <a:gd name="T18" fmla="*/ 292 w 1516"/>
                      <a:gd name="T19" fmla="*/ 1300 h 1316"/>
                      <a:gd name="T20" fmla="*/ 320 w 1516"/>
                      <a:gd name="T21" fmla="*/ 1288 h 1316"/>
                      <a:gd name="T22" fmla="*/ 352 w 1516"/>
                      <a:gd name="T23" fmla="*/ 1288 h 1316"/>
                      <a:gd name="T24" fmla="*/ 384 w 1516"/>
                      <a:gd name="T25" fmla="*/ 1288 h 1316"/>
                      <a:gd name="T26" fmla="*/ 412 w 1516"/>
                      <a:gd name="T27" fmla="*/ 1260 h 1316"/>
                      <a:gd name="T28" fmla="*/ 444 w 1516"/>
                      <a:gd name="T29" fmla="*/ 1252 h 1316"/>
                      <a:gd name="T30" fmla="*/ 476 w 1516"/>
                      <a:gd name="T31" fmla="*/ 1252 h 1316"/>
                      <a:gd name="T32" fmla="*/ 504 w 1516"/>
                      <a:gd name="T33" fmla="*/ 1256 h 1316"/>
                      <a:gd name="T34" fmla="*/ 536 w 1516"/>
                      <a:gd name="T35" fmla="*/ 1264 h 1316"/>
                      <a:gd name="T36" fmla="*/ 568 w 1516"/>
                      <a:gd name="T37" fmla="*/ 1268 h 1316"/>
                      <a:gd name="T38" fmla="*/ 596 w 1516"/>
                      <a:gd name="T39" fmla="*/ 1284 h 1316"/>
                      <a:gd name="T40" fmla="*/ 628 w 1516"/>
                      <a:gd name="T41" fmla="*/ 1304 h 1316"/>
                      <a:gd name="T42" fmla="*/ 660 w 1516"/>
                      <a:gd name="T43" fmla="*/ 1300 h 1316"/>
                      <a:gd name="T44" fmla="*/ 688 w 1516"/>
                      <a:gd name="T45" fmla="*/ 1280 h 1316"/>
                      <a:gd name="T46" fmla="*/ 720 w 1516"/>
                      <a:gd name="T47" fmla="*/ 1268 h 1316"/>
                      <a:gd name="T48" fmla="*/ 748 w 1516"/>
                      <a:gd name="T49" fmla="*/ 1288 h 1316"/>
                      <a:gd name="T50" fmla="*/ 780 w 1516"/>
                      <a:gd name="T51" fmla="*/ 1284 h 1316"/>
                      <a:gd name="T52" fmla="*/ 812 w 1516"/>
                      <a:gd name="T53" fmla="*/ 1280 h 1316"/>
                      <a:gd name="T54" fmla="*/ 840 w 1516"/>
                      <a:gd name="T55" fmla="*/ 1284 h 1316"/>
                      <a:gd name="T56" fmla="*/ 872 w 1516"/>
                      <a:gd name="T57" fmla="*/ 1292 h 1316"/>
                      <a:gd name="T58" fmla="*/ 904 w 1516"/>
                      <a:gd name="T59" fmla="*/ 1300 h 1316"/>
                      <a:gd name="T60" fmla="*/ 932 w 1516"/>
                      <a:gd name="T61" fmla="*/ 1304 h 1316"/>
                      <a:gd name="T62" fmla="*/ 964 w 1516"/>
                      <a:gd name="T63" fmla="*/ 1292 h 1316"/>
                      <a:gd name="T64" fmla="*/ 996 w 1516"/>
                      <a:gd name="T65" fmla="*/ 1280 h 1316"/>
                      <a:gd name="T66" fmla="*/ 1024 w 1516"/>
                      <a:gd name="T67" fmla="*/ 1260 h 1316"/>
                      <a:gd name="T68" fmla="*/ 1056 w 1516"/>
                      <a:gd name="T69" fmla="*/ 1248 h 1316"/>
                      <a:gd name="T70" fmla="*/ 1088 w 1516"/>
                      <a:gd name="T71" fmla="*/ 1200 h 1316"/>
                      <a:gd name="T72" fmla="*/ 1116 w 1516"/>
                      <a:gd name="T73" fmla="*/ 1100 h 1316"/>
                      <a:gd name="T74" fmla="*/ 1148 w 1516"/>
                      <a:gd name="T75" fmla="*/ 980 h 1316"/>
                      <a:gd name="T76" fmla="*/ 1180 w 1516"/>
                      <a:gd name="T77" fmla="*/ 940 h 1316"/>
                      <a:gd name="T78" fmla="*/ 1208 w 1516"/>
                      <a:gd name="T79" fmla="*/ 888 h 1316"/>
                      <a:gd name="T80" fmla="*/ 1240 w 1516"/>
                      <a:gd name="T81" fmla="*/ 732 h 1316"/>
                      <a:gd name="T82" fmla="*/ 1272 w 1516"/>
                      <a:gd name="T83" fmla="*/ 320 h 1316"/>
                      <a:gd name="T84" fmla="*/ 1300 w 1516"/>
                      <a:gd name="T85" fmla="*/ 0 h 1316"/>
                      <a:gd name="T86" fmla="*/ 1332 w 1516"/>
                      <a:gd name="T87" fmla="*/ 460 h 1316"/>
                      <a:gd name="T88" fmla="*/ 1364 w 1516"/>
                      <a:gd name="T89" fmla="*/ 1008 h 1316"/>
                      <a:gd name="T90" fmla="*/ 1392 w 1516"/>
                      <a:gd name="T91" fmla="*/ 1244 h 1316"/>
                      <a:gd name="T92" fmla="*/ 1424 w 1516"/>
                      <a:gd name="T93" fmla="*/ 1276 h 1316"/>
                      <a:gd name="T94" fmla="*/ 1456 w 1516"/>
                      <a:gd name="T95" fmla="*/ 1300 h 1316"/>
                      <a:gd name="T96" fmla="*/ 1484 w 1516"/>
                      <a:gd name="T97" fmla="*/ 1316 h 1316"/>
                      <a:gd name="T98" fmla="*/ 1516 w 1516"/>
                      <a:gd name="T99" fmla="*/ 1316 h 131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</a:cxnLst>
                    <a:rect l="0" t="0" r="r" b="b"/>
                    <a:pathLst>
                      <a:path w="1516" h="1316">
                        <a:moveTo>
                          <a:pt x="0" y="1316"/>
                        </a:moveTo>
                        <a:lnTo>
                          <a:pt x="16" y="1316"/>
                        </a:lnTo>
                        <a:lnTo>
                          <a:pt x="28" y="1316"/>
                        </a:lnTo>
                        <a:lnTo>
                          <a:pt x="44" y="1316"/>
                        </a:lnTo>
                        <a:lnTo>
                          <a:pt x="60" y="1316"/>
                        </a:lnTo>
                        <a:lnTo>
                          <a:pt x="76" y="1316"/>
                        </a:lnTo>
                        <a:lnTo>
                          <a:pt x="92" y="1316"/>
                        </a:lnTo>
                        <a:lnTo>
                          <a:pt x="108" y="1312"/>
                        </a:lnTo>
                        <a:lnTo>
                          <a:pt x="120" y="1312"/>
                        </a:lnTo>
                        <a:lnTo>
                          <a:pt x="136" y="1312"/>
                        </a:lnTo>
                        <a:lnTo>
                          <a:pt x="152" y="1312"/>
                        </a:lnTo>
                        <a:lnTo>
                          <a:pt x="168" y="1316"/>
                        </a:lnTo>
                        <a:lnTo>
                          <a:pt x="184" y="1316"/>
                        </a:lnTo>
                        <a:lnTo>
                          <a:pt x="200" y="1316"/>
                        </a:lnTo>
                        <a:lnTo>
                          <a:pt x="212" y="1308"/>
                        </a:lnTo>
                        <a:lnTo>
                          <a:pt x="228" y="1304"/>
                        </a:lnTo>
                        <a:lnTo>
                          <a:pt x="244" y="1304"/>
                        </a:lnTo>
                        <a:lnTo>
                          <a:pt x="260" y="1304"/>
                        </a:lnTo>
                        <a:lnTo>
                          <a:pt x="276" y="1300"/>
                        </a:lnTo>
                        <a:lnTo>
                          <a:pt x="292" y="1300"/>
                        </a:lnTo>
                        <a:lnTo>
                          <a:pt x="304" y="1296"/>
                        </a:lnTo>
                        <a:lnTo>
                          <a:pt x="320" y="1288"/>
                        </a:lnTo>
                        <a:lnTo>
                          <a:pt x="336" y="1284"/>
                        </a:lnTo>
                        <a:lnTo>
                          <a:pt x="352" y="1288"/>
                        </a:lnTo>
                        <a:lnTo>
                          <a:pt x="368" y="1296"/>
                        </a:lnTo>
                        <a:lnTo>
                          <a:pt x="384" y="1288"/>
                        </a:lnTo>
                        <a:lnTo>
                          <a:pt x="396" y="1272"/>
                        </a:lnTo>
                        <a:lnTo>
                          <a:pt x="412" y="1260"/>
                        </a:lnTo>
                        <a:lnTo>
                          <a:pt x="428" y="1256"/>
                        </a:lnTo>
                        <a:lnTo>
                          <a:pt x="444" y="1252"/>
                        </a:lnTo>
                        <a:lnTo>
                          <a:pt x="460" y="1252"/>
                        </a:lnTo>
                        <a:lnTo>
                          <a:pt x="476" y="1252"/>
                        </a:lnTo>
                        <a:lnTo>
                          <a:pt x="488" y="1252"/>
                        </a:lnTo>
                        <a:lnTo>
                          <a:pt x="504" y="1256"/>
                        </a:lnTo>
                        <a:lnTo>
                          <a:pt x="520" y="1260"/>
                        </a:lnTo>
                        <a:lnTo>
                          <a:pt x="536" y="1264"/>
                        </a:lnTo>
                        <a:lnTo>
                          <a:pt x="552" y="1264"/>
                        </a:lnTo>
                        <a:lnTo>
                          <a:pt x="568" y="1268"/>
                        </a:lnTo>
                        <a:lnTo>
                          <a:pt x="580" y="1276"/>
                        </a:lnTo>
                        <a:lnTo>
                          <a:pt x="596" y="1284"/>
                        </a:lnTo>
                        <a:lnTo>
                          <a:pt x="612" y="1296"/>
                        </a:lnTo>
                        <a:lnTo>
                          <a:pt x="628" y="1304"/>
                        </a:lnTo>
                        <a:lnTo>
                          <a:pt x="644" y="1304"/>
                        </a:lnTo>
                        <a:lnTo>
                          <a:pt x="660" y="1300"/>
                        </a:lnTo>
                        <a:lnTo>
                          <a:pt x="672" y="1292"/>
                        </a:lnTo>
                        <a:lnTo>
                          <a:pt x="688" y="1280"/>
                        </a:lnTo>
                        <a:lnTo>
                          <a:pt x="704" y="1272"/>
                        </a:lnTo>
                        <a:lnTo>
                          <a:pt x="720" y="1268"/>
                        </a:lnTo>
                        <a:lnTo>
                          <a:pt x="736" y="1276"/>
                        </a:lnTo>
                        <a:lnTo>
                          <a:pt x="748" y="1288"/>
                        </a:lnTo>
                        <a:lnTo>
                          <a:pt x="764" y="1288"/>
                        </a:lnTo>
                        <a:lnTo>
                          <a:pt x="780" y="1284"/>
                        </a:lnTo>
                        <a:lnTo>
                          <a:pt x="796" y="1280"/>
                        </a:lnTo>
                        <a:lnTo>
                          <a:pt x="812" y="1280"/>
                        </a:lnTo>
                        <a:lnTo>
                          <a:pt x="828" y="1280"/>
                        </a:lnTo>
                        <a:lnTo>
                          <a:pt x="840" y="1284"/>
                        </a:lnTo>
                        <a:lnTo>
                          <a:pt x="856" y="1288"/>
                        </a:lnTo>
                        <a:lnTo>
                          <a:pt x="872" y="1292"/>
                        </a:lnTo>
                        <a:lnTo>
                          <a:pt x="888" y="1296"/>
                        </a:lnTo>
                        <a:lnTo>
                          <a:pt x="904" y="1300"/>
                        </a:lnTo>
                        <a:lnTo>
                          <a:pt x="920" y="1304"/>
                        </a:lnTo>
                        <a:lnTo>
                          <a:pt x="932" y="1304"/>
                        </a:lnTo>
                        <a:lnTo>
                          <a:pt x="948" y="1296"/>
                        </a:lnTo>
                        <a:lnTo>
                          <a:pt x="964" y="1292"/>
                        </a:lnTo>
                        <a:lnTo>
                          <a:pt x="980" y="1288"/>
                        </a:lnTo>
                        <a:lnTo>
                          <a:pt x="996" y="1280"/>
                        </a:lnTo>
                        <a:lnTo>
                          <a:pt x="1012" y="1268"/>
                        </a:lnTo>
                        <a:lnTo>
                          <a:pt x="1024" y="1260"/>
                        </a:lnTo>
                        <a:lnTo>
                          <a:pt x="1040" y="1256"/>
                        </a:lnTo>
                        <a:lnTo>
                          <a:pt x="1056" y="1248"/>
                        </a:lnTo>
                        <a:lnTo>
                          <a:pt x="1072" y="1228"/>
                        </a:lnTo>
                        <a:lnTo>
                          <a:pt x="1088" y="1200"/>
                        </a:lnTo>
                        <a:lnTo>
                          <a:pt x="1104" y="1160"/>
                        </a:lnTo>
                        <a:lnTo>
                          <a:pt x="1116" y="1100"/>
                        </a:lnTo>
                        <a:lnTo>
                          <a:pt x="1132" y="1036"/>
                        </a:lnTo>
                        <a:lnTo>
                          <a:pt x="1148" y="980"/>
                        </a:lnTo>
                        <a:lnTo>
                          <a:pt x="1164" y="948"/>
                        </a:lnTo>
                        <a:lnTo>
                          <a:pt x="1180" y="940"/>
                        </a:lnTo>
                        <a:lnTo>
                          <a:pt x="1196" y="932"/>
                        </a:lnTo>
                        <a:lnTo>
                          <a:pt x="1208" y="888"/>
                        </a:lnTo>
                        <a:lnTo>
                          <a:pt x="1224" y="816"/>
                        </a:lnTo>
                        <a:lnTo>
                          <a:pt x="1240" y="732"/>
                        </a:lnTo>
                        <a:lnTo>
                          <a:pt x="1256" y="588"/>
                        </a:lnTo>
                        <a:lnTo>
                          <a:pt x="1272" y="320"/>
                        </a:lnTo>
                        <a:lnTo>
                          <a:pt x="1288" y="56"/>
                        </a:lnTo>
                        <a:lnTo>
                          <a:pt x="1300" y="0"/>
                        </a:lnTo>
                        <a:lnTo>
                          <a:pt x="1316" y="176"/>
                        </a:lnTo>
                        <a:lnTo>
                          <a:pt x="1332" y="460"/>
                        </a:lnTo>
                        <a:lnTo>
                          <a:pt x="1348" y="752"/>
                        </a:lnTo>
                        <a:lnTo>
                          <a:pt x="1364" y="1008"/>
                        </a:lnTo>
                        <a:lnTo>
                          <a:pt x="1380" y="1172"/>
                        </a:lnTo>
                        <a:lnTo>
                          <a:pt x="1392" y="1244"/>
                        </a:lnTo>
                        <a:lnTo>
                          <a:pt x="1408" y="1264"/>
                        </a:lnTo>
                        <a:lnTo>
                          <a:pt x="1424" y="1276"/>
                        </a:lnTo>
                        <a:lnTo>
                          <a:pt x="1440" y="1288"/>
                        </a:lnTo>
                        <a:lnTo>
                          <a:pt x="1456" y="1300"/>
                        </a:lnTo>
                        <a:lnTo>
                          <a:pt x="1472" y="1312"/>
                        </a:lnTo>
                        <a:lnTo>
                          <a:pt x="1484" y="1316"/>
                        </a:lnTo>
                        <a:lnTo>
                          <a:pt x="1500" y="1316"/>
                        </a:lnTo>
                        <a:lnTo>
                          <a:pt x="1516" y="1316"/>
                        </a:lnTo>
                      </a:path>
                    </a:pathLst>
                  </a:cu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it-IT"/>
                  </a:p>
                </p:txBody>
              </p:sp>
            </p:grpSp>
            <p:sp>
              <p:nvSpPr>
                <p:cNvPr id="444" name="Rectangle 60"/>
                <p:cNvSpPr>
                  <a:spLocks noChangeArrowheads="1"/>
                </p:cNvSpPr>
                <p:nvPr/>
              </p:nvSpPr>
              <p:spPr bwMode="auto">
                <a:xfrm rot="16200000">
                  <a:off x="-72579" y="3385049"/>
                  <a:ext cx="804955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it-IT" altLang="it-IT" sz="900" b="1" i="0" u="none" strike="noStrike" cap="none" normalizeH="0" baseline="0" dirty="0" err="1">
                      <a:ln>
                        <a:noFill/>
                      </a:ln>
                      <a:effectLst/>
                      <a:latin typeface="+mj-lt"/>
                      <a:cs typeface="Arial" pitchFamily="34" charset="0"/>
                    </a:rPr>
                    <a:t>Probability</a:t>
                  </a:r>
                  <a:r>
                    <a:rPr kumimoji="0" lang="it-IT" altLang="it-IT" sz="900" b="1" i="0" u="none" strike="noStrike" cap="none" normalizeH="0" baseline="0" dirty="0">
                      <a:ln>
                        <a:noFill/>
                      </a:ln>
                      <a:effectLst/>
                      <a:latin typeface="+mj-lt"/>
                      <a:cs typeface="Arial" pitchFamily="34" charset="0"/>
                    </a:rPr>
                    <a:t> </a:t>
                  </a:r>
                  <a:r>
                    <a:rPr kumimoji="0" lang="it-IT" altLang="it-IT" sz="900" b="1" i="0" u="none" strike="noStrike" cap="none" normalizeH="0" baseline="0" dirty="0" err="1">
                      <a:ln>
                        <a:noFill/>
                      </a:ln>
                      <a:effectLst/>
                      <a:latin typeface="+mj-lt"/>
                      <a:cs typeface="Arial" pitchFamily="34" charset="0"/>
                    </a:rPr>
                    <a:t>density</a:t>
                  </a:r>
                  <a:r>
                    <a:rPr kumimoji="0" lang="it-IT" altLang="it-IT" sz="900" b="1" i="0" u="none" strike="noStrike" cap="none" normalizeH="0" baseline="0" dirty="0">
                      <a:ln>
                        <a:noFill/>
                      </a:ln>
                      <a:effectLst/>
                      <a:latin typeface="+mj-lt"/>
                      <a:cs typeface="Arial" pitchFamily="34" charset="0"/>
                    </a:rPr>
                    <a:t> </a:t>
                  </a:r>
                  <a:endParaRPr kumimoji="0" lang="it-IT" altLang="it-IT" sz="1100" b="0" i="0" u="none" strike="noStrike" cap="none" normalizeH="0" baseline="0" dirty="0">
                    <a:ln>
                      <a:noFill/>
                    </a:ln>
                    <a:effectLst/>
                    <a:latin typeface="+mj-lt"/>
                    <a:cs typeface="Arial" pitchFamily="34" charset="0"/>
                  </a:endParaRPr>
                </a:p>
              </p:txBody>
            </p:sp>
          </p:grpSp>
          <p:sp>
            <p:nvSpPr>
              <p:cNvPr id="437" name="Rectangle 59"/>
              <p:cNvSpPr>
                <a:spLocks noChangeArrowheads="1"/>
              </p:cNvSpPr>
              <p:nvPr/>
            </p:nvSpPr>
            <p:spPr bwMode="auto">
              <a:xfrm>
                <a:off x="803496" y="3810605"/>
                <a:ext cx="607539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 err="1">
                    <a:latin typeface="+mj-lt"/>
                  </a:rPr>
                  <a:t>f</a:t>
                </a:r>
                <a:r>
                  <a:rPr kumimoji="0" lang="it-IT" altLang="it-IT" sz="800" b="1" i="0" u="none" strike="noStrike" cap="none" normalizeH="0" baseline="0" dirty="0" err="1">
                    <a:ln>
                      <a:noFill/>
                    </a:ln>
                    <a:effectLst/>
                    <a:latin typeface="+mj-lt"/>
                  </a:rPr>
                  <a:t>ight</a:t>
                </a:r>
                <a:r>
                  <a:rPr lang="it-IT" altLang="it-IT" sz="800" b="1" dirty="0">
                    <a:latin typeface="+mj-lt"/>
                  </a:rPr>
                  <a:t>-club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sp>
            <p:nvSpPr>
              <p:cNvPr id="438" name="Rectangle 59"/>
              <p:cNvSpPr>
                <a:spLocks noChangeArrowheads="1"/>
              </p:cNvSpPr>
              <p:nvPr/>
            </p:nvSpPr>
            <p:spPr bwMode="auto">
              <a:xfrm>
                <a:off x="1807978" y="3512626"/>
                <a:ext cx="403957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>
                    <a:latin typeface="+mj-lt"/>
                  </a:rPr>
                  <a:t>date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sp>
            <p:nvSpPr>
              <p:cNvPr id="439" name="Rectangle 59"/>
              <p:cNvSpPr>
                <a:spLocks noChangeArrowheads="1"/>
              </p:cNvSpPr>
              <p:nvPr/>
            </p:nvSpPr>
            <p:spPr bwMode="auto">
              <a:xfrm>
                <a:off x="2564904" y="3008729"/>
                <a:ext cx="434414" cy="1136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it-IT" altLang="it-IT" sz="800" b="1" dirty="0">
                    <a:latin typeface="+mj-lt"/>
                  </a:rPr>
                  <a:t>party </a:t>
                </a:r>
                <a:r>
                  <a:rPr lang="it-IT" altLang="it-IT" sz="800" b="1" dirty="0" err="1">
                    <a:latin typeface="+mj-lt"/>
                  </a:rPr>
                  <a:t>hubs</a:t>
                </a:r>
                <a:endParaRPr kumimoji="0" lang="it-IT" altLang="it-IT" sz="1050" b="1" i="0" u="none" strike="noStrike" cap="none" normalizeH="0" baseline="0" dirty="0">
                  <a:ln>
                    <a:noFill/>
                  </a:ln>
                  <a:effectLst/>
                  <a:latin typeface="+mj-lt"/>
                </a:endParaRPr>
              </a:p>
            </p:txBody>
          </p:sp>
          <p:cxnSp>
            <p:nvCxnSpPr>
              <p:cNvPr id="440" name="Connettore 2 439"/>
              <p:cNvCxnSpPr/>
              <p:nvPr/>
            </p:nvCxnSpPr>
            <p:spPr>
              <a:xfrm>
                <a:off x="1285567" y="3995322"/>
                <a:ext cx="97282" cy="19340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1" name="Connettore 2 440"/>
              <p:cNvCxnSpPr/>
              <p:nvPr/>
            </p:nvCxnSpPr>
            <p:spPr>
              <a:xfrm>
                <a:off x="2154190" y="3675307"/>
                <a:ext cx="97282" cy="19340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2" name="Connettore 2 441"/>
              <p:cNvCxnSpPr/>
              <p:nvPr/>
            </p:nvCxnSpPr>
            <p:spPr>
              <a:xfrm flipH="1" flipV="1">
                <a:off x="2548391" y="2837715"/>
                <a:ext cx="195043" cy="15010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873158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xmlns="" id="{C2CBC874-1DAE-46B1-89F9-5598DD074D58}"/>
              </a:ext>
            </a:extLst>
          </p:cNvPr>
          <p:cNvGrpSpPr/>
          <p:nvPr/>
        </p:nvGrpSpPr>
        <p:grpSpPr>
          <a:xfrm>
            <a:off x="532490" y="1282446"/>
            <a:ext cx="5883190" cy="7605225"/>
            <a:chOff x="443590" y="177546"/>
            <a:chExt cx="5883190" cy="7605225"/>
          </a:xfrm>
        </p:grpSpPr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xmlns="" id="{66966A33-B31D-4D48-B4E5-C4CE4967DF1C}"/>
                </a:ext>
              </a:extLst>
            </p:cNvPr>
            <p:cNvGrpSpPr/>
            <p:nvPr/>
          </p:nvGrpSpPr>
          <p:grpSpPr>
            <a:xfrm>
              <a:off x="443590" y="177546"/>
              <a:ext cx="5174536" cy="3753556"/>
              <a:chOff x="443590" y="177546"/>
              <a:chExt cx="5174536" cy="3753556"/>
            </a:xfrm>
          </p:grpSpPr>
          <p:grpSp>
            <p:nvGrpSpPr>
              <p:cNvPr id="20" name="Gruppo 19">
                <a:extLst>
                  <a:ext uri="{FF2B5EF4-FFF2-40B4-BE49-F238E27FC236}">
                    <a16:creationId xmlns:a16="http://schemas.microsoft.com/office/drawing/2014/main" xmlns="" id="{D7BBAE0E-A252-4C16-8CD0-EB8D36C22FEF}"/>
                  </a:ext>
                </a:extLst>
              </p:cNvPr>
              <p:cNvGrpSpPr/>
              <p:nvPr/>
            </p:nvGrpSpPr>
            <p:grpSpPr>
              <a:xfrm>
                <a:off x="443590" y="205202"/>
                <a:ext cx="5174536" cy="3725900"/>
                <a:chOff x="443590" y="205202"/>
                <a:chExt cx="5174536" cy="3725900"/>
              </a:xfrm>
            </p:grpSpPr>
            <p:pic>
              <p:nvPicPr>
                <p:cNvPr id="22" name="Immagine 21">
                  <a:extLst>
                    <a:ext uri="{FF2B5EF4-FFF2-40B4-BE49-F238E27FC236}">
                      <a16:creationId xmlns:a16="http://schemas.microsoft.com/office/drawing/2014/main" xmlns="" id="{4D5D09E3-BA30-49C4-8F21-AFF0FF73DA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666"/>
                <a:stretch/>
              </p:blipFill>
              <p:spPr>
                <a:xfrm>
                  <a:off x="1401371" y="1025642"/>
                  <a:ext cx="3642282" cy="2905460"/>
                </a:xfrm>
                <a:prstGeom prst="rect">
                  <a:avLst/>
                </a:prstGeom>
              </p:spPr>
            </p:pic>
            <p:sp>
              <p:nvSpPr>
                <p:cNvPr id="23" name="Rettangolo 22">
                  <a:extLst>
                    <a:ext uri="{FF2B5EF4-FFF2-40B4-BE49-F238E27FC236}">
                      <a16:creationId xmlns:a16="http://schemas.microsoft.com/office/drawing/2014/main" xmlns="" id="{620A6BC6-8A9C-488D-B2E3-44DEBDFBAD19}"/>
                    </a:ext>
                  </a:extLst>
                </p:cNvPr>
                <p:cNvSpPr/>
                <p:nvPr/>
              </p:nvSpPr>
              <p:spPr>
                <a:xfrm>
                  <a:off x="1364867" y="951311"/>
                  <a:ext cx="3678785" cy="1357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4" name="Rettangolo 23">
                  <a:extLst>
                    <a:ext uri="{FF2B5EF4-FFF2-40B4-BE49-F238E27FC236}">
                      <a16:creationId xmlns:a16="http://schemas.microsoft.com/office/drawing/2014/main" xmlns="" id="{8D7097A3-BC58-4752-9F37-D6932553AA8A}"/>
                    </a:ext>
                  </a:extLst>
                </p:cNvPr>
                <p:cNvSpPr/>
                <p:nvPr/>
              </p:nvSpPr>
              <p:spPr>
                <a:xfrm rot="7950703">
                  <a:off x="1067182" y="1393596"/>
                  <a:ext cx="1614832" cy="20214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5" name="Rettangolo 24">
                  <a:extLst>
                    <a:ext uri="{FF2B5EF4-FFF2-40B4-BE49-F238E27FC236}">
                      <a16:creationId xmlns:a16="http://schemas.microsoft.com/office/drawing/2014/main" xmlns="" id="{617D57A5-60CE-4364-AFA3-472D6CDBCCFB}"/>
                    </a:ext>
                  </a:extLst>
                </p:cNvPr>
                <p:cNvSpPr/>
                <p:nvPr/>
              </p:nvSpPr>
              <p:spPr>
                <a:xfrm rot="13492559">
                  <a:off x="3975643" y="1238418"/>
                  <a:ext cx="1642483" cy="4852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6" name="CasellaDiTesto 25">
                  <a:extLst>
                    <a:ext uri="{FF2B5EF4-FFF2-40B4-BE49-F238E27FC236}">
                      <a16:creationId xmlns:a16="http://schemas.microsoft.com/office/drawing/2014/main" xmlns="" id="{752F9FAB-6D15-442C-90EB-B37C90DF38AC}"/>
                    </a:ext>
                  </a:extLst>
                </p:cNvPr>
                <p:cNvSpPr txBox="1"/>
                <p:nvPr/>
              </p:nvSpPr>
              <p:spPr>
                <a:xfrm rot="2605325">
                  <a:off x="4345598" y="1642958"/>
                  <a:ext cx="972000" cy="246221"/>
                </a:xfrm>
                <a:prstGeom prst="rect">
                  <a:avLst/>
                </a:prstGeom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rgbClr val="FFC000"/>
                      </a:solidFill>
                    </a:rPr>
                    <a:t>Triple negative </a:t>
                  </a:r>
                </a:p>
              </p:txBody>
            </p:sp>
            <p:sp>
              <p:nvSpPr>
                <p:cNvPr id="27" name="CasellaDiTesto 26">
                  <a:extLst>
                    <a:ext uri="{FF2B5EF4-FFF2-40B4-BE49-F238E27FC236}">
                      <a16:creationId xmlns:a16="http://schemas.microsoft.com/office/drawing/2014/main" xmlns="" id="{5C5629BC-27F5-4AB3-AA68-FE6EB5E76C96}"/>
                    </a:ext>
                  </a:extLst>
                </p:cNvPr>
                <p:cNvSpPr txBox="1"/>
                <p:nvPr/>
              </p:nvSpPr>
              <p:spPr>
                <a:xfrm>
                  <a:off x="1729846" y="906594"/>
                  <a:ext cx="1368000" cy="246221"/>
                </a:xfrm>
                <a:prstGeom prst="rect">
                  <a:avLst/>
                </a:prstGeom>
              </p:spPr>
              <p:style>
                <a:lnRef idx="2">
                  <a:schemeClr val="accent2"/>
                </a:lnRef>
                <a:fillRef idx="1">
                  <a:schemeClr val="lt1"/>
                </a:fillRef>
                <a:effectRef idx="0">
                  <a:schemeClr val="accent2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rgbClr val="C00000"/>
                      </a:solidFill>
                    </a:rPr>
                    <a:t>Luminal B </a:t>
                  </a:r>
                  <a:r>
                    <a:rPr lang="it-IT" sz="1000" b="1" dirty="0" err="1">
                      <a:solidFill>
                        <a:srgbClr val="C00000"/>
                      </a:solidFill>
                    </a:rPr>
                    <a:t>like</a:t>
                  </a:r>
                  <a:r>
                    <a:rPr lang="it-IT" sz="1000" b="1" dirty="0">
                      <a:solidFill>
                        <a:srgbClr val="C00000"/>
                      </a:solidFill>
                    </a:rPr>
                    <a:t> (HER2+)</a:t>
                  </a:r>
                </a:p>
              </p:txBody>
            </p:sp>
            <p:sp>
              <p:nvSpPr>
                <p:cNvPr id="28" name="CasellaDiTesto 27">
                  <a:extLst>
                    <a:ext uri="{FF2B5EF4-FFF2-40B4-BE49-F238E27FC236}">
                      <a16:creationId xmlns:a16="http://schemas.microsoft.com/office/drawing/2014/main" xmlns="" id="{10E25226-4B34-41B3-A567-142ED68F1987}"/>
                    </a:ext>
                  </a:extLst>
                </p:cNvPr>
                <p:cNvSpPr txBox="1"/>
                <p:nvPr/>
              </p:nvSpPr>
              <p:spPr>
                <a:xfrm rot="19057168">
                  <a:off x="908786" y="1705151"/>
                  <a:ext cx="1260000" cy="253916"/>
                </a:xfrm>
                <a:prstGeom prst="rect">
                  <a:avLst/>
                </a:prstGeom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chemeClr val="tx2"/>
                      </a:solidFill>
                    </a:rPr>
                    <a:t>HER2+(non luminal) </a:t>
                  </a:r>
                </a:p>
              </p:txBody>
            </p:sp>
            <p:sp>
              <p:nvSpPr>
                <p:cNvPr id="29" name="CasellaDiTesto 28">
                  <a:extLst>
                    <a:ext uri="{FF2B5EF4-FFF2-40B4-BE49-F238E27FC236}">
                      <a16:creationId xmlns:a16="http://schemas.microsoft.com/office/drawing/2014/main" xmlns="" id="{1E8D0918-4DAD-4F97-99BF-50B2841BE07B}"/>
                    </a:ext>
                  </a:extLst>
                </p:cNvPr>
                <p:cNvSpPr txBox="1"/>
                <p:nvPr/>
              </p:nvSpPr>
              <p:spPr>
                <a:xfrm>
                  <a:off x="3313870" y="906594"/>
                  <a:ext cx="1368000" cy="246221"/>
                </a:xfrm>
                <a:prstGeom prst="rect">
                  <a:avLst/>
                </a:prstGeom>
                <a:ln>
                  <a:solidFill>
                    <a:schemeClr val="accent6"/>
                  </a:solidFill>
                </a:ln>
              </p:spPr>
              <p:style>
                <a:lnRef idx="2">
                  <a:schemeClr val="accent3"/>
                </a:lnRef>
                <a:fillRef idx="1">
                  <a:schemeClr val="lt1"/>
                </a:fillRef>
                <a:effectRef idx="0">
                  <a:schemeClr val="accent3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solidFill>
                        <a:srgbClr val="00B050"/>
                      </a:solidFill>
                    </a:rPr>
                    <a:t>Luminal HER2 -</a:t>
                  </a:r>
                  <a:endParaRPr lang="it-IT" sz="1000" b="1" dirty="0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30" name="CasellaDiTesto 29">
                  <a:extLst>
                    <a:ext uri="{FF2B5EF4-FFF2-40B4-BE49-F238E27FC236}">
                      <a16:creationId xmlns:a16="http://schemas.microsoft.com/office/drawing/2014/main" xmlns="" id="{4CDF078A-6E77-4191-9617-C03AD664DB4E}"/>
                    </a:ext>
                  </a:extLst>
                </p:cNvPr>
                <p:cNvSpPr txBox="1"/>
                <p:nvPr/>
              </p:nvSpPr>
              <p:spPr>
                <a:xfrm>
                  <a:off x="443590" y="205202"/>
                  <a:ext cx="35080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</p:grp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xmlns="" id="{D7F9CFDA-EAD9-46BC-A653-FC39DE1456B0}"/>
                  </a:ext>
                </a:extLst>
              </p:cNvPr>
              <p:cNvSpPr txBox="1"/>
              <p:nvPr/>
            </p:nvSpPr>
            <p:spPr>
              <a:xfrm>
                <a:off x="1257730" y="177546"/>
                <a:ext cx="381642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2000" b="1" dirty="0">
                    <a:solidFill>
                      <a:srgbClr val="00B050"/>
                    </a:solidFill>
                  </a:rPr>
                  <a:t>IHC </a:t>
                </a:r>
                <a:r>
                  <a:rPr lang="it-IT" sz="2000" b="1" dirty="0" err="1">
                    <a:solidFill>
                      <a:srgbClr val="00B050"/>
                    </a:solidFill>
                  </a:rPr>
                  <a:t>classification</a:t>
                </a:r>
                <a:endParaRPr lang="it-IT" sz="2000" b="1" dirty="0">
                  <a:solidFill>
                    <a:srgbClr val="00B050"/>
                  </a:solidFill>
                </a:endParaRPr>
              </a:p>
            </p:txBody>
          </p:sp>
        </p:grpSp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xmlns="" id="{E2F11BB2-66F8-4F69-8FDF-485CCF271A32}"/>
                </a:ext>
              </a:extLst>
            </p:cNvPr>
            <p:cNvGrpSpPr/>
            <p:nvPr/>
          </p:nvGrpSpPr>
          <p:grpSpPr>
            <a:xfrm>
              <a:off x="486695" y="4132401"/>
              <a:ext cx="5840085" cy="3650370"/>
              <a:chOff x="486695" y="3943715"/>
              <a:chExt cx="5840085" cy="3650370"/>
            </a:xfrm>
          </p:grpSpPr>
          <p:grpSp>
            <p:nvGrpSpPr>
              <p:cNvPr id="7" name="Gruppo 6">
                <a:extLst>
                  <a:ext uri="{FF2B5EF4-FFF2-40B4-BE49-F238E27FC236}">
                    <a16:creationId xmlns:a16="http://schemas.microsoft.com/office/drawing/2014/main" xmlns="" id="{6CB26E78-8536-49C1-A482-2452A4459A3A}"/>
                  </a:ext>
                </a:extLst>
              </p:cNvPr>
              <p:cNvGrpSpPr/>
              <p:nvPr/>
            </p:nvGrpSpPr>
            <p:grpSpPr>
              <a:xfrm>
                <a:off x="486695" y="4007583"/>
                <a:ext cx="4900597" cy="3586502"/>
                <a:chOff x="486695" y="4007583"/>
                <a:chExt cx="4900597" cy="3586502"/>
              </a:xfrm>
            </p:grpSpPr>
            <p:grpSp>
              <p:nvGrpSpPr>
                <p:cNvPr id="9" name="Gruppo 8">
                  <a:extLst>
                    <a:ext uri="{FF2B5EF4-FFF2-40B4-BE49-F238E27FC236}">
                      <a16:creationId xmlns:a16="http://schemas.microsoft.com/office/drawing/2014/main" xmlns="" id="{30F30791-FD72-448D-8D35-79DE886FA7A5}"/>
                    </a:ext>
                  </a:extLst>
                </p:cNvPr>
                <p:cNvGrpSpPr/>
                <p:nvPr/>
              </p:nvGrpSpPr>
              <p:grpSpPr>
                <a:xfrm>
                  <a:off x="1364867" y="4355713"/>
                  <a:ext cx="3803148" cy="3238372"/>
                  <a:chOff x="1259632" y="377917"/>
                  <a:chExt cx="6623936" cy="5919315"/>
                </a:xfrm>
              </p:grpSpPr>
              <p:pic>
                <p:nvPicPr>
                  <p:cNvPr id="15" name="Picture 3" descr="C:\Users\feder\Dropbox\Giulia&amp;Fede\Progetti\Mariarosaria_2019\classification_subtype_genetic\venn_result21269.png">
                    <a:extLst>
                      <a:ext uri="{FF2B5EF4-FFF2-40B4-BE49-F238E27FC236}">
                        <a16:creationId xmlns:a16="http://schemas.microsoft.com/office/drawing/2014/main" xmlns="" id="{476C6120-AC2A-47DE-BE69-B7D31DB3993E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7704" b="-1"/>
                  <a:stretch/>
                </p:blipFill>
                <p:spPr bwMode="auto">
                  <a:xfrm>
                    <a:off x="1259632" y="982510"/>
                    <a:ext cx="6623936" cy="5314722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6" name="Rettangolo 15">
                    <a:extLst>
                      <a:ext uri="{FF2B5EF4-FFF2-40B4-BE49-F238E27FC236}">
                        <a16:creationId xmlns:a16="http://schemas.microsoft.com/office/drawing/2014/main" xmlns="" id="{7A11FCE9-3535-4B2C-8767-04D0A1584378}"/>
                      </a:ext>
                    </a:extLst>
                  </p:cNvPr>
                  <p:cNvSpPr/>
                  <p:nvPr/>
                </p:nvSpPr>
                <p:spPr>
                  <a:xfrm rot="7883539">
                    <a:off x="783272" y="1775499"/>
                    <a:ext cx="1865121" cy="54157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17" name="Rettangolo 16">
                    <a:extLst>
                      <a:ext uri="{FF2B5EF4-FFF2-40B4-BE49-F238E27FC236}">
                        <a16:creationId xmlns:a16="http://schemas.microsoft.com/office/drawing/2014/main" xmlns="" id="{7FD47C2D-6DF8-4F40-A45F-6C60690D52B6}"/>
                      </a:ext>
                    </a:extLst>
                  </p:cNvPr>
                  <p:cNvSpPr/>
                  <p:nvPr/>
                </p:nvSpPr>
                <p:spPr>
                  <a:xfrm rot="13619516">
                    <a:off x="6670968" y="1850979"/>
                    <a:ext cx="1865121" cy="54157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18" name="Rettangolo 17">
                    <a:extLst>
                      <a:ext uri="{FF2B5EF4-FFF2-40B4-BE49-F238E27FC236}">
                        <a16:creationId xmlns:a16="http://schemas.microsoft.com/office/drawing/2014/main" xmlns="" id="{BBAE9231-C2D3-4415-8491-4E61EA19C223}"/>
                      </a:ext>
                    </a:extLst>
                  </p:cNvPr>
                  <p:cNvSpPr/>
                  <p:nvPr/>
                </p:nvSpPr>
                <p:spPr>
                  <a:xfrm>
                    <a:off x="5337652" y="377917"/>
                    <a:ext cx="1865121" cy="54157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19" name="Rettangolo 18">
                    <a:extLst>
                      <a:ext uri="{FF2B5EF4-FFF2-40B4-BE49-F238E27FC236}">
                        <a16:creationId xmlns:a16="http://schemas.microsoft.com/office/drawing/2014/main" xmlns="" id="{D4CFEE72-4B51-49AE-9760-A78616AEF2CC}"/>
                      </a:ext>
                    </a:extLst>
                  </p:cNvPr>
                  <p:cNvSpPr/>
                  <p:nvPr/>
                </p:nvSpPr>
                <p:spPr>
                  <a:xfrm>
                    <a:off x="1715832" y="519495"/>
                    <a:ext cx="2496128" cy="40972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10" name="CasellaDiTesto 9">
                  <a:extLst>
                    <a:ext uri="{FF2B5EF4-FFF2-40B4-BE49-F238E27FC236}">
                      <a16:creationId xmlns:a16="http://schemas.microsoft.com/office/drawing/2014/main" xmlns="" id="{64E9CEBB-9F74-46D5-9298-E3AB1DCF30B5}"/>
                    </a:ext>
                  </a:extLst>
                </p:cNvPr>
                <p:cNvSpPr txBox="1"/>
                <p:nvPr/>
              </p:nvSpPr>
              <p:spPr>
                <a:xfrm>
                  <a:off x="1997459" y="4478078"/>
                  <a:ext cx="1026695" cy="246221"/>
                </a:xfrm>
                <a:prstGeom prst="rect">
                  <a:avLst/>
                </a:prstGeom>
              </p:spPr>
              <p:style>
                <a:lnRef idx="2">
                  <a:schemeClr val="accent2"/>
                </a:lnRef>
                <a:fillRef idx="1">
                  <a:schemeClr val="lt1"/>
                </a:fillRef>
                <a:effectRef idx="0">
                  <a:schemeClr val="accent2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rgbClr val="C00000"/>
                      </a:solidFill>
                    </a:rPr>
                    <a:t>Her2-enriched</a:t>
                  </a:r>
                </a:p>
              </p:txBody>
            </p:sp>
            <p:sp>
              <p:nvSpPr>
                <p:cNvPr id="11" name="CasellaDiTesto 10">
                  <a:extLst>
                    <a:ext uri="{FF2B5EF4-FFF2-40B4-BE49-F238E27FC236}">
                      <a16:creationId xmlns:a16="http://schemas.microsoft.com/office/drawing/2014/main" xmlns="" id="{F41386BA-F8C6-4520-BC9A-2DC469CDBA2B}"/>
                    </a:ext>
                  </a:extLst>
                </p:cNvPr>
                <p:cNvSpPr txBox="1"/>
                <p:nvPr/>
              </p:nvSpPr>
              <p:spPr>
                <a:xfrm rot="19057168">
                  <a:off x="1314117" y="5144349"/>
                  <a:ext cx="756000" cy="246221"/>
                </a:xfrm>
                <a:prstGeom prst="rect">
                  <a:avLst/>
                </a:prstGeom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 err="1">
                      <a:solidFill>
                        <a:schemeClr val="tx2"/>
                      </a:solidFill>
                    </a:rPr>
                    <a:t>Basal-like</a:t>
                  </a:r>
                  <a:endParaRPr lang="it-IT" sz="1000" b="1" dirty="0">
                    <a:solidFill>
                      <a:schemeClr val="tx2"/>
                    </a:solidFill>
                  </a:endParaRPr>
                </a:p>
              </p:txBody>
            </p:sp>
            <p:sp>
              <p:nvSpPr>
                <p:cNvPr id="12" name="CasellaDiTesto 11">
                  <a:extLst>
                    <a:ext uri="{FF2B5EF4-FFF2-40B4-BE49-F238E27FC236}">
                      <a16:creationId xmlns:a16="http://schemas.microsoft.com/office/drawing/2014/main" xmlns="" id="{B8FCB2EC-2533-43E5-B90A-0D93433B1F72}"/>
                    </a:ext>
                  </a:extLst>
                </p:cNvPr>
                <p:cNvSpPr txBox="1"/>
                <p:nvPr/>
              </p:nvSpPr>
              <p:spPr>
                <a:xfrm>
                  <a:off x="3581946" y="4478078"/>
                  <a:ext cx="756000" cy="246221"/>
                </a:xfrm>
                <a:prstGeom prst="rect">
                  <a:avLst/>
                </a:prstGeom>
                <a:ln>
                  <a:solidFill>
                    <a:schemeClr val="accent6"/>
                  </a:solidFill>
                </a:ln>
              </p:spPr>
              <p:style>
                <a:lnRef idx="2">
                  <a:schemeClr val="accent3"/>
                </a:lnRef>
                <a:fillRef idx="1">
                  <a:schemeClr val="lt1"/>
                </a:fillRef>
                <a:effectRef idx="0">
                  <a:schemeClr val="accent3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rgbClr val="00B050"/>
                      </a:solidFill>
                    </a:rPr>
                    <a:t>Luminal A</a:t>
                  </a:r>
                </a:p>
              </p:txBody>
            </p:sp>
            <p:sp>
              <p:nvSpPr>
                <p:cNvPr id="13" name="CasellaDiTesto 12">
                  <a:extLst>
                    <a:ext uri="{FF2B5EF4-FFF2-40B4-BE49-F238E27FC236}">
                      <a16:creationId xmlns:a16="http://schemas.microsoft.com/office/drawing/2014/main" xmlns="" id="{72338B4B-9958-4060-8E84-1B0E9D35EF68}"/>
                    </a:ext>
                  </a:extLst>
                </p:cNvPr>
                <p:cNvSpPr txBox="1"/>
                <p:nvPr/>
              </p:nvSpPr>
              <p:spPr>
                <a:xfrm rot="2605325">
                  <a:off x="4381262" y="5152773"/>
                  <a:ext cx="1006030" cy="246221"/>
                </a:xfrm>
                <a:prstGeom prst="rect">
                  <a:avLst/>
                </a:prstGeom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dirty="0">
                      <a:solidFill>
                        <a:srgbClr val="FFC000"/>
                      </a:solidFill>
                    </a:rPr>
                    <a:t>Luminal B</a:t>
                  </a:r>
                </a:p>
              </p:txBody>
            </p:sp>
            <p:sp>
              <p:nvSpPr>
                <p:cNvPr id="14" name="CasellaDiTesto 13">
                  <a:extLst>
                    <a:ext uri="{FF2B5EF4-FFF2-40B4-BE49-F238E27FC236}">
                      <a16:creationId xmlns:a16="http://schemas.microsoft.com/office/drawing/2014/main" xmlns="" id="{2073BF8D-EC76-485E-9E35-F2878C5ABA0D}"/>
                    </a:ext>
                  </a:extLst>
                </p:cNvPr>
                <p:cNvSpPr txBox="1"/>
                <p:nvPr/>
              </p:nvSpPr>
              <p:spPr>
                <a:xfrm>
                  <a:off x="486695" y="4007583"/>
                  <a:ext cx="35080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2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</p:grpSp>
          <p:sp>
            <p:nvSpPr>
              <p:cNvPr id="8" name="CasellaDiTesto 8">
                <a:extLst>
                  <a:ext uri="{FF2B5EF4-FFF2-40B4-BE49-F238E27FC236}">
                    <a16:creationId xmlns:a16="http://schemas.microsoft.com/office/drawing/2014/main" xmlns="" id="{2DCD6083-8D73-4D81-95CB-F260C27B8E0F}"/>
                  </a:ext>
                </a:extLst>
              </p:cNvPr>
              <p:cNvSpPr txBox="1"/>
              <p:nvPr/>
            </p:nvSpPr>
            <p:spPr>
              <a:xfrm>
                <a:off x="782164" y="3943715"/>
                <a:ext cx="554461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it-IT" sz="2000" b="1" dirty="0">
                    <a:solidFill>
                      <a:srgbClr val="0070C0"/>
                    </a:solidFill>
                  </a:rPr>
                  <a:t>PAM50 </a:t>
                </a:r>
                <a:r>
                  <a:rPr lang="it-IT" sz="2000" b="1" dirty="0" err="1">
                    <a:solidFill>
                      <a:srgbClr val="0070C0"/>
                    </a:solidFill>
                  </a:rPr>
                  <a:t>classification</a:t>
                </a:r>
                <a:r>
                  <a:rPr lang="it-IT" sz="2000" b="1" dirty="0">
                    <a:solidFill>
                      <a:srgbClr val="0070C0"/>
                    </a:solidFill>
                  </a:rPr>
                  <a:t>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64238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7622" y="3129297"/>
            <a:ext cx="2789852" cy="17236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553" y="3155620"/>
            <a:ext cx="2769397" cy="1720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550" y="1067582"/>
            <a:ext cx="2744827" cy="17674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0785" y="6003835"/>
            <a:ext cx="258028" cy="1295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07" r="28818"/>
          <a:stretch/>
        </p:blipFill>
        <p:spPr bwMode="auto">
          <a:xfrm>
            <a:off x="3623023" y="7944238"/>
            <a:ext cx="2716378" cy="170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729" y="7957656"/>
            <a:ext cx="2744827" cy="17305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/>
          <p:cNvSpPr txBox="1">
            <a:spLocks noChangeAspect="1"/>
          </p:cNvSpPr>
          <p:nvPr/>
        </p:nvSpPr>
        <p:spPr>
          <a:xfrm>
            <a:off x="1635004" y="170857"/>
            <a:ext cx="37380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it-IT" sz="2000" b="1" dirty="0">
                <a:solidFill>
                  <a:srgbClr val="00B050"/>
                </a:solidFill>
              </a:rPr>
              <a:t>IHC </a:t>
            </a:r>
            <a:r>
              <a:rPr lang="it-IT" sz="2000" b="1" dirty="0" err="1">
                <a:solidFill>
                  <a:srgbClr val="00B050"/>
                </a:solidFill>
              </a:rPr>
              <a:t>classification</a:t>
            </a:r>
            <a:endParaRPr lang="it-IT" sz="2000" b="1" dirty="0">
              <a:solidFill>
                <a:srgbClr val="00B050"/>
              </a:solidFill>
            </a:endParaRPr>
          </a:p>
        </p:txBody>
      </p:sp>
      <p:sp>
        <p:nvSpPr>
          <p:cNvPr id="5" name="Rettangolo 4"/>
          <p:cNvSpPr>
            <a:spLocks noChangeAspect="1"/>
          </p:cNvSpPr>
          <p:nvPr/>
        </p:nvSpPr>
        <p:spPr>
          <a:xfrm>
            <a:off x="990699" y="2943886"/>
            <a:ext cx="173850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srgbClr val="00B0F0"/>
                </a:solidFill>
                <a:latin typeface="+mj-lt"/>
              </a:rPr>
              <a:t>HER2 positive (non luminal</a:t>
            </a:r>
            <a:r>
              <a:rPr lang="en-US" sz="1100" b="1" dirty="0">
                <a:solidFill>
                  <a:srgbClr val="00B0F0"/>
                </a:solidFill>
                <a:latin typeface="+mj-lt"/>
                <a:cs typeface="Arial" pitchFamily="34" charset="0"/>
              </a:rPr>
              <a:t>)</a:t>
            </a:r>
            <a:endParaRPr lang="it-IT" sz="1100" dirty="0">
              <a:solidFill>
                <a:srgbClr val="00B0F0"/>
              </a:solidFill>
              <a:latin typeface="+mj-lt"/>
            </a:endParaRPr>
          </a:p>
        </p:txBody>
      </p:sp>
      <p:sp>
        <p:nvSpPr>
          <p:cNvPr id="6" name="Rettangolo 5"/>
          <p:cNvSpPr>
            <a:spLocks noChangeAspect="1"/>
          </p:cNvSpPr>
          <p:nvPr/>
        </p:nvSpPr>
        <p:spPr>
          <a:xfrm>
            <a:off x="1119499" y="895346"/>
            <a:ext cx="144142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92D050"/>
                </a:solidFill>
                <a:latin typeface="+mj-lt"/>
                <a:cs typeface="Arial" pitchFamily="34" charset="0"/>
              </a:rPr>
              <a:t>Luminal B-like (HER2+)</a:t>
            </a:r>
            <a:endParaRPr lang="it-IT" sz="1100" b="1" dirty="0">
              <a:solidFill>
                <a:srgbClr val="92D050"/>
              </a:solidFill>
              <a:latin typeface="+mj-lt"/>
              <a:cs typeface="Arial" pitchFamily="34" charset="0"/>
            </a:endParaRPr>
          </a:p>
        </p:txBody>
      </p:sp>
      <p:sp>
        <p:nvSpPr>
          <p:cNvPr id="7" name="Rettangolo 6"/>
          <p:cNvSpPr>
            <a:spLocks noChangeAspect="1"/>
          </p:cNvSpPr>
          <p:nvPr/>
        </p:nvSpPr>
        <p:spPr>
          <a:xfrm>
            <a:off x="4715247" y="2952353"/>
            <a:ext cx="10102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7030A0"/>
                </a:solidFill>
                <a:latin typeface="+mj-lt"/>
              </a:rPr>
              <a:t>Triple negative</a:t>
            </a:r>
            <a:endParaRPr lang="it-IT" sz="1100" b="1" dirty="0">
              <a:solidFill>
                <a:srgbClr val="7030A0"/>
              </a:solidFill>
              <a:latin typeface="+mj-lt"/>
            </a:endParaRPr>
          </a:p>
        </p:txBody>
      </p:sp>
      <p:sp>
        <p:nvSpPr>
          <p:cNvPr id="8" name="Rettangolo 7"/>
          <p:cNvSpPr>
            <a:spLocks noChangeAspect="1"/>
          </p:cNvSpPr>
          <p:nvPr/>
        </p:nvSpPr>
        <p:spPr>
          <a:xfrm>
            <a:off x="224416" y="211566"/>
            <a:ext cx="6488705" cy="4682058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Rettangolo 8"/>
          <p:cNvSpPr>
            <a:spLocks noChangeAspect="1"/>
          </p:cNvSpPr>
          <p:nvPr/>
        </p:nvSpPr>
        <p:spPr>
          <a:xfrm>
            <a:off x="4486017" y="916678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+mj-lt"/>
              </a:rPr>
              <a:t>Luminal HER2-negative</a:t>
            </a:r>
            <a:endParaRPr lang="it-IT" sz="1100" b="1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10" name="CasellaDiTesto 8"/>
          <p:cNvSpPr txBox="1">
            <a:spLocks noChangeAspect="1"/>
          </p:cNvSpPr>
          <p:nvPr/>
        </p:nvSpPr>
        <p:spPr>
          <a:xfrm>
            <a:off x="859181" y="4901451"/>
            <a:ext cx="5430764" cy="3992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2000" b="1" dirty="0">
                <a:solidFill>
                  <a:srgbClr val="0070C0"/>
                </a:solidFill>
              </a:rPr>
              <a:t>PAM50 </a:t>
            </a:r>
            <a:r>
              <a:rPr lang="it-IT" sz="2000" b="1" dirty="0" err="1">
                <a:solidFill>
                  <a:srgbClr val="0070C0"/>
                </a:solidFill>
              </a:rPr>
              <a:t>classification</a:t>
            </a:r>
            <a:r>
              <a:rPr lang="it-IT" sz="2000" b="1" dirty="0">
                <a:solidFill>
                  <a:srgbClr val="0070C0"/>
                </a:solidFill>
              </a:rPr>
              <a:t> </a:t>
            </a:r>
          </a:p>
        </p:txBody>
      </p:sp>
      <p:sp>
        <p:nvSpPr>
          <p:cNvPr id="11" name="Rettangolo 10"/>
          <p:cNvSpPr>
            <a:spLocks noChangeAspect="1"/>
          </p:cNvSpPr>
          <p:nvPr/>
        </p:nvSpPr>
        <p:spPr>
          <a:xfrm>
            <a:off x="1468843" y="5591768"/>
            <a:ext cx="782218" cy="2610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36B907"/>
                </a:solidFill>
                <a:latin typeface="+mj-lt"/>
              </a:rPr>
              <a:t>Luminal  A</a:t>
            </a:r>
            <a:endParaRPr lang="it-IT" sz="1100" b="1" dirty="0">
              <a:solidFill>
                <a:srgbClr val="36B907"/>
              </a:solidFill>
              <a:latin typeface="+mj-lt"/>
            </a:endParaRPr>
          </a:p>
        </p:txBody>
      </p:sp>
      <p:sp>
        <p:nvSpPr>
          <p:cNvPr id="12" name="Rettangolo 11"/>
          <p:cNvSpPr>
            <a:spLocks noChangeAspect="1"/>
          </p:cNvSpPr>
          <p:nvPr/>
        </p:nvSpPr>
        <p:spPr>
          <a:xfrm>
            <a:off x="4832384" y="5591768"/>
            <a:ext cx="775938" cy="2610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+mj-lt"/>
              </a:rPr>
              <a:t>Luminal  B</a:t>
            </a:r>
            <a:endParaRPr lang="it-IT" sz="1100" b="1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13" name="Rettangolo 12"/>
          <p:cNvSpPr>
            <a:spLocks noChangeAspect="1"/>
          </p:cNvSpPr>
          <p:nvPr/>
        </p:nvSpPr>
        <p:spPr>
          <a:xfrm>
            <a:off x="1351087" y="7719202"/>
            <a:ext cx="1017731" cy="2610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100" b="1" dirty="0">
                <a:solidFill>
                  <a:srgbClr val="00B0F0"/>
                </a:solidFill>
                <a:latin typeface="+mj-lt"/>
              </a:rPr>
              <a:t>HER2 </a:t>
            </a:r>
            <a:r>
              <a:rPr lang="it-IT" sz="1100" b="1" dirty="0" err="1">
                <a:solidFill>
                  <a:srgbClr val="00B0F0"/>
                </a:solidFill>
                <a:latin typeface="+mj-lt"/>
              </a:rPr>
              <a:t>enriched</a:t>
            </a:r>
            <a:endParaRPr lang="it-IT" sz="1100" b="1" dirty="0">
              <a:solidFill>
                <a:srgbClr val="00B0F0"/>
              </a:solidFill>
              <a:latin typeface="+mj-lt"/>
            </a:endParaRPr>
          </a:p>
        </p:txBody>
      </p:sp>
      <p:sp>
        <p:nvSpPr>
          <p:cNvPr id="14" name="Rettangolo 13"/>
          <p:cNvSpPr>
            <a:spLocks noChangeAspect="1"/>
          </p:cNvSpPr>
          <p:nvPr/>
        </p:nvSpPr>
        <p:spPr>
          <a:xfrm>
            <a:off x="4855936" y="7742476"/>
            <a:ext cx="728835" cy="2610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it-IT" sz="1100" b="1" dirty="0" err="1">
                <a:solidFill>
                  <a:srgbClr val="7030A0"/>
                </a:solidFill>
                <a:latin typeface="+mj-lt"/>
              </a:rPr>
              <a:t>Basal-like</a:t>
            </a:r>
            <a:endParaRPr lang="it-IT" sz="1100" b="1" dirty="0">
              <a:solidFill>
                <a:srgbClr val="7030A0"/>
              </a:solidFill>
              <a:latin typeface="+mj-lt"/>
            </a:endParaRPr>
          </a:p>
        </p:txBody>
      </p:sp>
      <p:sp>
        <p:nvSpPr>
          <p:cNvPr id="15" name="Rettangolo 14"/>
          <p:cNvSpPr>
            <a:spLocks noChangeAspect="1"/>
          </p:cNvSpPr>
          <p:nvPr/>
        </p:nvSpPr>
        <p:spPr>
          <a:xfrm>
            <a:off x="224416" y="4944761"/>
            <a:ext cx="6488705" cy="4708354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295" t="20615" r="21759" b="10433"/>
          <a:stretch/>
        </p:blipFill>
        <p:spPr bwMode="auto">
          <a:xfrm>
            <a:off x="6376487" y="8183065"/>
            <a:ext cx="249837" cy="1292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3667" y="4958552"/>
            <a:ext cx="921661" cy="621980"/>
          </a:xfrm>
          <a:prstGeom prst="rect">
            <a:avLst/>
          </a:prstGeom>
          <a:noFill/>
          <a:ln w="12700">
            <a:solidFill>
              <a:srgbClr val="0070C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415" y="8181516"/>
            <a:ext cx="258028" cy="1295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92" b="6002"/>
          <a:stretch/>
        </p:blipFill>
        <p:spPr bwMode="auto">
          <a:xfrm>
            <a:off x="285354" y="5848555"/>
            <a:ext cx="2821026" cy="16755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040" y="6072666"/>
            <a:ext cx="258028" cy="1295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90" b="2549"/>
          <a:stretch/>
        </p:blipFill>
        <p:spPr bwMode="auto">
          <a:xfrm>
            <a:off x="3449038" y="5815483"/>
            <a:ext cx="2959565" cy="170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6"/>
          <a:stretch/>
        </p:blipFill>
        <p:spPr bwMode="auto">
          <a:xfrm>
            <a:off x="5445721" y="226777"/>
            <a:ext cx="1254171" cy="568952"/>
          </a:xfrm>
          <a:prstGeom prst="rect">
            <a:avLst/>
          </a:prstGeom>
          <a:noFill/>
          <a:ln w="12700">
            <a:solidFill>
              <a:srgbClr val="00B05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6112" y="1278799"/>
            <a:ext cx="297364" cy="14385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4563" y="1125578"/>
            <a:ext cx="2838312" cy="169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8027" y="1278799"/>
            <a:ext cx="286616" cy="14385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1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7747" y="3355806"/>
            <a:ext cx="297364" cy="14385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1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6112" y="3355806"/>
            <a:ext cx="297364" cy="14385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34206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xmlns="" id="{B594E4F7-ADFB-42F4-8610-3C36C836D4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8083288"/>
              </p:ext>
            </p:extLst>
          </p:nvPr>
        </p:nvGraphicFramePr>
        <p:xfrm>
          <a:off x="1367858" y="1303115"/>
          <a:ext cx="4341432" cy="7753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71883">
                  <a:extLst>
                    <a:ext uri="{9D8B030D-6E8A-4147-A177-3AD203B41FA5}">
                      <a16:colId xmlns:a16="http://schemas.microsoft.com/office/drawing/2014/main" xmlns="" val="1151463051"/>
                    </a:ext>
                  </a:extLst>
                </a:gridCol>
                <a:gridCol w="2469549">
                  <a:extLst>
                    <a:ext uri="{9D8B030D-6E8A-4147-A177-3AD203B41FA5}">
                      <a16:colId xmlns:a16="http://schemas.microsoft.com/office/drawing/2014/main" xmlns="" val="1170815813"/>
                    </a:ext>
                  </a:extLst>
                </a:gridCol>
              </a:tblGrid>
              <a:tr h="92710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ection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f </a:t>
                      </a:r>
                      <a:r>
                        <a:rPr lang="it-IT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uminal </a:t>
                      </a:r>
                      <a:r>
                        <a:rPr lang="it-IT" sz="1100" b="1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ubtypes</a:t>
                      </a:r>
                      <a:r>
                        <a:rPr lang="it-IT" sz="11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(ISS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itch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s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algn="l" defTabSz="685800" rtl="0" eaLnBrk="1" fontAlgn="b" latinLnBrk="0" hangingPunct="1"/>
                      <a:endParaRPr lang="it-IT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48129320"/>
                  </a:ext>
                </a:extLst>
              </a:tr>
              <a:tr h="142494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m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A+B) (PAM5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5B; MMP9; CACNA1D; FGFR3; PLA2G4F; SORD; GNG13; KCNJ3.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103778314"/>
                  </a:ext>
                </a:extLst>
              </a:tr>
              <a:tr h="9271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mB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ike (IH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C1; CREB3L4; KRT18; FN1.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76962992"/>
                  </a:ext>
                </a:extLst>
              </a:tr>
            </a:tbl>
          </a:graphicData>
        </a:graphic>
      </p:graphicFrame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89C06F19-3079-4FE3-A24A-06E9371AA980}"/>
              </a:ext>
            </a:extLst>
          </p:cNvPr>
          <p:cNvSpPr txBox="1"/>
          <p:nvPr/>
        </p:nvSpPr>
        <p:spPr>
          <a:xfrm>
            <a:off x="858581" y="1023997"/>
            <a:ext cx="435217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31" name="Immagine 3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3607" y="2189269"/>
            <a:ext cx="1366467" cy="1029600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xmlns="" id="{971C450E-3668-4F89-BBEB-855544C0DD6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8179" y="4394787"/>
            <a:ext cx="1367384" cy="1030292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FD0EE223-A3FE-403A-980F-5382D7351694}"/>
              </a:ext>
            </a:extLst>
          </p:cNvPr>
          <p:cNvSpPr txBox="1"/>
          <p:nvPr/>
        </p:nvSpPr>
        <p:spPr>
          <a:xfrm>
            <a:off x="920974" y="3283803"/>
            <a:ext cx="337626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6" name="Tabella 15">
            <a:extLst>
              <a:ext uri="{FF2B5EF4-FFF2-40B4-BE49-F238E27FC236}">
                <a16:creationId xmlns:a16="http://schemas.microsoft.com/office/drawing/2014/main" xmlns="" id="{B5538F95-68F0-4CC2-83A5-8CA00C0F19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2488825"/>
              </p:ext>
            </p:extLst>
          </p:nvPr>
        </p:nvGraphicFramePr>
        <p:xfrm>
          <a:off x="1367858" y="3537248"/>
          <a:ext cx="4341432" cy="7848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75435">
                  <a:extLst>
                    <a:ext uri="{9D8B030D-6E8A-4147-A177-3AD203B41FA5}">
                      <a16:colId xmlns:a16="http://schemas.microsoft.com/office/drawing/2014/main" xmlns="" val="1151463051"/>
                    </a:ext>
                  </a:extLst>
                </a:gridCol>
                <a:gridCol w="2465997">
                  <a:extLst>
                    <a:ext uri="{9D8B030D-6E8A-4147-A177-3AD203B41FA5}">
                      <a16:colId xmlns:a16="http://schemas.microsoft.com/office/drawing/2014/main" xmlns="" val="4234947616"/>
                    </a:ext>
                  </a:extLst>
                </a:gridCol>
              </a:tblGrid>
              <a:tr h="16894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ection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f Her2+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types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itch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s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48129320"/>
                  </a:ext>
                </a:extLst>
              </a:tr>
              <a:tr h="14586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er2+ (PAM50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S6ST3; GAL3ST2; GALE.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81578409"/>
                  </a:ext>
                </a:extLst>
              </a:tr>
              <a:tr h="9271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r2+ (PAM50) ꓵ Her2+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riched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IHC)</a:t>
                      </a: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TSTA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820455704"/>
                  </a:ext>
                </a:extLst>
              </a:tr>
              <a:tr h="9271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er2+ </a:t>
                      </a:r>
                      <a:r>
                        <a:rPr lang="it-IT" sz="9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nriched</a:t>
                      </a: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(IH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IGF2BP1; SALL4.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76962992"/>
                  </a:ext>
                </a:extLst>
              </a:tr>
            </a:tbl>
          </a:graphicData>
        </a:graphic>
      </p:graphicFrame>
      <p:graphicFrame>
        <p:nvGraphicFramePr>
          <p:cNvPr id="18" name="Tabella 17">
            <a:extLst>
              <a:ext uri="{FF2B5EF4-FFF2-40B4-BE49-F238E27FC236}">
                <a16:creationId xmlns:a16="http://schemas.microsoft.com/office/drawing/2014/main" xmlns="" id="{FC572DEC-004C-4972-9163-814484810E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6104787"/>
              </p:ext>
            </p:extLst>
          </p:nvPr>
        </p:nvGraphicFramePr>
        <p:xfrm>
          <a:off x="1367858" y="5560897"/>
          <a:ext cx="4341432" cy="7753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75435">
                  <a:extLst>
                    <a:ext uri="{9D8B030D-6E8A-4147-A177-3AD203B41FA5}">
                      <a16:colId xmlns:a16="http://schemas.microsoft.com/office/drawing/2014/main" xmlns="" val="1151463051"/>
                    </a:ext>
                  </a:extLst>
                </a:gridCol>
                <a:gridCol w="2465997">
                  <a:extLst>
                    <a:ext uri="{9D8B030D-6E8A-4147-A177-3AD203B41FA5}">
                      <a16:colId xmlns:a16="http://schemas.microsoft.com/office/drawing/2014/main" xmlns="" val="4234947616"/>
                    </a:ext>
                  </a:extLst>
                </a:gridCol>
              </a:tblGrid>
              <a:tr h="168944"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section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f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btypes</a:t>
                      </a: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itch </a:t>
                      </a:r>
                      <a:r>
                        <a:rPr lang="it-IT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s</a:t>
                      </a:r>
                      <a:endParaRPr lang="it-I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48129320"/>
                  </a:ext>
                </a:extLst>
              </a:tr>
              <a:tr h="9271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ike (PAM50) ꓵ Triple negative (IH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H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1037783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ple negative (IH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SG1; MAPT; PRSS27; MCM2; MCM4; CDC7.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76962992"/>
                  </a:ext>
                </a:extLst>
              </a:tr>
            </a:tbl>
          </a:graphicData>
        </a:graphic>
      </p:graphicFrame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EBF1E68B-3391-43FA-B80C-567518F82D7A}"/>
              </a:ext>
            </a:extLst>
          </p:cNvPr>
          <p:cNvSpPr txBox="1"/>
          <p:nvPr/>
        </p:nvSpPr>
        <p:spPr>
          <a:xfrm>
            <a:off x="951783" y="5390870"/>
            <a:ext cx="193258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xmlns="" id="{FF6CF933-60B3-4A23-A0AB-FD294D7635A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8638" y="6449508"/>
            <a:ext cx="1366467" cy="102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342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Immagine 19">
            <a:extLst>
              <a:ext uri="{FF2B5EF4-FFF2-40B4-BE49-F238E27FC236}">
                <a16:creationId xmlns:a16="http://schemas.microsoft.com/office/drawing/2014/main" xmlns="" id="{0EC7AECF-E8DB-4DDB-AA54-1FFF8A1BDB5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564" y="1985054"/>
            <a:ext cx="4001327" cy="1756680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xmlns="" id="{2A20C1D4-012E-4E59-96D9-D7B410173DE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36" r="29631"/>
          <a:stretch/>
        </p:blipFill>
        <p:spPr>
          <a:xfrm>
            <a:off x="675662" y="4090091"/>
            <a:ext cx="2511457" cy="19094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xmlns="" id="{5E88FAF8-9CEC-4C94-A763-A3375A8E25E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184" y="4071337"/>
            <a:ext cx="1965260" cy="13232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Rettangolo 24">
            <a:extLst>
              <a:ext uri="{FF2B5EF4-FFF2-40B4-BE49-F238E27FC236}">
                <a16:creationId xmlns:a16="http://schemas.microsoft.com/office/drawing/2014/main" xmlns="" id="{753A4BC2-D515-4DDA-8771-F057E9F3493B}"/>
              </a:ext>
            </a:extLst>
          </p:cNvPr>
          <p:cNvSpPr/>
          <p:nvPr/>
        </p:nvSpPr>
        <p:spPr>
          <a:xfrm>
            <a:off x="234616" y="1562701"/>
            <a:ext cx="6388768" cy="44877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xmlns="" id="{6C5FFC81-BA8E-44F2-8553-5934C56A9BEA}"/>
              </a:ext>
            </a:extLst>
          </p:cNvPr>
          <p:cNvSpPr txBox="1"/>
          <p:nvPr/>
        </p:nvSpPr>
        <p:spPr>
          <a:xfrm>
            <a:off x="295720" y="1562701"/>
            <a:ext cx="350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xmlns="" id="{E677B2A8-9F16-4046-AF5C-2EF40E516E80}"/>
              </a:ext>
            </a:extLst>
          </p:cNvPr>
          <p:cNvSpPr txBox="1"/>
          <p:nvPr/>
        </p:nvSpPr>
        <p:spPr>
          <a:xfrm>
            <a:off x="295720" y="3658897"/>
            <a:ext cx="350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xmlns="" id="{B250FA0F-2063-43F6-8C71-CA1984486DB1}"/>
              </a:ext>
            </a:extLst>
          </p:cNvPr>
          <p:cNvSpPr txBox="1"/>
          <p:nvPr/>
        </p:nvSpPr>
        <p:spPr>
          <a:xfrm>
            <a:off x="3384621" y="3621934"/>
            <a:ext cx="350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0" name="Rettangolo 29">
            <a:extLst>
              <a:ext uri="{FF2B5EF4-FFF2-40B4-BE49-F238E27FC236}">
                <a16:creationId xmlns:a16="http://schemas.microsoft.com/office/drawing/2014/main" xmlns="" id="{0D2C2601-6EB8-468A-AA5A-1B0947D382D2}"/>
              </a:ext>
            </a:extLst>
          </p:cNvPr>
          <p:cNvSpPr/>
          <p:nvPr/>
        </p:nvSpPr>
        <p:spPr>
          <a:xfrm>
            <a:off x="4707296" y="1668471"/>
            <a:ext cx="19303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°12 IS-switches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99524711-EE4F-4497-A378-39D50817802E}"/>
              </a:ext>
            </a:extLst>
          </p:cNvPr>
          <p:cNvSpPr txBox="1"/>
          <p:nvPr/>
        </p:nvSpPr>
        <p:spPr>
          <a:xfrm>
            <a:off x="4372490" y="3804643"/>
            <a:ext cx="752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MCODE1</a:t>
            </a:r>
          </a:p>
        </p:txBody>
      </p:sp>
    </p:spTree>
    <p:extLst>
      <p:ext uri="{BB962C8B-B14F-4D97-AF65-F5344CB8AC3E}">
        <p14:creationId xmlns:p14="http://schemas.microsoft.com/office/powerpoint/2010/main" val="3352812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>
            <a:extLst>
              <a:ext uri="{FF2B5EF4-FFF2-40B4-BE49-F238E27FC236}">
                <a16:creationId xmlns:a16="http://schemas.microsoft.com/office/drawing/2014/main" xmlns="" id="{C69B997E-A7ED-4973-8698-29E7DB537456}"/>
              </a:ext>
            </a:extLst>
          </p:cNvPr>
          <p:cNvGrpSpPr/>
          <p:nvPr/>
        </p:nvGrpSpPr>
        <p:grpSpPr>
          <a:xfrm>
            <a:off x="-301634" y="1760239"/>
            <a:ext cx="6966819" cy="4591526"/>
            <a:chOff x="-273695" y="4809746"/>
            <a:chExt cx="6966819" cy="4591526"/>
          </a:xfrm>
        </p:grpSpPr>
        <p:graphicFrame>
          <p:nvGraphicFramePr>
            <p:cNvPr id="7" name="Grafico 6">
              <a:extLst>
                <a:ext uri="{FF2B5EF4-FFF2-40B4-BE49-F238E27FC236}">
                  <a16:creationId xmlns:a16="http://schemas.microsoft.com/office/drawing/2014/main" xmlns="" id="{D03D61E7-E9C6-4D82-A3FB-05EBD9AB82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54155761"/>
                </p:ext>
              </p:extLst>
            </p:nvPr>
          </p:nvGraphicFramePr>
          <p:xfrm>
            <a:off x="-273695" y="4809746"/>
            <a:ext cx="6966819" cy="45915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xmlns="" id="{FC3281D9-B092-43C4-B889-405035456EEC}"/>
                </a:ext>
              </a:extLst>
            </p:cNvPr>
            <p:cNvSpPr txBox="1"/>
            <p:nvPr/>
          </p:nvSpPr>
          <p:spPr>
            <a:xfrm>
              <a:off x="736659" y="6998153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xmlns="" id="{6EB29A00-90B1-4F31-BDA5-8EA8577D9FF9}"/>
                </a:ext>
              </a:extLst>
            </p:cNvPr>
            <p:cNvSpPr txBox="1"/>
            <p:nvPr/>
          </p:nvSpPr>
          <p:spPr>
            <a:xfrm>
              <a:off x="817495" y="587833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xmlns="" id="{7C63B41F-3628-4E37-BFF4-AB57C09CD6A5}"/>
                </a:ext>
              </a:extLst>
            </p:cNvPr>
            <p:cNvSpPr txBox="1"/>
            <p:nvPr/>
          </p:nvSpPr>
          <p:spPr>
            <a:xfrm>
              <a:off x="898332" y="752558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02D1435C-AE59-4257-8DF9-9946DADD3E69}"/>
                </a:ext>
              </a:extLst>
            </p:cNvPr>
            <p:cNvSpPr txBox="1"/>
            <p:nvPr/>
          </p:nvSpPr>
          <p:spPr>
            <a:xfrm>
              <a:off x="979172" y="786881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708C28E7-C909-462F-8B15-352CF15A0AC5}"/>
                </a:ext>
              </a:extLst>
            </p:cNvPr>
            <p:cNvSpPr txBox="1"/>
            <p:nvPr/>
          </p:nvSpPr>
          <p:spPr>
            <a:xfrm>
              <a:off x="1274696" y="6566132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xmlns="" id="{300BA3BF-DF7D-494F-9DEB-4616D6FFC79B}"/>
                </a:ext>
              </a:extLst>
            </p:cNvPr>
            <p:cNvSpPr txBox="1"/>
            <p:nvPr/>
          </p:nvSpPr>
          <p:spPr>
            <a:xfrm>
              <a:off x="1363485" y="7108140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xmlns="" id="{92E78E76-5AC6-4FD4-8308-516E23D91671}"/>
                </a:ext>
              </a:extLst>
            </p:cNvPr>
            <p:cNvSpPr txBox="1"/>
            <p:nvPr/>
          </p:nvSpPr>
          <p:spPr>
            <a:xfrm>
              <a:off x="1444323" y="7252587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xmlns="" id="{32F2E8D9-D074-4F47-BD73-2BFB74EF811A}"/>
                </a:ext>
              </a:extLst>
            </p:cNvPr>
            <p:cNvSpPr txBox="1"/>
            <p:nvPr/>
          </p:nvSpPr>
          <p:spPr>
            <a:xfrm>
              <a:off x="1533113" y="7675333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xmlns="" id="{C03F2B72-7EC3-49F3-AE90-AC819F0C2C56}"/>
                </a:ext>
              </a:extLst>
            </p:cNvPr>
            <p:cNvSpPr txBox="1"/>
            <p:nvPr/>
          </p:nvSpPr>
          <p:spPr>
            <a:xfrm>
              <a:off x="1820690" y="6778166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xmlns="" id="{73B79A90-38F4-4490-A02C-E83A4D241B10}"/>
                </a:ext>
              </a:extLst>
            </p:cNvPr>
            <p:cNvSpPr txBox="1"/>
            <p:nvPr/>
          </p:nvSpPr>
          <p:spPr>
            <a:xfrm>
              <a:off x="1917430" y="6358067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xmlns="" id="{1895BFD5-A7C1-46E6-864E-B000D888D542}"/>
                </a:ext>
              </a:extLst>
            </p:cNvPr>
            <p:cNvSpPr txBox="1"/>
            <p:nvPr/>
          </p:nvSpPr>
          <p:spPr>
            <a:xfrm>
              <a:off x="1998269" y="7257891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xmlns="" id="{C43CD65B-863E-49DD-B54A-680C82CEC356}"/>
                </a:ext>
              </a:extLst>
            </p:cNvPr>
            <p:cNvSpPr txBox="1"/>
            <p:nvPr/>
          </p:nvSpPr>
          <p:spPr>
            <a:xfrm>
              <a:off x="2079108" y="787941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xmlns="" id="{656DAC1E-17C0-4740-94DD-C9AEF560287D}"/>
                </a:ext>
              </a:extLst>
            </p:cNvPr>
            <p:cNvSpPr txBox="1"/>
            <p:nvPr/>
          </p:nvSpPr>
          <p:spPr>
            <a:xfrm>
              <a:off x="2933871" y="7406327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xmlns="" id="{A902975F-D03F-40FE-8910-A50F2F0E21FD}"/>
                </a:ext>
              </a:extLst>
            </p:cNvPr>
            <p:cNvSpPr txBox="1"/>
            <p:nvPr/>
          </p:nvSpPr>
          <p:spPr>
            <a:xfrm>
              <a:off x="3014709" y="6962380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xmlns="" id="{F872EB7F-2DAD-4941-9476-156852FE17B2}"/>
                </a:ext>
              </a:extLst>
            </p:cNvPr>
            <p:cNvSpPr txBox="1"/>
            <p:nvPr/>
          </p:nvSpPr>
          <p:spPr>
            <a:xfrm>
              <a:off x="3103499" y="7011410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xmlns="" id="{FDE142D8-5AF7-47A5-85A4-D7C9534C1444}"/>
                </a:ext>
              </a:extLst>
            </p:cNvPr>
            <p:cNvSpPr txBox="1"/>
            <p:nvPr/>
          </p:nvSpPr>
          <p:spPr>
            <a:xfrm>
              <a:off x="3478535" y="6026774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xmlns="" id="{0D196598-3C7D-4EA9-A77E-3B3A55CB5500}"/>
                </a:ext>
              </a:extLst>
            </p:cNvPr>
            <p:cNvSpPr txBox="1"/>
            <p:nvPr/>
          </p:nvSpPr>
          <p:spPr>
            <a:xfrm>
              <a:off x="3567325" y="4899014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xmlns="" id="{67A9C285-D3D5-447B-93C0-FDB3ACFCD0DB}"/>
                </a:ext>
              </a:extLst>
            </p:cNvPr>
            <p:cNvSpPr txBox="1"/>
            <p:nvPr/>
          </p:nvSpPr>
          <p:spPr>
            <a:xfrm>
              <a:off x="3648163" y="7071041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xmlns="" id="{E0308E19-B884-48A6-8828-71FA5550710E}"/>
                </a:ext>
              </a:extLst>
            </p:cNvPr>
            <p:cNvSpPr txBox="1"/>
            <p:nvPr/>
          </p:nvSpPr>
          <p:spPr>
            <a:xfrm>
              <a:off x="3736953" y="7923154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xmlns="" id="{56A70118-08D2-40D9-83BE-23F9BE7DB807}"/>
                </a:ext>
              </a:extLst>
            </p:cNvPr>
            <p:cNvSpPr txBox="1"/>
            <p:nvPr/>
          </p:nvSpPr>
          <p:spPr>
            <a:xfrm>
              <a:off x="4032476" y="6533006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xmlns="" id="{18951540-A945-4069-A82A-B08D31D5A432}"/>
                </a:ext>
              </a:extLst>
            </p:cNvPr>
            <p:cNvSpPr txBox="1"/>
            <p:nvPr/>
          </p:nvSpPr>
          <p:spPr>
            <a:xfrm>
              <a:off x="4121269" y="7043215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xmlns="" id="{85238A38-09A5-4182-BFC7-6169341EEA63}"/>
                </a:ext>
              </a:extLst>
            </p:cNvPr>
            <p:cNvSpPr txBox="1"/>
            <p:nvPr/>
          </p:nvSpPr>
          <p:spPr>
            <a:xfrm>
              <a:off x="4202110" y="7640882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xmlns="" id="{92528FD4-5AE0-4CB8-BBED-9099F1764266}"/>
                </a:ext>
              </a:extLst>
            </p:cNvPr>
            <p:cNvSpPr txBox="1"/>
            <p:nvPr/>
          </p:nvSpPr>
          <p:spPr>
            <a:xfrm>
              <a:off x="4290898" y="7499088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xmlns="" id="{2D5B2EE7-4546-4F5B-B647-382D4ACC2E2A}"/>
                </a:ext>
              </a:extLst>
            </p:cNvPr>
            <p:cNvSpPr txBox="1"/>
            <p:nvPr/>
          </p:nvSpPr>
          <p:spPr>
            <a:xfrm>
              <a:off x="4586418" y="7325484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xmlns="" id="{C01AEF64-94E1-40AD-B6B4-2811700D5184}"/>
                </a:ext>
              </a:extLst>
            </p:cNvPr>
            <p:cNvSpPr txBox="1"/>
            <p:nvPr/>
          </p:nvSpPr>
          <p:spPr>
            <a:xfrm>
              <a:off x="4675209" y="7326803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5622D4CE-1407-4310-800E-B2C512132D80}"/>
                </a:ext>
              </a:extLst>
            </p:cNvPr>
            <p:cNvSpPr txBox="1"/>
            <p:nvPr/>
          </p:nvSpPr>
          <p:spPr>
            <a:xfrm>
              <a:off x="4756046" y="7781360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55257873-2B54-4F0B-B598-0B94B560E493}"/>
                </a:ext>
              </a:extLst>
            </p:cNvPr>
            <p:cNvSpPr txBox="1"/>
            <p:nvPr/>
          </p:nvSpPr>
          <p:spPr>
            <a:xfrm>
              <a:off x="5688994" y="7203571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xmlns="" id="{2AA0A178-576C-4AE9-AE3E-603FC4DD444E}"/>
                </a:ext>
              </a:extLst>
            </p:cNvPr>
            <p:cNvSpPr txBox="1"/>
            <p:nvPr/>
          </p:nvSpPr>
          <p:spPr>
            <a:xfrm>
              <a:off x="5769836" y="7077673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6EED6F19-1181-4A16-9BA2-431AE7FBBC4B}"/>
                </a:ext>
              </a:extLst>
            </p:cNvPr>
            <p:cNvSpPr txBox="1"/>
            <p:nvPr/>
          </p:nvSpPr>
          <p:spPr>
            <a:xfrm>
              <a:off x="5938140" y="769124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xmlns="" id="{485E3C40-54C9-45BC-8125-E284FB4946DD}"/>
                </a:ext>
              </a:extLst>
            </p:cNvPr>
            <p:cNvSpPr txBox="1"/>
            <p:nvPr/>
          </p:nvSpPr>
          <p:spPr>
            <a:xfrm>
              <a:off x="6241613" y="7318869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xmlns="" id="{E665BA14-F87C-4754-A4BF-A49636E628BF}"/>
                </a:ext>
              </a:extLst>
            </p:cNvPr>
            <p:cNvSpPr txBox="1"/>
            <p:nvPr/>
          </p:nvSpPr>
          <p:spPr>
            <a:xfrm>
              <a:off x="6322451" y="6882876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E433EB00-6956-4A9A-B996-E5A46DA72C1B}"/>
                </a:ext>
              </a:extLst>
            </p:cNvPr>
            <p:cNvSpPr txBox="1"/>
            <p:nvPr/>
          </p:nvSpPr>
          <p:spPr>
            <a:xfrm>
              <a:off x="6411242" y="7265860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xmlns="" id="{EF4CE113-D7F7-4296-8411-23D172304DD6}"/>
                </a:ext>
              </a:extLst>
            </p:cNvPr>
            <p:cNvSpPr txBox="1"/>
            <p:nvPr/>
          </p:nvSpPr>
          <p:spPr>
            <a:xfrm>
              <a:off x="6492081" y="7450062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xmlns="" id="{AFB32A91-0611-4742-86A6-7CAC93C18BDD}"/>
                </a:ext>
              </a:extLst>
            </p:cNvPr>
            <p:cNvSpPr txBox="1"/>
            <p:nvPr/>
          </p:nvSpPr>
          <p:spPr>
            <a:xfrm>
              <a:off x="3176384" y="7664734"/>
              <a:ext cx="6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84018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0" y="492520"/>
            <a:ext cx="3441469" cy="2477193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1738" y="3584599"/>
            <a:ext cx="3441469" cy="2477193"/>
          </a:xfrm>
          <a:prstGeom prst="rect">
            <a:avLst/>
          </a:prstGeom>
        </p:spPr>
      </p:pic>
      <p:pic>
        <p:nvPicPr>
          <p:cNvPr id="3" name="Immagine 2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160" y="492520"/>
            <a:ext cx="3438144" cy="3200400"/>
          </a:xfrm>
          <a:prstGeom prst="rect">
            <a:avLst/>
          </a:prstGeom>
        </p:spPr>
      </p:pic>
      <p:pic>
        <p:nvPicPr>
          <p:cNvPr id="10" name="Immagine 9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2" y="3583768"/>
            <a:ext cx="3438144" cy="2478024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48B5FB1B-3F16-47F5-AF95-3799173ED5CC}"/>
              </a:ext>
            </a:extLst>
          </p:cNvPr>
          <p:cNvSpPr txBox="1"/>
          <p:nvPr/>
        </p:nvSpPr>
        <p:spPr>
          <a:xfrm>
            <a:off x="379542" y="262892"/>
            <a:ext cx="193258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89C06F19-3079-4FE3-A24A-06E9371AA980}"/>
              </a:ext>
            </a:extLst>
          </p:cNvPr>
          <p:cNvSpPr txBox="1"/>
          <p:nvPr/>
        </p:nvSpPr>
        <p:spPr>
          <a:xfrm>
            <a:off x="3603402" y="262892"/>
            <a:ext cx="435217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A17CFDD4-785C-44F4-934F-063F128A01A9}"/>
              </a:ext>
            </a:extLst>
          </p:cNvPr>
          <p:cNvSpPr txBox="1"/>
          <p:nvPr/>
        </p:nvSpPr>
        <p:spPr>
          <a:xfrm>
            <a:off x="307358" y="3492865"/>
            <a:ext cx="337626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6A060D85-E947-49A1-B11E-020164E3C693}"/>
              </a:ext>
            </a:extLst>
          </p:cNvPr>
          <p:cNvSpPr txBox="1"/>
          <p:nvPr/>
        </p:nvSpPr>
        <p:spPr>
          <a:xfrm>
            <a:off x="3786156" y="3492865"/>
            <a:ext cx="193258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03232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" y="516648"/>
            <a:ext cx="3399905" cy="2685011"/>
          </a:xfrm>
          <a:prstGeom prst="rect">
            <a:avLst/>
          </a:prstGeom>
        </p:spPr>
      </p:pic>
      <p:pic>
        <p:nvPicPr>
          <p:cNvPr id="6" name="Immagine 5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903" y="3777758"/>
            <a:ext cx="3399905" cy="2688336"/>
          </a:xfrm>
          <a:prstGeom prst="rect">
            <a:avLst/>
          </a:prstGeom>
        </p:spPr>
      </p:pic>
      <p:pic>
        <p:nvPicPr>
          <p:cNvPr id="2" name="Immagine 1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833" y="547001"/>
            <a:ext cx="3401568" cy="2688336"/>
          </a:xfrm>
          <a:prstGeom prst="rect">
            <a:avLst/>
          </a:prstGeom>
        </p:spPr>
      </p:pic>
      <p:pic>
        <p:nvPicPr>
          <p:cNvPr id="3" name="Immagine 2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14" y="3702269"/>
            <a:ext cx="3401568" cy="2688336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48B5FB1B-3F16-47F5-AF95-3799173ED5CC}"/>
              </a:ext>
            </a:extLst>
          </p:cNvPr>
          <p:cNvSpPr txBox="1"/>
          <p:nvPr/>
        </p:nvSpPr>
        <p:spPr>
          <a:xfrm>
            <a:off x="379542" y="262892"/>
            <a:ext cx="193258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89C06F19-3079-4FE3-A24A-06E9371AA980}"/>
              </a:ext>
            </a:extLst>
          </p:cNvPr>
          <p:cNvSpPr txBox="1"/>
          <p:nvPr/>
        </p:nvSpPr>
        <p:spPr>
          <a:xfrm>
            <a:off x="3603402" y="262892"/>
            <a:ext cx="435217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A17CFDD4-785C-44F4-934F-063F128A01A9}"/>
              </a:ext>
            </a:extLst>
          </p:cNvPr>
          <p:cNvSpPr txBox="1"/>
          <p:nvPr/>
        </p:nvSpPr>
        <p:spPr>
          <a:xfrm>
            <a:off x="307358" y="3492865"/>
            <a:ext cx="337626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6A060D85-E947-49A1-B11E-020164E3C693}"/>
              </a:ext>
            </a:extLst>
          </p:cNvPr>
          <p:cNvSpPr txBox="1"/>
          <p:nvPr/>
        </p:nvSpPr>
        <p:spPr>
          <a:xfrm>
            <a:off x="3786156" y="3492865"/>
            <a:ext cx="193258" cy="4001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it-IT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942867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53" t="19755" r="29314"/>
          <a:stretch/>
        </p:blipFill>
        <p:spPr>
          <a:xfrm>
            <a:off x="128353" y="739716"/>
            <a:ext cx="3075709" cy="2786784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353" y="4098949"/>
            <a:ext cx="3399905" cy="2668385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095" y="4082323"/>
            <a:ext cx="3399905" cy="2685011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9753" y="4552142"/>
            <a:ext cx="796992" cy="82449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18428" y="4552142"/>
            <a:ext cx="796992" cy="82449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4135824" y="4348841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p= 0.016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4935924" y="4348841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p= 0.044</a:t>
            </a: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8105" y="4532033"/>
            <a:ext cx="1895476" cy="132255"/>
          </a:xfrm>
          <a:prstGeom prst="rect">
            <a:avLst/>
          </a:prstGeom>
        </p:spPr>
      </p:pic>
      <p:sp>
        <p:nvSpPr>
          <p:cNvPr id="15" name="CasellaDiTesto 14"/>
          <p:cNvSpPr txBox="1"/>
          <p:nvPr/>
        </p:nvSpPr>
        <p:spPr>
          <a:xfrm>
            <a:off x="1828306" y="431701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p= 0.031</a:t>
            </a:r>
          </a:p>
        </p:txBody>
      </p:sp>
      <p:pic>
        <p:nvPicPr>
          <p:cNvPr id="16" name="Immagin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29299" y="1362395"/>
            <a:ext cx="796992" cy="82449"/>
          </a:xfrm>
          <a:prstGeom prst="rect">
            <a:avLst/>
          </a:prstGeom>
        </p:spPr>
      </p:pic>
      <p:sp>
        <p:nvSpPr>
          <p:cNvPr id="17" name="CasellaDiTesto 16"/>
          <p:cNvSpPr txBox="1"/>
          <p:nvPr/>
        </p:nvSpPr>
        <p:spPr>
          <a:xfrm>
            <a:off x="1446795" y="1159094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p= 0.031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6644" y="824221"/>
            <a:ext cx="3401568" cy="2686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75193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83</TotalTime>
  <Words>1195</Words>
  <Application>Microsoft Office PowerPoint</Application>
  <PresentationFormat>A4 (21x29,7 cm)</PresentationFormat>
  <Paragraphs>315</Paragraphs>
  <Slides>9</Slides>
  <Notes>9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0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Katia Pane</dc:creator>
  <cp:lastModifiedBy>Federica Conte</cp:lastModifiedBy>
  <cp:revision>144</cp:revision>
  <dcterms:created xsi:type="dcterms:W3CDTF">2019-09-23T15:43:25Z</dcterms:created>
  <dcterms:modified xsi:type="dcterms:W3CDTF">2020-09-07T14:15:06Z</dcterms:modified>
</cp:coreProperties>
</file>